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drawings/drawing1.xml" ContentType="application/vnd.openxmlformats-officedocument.drawingml.chartshapes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charts/chart14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charts/chart15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ppt/charts/chart16.xml" ContentType="application/vnd.openxmlformats-officedocument.drawingml.chart+xml"/>
  <Override PartName="/ppt/charts/style16.xml" ContentType="application/vnd.ms-office.chartstyle+xml"/>
  <Override PartName="/ppt/charts/colors16.xml" ContentType="application/vnd.ms-office.chartcolorstyle+xml"/>
  <Override PartName="/ppt/charts/chart17.xml" ContentType="application/vnd.openxmlformats-officedocument.drawingml.chart+xml"/>
  <Override PartName="/ppt/charts/style17.xml" ContentType="application/vnd.ms-office.chartstyle+xml"/>
  <Override PartName="/ppt/charts/colors17.xml" ContentType="application/vnd.ms-office.chartcolorstyle+xml"/>
  <Override PartName="/ppt/charts/chart18.xml" ContentType="application/vnd.openxmlformats-officedocument.drawingml.chart+xml"/>
  <Override PartName="/ppt/charts/style18.xml" ContentType="application/vnd.ms-office.chartstyle+xml"/>
  <Override PartName="/ppt/charts/colors18.xml" ContentType="application/vnd.ms-office.chartcolorstyle+xml"/>
  <Override PartName="/ppt/charts/chart19.xml" ContentType="application/vnd.openxmlformats-officedocument.drawingml.chart+xml"/>
  <Override PartName="/ppt/charts/style19.xml" ContentType="application/vnd.ms-office.chartstyle+xml"/>
  <Override PartName="/ppt/charts/colors19.xml" ContentType="application/vnd.ms-office.chartcolorstyle+xml"/>
  <Override PartName="/ppt/charts/chart20.xml" ContentType="application/vnd.openxmlformats-officedocument.drawingml.chart+xml"/>
  <Override PartName="/ppt/charts/style20.xml" ContentType="application/vnd.ms-office.chartstyle+xml"/>
  <Override PartName="/ppt/charts/colors20.xml" ContentType="application/vnd.ms-office.chartcolorstyle+xml"/>
  <Override PartName="/ppt/charts/chart21.xml" ContentType="application/vnd.openxmlformats-officedocument.drawingml.chart+xml"/>
  <Override PartName="/ppt/charts/style21.xml" ContentType="application/vnd.ms-office.chartstyle+xml"/>
  <Override PartName="/ppt/charts/colors21.xml" ContentType="application/vnd.ms-office.chartcolorstyle+xml"/>
  <Override PartName="/ppt/charts/chart22.xml" ContentType="application/vnd.openxmlformats-officedocument.drawingml.chart+xml"/>
  <Override PartName="/ppt/charts/style22.xml" ContentType="application/vnd.ms-office.chartstyle+xml"/>
  <Override PartName="/ppt/charts/colors22.xml" ContentType="application/vnd.ms-office.chartcolorstyle+xml"/>
  <Override PartName="/ppt/charts/chart23.xml" ContentType="application/vnd.openxmlformats-officedocument.drawingml.chart+xml"/>
  <Override PartName="/ppt/charts/style23.xml" ContentType="application/vnd.ms-office.chartstyle+xml"/>
  <Override PartName="/ppt/charts/colors23.xml" ContentType="application/vnd.ms-office.chartcolorstyle+xml"/>
  <Override PartName="/ppt/charts/chart24.xml" ContentType="application/vnd.openxmlformats-officedocument.drawingml.chart+xml"/>
  <Override PartName="/ppt/charts/style24.xml" ContentType="application/vnd.ms-office.chartstyle+xml"/>
  <Override PartName="/ppt/charts/colors24.xml" ContentType="application/vnd.ms-office.chartcolorstyle+xml"/>
  <Override PartName="/ppt/charts/chart25.xml" ContentType="application/vnd.openxmlformats-officedocument.drawingml.chart+xml"/>
  <Override PartName="/ppt/charts/style25.xml" ContentType="application/vnd.ms-office.chartstyle+xml"/>
  <Override PartName="/ppt/charts/colors25.xml" ContentType="application/vnd.ms-office.chartcolorstyle+xml"/>
  <Override PartName="/ppt/charts/chart26.xml" ContentType="application/vnd.openxmlformats-officedocument.drawingml.chart+xml"/>
  <Override PartName="/ppt/charts/style26.xml" ContentType="application/vnd.ms-office.chartstyle+xml"/>
  <Override PartName="/ppt/charts/colors26.xml" ContentType="application/vnd.ms-office.chartcolorstyle+xml"/>
  <Override PartName="/ppt/charts/chart27.xml" ContentType="application/vnd.openxmlformats-officedocument.drawingml.chart+xml"/>
  <Override PartName="/ppt/charts/style27.xml" ContentType="application/vnd.ms-office.chartstyle+xml"/>
  <Override PartName="/ppt/charts/colors27.xml" ContentType="application/vnd.ms-office.chartcolorstyle+xml"/>
  <Override PartName="/ppt/charts/chart28.xml" ContentType="application/vnd.openxmlformats-officedocument.drawingml.chart+xml"/>
  <Override PartName="/ppt/charts/style28.xml" ContentType="application/vnd.ms-office.chartstyle+xml"/>
  <Override PartName="/ppt/charts/colors28.xml" ContentType="application/vnd.ms-office.chartcolorstyle+xml"/>
  <Override PartName="/ppt/charts/chart29.xml" ContentType="application/vnd.openxmlformats-officedocument.drawingml.chart+xml"/>
  <Override PartName="/ppt/charts/style29.xml" ContentType="application/vnd.ms-office.chartstyle+xml"/>
  <Override PartName="/ppt/charts/colors29.xml" ContentType="application/vnd.ms-office.chartcolorstyle+xml"/>
  <Override PartName="/ppt/charts/chart30.xml" ContentType="application/vnd.openxmlformats-officedocument.drawingml.chart+xml"/>
  <Override PartName="/ppt/charts/style30.xml" ContentType="application/vnd.ms-office.chartstyle+xml"/>
  <Override PartName="/ppt/charts/colors30.xml" ContentType="application/vnd.ms-office.chartcolorstyle+xml"/>
  <Override PartName="/ppt/charts/chart31.xml" ContentType="application/vnd.openxmlformats-officedocument.drawingml.chart+xml"/>
  <Override PartName="/ppt/charts/style31.xml" ContentType="application/vnd.ms-office.chartstyle+xml"/>
  <Override PartName="/ppt/charts/colors31.xml" ContentType="application/vnd.ms-office.chartcolorstyle+xml"/>
  <Override PartName="/ppt/charts/chart32.xml" ContentType="application/vnd.openxmlformats-officedocument.drawingml.chart+xml"/>
  <Override PartName="/ppt/charts/style32.xml" ContentType="application/vnd.ms-office.chartstyle+xml"/>
  <Override PartName="/ppt/charts/colors32.xml" ContentType="application/vnd.ms-office.chartcolorstyle+xml"/>
  <Override PartName="/ppt/charts/chart33.xml" ContentType="application/vnd.openxmlformats-officedocument.drawingml.chart+xml"/>
  <Override PartName="/ppt/charts/style33.xml" ContentType="application/vnd.ms-office.chartstyle+xml"/>
  <Override PartName="/ppt/charts/colors33.xml" ContentType="application/vnd.ms-office.chartcolorstyle+xml"/>
  <Override PartName="/ppt/charts/chart34.xml" ContentType="application/vnd.openxmlformats-officedocument.drawingml.chart+xml"/>
  <Override PartName="/ppt/charts/style34.xml" ContentType="application/vnd.ms-office.chartstyle+xml"/>
  <Override PartName="/ppt/charts/colors34.xml" ContentType="application/vnd.ms-office.chartcolorstyle+xml"/>
  <Override PartName="/ppt/charts/chart35.xml" ContentType="application/vnd.openxmlformats-officedocument.drawingml.chart+xml"/>
  <Override PartName="/ppt/charts/style35.xml" ContentType="application/vnd.ms-office.chartstyle+xml"/>
  <Override PartName="/ppt/charts/colors35.xml" ContentType="application/vnd.ms-office.chartcolorstyle+xml"/>
  <Override PartName="/ppt/charts/chart36.xml" ContentType="application/vnd.openxmlformats-officedocument.drawingml.chart+xml"/>
  <Override PartName="/ppt/charts/style36.xml" ContentType="application/vnd.ms-office.chartstyle+xml"/>
  <Override PartName="/ppt/charts/colors36.xml" ContentType="application/vnd.ms-office.chartcolorstyle+xml"/>
  <Override PartName="/ppt/charts/chart37.xml" ContentType="application/vnd.openxmlformats-officedocument.drawingml.chart+xml"/>
  <Override PartName="/ppt/charts/style37.xml" ContentType="application/vnd.ms-office.chartstyle+xml"/>
  <Override PartName="/ppt/charts/colors37.xml" ContentType="application/vnd.ms-office.chartcolorstyle+xml"/>
  <Override PartName="/ppt/charts/chart38.xml" ContentType="application/vnd.openxmlformats-officedocument.drawingml.chart+xml"/>
  <Override PartName="/ppt/charts/style38.xml" ContentType="application/vnd.ms-office.chartstyle+xml"/>
  <Override PartName="/ppt/charts/colors38.xml" ContentType="application/vnd.ms-office.chartcolorstyle+xml"/>
  <Override PartName="/ppt/charts/chart39.xml" ContentType="application/vnd.openxmlformats-officedocument.drawingml.chart+xml"/>
  <Override PartName="/ppt/charts/style39.xml" ContentType="application/vnd.ms-office.chartstyle+xml"/>
  <Override PartName="/ppt/charts/colors39.xml" ContentType="application/vnd.ms-office.chartcolorstyle+xml"/>
  <Override PartName="/ppt/charts/chart40.xml" ContentType="application/vnd.openxmlformats-officedocument.drawingml.chart+xml"/>
  <Override PartName="/ppt/charts/style40.xml" ContentType="application/vnd.ms-office.chartstyle+xml"/>
  <Override PartName="/ppt/charts/colors40.xml" ContentType="application/vnd.ms-office.chartcolorstyle+xml"/>
  <Override PartName="/ppt/charts/chart41.xml" ContentType="application/vnd.openxmlformats-officedocument.drawingml.chart+xml"/>
  <Override PartName="/ppt/charts/style41.xml" ContentType="application/vnd.ms-office.chartstyle+xml"/>
  <Override PartName="/ppt/charts/colors41.xml" ContentType="application/vnd.ms-office.chartcolorstyle+xml"/>
  <Override PartName="/ppt/charts/chart42.xml" ContentType="application/vnd.openxmlformats-officedocument.drawingml.chart+xml"/>
  <Override PartName="/ppt/charts/style42.xml" ContentType="application/vnd.ms-office.chartstyle+xml"/>
  <Override PartName="/ppt/charts/colors42.xml" ContentType="application/vnd.ms-office.chartcolorstyle+xml"/>
  <Override PartName="/ppt/charts/chart43.xml" ContentType="application/vnd.openxmlformats-officedocument.drawingml.chart+xml"/>
  <Override PartName="/ppt/charts/style43.xml" ContentType="application/vnd.ms-office.chartstyle+xml"/>
  <Override PartName="/ppt/charts/colors43.xml" ContentType="application/vnd.ms-office.chartcolorstyle+xml"/>
  <Override PartName="/ppt/charts/chart44.xml" ContentType="application/vnd.openxmlformats-officedocument.drawingml.chart+xml"/>
  <Override PartName="/ppt/charts/style44.xml" ContentType="application/vnd.ms-office.chartstyle+xml"/>
  <Override PartName="/ppt/charts/colors44.xml" ContentType="application/vnd.ms-office.chartcolorstyle+xml"/>
  <Override PartName="/ppt/charts/chart45.xml" ContentType="application/vnd.openxmlformats-officedocument.drawingml.chart+xml"/>
  <Override PartName="/ppt/charts/style45.xml" ContentType="application/vnd.ms-office.chartstyle+xml"/>
  <Override PartName="/ppt/charts/colors45.xml" ContentType="application/vnd.ms-office.chartcolorstyle+xml"/>
  <Override PartName="/ppt/charts/chart46.xml" ContentType="application/vnd.openxmlformats-officedocument.drawingml.chart+xml"/>
  <Override PartName="/ppt/charts/style46.xml" ContentType="application/vnd.ms-office.chartstyle+xml"/>
  <Override PartName="/ppt/charts/colors46.xml" ContentType="application/vnd.ms-office.chartcolorstyle+xml"/>
  <Override PartName="/ppt/charts/chart47.xml" ContentType="application/vnd.openxmlformats-officedocument.drawingml.chart+xml"/>
  <Override PartName="/ppt/charts/style47.xml" ContentType="application/vnd.ms-office.chartstyle+xml"/>
  <Override PartName="/ppt/charts/colors47.xml" ContentType="application/vnd.ms-office.chartcolorstyle+xml"/>
  <Override PartName="/ppt/charts/chart48.xml" ContentType="application/vnd.openxmlformats-officedocument.drawingml.chart+xml"/>
  <Override PartName="/ppt/charts/style48.xml" ContentType="application/vnd.ms-office.chartstyle+xml"/>
  <Override PartName="/ppt/charts/colors48.xml" ContentType="application/vnd.ms-office.chartcolorstyle+xml"/>
  <Override PartName="/ppt/charts/chart49.xml" ContentType="application/vnd.openxmlformats-officedocument.drawingml.chart+xml"/>
  <Override PartName="/ppt/charts/style49.xml" ContentType="application/vnd.ms-office.chartstyle+xml"/>
  <Override PartName="/ppt/charts/colors49.xml" ContentType="application/vnd.ms-office.chartcolorstyle+xml"/>
  <Override PartName="/ppt/charts/chart50.xml" ContentType="application/vnd.openxmlformats-officedocument.drawingml.chart+xml"/>
  <Override PartName="/ppt/charts/style50.xml" ContentType="application/vnd.ms-office.chartstyle+xml"/>
  <Override PartName="/ppt/charts/colors50.xml" ContentType="application/vnd.ms-office.chartcolorstyle+xml"/>
  <Override PartName="/ppt/charts/chart51.xml" ContentType="application/vnd.openxmlformats-officedocument.drawingml.chart+xml"/>
  <Override PartName="/ppt/charts/style51.xml" ContentType="application/vnd.ms-office.chartstyle+xml"/>
  <Override PartName="/ppt/charts/colors51.xml" ContentType="application/vnd.ms-office.chartcolorstyle+xml"/>
  <Override PartName="/ppt/charts/chart52.xml" ContentType="application/vnd.openxmlformats-officedocument.drawingml.chart+xml"/>
  <Override PartName="/ppt/charts/style52.xml" ContentType="application/vnd.ms-office.chartstyle+xml"/>
  <Override PartName="/ppt/charts/colors52.xml" ContentType="application/vnd.ms-office.chartcolorstyle+xml"/>
  <Override PartName="/ppt/charts/chart53.xml" ContentType="application/vnd.openxmlformats-officedocument.drawingml.chart+xml"/>
  <Override PartName="/ppt/charts/style53.xml" ContentType="application/vnd.ms-office.chartstyle+xml"/>
  <Override PartName="/ppt/charts/colors53.xml" ContentType="application/vnd.ms-office.chartcolorstyle+xml"/>
  <Override PartName="/ppt/charts/chart54.xml" ContentType="application/vnd.openxmlformats-officedocument.drawingml.chart+xml"/>
  <Override PartName="/ppt/charts/style54.xml" ContentType="application/vnd.ms-office.chartstyle+xml"/>
  <Override PartName="/ppt/charts/colors54.xml" ContentType="application/vnd.ms-office.chartcolorstyle+xml"/>
  <Override PartName="/ppt/charts/chart55.xml" ContentType="application/vnd.openxmlformats-officedocument.drawingml.chart+xml"/>
  <Override PartName="/ppt/charts/style55.xml" ContentType="application/vnd.ms-office.chartstyle+xml"/>
  <Override PartName="/ppt/charts/colors55.xml" ContentType="application/vnd.ms-office.chartcolorstyle+xml"/>
  <Override PartName="/ppt/charts/chart56.xml" ContentType="application/vnd.openxmlformats-officedocument.drawingml.chart+xml"/>
  <Override PartName="/ppt/charts/style56.xml" ContentType="application/vnd.ms-office.chartstyle+xml"/>
  <Override PartName="/ppt/charts/colors56.xml" ContentType="application/vnd.ms-office.chartcolorstyle+xml"/>
  <Override PartName="/ppt/charts/chart57.xml" ContentType="application/vnd.openxmlformats-officedocument.drawingml.chart+xml"/>
  <Override PartName="/ppt/charts/style57.xml" ContentType="application/vnd.ms-office.chartstyle+xml"/>
  <Override PartName="/ppt/charts/colors57.xml" ContentType="application/vnd.ms-office.chartcolorstyle+xml"/>
  <Override PartName="/ppt/charts/chart58.xml" ContentType="application/vnd.openxmlformats-officedocument.drawingml.chart+xml"/>
  <Override PartName="/ppt/charts/style58.xml" ContentType="application/vnd.ms-office.chartstyle+xml"/>
  <Override PartName="/ppt/charts/colors58.xml" ContentType="application/vnd.ms-office.chartcolorstyle+xml"/>
  <Override PartName="/ppt/charts/chart59.xml" ContentType="application/vnd.openxmlformats-officedocument.drawingml.chart+xml"/>
  <Override PartName="/ppt/charts/style59.xml" ContentType="application/vnd.ms-office.chartstyle+xml"/>
  <Override PartName="/ppt/charts/colors59.xml" ContentType="application/vnd.ms-office.chartcolorstyle+xml"/>
  <Override PartName="/ppt/charts/chart60.xml" ContentType="application/vnd.openxmlformats-officedocument.drawingml.chart+xml"/>
  <Override PartName="/ppt/charts/style60.xml" ContentType="application/vnd.ms-office.chartstyle+xml"/>
  <Override PartName="/ppt/charts/colors60.xml" ContentType="application/vnd.ms-office.chartcolorstyle+xml"/>
  <Override PartName="/ppt/charts/chart61.xml" ContentType="application/vnd.openxmlformats-officedocument.drawingml.chart+xml"/>
  <Override PartName="/ppt/charts/style61.xml" ContentType="application/vnd.ms-office.chartstyle+xml"/>
  <Override PartName="/ppt/charts/colors61.xml" ContentType="application/vnd.ms-office.chartcolorstyle+xml"/>
  <Override PartName="/ppt/charts/chart62.xml" ContentType="application/vnd.openxmlformats-officedocument.drawingml.chart+xml"/>
  <Override PartName="/ppt/charts/style62.xml" ContentType="application/vnd.ms-office.chartstyle+xml"/>
  <Override PartName="/ppt/charts/colors62.xml" ContentType="application/vnd.ms-office.chartcolorstyle+xml"/>
  <Override PartName="/ppt/charts/chart63.xml" ContentType="application/vnd.openxmlformats-officedocument.drawingml.chart+xml"/>
  <Override PartName="/ppt/charts/style63.xml" ContentType="application/vnd.ms-office.chartstyle+xml"/>
  <Override PartName="/ppt/charts/colors63.xml" ContentType="application/vnd.ms-office.chartcolorstyle+xml"/>
  <Override PartName="/ppt/charts/chart64.xml" ContentType="application/vnd.openxmlformats-officedocument.drawingml.chart+xml"/>
  <Override PartName="/ppt/charts/style64.xml" ContentType="application/vnd.ms-office.chartstyle+xml"/>
  <Override PartName="/ppt/charts/colors64.xml" ContentType="application/vnd.ms-office.chartcolorstyle+xml"/>
  <Override PartName="/ppt/charts/chart65.xml" ContentType="application/vnd.openxmlformats-officedocument.drawingml.chart+xml"/>
  <Override PartName="/ppt/charts/style65.xml" ContentType="application/vnd.ms-office.chartstyle+xml"/>
  <Override PartName="/ppt/charts/colors65.xml" ContentType="application/vnd.ms-office.chartcolorstyle+xml"/>
  <Override PartName="/ppt/charts/chart66.xml" ContentType="application/vnd.openxmlformats-officedocument.drawingml.chart+xml"/>
  <Override PartName="/ppt/charts/style66.xml" ContentType="application/vnd.ms-office.chartstyle+xml"/>
  <Override PartName="/ppt/charts/colors66.xml" ContentType="application/vnd.ms-office.chartcolorstyle+xml"/>
  <Override PartName="/ppt/charts/chart67.xml" ContentType="application/vnd.openxmlformats-officedocument.drawingml.chart+xml"/>
  <Override PartName="/ppt/charts/style67.xml" ContentType="application/vnd.ms-office.chartstyle+xml"/>
  <Override PartName="/ppt/charts/colors67.xml" ContentType="application/vnd.ms-office.chartcolorstyle+xml"/>
  <Override PartName="/ppt/charts/chart68.xml" ContentType="application/vnd.openxmlformats-officedocument.drawingml.chart+xml"/>
  <Override PartName="/ppt/charts/style68.xml" ContentType="application/vnd.ms-office.chartstyle+xml"/>
  <Override PartName="/ppt/charts/colors68.xml" ContentType="application/vnd.ms-office.chartcolorstyle+xml"/>
  <Override PartName="/ppt/charts/chart69.xml" ContentType="application/vnd.openxmlformats-officedocument.drawingml.chart+xml"/>
  <Override PartName="/ppt/charts/style69.xml" ContentType="application/vnd.ms-office.chartstyle+xml"/>
  <Override PartName="/ppt/charts/colors69.xml" ContentType="application/vnd.ms-office.chartcolorstyle+xml"/>
  <Override PartName="/ppt/charts/chart70.xml" ContentType="application/vnd.openxmlformats-officedocument.drawingml.chart+xml"/>
  <Override PartName="/ppt/charts/style70.xml" ContentType="application/vnd.ms-office.chartstyle+xml"/>
  <Override PartName="/ppt/charts/colors70.xml" ContentType="application/vnd.ms-office.chartcolorstyle+xml"/>
  <Override PartName="/ppt/charts/chart71.xml" ContentType="application/vnd.openxmlformats-officedocument.drawingml.chart+xml"/>
  <Override PartName="/ppt/charts/style71.xml" ContentType="application/vnd.ms-office.chartstyle+xml"/>
  <Override PartName="/ppt/charts/colors71.xml" ContentType="application/vnd.ms-office.chartcolorstyle+xml"/>
  <Override PartName="/ppt/charts/chart72.xml" ContentType="application/vnd.openxmlformats-officedocument.drawingml.chart+xml"/>
  <Override PartName="/ppt/charts/style72.xml" ContentType="application/vnd.ms-office.chartstyle+xml"/>
  <Override PartName="/ppt/charts/colors72.xml" ContentType="application/vnd.ms-office.chartcolorstyle+xml"/>
  <Override PartName="/ppt/charts/chart73.xml" ContentType="application/vnd.openxmlformats-officedocument.drawingml.chart+xml"/>
  <Override PartName="/ppt/charts/style73.xml" ContentType="application/vnd.ms-office.chartstyle+xml"/>
  <Override PartName="/ppt/charts/colors73.xml" ContentType="application/vnd.ms-office.chartcolorstyle+xml"/>
  <Override PartName="/ppt/charts/chart74.xml" ContentType="application/vnd.openxmlformats-officedocument.drawingml.chart+xml"/>
  <Override PartName="/ppt/charts/style74.xml" ContentType="application/vnd.ms-office.chartstyle+xml"/>
  <Override PartName="/ppt/charts/colors74.xml" ContentType="application/vnd.ms-office.chartcolorstyle+xml"/>
  <Override PartName="/ppt/charts/chart75.xml" ContentType="application/vnd.openxmlformats-officedocument.drawingml.chart+xml"/>
  <Override PartName="/ppt/charts/style75.xml" ContentType="application/vnd.ms-office.chartstyle+xml"/>
  <Override PartName="/ppt/charts/colors75.xml" ContentType="application/vnd.ms-office.chartcolorstyle+xml"/>
  <Override PartName="/ppt/charts/chart76.xml" ContentType="application/vnd.openxmlformats-officedocument.drawingml.chart+xml"/>
  <Override PartName="/ppt/charts/style76.xml" ContentType="application/vnd.ms-office.chartstyle+xml"/>
  <Override PartName="/ppt/charts/colors76.xml" ContentType="application/vnd.ms-office.chartcolorstyle+xml"/>
  <Override PartName="/ppt/charts/chart77.xml" ContentType="application/vnd.openxmlformats-officedocument.drawingml.chart+xml"/>
  <Override PartName="/ppt/charts/style77.xml" ContentType="application/vnd.ms-office.chartstyle+xml"/>
  <Override PartName="/ppt/charts/colors77.xml" ContentType="application/vnd.ms-office.chartcolorstyle+xml"/>
  <Override PartName="/ppt/charts/chart78.xml" ContentType="application/vnd.openxmlformats-officedocument.drawingml.chart+xml"/>
  <Override PartName="/ppt/charts/style78.xml" ContentType="application/vnd.ms-office.chartstyle+xml"/>
  <Override PartName="/ppt/charts/colors78.xml" ContentType="application/vnd.ms-office.chartcolorstyle+xml"/>
  <Override PartName="/ppt/charts/chart79.xml" ContentType="application/vnd.openxmlformats-officedocument.drawingml.chart+xml"/>
  <Override PartName="/ppt/charts/style79.xml" ContentType="application/vnd.ms-office.chartstyle+xml"/>
  <Override PartName="/ppt/charts/colors79.xml" ContentType="application/vnd.ms-office.chartcolorstyle+xml"/>
  <Override PartName="/ppt/charts/chart80.xml" ContentType="application/vnd.openxmlformats-officedocument.drawingml.chart+xml"/>
  <Override PartName="/ppt/charts/style80.xml" ContentType="application/vnd.ms-office.chartstyle+xml"/>
  <Override PartName="/ppt/charts/colors80.xml" ContentType="application/vnd.ms-office.chartcolorstyle+xml"/>
  <Override PartName="/ppt/charts/chart81.xml" ContentType="application/vnd.openxmlformats-officedocument.drawingml.chart+xml"/>
  <Override PartName="/ppt/charts/style81.xml" ContentType="application/vnd.ms-office.chartstyle+xml"/>
  <Override PartName="/ppt/charts/colors81.xml" ContentType="application/vnd.ms-office.chartcolorstyle+xml"/>
  <Override PartName="/ppt/charts/chart82.xml" ContentType="application/vnd.openxmlformats-officedocument.drawingml.chart+xml"/>
  <Override PartName="/ppt/charts/style82.xml" ContentType="application/vnd.ms-office.chartstyle+xml"/>
  <Override PartName="/ppt/charts/colors82.xml" ContentType="application/vnd.ms-office.chartcolorstyle+xml"/>
  <Override PartName="/ppt/charts/chart83.xml" ContentType="application/vnd.openxmlformats-officedocument.drawingml.chart+xml"/>
  <Override PartName="/ppt/charts/style83.xml" ContentType="application/vnd.ms-office.chartstyle+xml"/>
  <Override PartName="/ppt/charts/colors83.xml" ContentType="application/vnd.ms-office.chartcolorstyle+xml"/>
  <Override PartName="/ppt/charts/chart84.xml" ContentType="application/vnd.openxmlformats-officedocument.drawingml.chart+xml"/>
  <Override PartName="/ppt/charts/style84.xml" ContentType="application/vnd.ms-office.chartstyle+xml"/>
  <Override PartName="/ppt/charts/colors84.xml" ContentType="application/vnd.ms-office.chartcolorstyle+xml"/>
  <Override PartName="/ppt/charts/chart85.xml" ContentType="application/vnd.openxmlformats-officedocument.drawingml.chart+xml"/>
  <Override PartName="/ppt/charts/style85.xml" ContentType="application/vnd.ms-office.chartstyle+xml"/>
  <Override PartName="/ppt/charts/colors85.xml" ContentType="application/vnd.ms-office.chartcolorstyle+xml"/>
  <Override PartName="/ppt/charts/chart86.xml" ContentType="application/vnd.openxmlformats-officedocument.drawingml.chart+xml"/>
  <Override PartName="/ppt/charts/style86.xml" ContentType="application/vnd.ms-office.chartstyle+xml"/>
  <Override PartName="/ppt/charts/colors86.xml" ContentType="application/vnd.ms-office.chartcolorstyle+xml"/>
  <Override PartName="/ppt/charts/chart87.xml" ContentType="application/vnd.openxmlformats-officedocument.drawingml.chart+xml"/>
  <Override PartName="/ppt/charts/style87.xml" ContentType="application/vnd.ms-office.chartstyle+xml"/>
  <Override PartName="/ppt/charts/colors87.xml" ContentType="application/vnd.ms-office.chartcolorstyle+xml"/>
  <Override PartName="/ppt/charts/chart88.xml" ContentType="application/vnd.openxmlformats-officedocument.drawingml.chart+xml"/>
  <Override PartName="/ppt/charts/style88.xml" ContentType="application/vnd.ms-office.chartstyle+xml"/>
  <Override PartName="/ppt/charts/colors88.xml" ContentType="application/vnd.ms-office.chartcolorstyle+xml"/>
  <Override PartName="/ppt/charts/chart89.xml" ContentType="application/vnd.openxmlformats-officedocument.drawingml.chart+xml"/>
  <Override PartName="/ppt/charts/style89.xml" ContentType="application/vnd.ms-office.chartstyle+xml"/>
  <Override PartName="/ppt/charts/colors89.xml" ContentType="application/vnd.ms-office.chartcolorstyle+xml"/>
  <Override PartName="/ppt/charts/chart90.xml" ContentType="application/vnd.openxmlformats-officedocument.drawingml.chart+xml"/>
  <Override PartName="/ppt/charts/style90.xml" ContentType="application/vnd.ms-office.chartstyle+xml"/>
  <Override PartName="/ppt/charts/colors90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  <p:sldId id="258" r:id="rId3"/>
    <p:sldId id="259" r:id="rId4"/>
    <p:sldId id="260" r:id="rId5"/>
    <p:sldId id="261" r:id="rId6"/>
    <p:sldId id="262" r:id="rId7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DDDDD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1E4AEA4-8DFA-4A89-87EB-49C32662AFE0}" styleName="中間スタイル 2 - アクセント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95" d="100"/>
          <a:sy n="95" d="100"/>
        </p:scale>
        <p:origin x="1092" y="-33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HOP%20&amp;%20NCI%20(2)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HOP%20&amp;%20NCI%20(2)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HOP%20&amp;%20NCI%20(2)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HOP%20&amp;%20NCI%20(2).xlsx" TargetMode="External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HOP%20&amp;%20NCI%20(2).xlsx" TargetMode="External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HOP%20&amp;%20NCI%20(2).xlsx" TargetMode="External"/><Relationship Id="rId2" Type="http://schemas.microsoft.com/office/2011/relationships/chartColorStyle" Target="colors14.xml"/><Relationship Id="rId1" Type="http://schemas.microsoft.com/office/2011/relationships/chartStyle" Target="style14.xm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HOP%20&amp;%20NCI%20(2).xlsx" TargetMode="External"/><Relationship Id="rId2" Type="http://schemas.microsoft.com/office/2011/relationships/chartColorStyle" Target="colors15.xml"/><Relationship Id="rId1" Type="http://schemas.microsoft.com/office/2011/relationships/chartStyle" Target="style15.xml"/></Relationships>
</file>

<file path=ppt/charts/_rels/chart16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HOP%20&amp;%20NCI%20(2).xlsx" TargetMode="External"/><Relationship Id="rId2" Type="http://schemas.microsoft.com/office/2011/relationships/chartColorStyle" Target="colors16.xml"/><Relationship Id="rId1" Type="http://schemas.microsoft.com/office/2011/relationships/chartStyle" Target="style16.xml"/></Relationships>
</file>

<file path=ppt/charts/_rels/chart17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HOP%20&amp;%20NCI%20(2).xlsx" TargetMode="External"/><Relationship Id="rId2" Type="http://schemas.microsoft.com/office/2011/relationships/chartColorStyle" Target="colors17.xml"/><Relationship Id="rId1" Type="http://schemas.microsoft.com/office/2011/relationships/chartStyle" Target="style17.xml"/></Relationships>
</file>

<file path=ppt/charts/_rels/chart18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HOP%20&amp;%20NCI%20(2).xlsx" TargetMode="External"/><Relationship Id="rId2" Type="http://schemas.microsoft.com/office/2011/relationships/chartColorStyle" Target="colors18.xml"/><Relationship Id="rId1" Type="http://schemas.microsoft.com/office/2011/relationships/chartStyle" Target="style18.xml"/></Relationships>
</file>

<file path=ppt/charts/_rels/chart19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HOP%20&amp;%20NCI%20(2).xlsx" TargetMode="External"/><Relationship Id="rId2" Type="http://schemas.microsoft.com/office/2011/relationships/chartColorStyle" Target="colors19.xml"/><Relationship Id="rId1" Type="http://schemas.microsoft.com/office/2011/relationships/chartStyle" Target="style19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HOP%20&amp;%20NCI%20(2)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20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HOP%20&amp;%20NCI%20(2).xlsx" TargetMode="External"/><Relationship Id="rId2" Type="http://schemas.microsoft.com/office/2011/relationships/chartColorStyle" Target="colors20.xml"/><Relationship Id="rId1" Type="http://schemas.microsoft.com/office/2011/relationships/chartStyle" Target="style20.xml"/></Relationships>
</file>

<file path=ppt/charts/_rels/chart21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HOP%20&amp;%20NCI%20(2).xlsx" TargetMode="External"/><Relationship Id="rId2" Type="http://schemas.microsoft.com/office/2011/relationships/chartColorStyle" Target="colors21.xml"/><Relationship Id="rId1" Type="http://schemas.microsoft.com/office/2011/relationships/chartStyle" Target="style21.xml"/></Relationships>
</file>

<file path=ppt/charts/_rels/chart22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HOP%20&amp;%20NCI%20(2).xlsx" TargetMode="External"/><Relationship Id="rId2" Type="http://schemas.microsoft.com/office/2011/relationships/chartColorStyle" Target="colors22.xml"/><Relationship Id="rId1" Type="http://schemas.microsoft.com/office/2011/relationships/chartStyle" Target="style22.xml"/></Relationships>
</file>

<file path=ppt/charts/_rels/chart23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HOP%20&amp;%20NCI%20(2).xlsx" TargetMode="External"/><Relationship Id="rId2" Type="http://schemas.microsoft.com/office/2011/relationships/chartColorStyle" Target="colors23.xml"/><Relationship Id="rId1" Type="http://schemas.microsoft.com/office/2011/relationships/chartStyle" Target="style23.xml"/></Relationships>
</file>

<file path=ppt/charts/_rels/chart24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HOP%20&amp;%20NCI%20(2).xlsx" TargetMode="External"/><Relationship Id="rId2" Type="http://schemas.microsoft.com/office/2011/relationships/chartColorStyle" Target="colors24.xml"/><Relationship Id="rId1" Type="http://schemas.microsoft.com/office/2011/relationships/chartStyle" Target="style24.xml"/></Relationships>
</file>

<file path=ppt/charts/_rels/chart25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HOP%20&amp;%20NCI%20(2).xlsx" TargetMode="External"/><Relationship Id="rId2" Type="http://schemas.microsoft.com/office/2011/relationships/chartColorStyle" Target="colors25.xml"/><Relationship Id="rId1" Type="http://schemas.microsoft.com/office/2011/relationships/chartStyle" Target="style25.xml"/></Relationships>
</file>

<file path=ppt/charts/_rels/chart26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HOP%20&amp;%20NCI%20(2).xlsx" TargetMode="External"/><Relationship Id="rId2" Type="http://schemas.microsoft.com/office/2011/relationships/chartColorStyle" Target="colors26.xml"/><Relationship Id="rId1" Type="http://schemas.microsoft.com/office/2011/relationships/chartStyle" Target="style26.xml"/></Relationships>
</file>

<file path=ppt/charts/_rels/chart27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HOP%20&amp;%20NCI%20(2).xlsx" TargetMode="External"/><Relationship Id="rId2" Type="http://schemas.microsoft.com/office/2011/relationships/chartColorStyle" Target="colors27.xml"/><Relationship Id="rId1" Type="http://schemas.microsoft.com/office/2011/relationships/chartStyle" Target="style27.xml"/></Relationships>
</file>

<file path=ppt/charts/_rels/chart28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HOP%20&amp;%20NCI%20(2).xlsx" TargetMode="External"/><Relationship Id="rId2" Type="http://schemas.microsoft.com/office/2011/relationships/chartColorStyle" Target="colors28.xml"/><Relationship Id="rId1" Type="http://schemas.microsoft.com/office/2011/relationships/chartStyle" Target="style28.xml"/></Relationships>
</file>

<file path=ppt/charts/_rels/chart29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HOP%20&amp;%20NCI%20(2).xlsx" TargetMode="External"/><Relationship Id="rId2" Type="http://schemas.microsoft.com/office/2011/relationships/chartColorStyle" Target="colors29.xml"/><Relationship Id="rId1" Type="http://schemas.microsoft.com/office/2011/relationships/chartStyle" Target="style29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HOP%20&amp;%20NCI%20(2)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30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HOP%20&amp;%20NCI%20(2).xlsx" TargetMode="External"/><Relationship Id="rId2" Type="http://schemas.microsoft.com/office/2011/relationships/chartColorStyle" Target="colors30.xml"/><Relationship Id="rId1" Type="http://schemas.microsoft.com/office/2011/relationships/chartStyle" Target="style30.xml"/></Relationships>
</file>

<file path=ppt/charts/_rels/chart31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PC%20&amp;%20DU.xlsx" TargetMode="External"/><Relationship Id="rId2" Type="http://schemas.microsoft.com/office/2011/relationships/chartColorStyle" Target="colors31.xml"/><Relationship Id="rId1" Type="http://schemas.microsoft.com/office/2011/relationships/chartStyle" Target="style31.xml"/></Relationships>
</file>

<file path=ppt/charts/_rels/chart32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PC%20&amp;%20DU.xlsx" TargetMode="External"/><Relationship Id="rId2" Type="http://schemas.microsoft.com/office/2011/relationships/chartColorStyle" Target="colors32.xml"/><Relationship Id="rId1" Type="http://schemas.microsoft.com/office/2011/relationships/chartStyle" Target="style32.xml"/></Relationships>
</file>

<file path=ppt/charts/_rels/chart33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PC%20&amp;%20DU.xlsx" TargetMode="External"/><Relationship Id="rId2" Type="http://schemas.microsoft.com/office/2011/relationships/chartColorStyle" Target="colors33.xml"/><Relationship Id="rId1" Type="http://schemas.microsoft.com/office/2011/relationships/chartStyle" Target="style33.xml"/></Relationships>
</file>

<file path=ppt/charts/_rels/chart34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PC%20&amp;%20DU.xlsx" TargetMode="External"/><Relationship Id="rId2" Type="http://schemas.microsoft.com/office/2011/relationships/chartColorStyle" Target="colors34.xml"/><Relationship Id="rId1" Type="http://schemas.microsoft.com/office/2011/relationships/chartStyle" Target="style34.xml"/></Relationships>
</file>

<file path=ppt/charts/_rels/chart35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PC%20&amp;%20DU.xlsx" TargetMode="External"/><Relationship Id="rId2" Type="http://schemas.microsoft.com/office/2011/relationships/chartColorStyle" Target="colors35.xml"/><Relationship Id="rId1" Type="http://schemas.microsoft.com/office/2011/relationships/chartStyle" Target="style35.xml"/></Relationships>
</file>

<file path=ppt/charts/_rels/chart36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PC%20&amp;%20DU.xlsx" TargetMode="External"/><Relationship Id="rId2" Type="http://schemas.microsoft.com/office/2011/relationships/chartColorStyle" Target="colors36.xml"/><Relationship Id="rId1" Type="http://schemas.microsoft.com/office/2011/relationships/chartStyle" Target="style36.xml"/></Relationships>
</file>

<file path=ppt/charts/_rels/chart37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PC%20&amp;%20DU.xlsx" TargetMode="External"/><Relationship Id="rId2" Type="http://schemas.microsoft.com/office/2011/relationships/chartColorStyle" Target="colors37.xml"/><Relationship Id="rId1" Type="http://schemas.microsoft.com/office/2011/relationships/chartStyle" Target="style37.xml"/></Relationships>
</file>

<file path=ppt/charts/_rels/chart38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PC%20&amp;%20DU.xlsx" TargetMode="External"/><Relationship Id="rId2" Type="http://schemas.microsoft.com/office/2011/relationships/chartColorStyle" Target="colors38.xml"/><Relationship Id="rId1" Type="http://schemas.microsoft.com/office/2011/relationships/chartStyle" Target="style38.xml"/></Relationships>
</file>

<file path=ppt/charts/_rels/chart39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PC%20&amp;%20DU.xlsx" TargetMode="External"/><Relationship Id="rId2" Type="http://schemas.microsoft.com/office/2011/relationships/chartColorStyle" Target="colors39.xml"/><Relationship Id="rId1" Type="http://schemas.microsoft.com/office/2011/relationships/chartStyle" Target="style39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HOP%20&amp;%20NCI%20(2)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40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PC%20&amp;%20DU.xlsx" TargetMode="External"/><Relationship Id="rId2" Type="http://schemas.microsoft.com/office/2011/relationships/chartColorStyle" Target="colors40.xml"/><Relationship Id="rId1" Type="http://schemas.microsoft.com/office/2011/relationships/chartStyle" Target="style40.xml"/></Relationships>
</file>

<file path=ppt/charts/_rels/chart41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PC%20&amp;%20DU.xlsx" TargetMode="External"/><Relationship Id="rId2" Type="http://schemas.microsoft.com/office/2011/relationships/chartColorStyle" Target="colors41.xml"/><Relationship Id="rId1" Type="http://schemas.microsoft.com/office/2011/relationships/chartStyle" Target="style41.xml"/></Relationships>
</file>

<file path=ppt/charts/_rels/chart42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PC%20&amp;%20DU.xlsx" TargetMode="External"/><Relationship Id="rId2" Type="http://schemas.microsoft.com/office/2011/relationships/chartColorStyle" Target="colors42.xml"/><Relationship Id="rId1" Type="http://schemas.microsoft.com/office/2011/relationships/chartStyle" Target="style42.xml"/></Relationships>
</file>

<file path=ppt/charts/_rels/chart43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PC%20&amp;%20DU.xlsx" TargetMode="External"/><Relationship Id="rId2" Type="http://schemas.microsoft.com/office/2011/relationships/chartColorStyle" Target="colors43.xml"/><Relationship Id="rId1" Type="http://schemas.microsoft.com/office/2011/relationships/chartStyle" Target="style43.xml"/></Relationships>
</file>

<file path=ppt/charts/_rels/chart44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PC%20&amp;%20DU.xlsx" TargetMode="External"/><Relationship Id="rId2" Type="http://schemas.microsoft.com/office/2011/relationships/chartColorStyle" Target="colors44.xml"/><Relationship Id="rId1" Type="http://schemas.microsoft.com/office/2011/relationships/chartStyle" Target="style44.xml"/></Relationships>
</file>

<file path=ppt/charts/_rels/chart45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PC%20&amp;%20DU.xlsx" TargetMode="External"/><Relationship Id="rId2" Type="http://schemas.microsoft.com/office/2011/relationships/chartColorStyle" Target="colors45.xml"/><Relationship Id="rId1" Type="http://schemas.microsoft.com/office/2011/relationships/chartStyle" Target="style45.xml"/></Relationships>
</file>

<file path=ppt/charts/_rels/chart46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PC%20&amp;%20DU.xlsx" TargetMode="External"/><Relationship Id="rId2" Type="http://schemas.microsoft.com/office/2011/relationships/chartColorStyle" Target="colors46.xml"/><Relationship Id="rId1" Type="http://schemas.microsoft.com/office/2011/relationships/chartStyle" Target="style46.xml"/></Relationships>
</file>

<file path=ppt/charts/_rels/chart47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PC%20&amp;%20DU.xlsx" TargetMode="External"/><Relationship Id="rId2" Type="http://schemas.microsoft.com/office/2011/relationships/chartColorStyle" Target="colors47.xml"/><Relationship Id="rId1" Type="http://schemas.microsoft.com/office/2011/relationships/chartStyle" Target="style47.xml"/></Relationships>
</file>

<file path=ppt/charts/_rels/chart48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PC%20&amp;%20DU.xlsx" TargetMode="External"/><Relationship Id="rId2" Type="http://schemas.microsoft.com/office/2011/relationships/chartColorStyle" Target="colors48.xml"/><Relationship Id="rId1" Type="http://schemas.microsoft.com/office/2011/relationships/chartStyle" Target="style48.xml"/></Relationships>
</file>

<file path=ppt/charts/_rels/chart49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PC%20&amp;%20DU.xlsx" TargetMode="External"/><Relationship Id="rId2" Type="http://schemas.microsoft.com/office/2011/relationships/chartColorStyle" Target="colors49.xml"/><Relationship Id="rId1" Type="http://schemas.microsoft.com/office/2011/relationships/chartStyle" Target="style49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HOP%20&amp;%20NCI%20(2)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50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PC%20&amp;%20DU.xlsx" TargetMode="External"/><Relationship Id="rId2" Type="http://schemas.microsoft.com/office/2011/relationships/chartColorStyle" Target="colors50.xml"/><Relationship Id="rId1" Type="http://schemas.microsoft.com/office/2011/relationships/chartStyle" Target="style50.xml"/></Relationships>
</file>

<file path=ppt/charts/_rels/chart51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PC%20&amp;%20DU.xlsx" TargetMode="External"/><Relationship Id="rId2" Type="http://schemas.microsoft.com/office/2011/relationships/chartColorStyle" Target="colors51.xml"/><Relationship Id="rId1" Type="http://schemas.microsoft.com/office/2011/relationships/chartStyle" Target="style51.xml"/></Relationships>
</file>

<file path=ppt/charts/_rels/chart52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PC%20&amp;%20DU.xlsx" TargetMode="External"/><Relationship Id="rId2" Type="http://schemas.microsoft.com/office/2011/relationships/chartColorStyle" Target="colors52.xml"/><Relationship Id="rId1" Type="http://schemas.microsoft.com/office/2011/relationships/chartStyle" Target="style52.xml"/></Relationships>
</file>

<file path=ppt/charts/_rels/chart53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PC%20&amp;%20DU.xlsx" TargetMode="External"/><Relationship Id="rId2" Type="http://schemas.microsoft.com/office/2011/relationships/chartColorStyle" Target="colors53.xml"/><Relationship Id="rId1" Type="http://schemas.microsoft.com/office/2011/relationships/chartStyle" Target="style53.xml"/></Relationships>
</file>

<file path=ppt/charts/_rels/chart54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PC%20&amp;%20DU.xlsx" TargetMode="External"/><Relationship Id="rId2" Type="http://schemas.microsoft.com/office/2011/relationships/chartColorStyle" Target="colors54.xml"/><Relationship Id="rId1" Type="http://schemas.microsoft.com/office/2011/relationships/chartStyle" Target="style54.xml"/></Relationships>
</file>

<file path=ppt/charts/_rels/chart55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PC%20&amp;%20DU.xlsx" TargetMode="External"/><Relationship Id="rId2" Type="http://schemas.microsoft.com/office/2011/relationships/chartColorStyle" Target="colors55.xml"/><Relationship Id="rId1" Type="http://schemas.microsoft.com/office/2011/relationships/chartStyle" Target="style55.xml"/></Relationships>
</file>

<file path=ppt/charts/_rels/chart56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PC%20&amp;%20DU.xlsx" TargetMode="External"/><Relationship Id="rId2" Type="http://schemas.microsoft.com/office/2011/relationships/chartColorStyle" Target="colors56.xml"/><Relationship Id="rId1" Type="http://schemas.microsoft.com/office/2011/relationships/chartStyle" Target="style56.xml"/></Relationships>
</file>

<file path=ppt/charts/_rels/chart57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PC%20&amp;%20DU.xlsx" TargetMode="External"/><Relationship Id="rId2" Type="http://schemas.microsoft.com/office/2011/relationships/chartColorStyle" Target="colors57.xml"/><Relationship Id="rId1" Type="http://schemas.microsoft.com/office/2011/relationships/chartStyle" Target="style57.xml"/></Relationships>
</file>

<file path=ppt/charts/_rels/chart58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PC%20&amp;%20DU.xlsx" TargetMode="External"/><Relationship Id="rId2" Type="http://schemas.microsoft.com/office/2011/relationships/chartColorStyle" Target="colors58.xml"/><Relationship Id="rId1" Type="http://schemas.microsoft.com/office/2011/relationships/chartStyle" Target="style58.xml"/></Relationships>
</file>

<file path=ppt/charts/_rels/chart59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PC%20&amp;%20DU.xlsx" TargetMode="External"/><Relationship Id="rId2" Type="http://schemas.microsoft.com/office/2011/relationships/chartColorStyle" Target="colors59.xml"/><Relationship Id="rId1" Type="http://schemas.microsoft.com/office/2011/relationships/chartStyle" Target="style59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HOP%20&amp;%20NCI%20(2)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60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PC%20&amp;%20DU.xlsx" TargetMode="External"/><Relationship Id="rId2" Type="http://schemas.microsoft.com/office/2011/relationships/chartColorStyle" Target="colors60.xml"/><Relationship Id="rId1" Type="http://schemas.microsoft.com/office/2011/relationships/chartStyle" Target="style60.xml"/></Relationships>
</file>

<file path=ppt/charts/_rels/chart61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SK%20&amp;%20MDA.xlsx" TargetMode="External"/><Relationship Id="rId2" Type="http://schemas.microsoft.com/office/2011/relationships/chartColorStyle" Target="colors61.xml"/><Relationship Id="rId1" Type="http://schemas.microsoft.com/office/2011/relationships/chartStyle" Target="style61.xml"/></Relationships>
</file>

<file path=ppt/charts/_rels/chart62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SK%20&amp;%20MDA.xlsx" TargetMode="External"/><Relationship Id="rId2" Type="http://schemas.microsoft.com/office/2011/relationships/chartColorStyle" Target="colors62.xml"/><Relationship Id="rId1" Type="http://schemas.microsoft.com/office/2011/relationships/chartStyle" Target="style62.xml"/></Relationships>
</file>

<file path=ppt/charts/_rels/chart63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SK%20&amp;%20MDA.xlsx" TargetMode="External"/><Relationship Id="rId2" Type="http://schemas.microsoft.com/office/2011/relationships/chartColorStyle" Target="colors63.xml"/><Relationship Id="rId1" Type="http://schemas.microsoft.com/office/2011/relationships/chartStyle" Target="style63.xml"/></Relationships>
</file>

<file path=ppt/charts/_rels/chart64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SK%20&amp;%20MDA.xlsx" TargetMode="External"/><Relationship Id="rId2" Type="http://schemas.microsoft.com/office/2011/relationships/chartColorStyle" Target="colors64.xml"/><Relationship Id="rId1" Type="http://schemas.microsoft.com/office/2011/relationships/chartStyle" Target="style64.xml"/></Relationships>
</file>

<file path=ppt/charts/_rels/chart65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SK%20&amp;%20MDA.xlsx" TargetMode="External"/><Relationship Id="rId2" Type="http://schemas.microsoft.com/office/2011/relationships/chartColorStyle" Target="colors65.xml"/><Relationship Id="rId1" Type="http://schemas.microsoft.com/office/2011/relationships/chartStyle" Target="style65.xml"/></Relationships>
</file>

<file path=ppt/charts/_rels/chart66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SK%20&amp;%20MDA.xlsx" TargetMode="External"/><Relationship Id="rId2" Type="http://schemas.microsoft.com/office/2011/relationships/chartColorStyle" Target="colors66.xml"/><Relationship Id="rId1" Type="http://schemas.microsoft.com/office/2011/relationships/chartStyle" Target="style66.xml"/></Relationships>
</file>

<file path=ppt/charts/_rels/chart67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SK%20&amp;%20MDA.xlsx" TargetMode="External"/><Relationship Id="rId2" Type="http://schemas.microsoft.com/office/2011/relationships/chartColorStyle" Target="colors67.xml"/><Relationship Id="rId1" Type="http://schemas.microsoft.com/office/2011/relationships/chartStyle" Target="style67.xml"/></Relationships>
</file>

<file path=ppt/charts/_rels/chart68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SK%20&amp;%20MDA.xlsx" TargetMode="External"/><Relationship Id="rId2" Type="http://schemas.microsoft.com/office/2011/relationships/chartColorStyle" Target="colors68.xml"/><Relationship Id="rId1" Type="http://schemas.microsoft.com/office/2011/relationships/chartStyle" Target="style68.xml"/></Relationships>
</file>

<file path=ppt/charts/_rels/chart69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SK%20&amp;%20MDA.xlsx" TargetMode="External"/><Relationship Id="rId2" Type="http://schemas.microsoft.com/office/2011/relationships/chartColorStyle" Target="colors69.xml"/><Relationship Id="rId1" Type="http://schemas.microsoft.com/office/2011/relationships/chartStyle" Target="style69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HOP%20&amp;%20NCI%20(2)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70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SK%20&amp;%20MDA.xlsx" TargetMode="External"/><Relationship Id="rId2" Type="http://schemas.microsoft.com/office/2011/relationships/chartColorStyle" Target="colors70.xml"/><Relationship Id="rId1" Type="http://schemas.microsoft.com/office/2011/relationships/chartStyle" Target="style70.xml"/></Relationships>
</file>

<file path=ppt/charts/_rels/chart71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SK%20&amp;%20MDA.xlsx" TargetMode="External"/><Relationship Id="rId2" Type="http://schemas.microsoft.com/office/2011/relationships/chartColorStyle" Target="colors71.xml"/><Relationship Id="rId1" Type="http://schemas.microsoft.com/office/2011/relationships/chartStyle" Target="style71.xml"/></Relationships>
</file>

<file path=ppt/charts/_rels/chart72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SK%20&amp;%20MDA.xlsx" TargetMode="External"/><Relationship Id="rId2" Type="http://schemas.microsoft.com/office/2011/relationships/chartColorStyle" Target="colors72.xml"/><Relationship Id="rId1" Type="http://schemas.microsoft.com/office/2011/relationships/chartStyle" Target="style72.xml"/></Relationships>
</file>

<file path=ppt/charts/_rels/chart73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SK%20&amp;%20MDA.xlsx" TargetMode="External"/><Relationship Id="rId2" Type="http://schemas.microsoft.com/office/2011/relationships/chartColorStyle" Target="colors73.xml"/><Relationship Id="rId1" Type="http://schemas.microsoft.com/office/2011/relationships/chartStyle" Target="style73.xml"/></Relationships>
</file>

<file path=ppt/charts/_rels/chart74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SK%20&amp;%20MDA.xlsx" TargetMode="External"/><Relationship Id="rId2" Type="http://schemas.microsoft.com/office/2011/relationships/chartColorStyle" Target="colors74.xml"/><Relationship Id="rId1" Type="http://schemas.microsoft.com/office/2011/relationships/chartStyle" Target="style74.xml"/></Relationships>
</file>

<file path=ppt/charts/_rels/chart75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SK%20&amp;%20MDA.xlsx" TargetMode="External"/><Relationship Id="rId2" Type="http://schemas.microsoft.com/office/2011/relationships/chartColorStyle" Target="colors75.xml"/><Relationship Id="rId1" Type="http://schemas.microsoft.com/office/2011/relationships/chartStyle" Target="style75.xml"/></Relationships>
</file>

<file path=ppt/charts/_rels/chart76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SK%20&amp;%20MDA.xlsx" TargetMode="External"/><Relationship Id="rId2" Type="http://schemas.microsoft.com/office/2011/relationships/chartColorStyle" Target="colors76.xml"/><Relationship Id="rId1" Type="http://schemas.microsoft.com/office/2011/relationships/chartStyle" Target="style76.xml"/></Relationships>
</file>

<file path=ppt/charts/_rels/chart77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SK%20&amp;%20MDA.xlsx" TargetMode="External"/><Relationship Id="rId2" Type="http://schemas.microsoft.com/office/2011/relationships/chartColorStyle" Target="colors77.xml"/><Relationship Id="rId1" Type="http://schemas.microsoft.com/office/2011/relationships/chartStyle" Target="style77.xml"/></Relationships>
</file>

<file path=ppt/charts/_rels/chart78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SK%20&amp;%20MDA.xlsx" TargetMode="External"/><Relationship Id="rId2" Type="http://schemas.microsoft.com/office/2011/relationships/chartColorStyle" Target="colors78.xml"/><Relationship Id="rId1" Type="http://schemas.microsoft.com/office/2011/relationships/chartStyle" Target="style78.xml"/></Relationships>
</file>

<file path=ppt/charts/_rels/chart79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SK%20&amp;%20MDA.xlsx" TargetMode="External"/><Relationship Id="rId2" Type="http://schemas.microsoft.com/office/2011/relationships/chartColorStyle" Target="colors79.xml"/><Relationship Id="rId1" Type="http://schemas.microsoft.com/office/2011/relationships/chartStyle" Target="style79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HOP%20&amp;%20NCI%20(2).xlsx" TargetMode="External"/><Relationship Id="rId2" Type="http://schemas.microsoft.com/office/2011/relationships/chartColorStyle" Target="colors8.xml"/><Relationship Id="rId1" Type="http://schemas.microsoft.com/office/2011/relationships/chartStyle" Target="style8.xml"/><Relationship Id="rId4" Type="http://schemas.openxmlformats.org/officeDocument/2006/relationships/chartUserShapes" Target="../drawings/drawing1.xml"/></Relationships>
</file>

<file path=ppt/charts/_rels/chart80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SK%20&amp;%20MDA.xlsx" TargetMode="External"/><Relationship Id="rId2" Type="http://schemas.microsoft.com/office/2011/relationships/chartColorStyle" Target="colors80.xml"/><Relationship Id="rId1" Type="http://schemas.microsoft.com/office/2011/relationships/chartStyle" Target="style80.xml"/></Relationships>
</file>

<file path=ppt/charts/_rels/chart81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SK%20&amp;%20MDA.xlsx" TargetMode="External"/><Relationship Id="rId2" Type="http://schemas.microsoft.com/office/2011/relationships/chartColorStyle" Target="colors81.xml"/><Relationship Id="rId1" Type="http://schemas.microsoft.com/office/2011/relationships/chartStyle" Target="style81.xml"/></Relationships>
</file>

<file path=ppt/charts/_rels/chart82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SK%20&amp;%20MDA.xlsx" TargetMode="External"/><Relationship Id="rId2" Type="http://schemas.microsoft.com/office/2011/relationships/chartColorStyle" Target="colors82.xml"/><Relationship Id="rId1" Type="http://schemas.microsoft.com/office/2011/relationships/chartStyle" Target="style82.xml"/></Relationships>
</file>

<file path=ppt/charts/_rels/chart83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SK%20&amp;%20MDA.xlsx" TargetMode="External"/><Relationship Id="rId2" Type="http://schemas.microsoft.com/office/2011/relationships/chartColorStyle" Target="colors83.xml"/><Relationship Id="rId1" Type="http://schemas.microsoft.com/office/2011/relationships/chartStyle" Target="style83.xml"/></Relationships>
</file>

<file path=ppt/charts/_rels/chart84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SK%20&amp;%20MDA.xlsx" TargetMode="External"/><Relationship Id="rId2" Type="http://schemas.microsoft.com/office/2011/relationships/chartColorStyle" Target="colors84.xml"/><Relationship Id="rId1" Type="http://schemas.microsoft.com/office/2011/relationships/chartStyle" Target="style84.xml"/></Relationships>
</file>

<file path=ppt/charts/_rels/chart85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SK%20&amp;%20MDA.xlsx" TargetMode="External"/><Relationship Id="rId2" Type="http://schemas.microsoft.com/office/2011/relationships/chartColorStyle" Target="colors85.xml"/><Relationship Id="rId1" Type="http://schemas.microsoft.com/office/2011/relationships/chartStyle" Target="style85.xml"/></Relationships>
</file>

<file path=ppt/charts/_rels/chart86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SK%20&amp;%20MDA.xlsx" TargetMode="External"/><Relationship Id="rId2" Type="http://schemas.microsoft.com/office/2011/relationships/chartColorStyle" Target="colors86.xml"/><Relationship Id="rId1" Type="http://schemas.microsoft.com/office/2011/relationships/chartStyle" Target="style86.xml"/></Relationships>
</file>

<file path=ppt/charts/_rels/chart87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SK%20&amp;%20MDA.xlsx" TargetMode="External"/><Relationship Id="rId2" Type="http://schemas.microsoft.com/office/2011/relationships/chartColorStyle" Target="colors87.xml"/><Relationship Id="rId1" Type="http://schemas.microsoft.com/office/2011/relationships/chartStyle" Target="style87.xml"/></Relationships>
</file>

<file path=ppt/charts/_rels/chart88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SK%20&amp;%20MDA.xlsx" TargetMode="External"/><Relationship Id="rId2" Type="http://schemas.microsoft.com/office/2011/relationships/chartColorStyle" Target="colors88.xml"/><Relationship Id="rId1" Type="http://schemas.microsoft.com/office/2011/relationships/chartStyle" Target="style88.xml"/></Relationships>
</file>

<file path=ppt/charts/_rels/chart89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SK%20&amp;%20MDA.xlsx" TargetMode="External"/><Relationship Id="rId2" Type="http://schemas.microsoft.com/office/2011/relationships/chartColorStyle" Target="colors89.xml"/><Relationship Id="rId1" Type="http://schemas.microsoft.com/office/2011/relationships/chartStyle" Target="style89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HOP%20&amp;%20NCI%20(2)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_rels/chart90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30740;&#31350;&#23460;\&#23455;&#39443;&#32080;&#26524;\&#23455;&#39443;&#32080;&#26524;(qPCR)%20%20SK%20&amp;%20MDA.xlsx" TargetMode="External"/><Relationship Id="rId2" Type="http://schemas.microsoft.com/office/2011/relationships/chartColorStyle" Target="colors90.xml"/><Relationship Id="rId1" Type="http://schemas.microsoft.com/office/2011/relationships/chartStyle" Target="style90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ATP5F1!$K$4:$K$10</c:f>
                <c:numCache>
                  <c:formatCode>General</c:formatCode>
                  <c:ptCount val="7"/>
                  <c:pt idx="0">
                    <c:v>4.0708560119759436E-2</c:v>
                  </c:pt>
                  <c:pt idx="1">
                    <c:v>2.215534069625022E-2</c:v>
                  </c:pt>
                  <c:pt idx="2">
                    <c:v>4.6048219812323779E-2</c:v>
                  </c:pt>
                  <c:pt idx="3">
                    <c:v>3.0445648099864046E-2</c:v>
                  </c:pt>
                  <c:pt idx="4">
                    <c:v>2.2888131452771004E-2</c:v>
                  </c:pt>
                  <c:pt idx="5">
                    <c:v>3.4401095977571551E-2</c:v>
                  </c:pt>
                  <c:pt idx="6">
                    <c:v>4.3368210771346408E-2</c:v>
                  </c:pt>
                </c:numCache>
              </c:numRef>
            </c:plus>
            <c:minus>
              <c:numRef>
                <c:f>ATP5F1!$K$4:$K$10</c:f>
                <c:numCache>
                  <c:formatCode>General</c:formatCode>
                  <c:ptCount val="7"/>
                  <c:pt idx="0">
                    <c:v>4.0708560119759436E-2</c:v>
                  </c:pt>
                  <c:pt idx="1">
                    <c:v>2.215534069625022E-2</c:v>
                  </c:pt>
                  <c:pt idx="2">
                    <c:v>4.6048219812323779E-2</c:v>
                  </c:pt>
                  <c:pt idx="3">
                    <c:v>3.0445648099864046E-2</c:v>
                  </c:pt>
                  <c:pt idx="4">
                    <c:v>2.2888131452771004E-2</c:v>
                  </c:pt>
                  <c:pt idx="5">
                    <c:v>3.4401095977571551E-2</c:v>
                  </c:pt>
                  <c:pt idx="6">
                    <c:v>4.336821077134640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ATP5F1!$I$4:$I$10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ATP5F1!$J$4:$J$10</c:f>
              <c:numCache>
                <c:formatCode>General</c:formatCode>
                <c:ptCount val="7"/>
                <c:pt idx="0">
                  <c:v>1</c:v>
                </c:pt>
                <c:pt idx="1">
                  <c:v>0.98892200439813394</c:v>
                </c:pt>
                <c:pt idx="2">
                  <c:v>0.89976350849306863</c:v>
                </c:pt>
                <c:pt idx="3">
                  <c:v>0.79154970645542699</c:v>
                </c:pt>
                <c:pt idx="4">
                  <c:v>0.76670508375790236</c:v>
                </c:pt>
                <c:pt idx="5">
                  <c:v>0.77088644695828645</c:v>
                </c:pt>
                <c:pt idx="6">
                  <c:v>0.7655013522544088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9AC-4C46-8BCF-0B69448A488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1364776"/>
        <c:axId val="421357232"/>
      </c:barChart>
      <c:catAx>
        <c:axId val="42136477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21357232"/>
        <c:crosses val="autoZero"/>
        <c:auto val="1"/>
        <c:lblAlgn val="ctr"/>
        <c:lblOffset val="100"/>
        <c:noMultiLvlLbl val="0"/>
      </c:catAx>
      <c:valAx>
        <c:axId val="421357232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ATP5F1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6.166330247814087E-2"/>
              <c:y val="1.5792729748466582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21364776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PS18-2'!$K$4:$K$10</c:f>
                <c:numCache>
                  <c:formatCode>General</c:formatCode>
                  <c:ptCount val="7"/>
                  <c:pt idx="0">
                    <c:v>1.9778430127141176E-2</c:v>
                  </c:pt>
                  <c:pt idx="1">
                    <c:v>7.9831866585712979E-2</c:v>
                  </c:pt>
                  <c:pt idx="2">
                    <c:v>4.1639512002682649E-2</c:v>
                  </c:pt>
                  <c:pt idx="3">
                    <c:v>3.5519386173927754E-2</c:v>
                  </c:pt>
                  <c:pt idx="4">
                    <c:v>7.9689081712178228E-2</c:v>
                  </c:pt>
                  <c:pt idx="5">
                    <c:v>8.3276455884169764E-2</c:v>
                  </c:pt>
                  <c:pt idx="6">
                    <c:v>4.9514451566902359E-2</c:v>
                  </c:pt>
                </c:numCache>
              </c:numRef>
            </c:plus>
            <c:minus>
              <c:numRef>
                <c:f>'RPS18-2'!$K$4:$K$10</c:f>
                <c:numCache>
                  <c:formatCode>General</c:formatCode>
                  <c:ptCount val="7"/>
                  <c:pt idx="0">
                    <c:v>1.9778430127141176E-2</c:v>
                  </c:pt>
                  <c:pt idx="1">
                    <c:v>7.9831866585712979E-2</c:v>
                  </c:pt>
                  <c:pt idx="2">
                    <c:v>4.1639512002682649E-2</c:v>
                  </c:pt>
                  <c:pt idx="3">
                    <c:v>3.5519386173927754E-2</c:v>
                  </c:pt>
                  <c:pt idx="4">
                    <c:v>7.9689081712178228E-2</c:v>
                  </c:pt>
                  <c:pt idx="5">
                    <c:v>8.3276455884169764E-2</c:v>
                  </c:pt>
                  <c:pt idx="6">
                    <c:v>4.9514451566902359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RPS18-2'!$I$4:$I$10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'RPS18-2'!$J$4:$J$10</c:f>
              <c:numCache>
                <c:formatCode>General</c:formatCode>
                <c:ptCount val="7"/>
                <c:pt idx="0">
                  <c:v>1</c:v>
                </c:pt>
                <c:pt idx="1">
                  <c:v>1.0081732136163333</c:v>
                </c:pt>
                <c:pt idx="2">
                  <c:v>1.0480833722205898</c:v>
                </c:pt>
                <c:pt idx="3">
                  <c:v>1.0366821277185243</c:v>
                </c:pt>
                <c:pt idx="4">
                  <c:v>1.0168026607403531</c:v>
                </c:pt>
                <c:pt idx="5">
                  <c:v>1.0684791348028713</c:v>
                </c:pt>
                <c:pt idx="6">
                  <c:v>1.020932674948036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BBD-4221-AEB7-1F9520769A3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45339920"/>
        <c:axId val="545341888"/>
      </c:barChart>
      <c:catAx>
        <c:axId val="54533992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45341888"/>
        <c:crosses val="autoZero"/>
        <c:auto val="1"/>
        <c:lblAlgn val="ctr"/>
        <c:lblOffset val="100"/>
        <c:noMultiLvlLbl val="0"/>
      </c:catAx>
      <c:valAx>
        <c:axId val="545341888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RPS18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6.166330247814087E-2"/>
              <c:y val="6.3170918993866329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45339920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TBP!$K$4:$K$10</c:f>
                <c:numCache>
                  <c:formatCode>General</c:formatCode>
                  <c:ptCount val="7"/>
                  <c:pt idx="0">
                    <c:v>6.3037469406391378E-2</c:v>
                  </c:pt>
                  <c:pt idx="1">
                    <c:v>9.5110231687576485E-2</c:v>
                  </c:pt>
                  <c:pt idx="2">
                    <c:v>1.5206208894499614E-2</c:v>
                  </c:pt>
                  <c:pt idx="3">
                    <c:v>4.676455082370936E-2</c:v>
                  </c:pt>
                  <c:pt idx="4">
                    <c:v>1.2744604724396284E-2</c:v>
                  </c:pt>
                  <c:pt idx="5">
                    <c:v>2.6405412223345252E-2</c:v>
                  </c:pt>
                  <c:pt idx="6">
                    <c:v>9.3155902747672908E-2</c:v>
                  </c:pt>
                </c:numCache>
              </c:numRef>
            </c:plus>
            <c:minus>
              <c:numRef>
                <c:f>TBP!$K$4:$K$10</c:f>
                <c:numCache>
                  <c:formatCode>General</c:formatCode>
                  <c:ptCount val="7"/>
                  <c:pt idx="0">
                    <c:v>6.3037469406391378E-2</c:v>
                  </c:pt>
                  <c:pt idx="1">
                    <c:v>9.5110231687576485E-2</c:v>
                  </c:pt>
                  <c:pt idx="2">
                    <c:v>1.5206208894499614E-2</c:v>
                  </c:pt>
                  <c:pt idx="3">
                    <c:v>4.676455082370936E-2</c:v>
                  </c:pt>
                  <c:pt idx="4">
                    <c:v>1.2744604724396284E-2</c:v>
                  </c:pt>
                  <c:pt idx="5">
                    <c:v>2.6405412223345252E-2</c:v>
                  </c:pt>
                  <c:pt idx="6">
                    <c:v>9.315590274767290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TBP!$I$4:$I$10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TBP!$J$4:$J$10</c:f>
              <c:numCache>
                <c:formatCode>General</c:formatCode>
                <c:ptCount val="7"/>
                <c:pt idx="0">
                  <c:v>1</c:v>
                </c:pt>
                <c:pt idx="1">
                  <c:v>1.0989420330555435</c:v>
                </c:pt>
                <c:pt idx="2">
                  <c:v>0.93882638099168558</c:v>
                </c:pt>
                <c:pt idx="3">
                  <c:v>0.87729286645431392</c:v>
                </c:pt>
                <c:pt idx="4">
                  <c:v>0.75000747950876911</c:v>
                </c:pt>
                <c:pt idx="5">
                  <c:v>0.84586994003433225</c:v>
                </c:pt>
                <c:pt idx="6">
                  <c:v>0.8521516781422890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9A3-4680-8CBB-EA662533F8A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79604328"/>
        <c:axId val="579606296"/>
      </c:barChart>
      <c:catAx>
        <c:axId val="57960432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79606296"/>
        <c:crosses val="autoZero"/>
        <c:auto val="1"/>
        <c:lblAlgn val="ctr"/>
        <c:lblOffset val="100"/>
        <c:noMultiLvlLbl val="0"/>
      </c:catAx>
      <c:valAx>
        <c:axId val="579606296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TBP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79604328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PGK1'!$K$4:$K$10</c:f>
                <c:numCache>
                  <c:formatCode>General</c:formatCode>
                  <c:ptCount val="7"/>
                  <c:pt idx="0">
                    <c:v>7.9104878503313492E-2</c:v>
                  </c:pt>
                  <c:pt idx="1">
                    <c:v>6.2532786046749098E-2</c:v>
                  </c:pt>
                  <c:pt idx="2">
                    <c:v>9.2485027574066625E-2</c:v>
                  </c:pt>
                  <c:pt idx="3">
                    <c:v>9.2389154811246016E-2</c:v>
                  </c:pt>
                  <c:pt idx="4">
                    <c:v>5.2026900766373015E-2</c:v>
                  </c:pt>
                  <c:pt idx="5">
                    <c:v>5.9521811809645143E-2</c:v>
                  </c:pt>
                  <c:pt idx="6">
                    <c:v>2.340896386130982E-2</c:v>
                  </c:pt>
                </c:numCache>
              </c:numRef>
            </c:plus>
            <c:minus>
              <c:numRef>
                <c:f>'PGK1'!$K$4:$K$10</c:f>
                <c:numCache>
                  <c:formatCode>General</c:formatCode>
                  <c:ptCount val="7"/>
                  <c:pt idx="0">
                    <c:v>7.9104878503313492E-2</c:v>
                  </c:pt>
                  <c:pt idx="1">
                    <c:v>6.2532786046749098E-2</c:v>
                  </c:pt>
                  <c:pt idx="2">
                    <c:v>9.2485027574066625E-2</c:v>
                  </c:pt>
                  <c:pt idx="3">
                    <c:v>9.2389154811246016E-2</c:v>
                  </c:pt>
                  <c:pt idx="4">
                    <c:v>5.2026900766373015E-2</c:v>
                  </c:pt>
                  <c:pt idx="5">
                    <c:v>5.9521811809645143E-2</c:v>
                  </c:pt>
                  <c:pt idx="6">
                    <c:v>2.34089638613098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PGK1'!$I$4:$I$10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'PGK1'!$J$4:$J$10</c:f>
              <c:numCache>
                <c:formatCode>General</c:formatCode>
                <c:ptCount val="7"/>
                <c:pt idx="0">
                  <c:v>1</c:v>
                </c:pt>
                <c:pt idx="1">
                  <c:v>1.1956569224945477</c:v>
                </c:pt>
                <c:pt idx="2">
                  <c:v>1.1039815355924747</c:v>
                </c:pt>
                <c:pt idx="3">
                  <c:v>1.110146389403208</c:v>
                </c:pt>
                <c:pt idx="4">
                  <c:v>1.0554893643625043</c:v>
                </c:pt>
                <c:pt idx="5">
                  <c:v>1.1749663865898601</c:v>
                </c:pt>
                <c:pt idx="6">
                  <c:v>1.242457501480057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94C-455A-A69C-CC6EDBE34EF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3367568"/>
        <c:axId val="423367896"/>
      </c:barChart>
      <c:catAx>
        <c:axId val="42336756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23367896"/>
        <c:crosses val="autoZero"/>
        <c:auto val="1"/>
        <c:lblAlgn val="ctr"/>
        <c:lblOffset val="100"/>
        <c:noMultiLvlLbl val="0"/>
      </c:catAx>
      <c:valAx>
        <c:axId val="423367896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PGK1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23367568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PPIA-3'!$K$4:$K$10</c:f>
                <c:numCache>
                  <c:formatCode>General</c:formatCode>
                  <c:ptCount val="7"/>
                  <c:pt idx="0">
                    <c:v>9.2156727470512761E-2</c:v>
                  </c:pt>
                  <c:pt idx="1">
                    <c:v>6.6779192164117679E-2</c:v>
                  </c:pt>
                  <c:pt idx="2">
                    <c:v>0.10464154588162275</c:v>
                  </c:pt>
                  <c:pt idx="3">
                    <c:v>5.4155854066423544E-2</c:v>
                  </c:pt>
                  <c:pt idx="4">
                    <c:v>5.5541384741311067E-2</c:v>
                  </c:pt>
                  <c:pt idx="5">
                    <c:v>9.8698434848350558E-2</c:v>
                  </c:pt>
                  <c:pt idx="6">
                    <c:v>5.0235287852409376E-2</c:v>
                  </c:pt>
                </c:numCache>
              </c:numRef>
            </c:plus>
            <c:minus>
              <c:numRef>
                <c:f>'PPIA-3'!$K$4:$K$10</c:f>
                <c:numCache>
                  <c:formatCode>General</c:formatCode>
                  <c:ptCount val="7"/>
                  <c:pt idx="0">
                    <c:v>9.2156727470512761E-2</c:v>
                  </c:pt>
                  <c:pt idx="1">
                    <c:v>6.6779192164117679E-2</c:v>
                  </c:pt>
                  <c:pt idx="2">
                    <c:v>0.10464154588162275</c:v>
                  </c:pt>
                  <c:pt idx="3">
                    <c:v>5.4155854066423544E-2</c:v>
                  </c:pt>
                  <c:pt idx="4">
                    <c:v>5.5541384741311067E-2</c:v>
                  </c:pt>
                  <c:pt idx="5">
                    <c:v>9.8698434848350558E-2</c:v>
                  </c:pt>
                  <c:pt idx="6">
                    <c:v>5.023528785240937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PPIA-3'!$I$4:$I$10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'PPIA-3'!$J$4:$J$10</c:f>
              <c:numCache>
                <c:formatCode>General</c:formatCode>
                <c:ptCount val="7"/>
                <c:pt idx="0">
                  <c:v>1</c:v>
                </c:pt>
                <c:pt idx="1">
                  <c:v>1.0081973276671883</c:v>
                </c:pt>
                <c:pt idx="2">
                  <c:v>1.00468492422865</c:v>
                </c:pt>
                <c:pt idx="3">
                  <c:v>0.94022523834802285</c:v>
                </c:pt>
                <c:pt idx="4">
                  <c:v>0.94978305002864893</c:v>
                </c:pt>
                <c:pt idx="5">
                  <c:v>1.002194941231322</c:v>
                </c:pt>
                <c:pt idx="6">
                  <c:v>1.104548055925645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F32-475D-8175-42E0F5C91F5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74336248"/>
        <c:axId val="574332640"/>
      </c:barChart>
      <c:catAx>
        <c:axId val="57433624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74332640"/>
        <c:crosses val="autoZero"/>
        <c:auto val="1"/>
        <c:lblAlgn val="ctr"/>
        <c:lblOffset val="100"/>
        <c:noMultiLvlLbl val="0"/>
      </c:catAx>
      <c:valAx>
        <c:axId val="574332640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PPIA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74336248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GAPDH-2'!$K$4:$K$10</c:f>
                <c:numCache>
                  <c:formatCode>General</c:formatCode>
                  <c:ptCount val="7"/>
                  <c:pt idx="0">
                    <c:v>5.3242285122226771E-2</c:v>
                  </c:pt>
                  <c:pt idx="1">
                    <c:v>7.3861799811760734E-2</c:v>
                  </c:pt>
                  <c:pt idx="2">
                    <c:v>8.1134118033171582E-2</c:v>
                  </c:pt>
                  <c:pt idx="3">
                    <c:v>5.2557142085923506E-2</c:v>
                  </c:pt>
                  <c:pt idx="4">
                    <c:v>4.2085311811060101E-2</c:v>
                  </c:pt>
                  <c:pt idx="5">
                    <c:v>6.0897185725977639E-2</c:v>
                  </c:pt>
                  <c:pt idx="6">
                    <c:v>5.1187952823776743E-2</c:v>
                  </c:pt>
                </c:numCache>
              </c:numRef>
            </c:plus>
            <c:minus>
              <c:numRef>
                <c:f>'GAPDH-2'!$K$4:$K$10</c:f>
                <c:numCache>
                  <c:formatCode>General</c:formatCode>
                  <c:ptCount val="7"/>
                  <c:pt idx="0">
                    <c:v>5.3242285122226771E-2</c:v>
                  </c:pt>
                  <c:pt idx="1">
                    <c:v>7.3861799811760734E-2</c:v>
                  </c:pt>
                  <c:pt idx="2">
                    <c:v>8.1134118033171582E-2</c:v>
                  </c:pt>
                  <c:pt idx="3">
                    <c:v>5.2557142085923506E-2</c:v>
                  </c:pt>
                  <c:pt idx="4">
                    <c:v>4.2085311811060101E-2</c:v>
                  </c:pt>
                  <c:pt idx="5">
                    <c:v>6.0897185725977639E-2</c:v>
                  </c:pt>
                  <c:pt idx="6">
                    <c:v>5.118795282377674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GAPDH-2'!$I$4:$I$10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'GAPDH-2'!$J$4:$J$10</c:f>
              <c:numCache>
                <c:formatCode>General</c:formatCode>
                <c:ptCount val="7"/>
                <c:pt idx="0">
                  <c:v>1</c:v>
                </c:pt>
                <c:pt idx="1">
                  <c:v>0.9912841684174597</c:v>
                </c:pt>
                <c:pt idx="2">
                  <c:v>0.99177015865923313</c:v>
                </c:pt>
                <c:pt idx="3">
                  <c:v>0.92056180116191433</c:v>
                </c:pt>
                <c:pt idx="4">
                  <c:v>0.87062207919864687</c:v>
                </c:pt>
                <c:pt idx="5">
                  <c:v>0.94996673920902175</c:v>
                </c:pt>
                <c:pt idx="6">
                  <c:v>0.904981271651341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502-4195-BF69-2B0764BC875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32027032"/>
        <c:axId val="532029656"/>
      </c:barChart>
      <c:catAx>
        <c:axId val="53202703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32029656"/>
        <c:crosses val="autoZero"/>
        <c:auto val="1"/>
        <c:lblAlgn val="ctr"/>
        <c:lblOffset val="100"/>
        <c:noMultiLvlLbl val="0"/>
      </c:catAx>
      <c:valAx>
        <c:axId val="532029656"/>
        <c:scaling>
          <c:orientation val="minMax"/>
          <c:max val="1.3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GAPDH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6.1759504862953139E-2"/>
              <c:y val="0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32027032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GUSB!$K$4:$K$10</c:f>
                <c:numCache>
                  <c:formatCode>General</c:formatCode>
                  <c:ptCount val="7"/>
                  <c:pt idx="0">
                    <c:v>8.9999098211655096E-2</c:v>
                  </c:pt>
                  <c:pt idx="1">
                    <c:v>5.8236099366234799E-2</c:v>
                  </c:pt>
                  <c:pt idx="2">
                    <c:v>3.563629644048303E-2</c:v>
                  </c:pt>
                  <c:pt idx="3">
                    <c:v>2.6478502610595304E-2</c:v>
                  </c:pt>
                  <c:pt idx="4">
                    <c:v>8.8743426648927565E-2</c:v>
                  </c:pt>
                  <c:pt idx="5">
                    <c:v>0.1031548093216441</c:v>
                  </c:pt>
                  <c:pt idx="6">
                    <c:v>5.2585047880435228E-2</c:v>
                  </c:pt>
                </c:numCache>
              </c:numRef>
            </c:plus>
            <c:minus>
              <c:numRef>
                <c:f>GUSB!$K$4:$K$10</c:f>
                <c:numCache>
                  <c:formatCode>General</c:formatCode>
                  <c:ptCount val="7"/>
                  <c:pt idx="0">
                    <c:v>8.9999098211655096E-2</c:v>
                  </c:pt>
                  <c:pt idx="1">
                    <c:v>5.8236099366234799E-2</c:v>
                  </c:pt>
                  <c:pt idx="2">
                    <c:v>3.563629644048303E-2</c:v>
                  </c:pt>
                  <c:pt idx="3">
                    <c:v>2.6478502610595304E-2</c:v>
                  </c:pt>
                  <c:pt idx="4">
                    <c:v>8.8743426648927565E-2</c:v>
                  </c:pt>
                  <c:pt idx="5">
                    <c:v>0.1031548093216441</c:v>
                  </c:pt>
                  <c:pt idx="6">
                    <c:v>5.258504788043522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GUSB!$I$4:$I$10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GUSB!$J$4:$J$10</c:f>
              <c:numCache>
                <c:formatCode>General</c:formatCode>
                <c:ptCount val="7"/>
                <c:pt idx="0">
                  <c:v>1</c:v>
                </c:pt>
                <c:pt idx="1">
                  <c:v>1.0478536826481768</c:v>
                </c:pt>
                <c:pt idx="2">
                  <c:v>1.1257640577590833</c:v>
                </c:pt>
                <c:pt idx="3">
                  <c:v>1.0510727136801288</c:v>
                </c:pt>
                <c:pt idx="4">
                  <c:v>1.0657462784660379</c:v>
                </c:pt>
                <c:pt idx="5">
                  <c:v>1.0994750761285095</c:v>
                </c:pt>
                <c:pt idx="6">
                  <c:v>1.083306359742806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281-480D-A7D5-A7EA959574D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76831224"/>
        <c:axId val="576836472"/>
      </c:barChart>
      <c:catAx>
        <c:axId val="57683122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76836472"/>
        <c:crosses val="autoZero"/>
        <c:auto val="1"/>
        <c:lblAlgn val="ctr"/>
        <c:lblOffset val="100"/>
        <c:noMultiLvlLbl val="0"/>
      </c:catAx>
      <c:valAx>
        <c:axId val="576836472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GUSB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6.1663275260093665E-2"/>
              <c:y val="1.6715430975141391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76831224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ATP5F1!$K$28:$K$34</c:f>
                <c:numCache>
                  <c:formatCode>General</c:formatCode>
                  <c:ptCount val="7"/>
                  <c:pt idx="0">
                    <c:v>3.7854880474032251E-2</c:v>
                  </c:pt>
                  <c:pt idx="1">
                    <c:v>5.6833818744349507E-2</c:v>
                  </c:pt>
                  <c:pt idx="2">
                    <c:v>3.0535705165466429E-2</c:v>
                  </c:pt>
                  <c:pt idx="3">
                    <c:v>3.6769742247504074E-2</c:v>
                  </c:pt>
                  <c:pt idx="4">
                    <c:v>3.2108088104186312E-2</c:v>
                  </c:pt>
                  <c:pt idx="5">
                    <c:v>3.175576212788505E-2</c:v>
                  </c:pt>
                  <c:pt idx="6">
                    <c:v>6.9864799106897177E-2</c:v>
                  </c:pt>
                </c:numCache>
              </c:numRef>
            </c:plus>
            <c:minus>
              <c:numRef>
                <c:f>ATP5F1!$K$28:$K$34</c:f>
                <c:numCache>
                  <c:formatCode>General</c:formatCode>
                  <c:ptCount val="7"/>
                  <c:pt idx="0">
                    <c:v>3.7854880474032251E-2</c:v>
                  </c:pt>
                  <c:pt idx="1">
                    <c:v>5.6833818744349507E-2</c:v>
                  </c:pt>
                  <c:pt idx="2">
                    <c:v>3.0535705165466429E-2</c:v>
                  </c:pt>
                  <c:pt idx="3">
                    <c:v>3.6769742247504074E-2</c:v>
                  </c:pt>
                  <c:pt idx="4">
                    <c:v>3.2108088104186312E-2</c:v>
                  </c:pt>
                  <c:pt idx="5">
                    <c:v>3.175576212788505E-2</c:v>
                  </c:pt>
                  <c:pt idx="6">
                    <c:v>6.986479910689717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ATP5F1!$I$28:$I$34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ATP5F1!$J$28:$J$34</c:f>
              <c:numCache>
                <c:formatCode>General</c:formatCode>
                <c:ptCount val="7"/>
                <c:pt idx="0">
                  <c:v>1</c:v>
                </c:pt>
                <c:pt idx="1">
                  <c:v>1.0022555600554723</c:v>
                </c:pt>
                <c:pt idx="2">
                  <c:v>1.0138921736689959</c:v>
                </c:pt>
                <c:pt idx="3">
                  <c:v>0.99062960623289109</c:v>
                </c:pt>
                <c:pt idx="4">
                  <c:v>0.95942825893077677</c:v>
                </c:pt>
                <c:pt idx="5">
                  <c:v>0.89471873385867007</c:v>
                </c:pt>
                <c:pt idx="6">
                  <c:v>0.80543385627562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7C7-420D-B22B-7AC45600CED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1364776"/>
        <c:axId val="421357232"/>
      </c:barChart>
      <c:catAx>
        <c:axId val="42136477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21357232"/>
        <c:crosses val="autoZero"/>
        <c:auto val="1"/>
        <c:lblAlgn val="ctr"/>
        <c:lblOffset val="100"/>
        <c:noMultiLvlLbl val="0"/>
      </c:catAx>
      <c:valAx>
        <c:axId val="421357232"/>
        <c:scaling>
          <c:orientation val="minMax"/>
          <c:max val="1.3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ATP5F1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6.1663329696212098E-2"/>
              <c:y val="4.7378189245399743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21364776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TFRC!$K$28:$K$34</c:f>
                <c:numCache>
                  <c:formatCode>General</c:formatCode>
                  <c:ptCount val="7"/>
                  <c:pt idx="0">
                    <c:v>6.7925508590061509E-2</c:v>
                  </c:pt>
                  <c:pt idx="1">
                    <c:v>4.83566369320804E-2</c:v>
                  </c:pt>
                  <c:pt idx="2">
                    <c:v>6.4785746730412264E-2</c:v>
                  </c:pt>
                  <c:pt idx="3">
                    <c:v>6.6948462429085615E-2</c:v>
                  </c:pt>
                  <c:pt idx="4">
                    <c:v>2.8681058197625592E-2</c:v>
                  </c:pt>
                  <c:pt idx="5">
                    <c:v>2.3607950934840232E-2</c:v>
                  </c:pt>
                  <c:pt idx="6">
                    <c:v>4.4900579813594146E-2</c:v>
                  </c:pt>
                </c:numCache>
              </c:numRef>
            </c:plus>
            <c:minus>
              <c:numRef>
                <c:f>TFRC!$K$28:$K$34</c:f>
                <c:numCache>
                  <c:formatCode>General</c:formatCode>
                  <c:ptCount val="7"/>
                  <c:pt idx="0">
                    <c:v>6.7925508590061509E-2</c:v>
                  </c:pt>
                  <c:pt idx="1">
                    <c:v>4.83566369320804E-2</c:v>
                  </c:pt>
                  <c:pt idx="2">
                    <c:v>6.4785746730412264E-2</c:v>
                  </c:pt>
                  <c:pt idx="3">
                    <c:v>6.6948462429085615E-2</c:v>
                  </c:pt>
                  <c:pt idx="4">
                    <c:v>2.8681058197625592E-2</c:v>
                  </c:pt>
                  <c:pt idx="5">
                    <c:v>2.3607950934840232E-2</c:v>
                  </c:pt>
                  <c:pt idx="6">
                    <c:v>4.490057981359414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TFRC!$I$28:$I$34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TFRC!$J$28:$J$34</c:f>
              <c:numCache>
                <c:formatCode>General</c:formatCode>
                <c:ptCount val="7"/>
                <c:pt idx="0">
                  <c:v>1</c:v>
                </c:pt>
                <c:pt idx="1">
                  <c:v>1.0156489149607308</c:v>
                </c:pt>
                <c:pt idx="2">
                  <c:v>1.057773500165359</c:v>
                </c:pt>
                <c:pt idx="3">
                  <c:v>1.0061111246071841</c:v>
                </c:pt>
                <c:pt idx="4">
                  <c:v>1.0526250440068374</c:v>
                </c:pt>
                <c:pt idx="5">
                  <c:v>0.97624017662631857</c:v>
                </c:pt>
                <c:pt idx="6">
                  <c:v>0.871792115234354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62C-48E0-8458-F370EF6351F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16552000"/>
        <c:axId val="616555608"/>
      </c:barChart>
      <c:catAx>
        <c:axId val="61655200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16555608"/>
        <c:crosses val="autoZero"/>
        <c:auto val="1"/>
        <c:lblAlgn val="ctr"/>
        <c:lblOffset val="100"/>
        <c:noMultiLvlLbl val="0"/>
      </c:catAx>
      <c:valAx>
        <c:axId val="616555608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TFRC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16552000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YWHAZ!$K$28:$K$34</c:f>
                <c:numCache>
                  <c:formatCode>General</c:formatCode>
                  <c:ptCount val="7"/>
                  <c:pt idx="0">
                    <c:v>4.4160322149795844E-2</c:v>
                  </c:pt>
                  <c:pt idx="1">
                    <c:v>5.4440117125157533E-2</c:v>
                  </c:pt>
                  <c:pt idx="2">
                    <c:v>8.0892733233191155E-2</c:v>
                  </c:pt>
                  <c:pt idx="3">
                    <c:v>9.2184791336961405E-2</c:v>
                  </c:pt>
                  <c:pt idx="4">
                    <c:v>4.6772232610998471E-2</c:v>
                  </c:pt>
                  <c:pt idx="5">
                    <c:v>3.2080541938656719E-2</c:v>
                  </c:pt>
                  <c:pt idx="6">
                    <c:v>6.1704738981582512E-2</c:v>
                  </c:pt>
                </c:numCache>
              </c:numRef>
            </c:plus>
            <c:minus>
              <c:numRef>
                <c:f>YWHAZ!$K$28:$K$34</c:f>
                <c:numCache>
                  <c:formatCode>General</c:formatCode>
                  <c:ptCount val="7"/>
                  <c:pt idx="0">
                    <c:v>4.4160322149795844E-2</c:v>
                  </c:pt>
                  <c:pt idx="1">
                    <c:v>5.4440117125157533E-2</c:v>
                  </c:pt>
                  <c:pt idx="2">
                    <c:v>8.0892733233191155E-2</c:v>
                  </c:pt>
                  <c:pt idx="3">
                    <c:v>9.2184791336961405E-2</c:v>
                  </c:pt>
                  <c:pt idx="4">
                    <c:v>4.6772232610998471E-2</c:v>
                  </c:pt>
                  <c:pt idx="5">
                    <c:v>3.2080541938656719E-2</c:v>
                  </c:pt>
                  <c:pt idx="6">
                    <c:v>6.170473898158251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YWHAZ!$I$28:$I$34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YWHAZ!$J$28:$J$34</c:f>
              <c:numCache>
                <c:formatCode>General</c:formatCode>
                <c:ptCount val="7"/>
                <c:pt idx="0">
                  <c:v>1</c:v>
                </c:pt>
                <c:pt idx="1">
                  <c:v>1.0344740420569953</c:v>
                </c:pt>
                <c:pt idx="2">
                  <c:v>1.0415830037063027</c:v>
                </c:pt>
                <c:pt idx="3">
                  <c:v>0.98760955161702546</c:v>
                </c:pt>
                <c:pt idx="4">
                  <c:v>0.98746554876138781</c:v>
                </c:pt>
                <c:pt idx="5">
                  <c:v>0.90257601227135476</c:v>
                </c:pt>
                <c:pt idx="6">
                  <c:v>0.964863466455937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1DD-427F-97CC-5DB017F67DE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5900728"/>
        <c:axId val="425902368"/>
      </c:barChart>
      <c:catAx>
        <c:axId val="42590072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25902368"/>
        <c:crosses val="autoZero"/>
        <c:auto val="1"/>
        <c:lblAlgn val="ctr"/>
        <c:lblOffset val="100"/>
        <c:noMultiLvlLbl val="0"/>
      </c:catAx>
      <c:valAx>
        <c:axId val="425902368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YWHAZ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6.1663329696212098E-2"/>
              <c:y val="3.1585459496933165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2590072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PLP0-2'!$K$28:$K$34</c:f>
                <c:numCache>
                  <c:formatCode>General</c:formatCode>
                  <c:ptCount val="7"/>
                  <c:pt idx="0">
                    <c:v>3.9123116514440809E-2</c:v>
                  </c:pt>
                  <c:pt idx="1">
                    <c:v>2.1417540606912491E-2</c:v>
                  </c:pt>
                  <c:pt idx="2">
                    <c:v>0.10082252497938579</c:v>
                  </c:pt>
                  <c:pt idx="3">
                    <c:v>1.8388710876562797E-2</c:v>
                  </c:pt>
                  <c:pt idx="4">
                    <c:v>3.1751607300820904E-2</c:v>
                  </c:pt>
                  <c:pt idx="5">
                    <c:v>4.2319118782420291E-2</c:v>
                  </c:pt>
                  <c:pt idx="6">
                    <c:v>9.6620905248195971E-2</c:v>
                  </c:pt>
                </c:numCache>
              </c:numRef>
            </c:plus>
            <c:minus>
              <c:numRef>
                <c:f>'RPLP0-2'!$K$28:$K$34</c:f>
                <c:numCache>
                  <c:formatCode>General</c:formatCode>
                  <c:ptCount val="7"/>
                  <c:pt idx="0">
                    <c:v>3.9123116514440809E-2</c:v>
                  </c:pt>
                  <c:pt idx="1">
                    <c:v>2.1417540606912491E-2</c:v>
                  </c:pt>
                  <c:pt idx="2">
                    <c:v>0.10082252497938579</c:v>
                  </c:pt>
                  <c:pt idx="3">
                    <c:v>1.8388710876562797E-2</c:v>
                  </c:pt>
                  <c:pt idx="4">
                    <c:v>3.1751607300820904E-2</c:v>
                  </c:pt>
                  <c:pt idx="5">
                    <c:v>4.2319118782420291E-2</c:v>
                  </c:pt>
                  <c:pt idx="6">
                    <c:v>9.662090524819597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RPLP0-2'!$I$28:$I$34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'RPLP0-2'!$J$28:$J$34</c:f>
              <c:numCache>
                <c:formatCode>General</c:formatCode>
                <c:ptCount val="7"/>
                <c:pt idx="0">
                  <c:v>1</c:v>
                </c:pt>
                <c:pt idx="1">
                  <c:v>1.0319108005384263</c:v>
                </c:pt>
                <c:pt idx="2">
                  <c:v>1.0995431261723436</c:v>
                </c:pt>
                <c:pt idx="3">
                  <c:v>1.0843965652824743</c:v>
                </c:pt>
                <c:pt idx="4">
                  <c:v>0.97835452569074255</c:v>
                </c:pt>
                <c:pt idx="5">
                  <c:v>0.95548377871496226</c:v>
                </c:pt>
                <c:pt idx="6">
                  <c:v>0.939722481612124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F50-4641-A602-C4B75E8662D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19124440"/>
        <c:axId val="319125752"/>
      </c:barChart>
      <c:catAx>
        <c:axId val="31912444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19125752"/>
        <c:crosses val="autoZero"/>
        <c:auto val="1"/>
        <c:lblAlgn val="ctr"/>
        <c:lblOffset val="100"/>
        <c:noMultiLvlLbl val="0"/>
      </c:catAx>
      <c:valAx>
        <c:axId val="319125752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RPLP0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6.1663329696212098E-2"/>
              <c:y val="5.5274554119633036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19124440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TFRC!$K$4:$K$10</c:f>
                <c:numCache>
                  <c:formatCode>General</c:formatCode>
                  <c:ptCount val="7"/>
                  <c:pt idx="0">
                    <c:v>5.6798938526072297E-2</c:v>
                  </c:pt>
                  <c:pt idx="1">
                    <c:v>0.10663388149272848</c:v>
                  </c:pt>
                  <c:pt idx="2">
                    <c:v>0.10605302045771577</c:v>
                  </c:pt>
                  <c:pt idx="3">
                    <c:v>4.983548886969219E-2</c:v>
                  </c:pt>
                  <c:pt idx="4">
                    <c:v>4.4230440499708139E-2</c:v>
                  </c:pt>
                  <c:pt idx="5">
                    <c:v>4.0975873353111508E-2</c:v>
                  </c:pt>
                  <c:pt idx="6">
                    <c:v>7.2427455452374778E-2</c:v>
                  </c:pt>
                </c:numCache>
              </c:numRef>
            </c:plus>
            <c:minus>
              <c:numRef>
                <c:f>TFRC!$K$4:$K$10</c:f>
                <c:numCache>
                  <c:formatCode>General</c:formatCode>
                  <c:ptCount val="7"/>
                  <c:pt idx="0">
                    <c:v>5.6798938526072297E-2</c:v>
                  </c:pt>
                  <c:pt idx="1">
                    <c:v>0.10663388149272848</c:v>
                  </c:pt>
                  <c:pt idx="2">
                    <c:v>0.10605302045771577</c:v>
                  </c:pt>
                  <c:pt idx="3">
                    <c:v>4.983548886969219E-2</c:v>
                  </c:pt>
                  <c:pt idx="4">
                    <c:v>4.4230440499708139E-2</c:v>
                  </c:pt>
                  <c:pt idx="5">
                    <c:v>4.0975873353111508E-2</c:v>
                  </c:pt>
                  <c:pt idx="6">
                    <c:v>7.242745545237477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TFRC!$I$4:$I$10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TFRC!$J$4:$J$10</c:f>
              <c:numCache>
                <c:formatCode>General</c:formatCode>
                <c:ptCount val="7"/>
                <c:pt idx="0">
                  <c:v>1</c:v>
                </c:pt>
                <c:pt idx="1">
                  <c:v>1.06756185058188</c:v>
                </c:pt>
                <c:pt idx="2">
                  <c:v>0.94348597547778412</c:v>
                </c:pt>
                <c:pt idx="3">
                  <c:v>0.84122280019490159</c:v>
                </c:pt>
                <c:pt idx="4">
                  <c:v>0.70772384604757477</c:v>
                </c:pt>
                <c:pt idx="5">
                  <c:v>0.86817142182844054</c:v>
                </c:pt>
                <c:pt idx="6">
                  <c:v>0.732067014540445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00B-41CB-B097-3D1460312E1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16552000"/>
        <c:axId val="616555608"/>
      </c:barChart>
      <c:catAx>
        <c:axId val="61655200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16555608"/>
        <c:crosses val="autoZero"/>
        <c:auto val="1"/>
        <c:lblAlgn val="ctr"/>
        <c:lblOffset val="100"/>
        <c:noMultiLvlLbl val="0"/>
      </c:catAx>
      <c:valAx>
        <c:axId val="616555608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TFRC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16552000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RPLP1!$K$28:$K$34</c:f>
                <c:numCache>
                  <c:formatCode>General</c:formatCode>
                  <c:ptCount val="7"/>
                  <c:pt idx="0">
                    <c:v>9.0585668925760046E-2</c:v>
                  </c:pt>
                  <c:pt idx="1">
                    <c:v>4.7043345906194071E-2</c:v>
                  </c:pt>
                  <c:pt idx="2">
                    <c:v>6.5438996554110281E-3</c:v>
                  </c:pt>
                  <c:pt idx="3">
                    <c:v>2.3978260427047877E-2</c:v>
                  </c:pt>
                  <c:pt idx="4">
                    <c:v>3.1852769286571797E-2</c:v>
                  </c:pt>
                  <c:pt idx="5">
                    <c:v>3.3496899011146955E-2</c:v>
                  </c:pt>
                  <c:pt idx="6">
                    <c:v>8.6931723490235688E-2</c:v>
                  </c:pt>
                </c:numCache>
              </c:numRef>
            </c:plus>
            <c:minus>
              <c:numRef>
                <c:f>RPLP1!$K$28:$K$34</c:f>
                <c:numCache>
                  <c:formatCode>General</c:formatCode>
                  <c:ptCount val="7"/>
                  <c:pt idx="0">
                    <c:v>9.0585668925760046E-2</c:v>
                  </c:pt>
                  <c:pt idx="1">
                    <c:v>4.7043345906194071E-2</c:v>
                  </c:pt>
                  <c:pt idx="2">
                    <c:v>6.5438996554110281E-3</c:v>
                  </c:pt>
                  <c:pt idx="3">
                    <c:v>2.3978260427047877E-2</c:v>
                  </c:pt>
                  <c:pt idx="4">
                    <c:v>3.1852769286571797E-2</c:v>
                  </c:pt>
                  <c:pt idx="5">
                    <c:v>3.3496899011146955E-2</c:v>
                  </c:pt>
                  <c:pt idx="6">
                    <c:v>8.693172349023568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RPLP1!$I$28:$I$34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RPLP1!$J$28:$J$34</c:f>
              <c:numCache>
                <c:formatCode>General</c:formatCode>
                <c:ptCount val="7"/>
                <c:pt idx="0">
                  <c:v>1</c:v>
                </c:pt>
                <c:pt idx="1">
                  <c:v>0.898870718801144</c:v>
                </c:pt>
                <c:pt idx="2">
                  <c:v>0.95048734025958448</c:v>
                </c:pt>
                <c:pt idx="3">
                  <c:v>0.94693971603048066</c:v>
                </c:pt>
                <c:pt idx="4">
                  <c:v>0.91063252565106223</c:v>
                </c:pt>
                <c:pt idx="5">
                  <c:v>0.81700727484160607</c:v>
                </c:pt>
                <c:pt idx="6">
                  <c:v>0.7608314905356149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D8C-4E6F-8E16-9D2FA552952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16535272"/>
        <c:axId val="616534288"/>
      </c:barChart>
      <c:catAx>
        <c:axId val="61653527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16534288"/>
        <c:crosses val="autoZero"/>
        <c:auto val="1"/>
        <c:lblAlgn val="ctr"/>
        <c:lblOffset val="100"/>
        <c:noMultiLvlLbl val="0"/>
      </c:catAx>
      <c:valAx>
        <c:axId val="616534288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RPLP1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6.166330247814087E-2"/>
              <c:y val="4.7378189245399743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16535272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ACTB-2'!$K$28:$K$34</c:f>
                <c:numCache>
                  <c:formatCode>General</c:formatCode>
                  <c:ptCount val="7"/>
                  <c:pt idx="0">
                    <c:v>8.4553194835731399E-2</c:v>
                  </c:pt>
                  <c:pt idx="1">
                    <c:v>1.647776901371727E-2</c:v>
                  </c:pt>
                  <c:pt idx="2">
                    <c:v>7.5813911783771781E-2</c:v>
                  </c:pt>
                  <c:pt idx="3">
                    <c:v>9.4630163730055589E-2</c:v>
                  </c:pt>
                  <c:pt idx="4">
                    <c:v>3.1228975617574161E-3</c:v>
                  </c:pt>
                  <c:pt idx="5">
                    <c:v>9.2998650917369349E-2</c:v>
                  </c:pt>
                  <c:pt idx="6">
                    <c:v>2.6869112434920885E-2</c:v>
                  </c:pt>
                </c:numCache>
              </c:numRef>
            </c:plus>
            <c:minus>
              <c:numRef>
                <c:f>'ACTB-2'!$K$28:$K$34</c:f>
                <c:numCache>
                  <c:formatCode>General</c:formatCode>
                  <c:ptCount val="7"/>
                  <c:pt idx="0">
                    <c:v>8.4553194835731399E-2</c:v>
                  </c:pt>
                  <c:pt idx="1">
                    <c:v>1.647776901371727E-2</c:v>
                  </c:pt>
                  <c:pt idx="2">
                    <c:v>7.5813911783771781E-2</c:v>
                  </c:pt>
                  <c:pt idx="3">
                    <c:v>9.4630163730055589E-2</c:v>
                  </c:pt>
                  <c:pt idx="4">
                    <c:v>3.1228975617574161E-3</c:v>
                  </c:pt>
                  <c:pt idx="5">
                    <c:v>9.2998650917369349E-2</c:v>
                  </c:pt>
                  <c:pt idx="6">
                    <c:v>2.6869112434920885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ACTB-2'!$I$28:$I$34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'ACTB-2'!$J$28:$J$34</c:f>
              <c:numCache>
                <c:formatCode>General</c:formatCode>
                <c:ptCount val="7"/>
                <c:pt idx="0">
                  <c:v>1</c:v>
                </c:pt>
                <c:pt idx="1">
                  <c:v>1.040768080252195</c:v>
                </c:pt>
                <c:pt idx="2">
                  <c:v>1.0840323686271478</c:v>
                </c:pt>
                <c:pt idx="3">
                  <c:v>1.038364520590477</c:v>
                </c:pt>
                <c:pt idx="4">
                  <c:v>1.0137186512565477</c:v>
                </c:pt>
                <c:pt idx="5">
                  <c:v>0.75517916845922839</c:v>
                </c:pt>
                <c:pt idx="6">
                  <c:v>0.49431160201995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302-49F4-AD02-585F6082682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76846640"/>
        <c:axId val="576847624"/>
      </c:barChart>
      <c:catAx>
        <c:axId val="57684664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76847624"/>
        <c:crosses val="autoZero"/>
        <c:auto val="1"/>
        <c:lblAlgn val="ctr"/>
        <c:lblOffset val="100"/>
        <c:noMultiLvlLbl val="0"/>
      </c:catAx>
      <c:valAx>
        <c:axId val="576847624"/>
        <c:scaling>
          <c:orientation val="minMax"/>
          <c:min val="0.4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ACTB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6.1663329696212098E-2"/>
              <c:y val="5.5274554119633036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76846640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RPLP2!$K$28:$K$34</c:f>
                <c:numCache>
                  <c:formatCode>General</c:formatCode>
                  <c:ptCount val="7"/>
                  <c:pt idx="0">
                    <c:v>3.3101719560320417E-2</c:v>
                  </c:pt>
                  <c:pt idx="1">
                    <c:v>6.1255524785912265E-2</c:v>
                  </c:pt>
                  <c:pt idx="2">
                    <c:v>1.8019335712837092E-2</c:v>
                  </c:pt>
                  <c:pt idx="3">
                    <c:v>5.3077621513408092E-2</c:v>
                  </c:pt>
                  <c:pt idx="4">
                    <c:v>4.4164811423263069E-2</c:v>
                  </c:pt>
                  <c:pt idx="5">
                    <c:v>4.2802950745340372E-2</c:v>
                  </c:pt>
                  <c:pt idx="6">
                    <c:v>1.7548578050879133E-2</c:v>
                  </c:pt>
                </c:numCache>
              </c:numRef>
            </c:plus>
            <c:minus>
              <c:numRef>
                <c:f>RPLP2!$K$28:$K$34</c:f>
                <c:numCache>
                  <c:formatCode>General</c:formatCode>
                  <c:ptCount val="7"/>
                  <c:pt idx="0">
                    <c:v>3.3101719560320417E-2</c:v>
                  </c:pt>
                  <c:pt idx="1">
                    <c:v>6.1255524785912265E-2</c:v>
                  </c:pt>
                  <c:pt idx="2">
                    <c:v>1.8019335712837092E-2</c:v>
                  </c:pt>
                  <c:pt idx="3">
                    <c:v>5.3077621513408092E-2</c:v>
                  </c:pt>
                  <c:pt idx="4">
                    <c:v>4.4164811423263069E-2</c:v>
                  </c:pt>
                  <c:pt idx="5">
                    <c:v>4.2802950745340372E-2</c:v>
                  </c:pt>
                  <c:pt idx="6">
                    <c:v>1.754857805087913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RPLP2!$I$28:$I$34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RPLP2!$J$28:$J$34</c:f>
              <c:numCache>
                <c:formatCode>General</c:formatCode>
                <c:ptCount val="7"/>
                <c:pt idx="0">
                  <c:v>1</c:v>
                </c:pt>
                <c:pt idx="1">
                  <c:v>0.95404741285755146</c:v>
                </c:pt>
                <c:pt idx="2">
                  <c:v>0.97458309789532993</c:v>
                </c:pt>
                <c:pt idx="3">
                  <c:v>0.97973083998656108</c:v>
                </c:pt>
                <c:pt idx="4">
                  <c:v>0.95657489924363037</c:v>
                </c:pt>
                <c:pt idx="5">
                  <c:v>0.92251789209042556</c:v>
                </c:pt>
                <c:pt idx="6">
                  <c:v>0.8814131969302189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BC8-4346-9B61-8B2213C0C36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7722768"/>
        <c:axId val="427719488"/>
      </c:barChart>
      <c:catAx>
        <c:axId val="42772276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27719488"/>
        <c:crosses val="autoZero"/>
        <c:auto val="1"/>
        <c:lblAlgn val="ctr"/>
        <c:lblOffset val="100"/>
        <c:noMultiLvlLbl val="0"/>
      </c:catAx>
      <c:valAx>
        <c:axId val="427719488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RPLP2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6.1663329696212098E-2"/>
              <c:y val="7.1067283868099615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27722768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HPRT1!$K$28:$K$34</c:f>
                <c:numCache>
                  <c:formatCode>General</c:formatCode>
                  <c:ptCount val="7"/>
                  <c:pt idx="0">
                    <c:v>4.9487934736254964E-2</c:v>
                  </c:pt>
                  <c:pt idx="1">
                    <c:v>6.986344070642013E-2</c:v>
                  </c:pt>
                  <c:pt idx="2">
                    <c:v>2.379321316008709E-2</c:v>
                  </c:pt>
                  <c:pt idx="3">
                    <c:v>1.4957886569165038E-2</c:v>
                  </c:pt>
                  <c:pt idx="4">
                    <c:v>3.4207358361686105E-2</c:v>
                  </c:pt>
                  <c:pt idx="5">
                    <c:v>5.3593914222501336E-2</c:v>
                  </c:pt>
                  <c:pt idx="6">
                    <c:v>2.9366755565423092E-2</c:v>
                  </c:pt>
                </c:numCache>
              </c:numRef>
            </c:plus>
            <c:minus>
              <c:numRef>
                <c:f>HPRT1!$K$28:$K$34</c:f>
                <c:numCache>
                  <c:formatCode>General</c:formatCode>
                  <c:ptCount val="7"/>
                  <c:pt idx="0">
                    <c:v>4.9487934736254964E-2</c:v>
                  </c:pt>
                  <c:pt idx="1">
                    <c:v>6.986344070642013E-2</c:v>
                  </c:pt>
                  <c:pt idx="2">
                    <c:v>2.379321316008709E-2</c:v>
                  </c:pt>
                  <c:pt idx="3">
                    <c:v>1.4957886569165038E-2</c:v>
                  </c:pt>
                  <c:pt idx="4">
                    <c:v>3.4207358361686105E-2</c:v>
                  </c:pt>
                  <c:pt idx="5">
                    <c:v>5.3593914222501336E-2</c:v>
                  </c:pt>
                  <c:pt idx="6">
                    <c:v>2.936675556542309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HPRT1!$I$28:$I$34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HPRT1!$J$28:$J$34</c:f>
              <c:numCache>
                <c:formatCode>General</c:formatCode>
                <c:ptCount val="7"/>
                <c:pt idx="0">
                  <c:v>1</c:v>
                </c:pt>
                <c:pt idx="1">
                  <c:v>0.98910824018967436</c:v>
                </c:pt>
                <c:pt idx="2">
                  <c:v>1.0208997615125097</c:v>
                </c:pt>
                <c:pt idx="3">
                  <c:v>1.037379443591169</c:v>
                </c:pt>
                <c:pt idx="4">
                  <c:v>1.0146517569198243</c:v>
                </c:pt>
                <c:pt idx="5">
                  <c:v>0.85796076397978938</c:v>
                </c:pt>
                <c:pt idx="6">
                  <c:v>0.7173089474750687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9B7-459F-8AB4-AE500175995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16481304"/>
        <c:axId val="416481632"/>
      </c:barChart>
      <c:catAx>
        <c:axId val="41648130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16481632"/>
        <c:crosses val="autoZero"/>
        <c:auto val="1"/>
        <c:lblAlgn val="ctr"/>
        <c:lblOffset val="100"/>
        <c:noMultiLvlLbl val="0"/>
      </c:catAx>
      <c:valAx>
        <c:axId val="416481632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HPRT1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6.1663329696212098E-2"/>
              <c:y val="3.9481824371166457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16481304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B2M!$K$28:$K$34</c:f>
                <c:numCache>
                  <c:formatCode>General</c:formatCode>
                  <c:ptCount val="7"/>
                  <c:pt idx="0">
                    <c:v>1.0983640389961103E-2</c:v>
                  </c:pt>
                  <c:pt idx="1">
                    <c:v>9.8771835816505338E-2</c:v>
                  </c:pt>
                  <c:pt idx="2">
                    <c:v>5.2629099437052108E-2</c:v>
                  </c:pt>
                  <c:pt idx="3">
                    <c:v>6.8386155428061438E-2</c:v>
                  </c:pt>
                  <c:pt idx="4">
                    <c:v>5.0474209459735332E-2</c:v>
                  </c:pt>
                  <c:pt idx="5">
                    <c:v>1.3562291919599085E-2</c:v>
                  </c:pt>
                  <c:pt idx="6">
                    <c:v>9.7411650917967663E-2</c:v>
                  </c:pt>
                </c:numCache>
              </c:numRef>
            </c:plus>
            <c:minus>
              <c:numRef>
                <c:f>B2M!$K$28:$K$34</c:f>
                <c:numCache>
                  <c:formatCode>General</c:formatCode>
                  <c:ptCount val="7"/>
                  <c:pt idx="0">
                    <c:v>1.0983640389961103E-2</c:v>
                  </c:pt>
                  <c:pt idx="1">
                    <c:v>9.8771835816505338E-2</c:v>
                  </c:pt>
                  <c:pt idx="2">
                    <c:v>5.2629099437052108E-2</c:v>
                  </c:pt>
                  <c:pt idx="3">
                    <c:v>6.8386155428061438E-2</c:v>
                  </c:pt>
                  <c:pt idx="4">
                    <c:v>5.0474209459735332E-2</c:v>
                  </c:pt>
                  <c:pt idx="5">
                    <c:v>1.3562291919599085E-2</c:v>
                  </c:pt>
                  <c:pt idx="6">
                    <c:v>9.741165091796766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B2M!$I$28:$I$34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B2M!$J$28:$J$34</c:f>
              <c:numCache>
                <c:formatCode>General</c:formatCode>
                <c:ptCount val="7"/>
                <c:pt idx="0">
                  <c:v>1</c:v>
                </c:pt>
                <c:pt idx="1">
                  <c:v>0.962794023615547</c:v>
                </c:pt>
                <c:pt idx="2">
                  <c:v>0.97532105987735163</c:v>
                </c:pt>
                <c:pt idx="3">
                  <c:v>0.98181580272306324</c:v>
                </c:pt>
                <c:pt idx="4">
                  <c:v>0.8816939974730692</c:v>
                </c:pt>
                <c:pt idx="5">
                  <c:v>0.93784080175879148</c:v>
                </c:pt>
                <c:pt idx="6">
                  <c:v>0.9039407673758317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B6D-4D1D-9B01-ABF23C7B6E2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43044032"/>
        <c:axId val="543036816"/>
      </c:barChart>
      <c:catAx>
        <c:axId val="54304403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43036816"/>
        <c:crosses val="autoZero"/>
        <c:auto val="1"/>
        <c:lblAlgn val="ctr"/>
        <c:lblOffset val="100"/>
        <c:noMultiLvlLbl val="0"/>
      </c:catAx>
      <c:valAx>
        <c:axId val="543036816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B2M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43044032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PS18-2'!$K$28:$K$34</c:f>
                <c:numCache>
                  <c:formatCode>General</c:formatCode>
                  <c:ptCount val="7"/>
                  <c:pt idx="0">
                    <c:v>4.0692108593123631E-2</c:v>
                  </c:pt>
                  <c:pt idx="1">
                    <c:v>7.6468215401610973E-2</c:v>
                  </c:pt>
                  <c:pt idx="2">
                    <c:v>1.2284440751534979E-2</c:v>
                  </c:pt>
                  <c:pt idx="3">
                    <c:v>4.9247117243854811E-2</c:v>
                  </c:pt>
                  <c:pt idx="4">
                    <c:v>2.5946344298010016E-2</c:v>
                  </c:pt>
                  <c:pt idx="5">
                    <c:v>7.8645725856399951E-2</c:v>
                  </c:pt>
                  <c:pt idx="6">
                    <c:v>1.7676006780868152E-2</c:v>
                  </c:pt>
                </c:numCache>
              </c:numRef>
            </c:plus>
            <c:minus>
              <c:numRef>
                <c:f>'RPS18-2'!$K$28:$K$34</c:f>
                <c:numCache>
                  <c:formatCode>General</c:formatCode>
                  <c:ptCount val="7"/>
                  <c:pt idx="0">
                    <c:v>4.0692108593123631E-2</c:v>
                  </c:pt>
                  <c:pt idx="1">
                    <c:v>7.6468215401610973E-2</c:v>
                  </c:pt>
                  <c:pt idx="2">
                    <c:v>1.2284440751534979E-2</c:v>
                  </c:pt>
                  <c:pt idx="3">
                    <c:v>4.9247117243854811E-2</c:v>
                  </c:pt>
                  <c:pt idx="4">
                    <c:v>2.5946344298010016E-2</c:v>
                  </c:pt>
                  <c:pt idx="5">
                    <c:v>7.8645725856399951E-2</c:v>
                  </c:pt>
                  <c:pt idx="6">
                    <c:v>1.767600678086815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RPS18-2'!$I$28:$I$34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'RPS18-2'!$J$28:$J$34</c:f>
              <c:numCache>
                <c:formatCode>General</c:formatCode>
                <c:ptCount val="7"/>
                <c:pt idx="0">
                  <c:v>1</c:v>
                </c:pt>
                <c:pt idx="1">
                  <c:v>0.9218881625592531</c:v>
                </c:pt>
                <c:pt idx="2">
                  <c:v>0.97095282906660385</c:v>
                </c:pt>
                <c:pt idx="3">
                  <c:v>0.95403200911683717</c:v>
                </c:pt>
                <c:pt idx="4">
                  <c:v>0.96604369566228565</c:v>
                </c:pt>
                <c:pt idx="5">
                  <c:v>0.96046017786192428</c:v>
                </c:pt>
                <c:pt idx="6">
                  <c:v>0.865283822027030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7C9-4CED-AF61-F569D9221B8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45339920"/>
        <c:axId val="545341888"/>
      </c:barChart>
      <c:catAx>
        <c:axId val="54533992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45341888"/>
        <c:crosses val="autoZero"/>
        <c:auto val="1"/>
        <c:lblAlgn val="ctr"/>
        <c:lblOffset val="100"/>
        <c:noMultiLvlLbl val="0"/>
      </c:catAx>
      <c:valAx>
        <c:axId val="545341888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RPS18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6.1663329696212098E-2"/>
              <c:y val="6.3170918993866329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45339920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TBP!$K$28:$K$34</c:f>
                <c:numCache>
                  <c:formatCode>General</c:formatCode>
                  <c:ptCount val="7"/>
                  <c:pt idx="0">
                    <c:v>9.8936263087346848E-2</c:v>
                  </c:pt>
                  <c:pt idx="1">
                    <c:v>0.11150185323811365</c:v>
                  </c:pt>
                  <c:pt idx="2">
                    <c:v>6.4778590858463284E-2</c:v>
                  </c:pt>
                  <c:pt idx="3">
                    <c:v>3.0106140438517053E-2</c:v>
                  </c:pt>
                  <c:pt idx="4">
                    <c:v>5.44274389643273E-2</c:v>
                  </c:pt>
                  <c:pt idx="5">
                    <c:v>0.1152010877188229</c:v>
                  </c:pt>
                  <c:pt idx="6">
                    <c:v>5.9371349957593161E-2</c:v>
                  </c:pt>
                </c:numCache>
              </c:numRef>
            </c:plus>
            <c:minus>
              <c:numRef>
                <c:f>TBP!$K$28:$K$34</c:f>
                <c:numCache>
                  <c:formatCode>General</c:formatCode>
                  <c:ptCount val="7"/>
                  <c:pt idx="0">
                    <c:v>9.8936263087346848E-2</c:v>
                  </c:pt>
                  <c:pt idx="1">
                    <c:v>0.11150185323811365</c:v>
                  </c:pt>
                  <c:pt idx="2">
                    <c:v>6.4778590858463284E-2</c:v>
                  </c:pt>
                  <c:pt idx="3">
                    <c:v>3.0106140438517053E-2</c:v>
                  </c:pt>
                  <c:pt idx="4">
                    <c:v>5.44274389643273E-2</c:v>
                  </c:pt>
                  <c:pt idx="5">
                    <c:v>0.1152010877188229</c:v>
                  </c:pt>
                  <c:pt idx="6">
                    <c:v>5.937134995759316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TBP!$I$28:$I$34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TBP!$J$28:$J$34</c:f>
              <c:numCache>
                <c:formatCode>General</c:formatCode>
                <c:ptCount val="7"/>
                <c:pt idx="0">
                  <c:v>1.0000000000000002</c:v>
                </c:pt>
                <c:pt idx="1">
                  <c:v>0.92876792304535039</c:v>
                </c:pt>
                <c:pt idx="2">
                  <c:v>0.94633271690000365</c:v>
                </c:pt>
                <c:pt idx="3">
                  <c:v>1.0038892038400831</c:v>
                </c:pt>
                <c:pt idx="4">
                  <c:v>0.96980281666990409</c:v>
                </c:pt>
                <c:pt idx="5">
                  <c:v>0.86214836471843503</c:v>
                </c:pt>
                <c:pt idx="6">
                  <c:v>0.6725792005669437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EC4-4DE4-9773-955B008D54C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79604328"/>
        <c:axId val="579606296"/>
      </c:barChart>
      <c:catAx>
        <c:axId val="57960432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79606296"/>
        <c:crosses val="autoZero"/>
        <c:auto val="1"/>
        <c:lblAlgn val="ctr"/>
        <c:lblOffset val="100"/>
        <c:noMultiLvlLbl val="0"/>
      </c:catAx>
      <c:valAx>
        <c:axId val="579606296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TBP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79604328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PPIA-5'!$K$28:$K$34</c:f>
                <c:numCache>
                  <c:formatCode>General</c:formatCode>
                  <c:ptCount val="7"/>
                  <c:pt idx="0">
                    <c:v>2.9830913303908291E-2</c:v>
                  </c:pt>
                  <c:pt idx="1">
                    <c:v>4.3144823216313404E-2</c:v>
                  </c:pt>
                  <c:pt idx="2">
                    <c:v>6.4398526943264492E-2</c:v>
                  </c:pt>
                  <c:pt idx="3">
                    <c:v>9.0205383582095469E-2</c:v>
                  </c:pt>
                  <c:pt idx="4">
                    <c:v>4.8523996994258453E-2</c:v>
                  </c:pt>
                  <c:pt idx="5">
                    <c:v>1.4389359117470151E-2</c:v>
                  </c:pt>
                  <c:pt idx="6">
                    <c:v>1.9753516242282648E-2</c:v>
                  </c:pt>
                </c:numCache>
              </c:numRef>
            </c:plus>
            <c:minus>
              <c:numRef>
                <c:f>'PPIA-5'!$K$28:$K$34</c:f>
                <c:numCache>
                  <c:formatCode>General</c:formatCode>
                  <c:ptCount val="7"/>
                  <c:pt idx="0">
                    <c:v>2.9830913303908291E-2</c:v>
                  </c:pt>
                  <c:pt idx="1">
                    <c:v>4.3144823216313404E-2</c:v>
                  </c:pt>
                  <c:pt idx="2">
                    <c:v>6.4398526943264492E-2</c:v>
                  </c:pt>
                  <c:pt idx="3">
                    <c:v>9.0205383582095469E-2</c:v>
                  </c:pt>
                  <c:pt idx="4">
                    <c:v>4.8523996994258453E-2</c:v>
                  </c:pt>
                  <c:pt idx="5">
                    <c:v>1.4389359117470151E-2</c:v>
                  </c:pt>
                  <c:pt idx="6">
                    <c:v>1.975351624228264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PPIA-5'!$I$28:$I$34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'PPIA-5'!$J$28:$J$34</c:f>
              <c:numCache>
                <c:formatCode>General</c:formatCode>
                <c:ptCount val="7"/>
                <c:pt idx="0">
                  <c:v>1</c:v>
                </c:pt>
                <c:pt idx="1">
                  <c:v>0.97764984279907841</c:v>
                </c:pt>
                <c:pt idx="2">
                  <c:v>0.9994092317323382</c:v>
                </c:pt>
                <c:pt idx="3">
                  <c:v>0.92538491909323917</c:v>
                </c:pt>
                <c:pt idx="4">
                  <c:v>0.94770306774754198</c:v>
                </c:pt>
                <c:pt idx="5">
                  <c:v>0.9502422720576108</c:v>
                </c:pt>
                <c:pt idx="6">
                  <c:v>0.8665911994985946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7F6-4A12-BB9E-4883CF2F3D1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31929592"/>
        <c:axId val="631924344"/>
      </c:barChart>
      <c:catAx>
        <c:axId val="63192959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31924344"/>
        <c:crosses val="autoZero"/>
        <c:auto val="1"/>
        <c:lblAlgn val="ctr"/>
        <c:lblOffset val="100"/>
        <c:noMultiLvlLbl val="0"/>
      </c:catAx>
      <c:valAx>
        <c:axId val="631924344"/>
        <c:scaling>
          <c:orientation val="minMax"/>
          <c:max val="1.3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PPIA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31929592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GAPDH-2'!$K$28:$K$34</c:f>
                <c:numCache>
                  <c:formatCode>General</c:formatCode>
                  <c:ptCount val="7"/>
                  <c:pt idx="0">
                    <c:v>6.5630558182256049E-2</c:v>
                  </c:pt>
                  <c:pt idx="1">
                    <c:v>5.6643897554837154E-2</c:v>
                  </c:pt>
                  <c:pt idx="2">
                    <c:v>1.3044226566151795E-2</c:v>
                  </c:pt>
                  <c:pt idx="3">
                    <c:v>2.1034235501102935E-2</c:v>
                  </c:pt>
                  <c:pt idx="4">
                    <c:v>2.6150905767221996E-2</c:v>
                  </c:pt>
                  <c:pt idx="5">
                    <c:v>4.5293457420510587E-2</c:v>
                  </c:pt>
                  <c:pt idx="6">
                    <c:v>8.7052185950425812E-2</c:v>
                  </c:pt>
                </c:numCache>
              </c:numRef>
            </c:plus>
            <c:minus>
              <c:numRef>
                <c:f>'GAPDH-2'!$K$28:$K$34</c:f>
                <c:numCache>
                  <c:formatCode>General</c:formatCode>
                  <c:ptCount val="7"/>
                  <c:pt idx="0">
                    <c:v>6.5630558182256049E-2</c:v>
                  </c:pt>
                  <c:pt idx="1">
                    <c:v>5.6643897554837154E-2</c:v>
                  </c:pt>
                  <c:pt idx="2">
                    <c:v>1.3044226566151795E-2</c:v>
                  </c:pt>
                  <c:pt idx="3">
                    <c:v>2.1034235501102935E-2</c:v>
                  </c:pt>
                  <c:pt idx="4">
                    <c:v>2.6150905767221996E-2</c:v>
                  </c:pt>
                  <c:pt idx="5">
                    <c:v>4.5293457420510587E-2</c:v>
                  </c:pt>
                  <c:pt idx="6">
                    <c:v>8.705218595042581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GAPDH-2'!$I$28:$I$34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'GAPDH-2'!$J$28:$J$34</c:f>
              <c:numCache>
                <c:formatCode>General</c:formatCode>
                <c:ptCount val="7"/>
                <c:pt idx="0">
                  <c:v>1.0000000000000002</c:v>
                </c:pt>
                <c:pt idx="1">
                  <c:v>0.90780864602970457</c:v>
                </c:pt>
                <c:pt idx="2">
                  <c:v>0.97303183680534044</c:v>
                </c:pt>
                <c:pt idx="3">
                  <c:v>0.94538643934663324</c:v>
                </c:pt>
                <c:pt idx="4">
                  <c:v>0.93425787443271435</c:v>
                </c:pt>
                <c:pt idx="5">
                  <c:v>0.93249091257424421</c:v>
                </c:pt>
                <c:pt idx="6">
                  <c:v>0.821027867222061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EA7-4014-91BE-FC15CB8E6C2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32027032"/>
        <c:axId val="532029656"/>
      </c:barChart>
      <c:catAx>
        <c:axId val="53202703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32029656"/>
        <c:crosses val="autoZero"/>
        <c:auto val="1"/>
        <c:lblAlgn val="ctr"/>
        <c:lblOffset val="100"/>
        <c:noMultiLvlLbl val="0"/>
      </c:catAx>
      <c:valAx>
        <c:axId val="532029656"/>
        <c:scaling>
          <c:orientation val="minMax"/>
          <c:max val="1.1000000000000001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GAPDH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6.1759450256896324E-2"/>
              <c:y val="2.4358324377440229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32027032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GUSB!$K$28:$K$34</c:f>
                <c:numCache>
                  <c:formatCode>General</c:formatCode>
                  <c:ptCount val="7"/>
                  <c:pt idx="0">
                    <c:v>3.0210372151897973E-2</c:v>
                  </c:pt>
                  <c:pt idx="1">
                    <c:v>3.1851321409055181E-2</c:v>
                  </c:pt>
                  <c:pt idx="2">
                    <c:v>2.2952695865832973E-2</c:v>
                  </c:pt>
                  <c:pt idx="3">
                    <c:v>9.0407080586613592E-2</c:v>
                  </c:pt>
                  <c:pt idx="4">
                    <c:v>5.9626516682544699E-2</c:v>
                  </c:pt>
                  <c:pt idx="5">
                    <c:v>4.1758635613141366E-2</c:v>
                  </c:pt>
                  <c:pt idx="6">
                    <c:v>8.9695064581226822E-2</c:v>
                  </c:pt>
                </c:numCache>
              </c:numRef>
            </c:plus>
            <c:minus>
              <c:numRef>
                <c:f>GUSB!$K$28:$K$34</c:f>
                <c:numCache>
                  <c:formatCode>General</c:formatCode>
                  <c:ptCount val="7"/>
                  <c:pt idx="0">
                    <c:v>3.0210372151897973E-2</c:v>
                  </c:pt>
                  <c:pt idx="1">
                    <c:v>3.1851321409055181E-2</c:v>
                  </c:pt>
                  <c:pt idx="2">
                    <c:v>2.2952695865832973E-2</c:v>
                  </c:pt>
                  <c:pt idx="3">
                    <c:v>9.0407080586613592E-2</c:v>
                  </c:pt>
                  <c:pt idx="4">
                    <c:v>5.9626516682544699E-2</c:v>
                  </c:pt>
                  <c:pt idx="5">
                    <c:v>4.1758635613141366E-2</c:v>
                  </c:pt>
                  <c:pt idx="6">
                    <c:v>8.969506458122682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GUSB!$I$28:$I$34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GUSB!$J$28:$J$34</c:f>
              <c:numCache>
                <c:formatCode>General</c:formatCode>
                <c:ptCount val="7"/>
                <c:pt idx="0">
                  <c:v>1</c:v>
                </c:pt>
                <c:pt idx="1">
                  <c:v>0.96410063462829532</c:v>
                </c:pt>
                <c:pt idx="2">
                  <c:v>0.95262108757421349</c:v>
                </c:pt>
                <c:pt idx="3">
                  <c:v>0.97379565161367809</c:v>
                </c:pt>
                <c:pt idx="4">
                  <c:v>0.94739383400573252</c:v>
                </c:pt>
                <c:pt idx="5">
                  <c:v>0.89794708644678545</c:v>
                </c:pt>
                <c:pt idx="6">
                  <c:v>0.812417361002074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62D-480B-9CB4-EDE5D2713E4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76831224"/>
        <c:axId val="576836472"/>
      </c:barChart>
      <c:catAx>
        <c:axId val="57683122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76836472"/>
        <c:crosses val="autoZero"/>
        <c:auto val="1"/>
        <c:lblAlgn val="ctr"/>
        <c:lblOffset val="100"/>
        <c:noMultiLvlLbl val="0"/>
      </c:catAx>
      <c:valAx>
        <c:axId val="576836472"/>
        <c:scaling>
          <c:orientation val="minMax"/>
          <c:max val="1.3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GUSB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6.1797971504809361E-2"/>
              <c:y val="5.6521852467156609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76831224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YWHAZ!$K$4:$K$10</c:f>
                <c:numCache>
                  <c:formatCode>General</c:formatCode>
                  <c:ptCount val="7"/>
                  <c:pt idx="0">
                    <c:v>5.6482883526118244E-2</c:v>
                  </c:pt>
                  <c:pt idx="1">
                    <c:v>4.6079260819443996E-2</c:v>
                  </c:pt>
                  <c:pt idx="2">
                    <c:v>3.863062755224099E-2</c:v>
                  </c:pt>
                  <c:pt idx="3">
                    <c:v>2.6123216092777773E-2</c:v>
                  </c:pt>
                  <c:pt idx="4">
                    <c:v>5.8144170448770821E-2</c:v>
                  </c:pt>
                  <c:pt idx="5">
                    <c:v>2.9010380739406046E-2</c:v>
                  </c:pt>
                  <c:pt idx="6">
                    <c:v>9.5250090164799489E-2</c:v>
                  </c:pt>
                </c:numCache>
              </c:numRef>
            </c:plus>
            <c:minus>
              <c:numRef>
                <c:f>YWHAZ!$K$4:$K$10</c:f>
                <c:numCache>
                  <c:formatCode>General</c:formatCode>
                  <c:ptCount val="7"/>
                  <c:pt idx="0">
                    <c:v>5.6482883526118244E-2</c:v>
                  </c:pt>
                  <c:pt idx="1">
                    <c:v>4.6079260819443996E-2</c:v>
                  </c:pt>
                  <c:pt idx="2">
                    <c:v>3.863062755224099E-2</c:v>
                  </c:pt>
                  <c:pt idx="3">
                    <c:v>2.6123216092777773E-2</c:v>
                  </c:pt>
                  <c:pt idx="4">
                    <c:v>5.8144170448770821E-2</c:v>
                  </c:pt>
                  <c:pt idx="5">
                    <c:v>2.9010380739406046E-2</c:v>
                  </c:pt>
                  <c:pt idx="6">
                    <c:v>9.5250090164799489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YWHAZ!$I$4:$I$10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YWHAZ!$J$4:$J$10</c:f>
              <c:numCache>
                <c:formatCode>General</c:formatCode>
                <c:ptCount val="7"/>
                <c:pt idx="0">
                  <c:v>1</c:v>
                </c:pt>
                <c:pt idx="1">
                  <c:v>1.0552179873221306</c:v>
                </c:pt>
                <c:pt idx="2">
                  <c:v>1.0508606172645678</c:v>
                </c:pt>
                <c:pt idx="3">
                  <c:v>1.04668249039647</c:v>
                </c:pt>
                <c:pt idx="4">
                  <c:v>1.1226103474035856</c:v>
                </c:pt>
                <c:pt idx="5">
                  <c:v>1.1294712898271808</c:v>
                </c:pt>
                <c:pt idx="6">
                  <c:v>1.072682062792062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1F5-4FC3-8F60-B94A5EEE4C0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5900728"/>
        <c:axId val="425902368"/>
      </c:barChart>
      <c:catAx>
        <c:axId val="42590072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25902368"/>
        <c:crosses val="autoZero"/>
        <c:auto val="1"/>
        <c:lblAlgn val="ctr"/>
        <c:lblOffset val="100"/>
        <c:noMultiLvlLbl val="0"/>
      </c:catAx>
      <c:valAx>
        <c:axId val="425902368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YWHAZ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6.166330247814087E-2"/>
              <c:y val="2.3689094622699872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25900728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PGK1'!$K$28:$K$34</c:f>
                <c:numCache>
                  <c:formatCode>General</c:formatCode>
                  <c:ptCount val="7"/>
                  <c:pt idx="0">
                    <c:v>5.9175940340821832E-2</c:v>
                  </c:pt>
                  <c:pt idx="1">
                    <c:v>1.6577044708080409E-3</c:v>
                  </c:pt>
                  <c:pt idx="2">
                    <c:v>6.8247099277255535E-3</c:v>
                  </c:pt>
                  <c:pt idx="3">
                    <c:v>6.5084712887099341E-2</c:v>
                  </c:pt>
                  <c:pt idx="4">
                    <c:v>3.9222918852961919E-2</c:v>
                  </c:pt>
                  <c:pt idx="5">
                    <c:v>7.2952979258524078E-2</c:v>
                  </c:pt>
                  <c:pt idx="6">
                    <c:v>6.3768087536916332E-2</c:v>
                  </c:pt>
                </c:numCache>
              </c:numRef>
            </c:plus>
            <c:minus>
              <c:numRef>
                <c:f>'PGK1'!$K$28:$K$34</c:f>
                <c:numCache>
                  <c:formatCode>General</c:formatCode>
                  <c:ptCount val="7"/>
                  <c:pt idx="0">
                    <c:v>5.9175940340821832E-2</c:v>
                  </c:pt>
                  <c:pt idx="1">
                    <c:v>1.6577044708080409E-3</c:v>
                  </c:pt>
                  <c:pt idx="2">
                    <c:v>6.8247099277255535E-3</c:v>
                  </c:pt>
                  <c:pt idx="3">
                    <c:v>6.5084712887099341E-2</c:v>
                  </c:pt>
                  <c:pt idx="4">
                    <c:v>3.9222918852961919E-2</c:v>
                  </c:pt>
                  <c:pt idx="5">
                    <c:v>7.2952979258524078E-2</c:v>
                  </c:pt>
                  <c:pt idx="6">
                    <c:v>6.376808753691633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PGK1'!$I$28:$I$34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'PGK1'!$J$28:$J$34</c:f>
              <c:numCache>
                <c:formatCode>General</c:formatCode>
                <c:ptCount val="7"/>
                <c:pt idx="0">
                  <c:v>1</c:v>
                </c:pt>
                <c:pt idx="1">
                  <c:v>0.93099835918634088</c:v>
                </c:pt>
                <c:pt idx="2">
                  <c:v>0.99936483364312212</c:v>
                </c:pt>
                <c:pt idx="3">
                  <c:v>0.9521401672692732</c:v>
                </c:pt>
                <c:pt idx="4">
                  <c:v>0.98360090592129812</c:v>
                </c:pt>
                <c:pt idx="5">
                  <c:v>0.87763395729982918</c:v>
                </c:pt>
                <c:pt idx="6">
                  <c:v>0.854139167425654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77C-45F8-B975-17216CB63A0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3367568"/>
        <c:axId val="423367896"/>
      </c:barChart>
      <c:catAx>
        <c:axId val="42336756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23367896"/>
        <c:crosses val="autoZero"/>
        <c:auto val="1"/>
        <c:lblAlgn val="ctr"/>
        <c:lblOffset val="100"/>
        <c:noMultiLvlLbl val="0"/>
      </c:catAx>
      <c:valAx>
        <c:axId val="423367896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PGK1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6.1663329696212098E-2"/>
              <c:y val="7.1067283868099615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233675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ATP5F1!$K$4:$K$10</c:f>
                <c:numCache>
                  <c:formatCode>General</c:formatCode>
                  <c:ptCount val="7"/>
                  <c:pt idx="0">
                    <c:v>9.8190507043370942E-2</c:v>
                  </c:pt>
                  <c:pt idx="1">
                    <c:v>8.9859075501503349E-2</c:v>
                  </c:pt>
                  <c:pt idx="2">
                    <c:v>4.6395412195346833E-2</c:v>
                  </c:pt>
                  <c:pt idx="3">
                    <c:v>3.9453630936090868E-2</c:v>
                  </c:pt>
                  <c:pt idx="4">
                    <c:v>3.8907513615916593E-2</c:v>
                  </c:pt>
                  <c:pt idx="5">
                    <c:v>3.3567271960925925E-2</c:v>
                  </c:pt>
                  <c:pt idx="6">
                    <c:v>1.2941259066755891E-2</c:v>
                  </c:pt>
                </c:numCache>
              </c:numRef>
            </c:plus>
            <c:minus>
              <c:numRef>
                <c:f>ATP5F1!$K$4:$K$10</c:f>
                <c:numCache>
                  <c:formatCode>General</c:formatCode>
                  <c:ptCount val="7"/>
                  <c:pt idx="0">
                    <c:v>9.8190507043370942E-2</c:v>
                  </c:pt>
                  <c:pt idx="1">
                    <c:v>8.9859075501503349E-2</c:v>
                  </c:pt>
                  <c:pt idx="2">
                    <c:v>4.6395412195346833E-2</c:v>
                  </c:pt>
                  <c:pt idx="3">
                    <c:v>3.9453630936090868E-2</c:v>
                  </c:pt>
                  <c:pt idx="4">
                    <c:v>3.8907513615916593E-2</c:v>
                  </c:pt>
                  <c:pt idx="5">
                    <c:v>3.3567271960925925E-2</c:v>
                  </c:pt>
                  <c:pt idx="6">
                    <c:v>1.294125906675589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ATP5F1!$I$4:$I$10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ATP5F1!$J$4:$J$10</c:f>
              <c:numCache>
                <c:formatCode>General</c:formatCode>
                <c:ptCount val="7"/>
                <c:pt idx="0">
                  <c:v>1</c:v>
                </c:pt>
                <c:pt idx="1">
                  <c:v>1.0468107187005702</c:v>
                </c:pt>
                <c:pt idx="2">
                  <c:v>0.90310073547504999</c:v>
                </c:pt>
                <c:pt idx="3">
                  <c:v>0.90236362417048321</c:v>
                </c:pt>
                <c:pt idx="4">
                  <c:v>0.72536826055203896</c:v>
                </c:pt>
                <c:pt idx="5">
                  <c:v>0.67956019704950521</c:v>
                </c:pt>
                <c:pt idx="6">
                  <c:v>0.784973506669070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456-4B34-A95F-7DCF584E3BD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21668000"/>
        <c:axId val="521671936"/>
      </c:barChart>
      <c:catAx>
        <c:axId val="52166800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dirty="0">
                    <a:solidFill>
                      <a:schemeClr val="tx1"/>
                    </a:solidFill>
                  </a:rPr>
                  <a:t>Atorvastatin (µM)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21671936"/>
        <c:crosses val="autoZero"/>
        <c:auto val="1"/>
        <c:lblAlgn val="ctr"/>
        <c:lblOffset val="100"/>
        <c:noMultiLvlLbl val="0"/>
      </c:catAx>
      <c:valAx>
        <c:axId val="521671936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ATP5F1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6.166330247814087E-2"/>
              <c:y val="3.1585459496933165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21668000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TFRC-3'!$K$4:$K$10</c:f>
                <c:numCache>
                  <c:formatCode>General</c:formatCode>
                  <c:ptCount val="7"/>
                  <c:pt idx="0">
                    <c:v>6.1448871839217253E-2</c:v>
                  </c:pt>
                  <c:pt idx="1">
                    <c:v>6.2617466217274265E-2</c:v>
                  </c:pt>
                  <c:pt idx="2">
                    <c:v>9.9908341705378559E-2</c:v>
                  </c:pt>
                  <c:pt idx="3">
                    <c:v>2.7564164025685768E-2</c:v>
                  </c:pt>
                  <c:pt idx="4">
                    <c:v>8.6850832308989198E-2</c:v>
                  </c:pt>
                  <c:pt idx="5">
                    <c:v>4.3521015328705059E-2</c:v>
                  </c:pt>
                  <c:pt idx="6">
                    <c:v>4.1364356007880423E-2</c:v>
                  </c:pt>
                </c:numCache>
              </c:numRef>
            </c:plus>
            <c:minus>
              <c:numRef>
                <c:f>'TFRC-3'!$K$4:$K$10</c:f>
                <c:numCache>
                  <c:formatCode>General</c:formatCode>
                  <c:ptCount val="7"/>
                  <c:pt idx="0">
                    <c:v>6.1448871839217253E-2</c:v>
                  </c:pt>
                  <c:pt idx="1">
                    <c:v>6.2617466217274265E-2</c:v>
                  </c:pt>
                  <c:pt idx="2">
                    <c:v>9.9908341705378559E-2</c:v>
                  </c:pt>
                  <c:pt idx="3">
                    <c:v>2.7564164025685768E-2</c:v>
                  </c:pt>
                  <c:pt idx="4">
                    <c:v>8.6850832308989198E-2</c:v>
                  </c:pt>
                  <c:pt idx="5">
                    <c:v>4.3521015328705059E-2</c:v>
                  </c:pt>
                  <c:pt idx="6">
                    <c:v>4.136435600788042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TFRC-3'!$I$4:$I$10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'TFRC-3'!$J$4:$J$10</c:f>
              <c:numCache>
                <c:formatCode>General</c:formatCode>
                <c:ptCount val="7"/>
                <c:pt idx="0">
                  <c:v>0.99999999999999989</c:v>
                </c:pt>
                <c:pt idx="1">
                  <c:v>1.0550795787626199</c:v>
                </c:pt>
                <c:pt idx="2">
                  <c:v>0.99368898807065342</c:v>
                </c:pt>
                <c:pt idx="3">
                  <c:v>1.0495731533120767</c:v>
                </c:pt>
                <c:pt idx="4">
                  <c:v>0.85408122649812623</c:v>
                </c:pt>
                <c:pt idx="5">
                  <c:v>0.78883954501398745</c:v>
                </c:pt>
                <c:pt idx="6">
                  <c:v>0.7800623143075262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525-47F9-B3CB-81B09EF7DDC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09174136"/>
        <c:axId val="509172168"/>
      </c:barChart>
      <c:catAx>
        <c:axId val="50917413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09172168"/>
        <c:crosses val="autoZero"/>
        <c:auto val="1"/>
        <c:lblAlgn val="ctr"/>
        <c:lblOffset val="100"/>
        <c:noMultiLvlLbl val="0"/>
      </c:catAx>
      <c:valAx>
        <c:axId val="509172168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TFRC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09174136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YWHAZ-3'!$K$4:$K$10</c:f>
                <c:numCache>
                  <c:formatCode>General</c:formatCode>
                  <c:ptCount val="7"/>
                  <c:pt idx="0">
                    <c:v>4.3713721284808861E-2</c:v>
                  </c:pt>
                  <c:pt idx="1">
                    <c:v>5.6010895353707207E-2</c:v>
                  </c:pt>
                  <c:pt idx="2">
                    <c:v>3.904643958224379E-2</c:v>
                  </c:pt>
                  <c:pt idx="3">
                    <c:v>3.6938118960832468E-2</c:v>
                  </c:pt>
                  <c:pt idx="4">
                    <c:v>2.7029107844546561E-2</c:v>
                  </c:pt>
                  <c:pt idx="5">
                    <c:v>6.0217373514653031E-3</c:v>
                  </c:pt>
                  <c:pt idx="6">
                    <c:v>1.3242939453229257E-2</c:v>
                  </c:pt>
                </c:numCache>
              </c:numRef>
            </c:plus>
            <c:minus>
              <c:numRef>
                <c:f>'YWHAZ-3'!$K$4:$K$10</c:f>
                <c:numCache>
                  <c:formatCode>General</c:formatCode>
                  <c:ptCount val="7"/>
                  <c:pt idx="0">
                    <c:v>4.3713721284808861E-2</c:v>
                  </c:pt>
                  <c:pt idx="1">
                    <c:v>5.6010895353707207E-2</c:v>
                  </c:pt>
                  <c:pt idx="2">
                    <c:v>3.904643958224379E-2</c:v>
                  </c:pt>
                  <c:pt idx="3">
                    <c:v>3.6938118960832468E-2</c:v>
                  </c:pt>
                  <c:pt idx="4">
                    <c:v>2.7029107844546561E-2</c:v>
                  </c:pt>
                  <c:pt idx="5">
                    <c:v>6.0217373514653031E-3</c:v>
                  </c:pt>
                  <c:pt idx="6">
                    <c:v>1.324293945322925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YWHAZ-3'!$I$4:$I$10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'YWHAZ-3'!$J$4:$J$10</c:f>
              <c:numCache>
                <c:formatCode>General</c:formatCode>
                <c:ptCount val="7"/>
                <c:pt idx="0">
                  <c:v>1</c:v>
                </c:pt>
                <c:pt idx="1">
                  <c:v>0.9937904690530982</c:v>
                </c:pt>
                <c:pt idx="2">
                  <c:v>0.97149415434365982</c:v>
                </c:pt>
                <c:pt idx="3">
                  <c:v>1.0182093457047223</c:v>
                </c:pt>
                <c:pt idx="4">
                  <c:v>1.1303609705438722</c:v>
                </c:pt>
                <c:pt idx="5">
                  <c:v>1.2506670282816497</c:v>
                </c:pt>
                <c:pt idx="6">
                  <c:v>1.369460368842209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093-45E2-A56E-2A9E338EBCF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16153624"/>
        <c:axId val="516154936"/>
      </c:barChart>
      <c:catAx>
        <c:axId val="51615362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16154936"/>
        <c:crosses val="autoZero"/>
        <c:auto val="1"/>
        <c:lblAlgn val="ctr"/>
        <c:lblOffset val="100"/>
        <c:noMultiLvlLbl val="0"/>
      </c:catAx>
      <c:valAx>
        <c:axId val="516154936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YWHAZ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6.1663329696212098E-2"/>
              <c:y val="3.1585459496933165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16153624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RPLP0!$K$4:$K$10</c:f>
                <c:numCache>
                  <c:formatCode>General</c:formatCode>
                  <c:ptCount val="7"/>
                  <c:pt idx="0">
                    <c:v>0.1030200619106907</c:v>
                  </c:pt>
                  <c:pt idx="1">
                    <c:v>4.4948287058846806E-2</c:v>
                  </c:pt>
                  <c:pt idx="2">
                    <c:v>5.8208650237480279E-2</c:v>
                  </c:pt>
                  <c:pt idx="3">
                    <c:v>6.4345186136270285E-2</c:v>
                  </c:pt>
                  <c:pt idx="4">
                    <c:v>9.3107060526946353E-3</c:v>
                  </c:pt>
                  <c:pt idx="5">
                    <c:v>1.5928808656694764E-2</c:v>
                  </c:pt>
                  <c:pt idx="6">
                    <c:v>4.8761064435391278E-2</c:v>
                  </c:pt>
                </c:numCache>
              </c:numRef>
            </c:plus>
            <c:minus>
              <c:numRef>
                <c:f>RPLP0!$K$4:$K$10</c:f>
                <c:numCache>
                  <c:formatCode>General</c:formatCode>
                  <c:ptCount val="7"/>
                  <c:pt idx="0">
                    <c:v>0.1030200619106907</c:v>
                  </c:pt>
                  <c:pt idx="1">
                    <c:v>4.4948287058846806E-2</c:v>
                  </c:pt>
                  <c:pt idx="2">
                    <c:v>5.8208650237480279E-2</c:v>
                  </c:pt>
                  <c:pt idx="3">
                    <c:v>6.4345186136270285E-2</c:v>
                  </c:pt>
                  <c:pt idx="4">
                    <c:v>9.3107060526946353E-3</c:v>
                  </c:pt>
                  <c:pt idx="5">
                    <c:v>1.5928808656694764E-2</c:v>
                  </c:pt>
                  <c:pt idx="6">
                    <c:v>4.876106443539127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RPLP0!$I$4:$I$10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RPLP0!$J$4:$J$10</c:f>
              <c:numCache>
                <c:formatCode>General</c:formatCode>
                <c:ptCount val="7"/>
                <c:pt idx="0">
                  <c:v>1</c:v>
                </c:pt>
                <c:pt idx="1">
                  <c:v>1.144605493984804</c:v>
                </c:pt>
                <c:pt idx="2">
                  <c:v>1.077895750203876</c:v>
                </c:pt>
                <c:pt idx="3">
                  <c:v>1.0645617173559703</c:v>
                </c:pt>
                <c:pt idx="4">
                  <c:v>1.0293396350587429</c:v>
                </c:pt>
                <c:pt idx="5">
                  <c:v>1.0479872296195667</c:v>
                </c:pt>
                <c:pt idx="6">
                  <c:v>1.0578431647258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27D-4C6E-8D2A-B0ADEB6593D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7694824"/>
        <c:axId val="427699744"/>
      </c:barChart>
      <c:catAx>
        <c:axId val="42769482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27699744"/>
        <c:crosses val="autoZero"/>
        <c:auto val="1"/>
        <c:lblAlgn val="ctr"/>
        <c:lblOffset val="100"/>
        <c:noMultiLvlLbl val="0"/>
      </c:catAx>
      <c:valAx>
        <c:axId val="427699744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RPLP0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6.166330247814087E-2"/>
              <c:y val="6.317087971667612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27694824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PLP1-2'!$K$4:$K$10</c:f>
                <c:numCache>
                  <c:formatCode>General</c:formatCode>
                  <c:ptCount val="7"/>
                  <c:pt idx="0">
                    <c:v>3.8008761722983828E-2</c:v>
                  </c:pt>
                  <c:pt idx="1">
                    <c:v>7.5073352053373399E-2</c:v>
                  </c:pt>
                  <c:pt idx="2">
                    <c:v>3.0396141320639371E-2</c:v>
                  </c:pt>
                  <c:pt idx="3">
                    <c:v>0.11878311387565116</c:v>
                  </c:pt>
                  <c:pt idx="4">
                    <c:v>3.5096281642715992E-2</c:v>
                  </c:pt>
                  <c:pt idx="5">
                    <c:v>9.3062183202825034E-3</c:v>
                  </c:pt>
                  <c:pt idx="6">
                    <c:v>6.2557869617399647E-2</c:v>
                  </c:pt>
                </c:numCache>
              </c:numRef>
            </c:plus>
            <c:minus>
              <c:numRef>
                <c:f>'RPLP1-2'!$K$4:$K$10</c:f>
                <c:numCache>
                  <c:formatCode>General</c:formatCode>
                  <c:ptCount val="7"/>
                  <c:pt idx="0">
                    <c:v>3.8008761722983828E-2</c:v>
                  </c:pt>
                  <c:pt idx="1">
                    <c:v>7.5073352053373399E-2</c:v>
                  </c:pt>
                  <c:pt idx="2">
                    <c:v>3.0396141320639371E-2</c:v>
                  </c:pt>
                  <c:pt idx="3">
                    <c:v>0.11878311387565116</c:v>
                  </c:pt>
                  <c:pt idx="4">
                    <c:v>3.5096281642715992E-2</c:v>
                  </c:pt>
                  <c:pt idx="5">
                    <c:v>9.3062183202825034E-3</c:v>
                  </c:pt>
                  <c:pt idx="6">
                    <c:v>6.255786961739964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RPLP1-2'!$I$4:$I$10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'RPLP1-2'!$J$4:$J$10</c:f>
              <c:numCache>
                <c:formatCode>General</c:formatCode>
                <c:ptCount val="7"/>
                <c:pt idx="0">
                  <c:v>1</c:v>
                </c:pt>
                <c:pt idx="1">
                  <c:v>0.96598600488992759</c:v>
                </c:pt>
                <c:pt idx="2">
                  <c:v>1.009692270796019</c:v>
                </c:pt>
                <c:pt idx="3">
                  <c:v>1.0103222137668657</c:v>
                </c:pt>
                <c:pt idx="4">
                  <c:v>0.92437716529613556</c:v>
                </c:pt>
                <c:pt idx="5">
                  <c:v>0.9552923760473756</c:v>
                </c:pt>
                <c:pt idx="6">
                  <c:v>1.002283371375771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3E0-4D72-AD1B-F9B8673D35A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58558680"/>
        <c:axId val="558555728"/>
      </c:barChart>
      <c:catAx>
        <c:axId val="55855868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58555728"/>
        <c:crosses val="autoZero"/>
        <c:auto val="1"/>
        <c:lblAlgn val="ctr"/>
        <c:lblOffset val="100"/>
        <c:noMultiLvlLbl val="0"/>
      </c:catAx>
      <c:valAx>
        <c:axId val="558555728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RPLP1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6.1663329696212098E-2"/>
              <c:y val="5.5274519752091605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58558680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ACTB!$K$4:$K$10</c:f>
                <c:numCache>
                  <c:formatCode>General</c:formatCode>
                  <c:ptCount val="7"/>
                  <c:pt idx="0">
                    <c:v>7.6346175442437464E-2</c:v>
                  </c:pt>
                  <c:pt idx="1">
                    <c:v>2.6403834382055045E-2</c:v>
                  </c:pt>
                  <c:pt idx="2">
                    <c:v>4.5817365353140432E-2</c:v>
                  </c:pt>
                  <c:pt idx="3">
                    <c:v>1.9910815975227474E-2</c:v>
                  </c:pt>
                  <c:pt idx="4">
                    <c:v>5.727080559604162E-2</c:v>
                  </c:pt>
                  <c:pt idx="5">
                    <c:v>4.3274932976525057E-2</c:v>
                  </c:pt>
                  <c:pt idx="6">
                    <c:v>3.6695612607687209E-2</c:v>
                  </c:pt>
                </c:numCache>
              </c:numRef>
            </c:plus>
            <c:minus>
              <c:numRef>
                <c:f>ACTB!$K$4:$K$10</c:f>
                <c:numCache>
                  <c:formatCode>General</c:formatCode>
                  <c:ptCount val="7"/>
                  <c:pt idx="0">
                    <c:v>7.6346175442437464E-2</c:v>
                  </c:pt>
                  <c:pt idx="1">
                    <c:v>2.6403834382055045E-2</c:v>
                  </c:pt>
                  <c:pt idx="2">
                    <c:v>4.5817365353140432E-2</c:v>
                  </c:pt>
                  <c:pt idx="3">
                    <c:v>1.9910815975227474E-2</c:v>
                  </c:pt>
                  <c:pt idx="4">
                    <c:v>5.727080559604162E-2</c:v>
                  </c:pt>
                  <c:pt idx="5">
                    <c:v>4.3274932976525057E-2</c:v>
                  </c:pt>
                  <c:pt idx="6">
                    <c:v>3.6695612607687209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ACTB!$I$4:$I$10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ACTB!$J$4:$J$10</c:f>
              <c:numCache>
                <c:formatCode>General</c:formatCode>
                <c:ptCount val="7"/>
                <c:pt idx="0">
                  <c:v>1</c:v>
                </c:pt>
                <c:pt idx="1">
                  <c:v>0.99733058139809405</c:v>
                </c:pt>
                <c:pt idx="2">
                  <c:v>0.94935632301026252</c:v>
                </c:pt>
                <c:pt idx="3">
                  <c:v>0.83452388082513318</c:v>
                </c:pt>
                <c:pt idx="4">
                  <c:v>0.77932116997839129</c:v>
                </c:pt>
                <c:pt idx="5">
                  <c:v>0.87081885812912307</c:v>
                </c:pt>
                <c:pt idx="6">
                  <c:v>0.8214824912055290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CD0-4318-82BE-28B6B66586B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80369776"/>
        <c:axId val="580371088"/>
      </c:barChart>
      <c:catAx>
        <c:axId val="58036977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80371088"/>
        <c:crosses val="autoZero"/>
        <c:auto val="1"/>
        <c:lblAlgn val="ctr"/>
        <c:lblOffset val="100"/>
        <c:noMultiLvlLbl val="0"/>
      </c:catAx>
      <c:valAx>
        <c:axId val="580371088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ACTB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6.1663329696212098E-2"/>
              <c:y val="7.1067239681260636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80369776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RPLP2!$K$4:$K$10</c:f>
                <c:numCache>
                  <c:formatCode>General</c:formatCode>
                  <c:ptCount val="7"/>
                  <c:pt idx="0">
                    <c:v>6.5759537241144181E-2</c:v>
                  </c:pt>
                  <c:pt idx="1">
                    <c:v>4.5894877715309992E-2</c:v>
                  </c:pt>
                  <c:pt idx="2">
                    <c:v>6.2517182612328762E-2</c:v>
                  </c:pt>
                  <c:pt idx="3">
                    <c:v>4.4068411192052508E-2</c:v>
                  </c:pt>
                  <c:pt idx="4">
                    <c:v>4.5476548167331252E-2</c:v>
                  </c:pt>
                  <c:pt idx="5">
                    <c:v>3.7116149548687895E-2</c:v>
                  </c:pt>
                  <c:pt idx="6">
                    <c:v>3.960109705448274E-2</c:v>
                  </c:pt>
                </c:numCache>
              </c:numRef>
            </c:plus>
            <c:minus>
              <c:numRef>
                <c:f>RPLP2!$K$4:$K$10</c:f>
                <c:numCache>
                  <c:formatCode>General</c:formatCode>
                  <c:ptCount val="7"/>
                  <c:pt idx="0">
                    <c:v>6.5759537241144181E-2</c:v>
                  </c:pt>
                  <c:pt idx="1">
                    <c:v>4.5894877715309992E-2</c:v>
                  </c:pt>
                  <c:pt idx="2">
                    <c:v>6.2517182612328762E-2</c:v>
                  </c:pt>
                  <c:pt idx="3">
                    <c:v>4.4068411192052508E-2</c:v>
                  </c:pt>
                  <c:pt idx="4">
                    <c:v>4.5476548167331252E-2</c:v>
                  </c:pt>
                  <c:pt idx="5">
                    <c:v>3.7116149548687895E-2</c:v>
                  </c:pt>
                  <c:pt idx="6">
                    <c:v>3.960109705448274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RPLP2!$I$4:$I$10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RPLP2!$J$4:$J$10</c:f>
              <c:numCache>
                <c:formatCode>General</c:formatCode>
                <c:ptCount val="7"/>
                <c:pt idx="0">
                  <c:v>1</c:v>
                </c:pt>
                <c:pt idx="1">
                  <c:v>0.97107102129987266</c:v>
                </c:pt>
                <c:pt idx="2">
                  <c:v>0.98859871879190619</c:v>
                </c:pt>
                <c:pt idx="3">
                  <c:v>0.94468353666324967</c:v>
                </c:pt>
                <c:pt idx="4">
                  <c:v>0.89385942989932587</c:v>
                </c:pt>
                <c:pt idx="5">
                  <c:v>0.90224250645369064</c:v>
                </c:pt>
                <c:pt idx="6">
                  <c:v>0.956589396730436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F9C-42FE-B10A-D95F439D0BE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80362560"/>
        <c:axId val="580362888"/>
      </c:barChart>
      <c:catAx>
        <c:axId val="58036256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80362888"/>
        <c:crosses val="autoZero"/>
        <c:auto val="1"/>
        <c:lblAlgn val="ctr"/>
        <c:lblOffset val="100"/>
        <c:noMultiLvlLbl val="0"/>
      </c:catAx>
      <c:valAx>
        <c:axId val="580362888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RPLP2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6.1663329696212098E-2"/>
              <c:y val="5.5274554119633036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80362560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HPRT1!$W$4:$W$10</c:f>
                <c:numCache>
                  <c:formatCode>General</c:formatCode>
                  <c:ptCount val="7"/>
                  <c:pt idx="0">
                    <c:v>6.4593769431233919E-2</c:v>
                  </c:pt>
                  <c:pt idx="1">
                    <c:v>4.9157796267990078E-2</c:v>
                  </c:pt>
                  <c:pt idx="2">
                    <c:v>4.10282033832279E-2</c:v>
                  </c:pt>
                  <c:pt idx="3">
                    <c:v>2.734179425015924E-2</c:v>
                  </c:pt>
                  <c:pt idx="4">
                    <c:v>9.1044521688977559E-3</c:v>
                  </c:pt>
                  <c:pt idx="5">
                    <c:v>3.272867994013668E-2</c:v>
                  </c:pt>
                  <c:pt idx="6">
                    <c:v>2.4980853149879235E-2</c:v>
                  </c:pt>
                </c:numCache>
              </c:numRef>
            </c:plus>
            <c:minus>
              <c:numRef>
                <c:f>HPRT1!$W$4:$W$10</c:f>
                <c:numCache>
                  <c:formatCode>General</c:formatCode>
                  <c:ptCount val="7"/>
                  <c:pt idx="0">
                    <c:v>6.4593769431233919E-2</c:v>
                  </c:pt>
                  <c:pt idx="1">
                    <c:v>4.9157796267990078E-2</c:v>
                  </c:pt>
                  <c:pt idx="2">
                    <c:v>4.10282033832279E-2</c:v>
                  </c:pt>
                  <c:pt idx="3">
                    <c:v>2.734179425015924E-2</c:v>
                  </c:pt>
                  <c:pt idx="4">
                    <c:v>9.1044521688977559E-3</c:v>
                  </c:pt>
                  <c:pt idx="5">
                    <c:v>3.272867994013668E-2</c:v>
                  </c:pt>
                  <c:pt idx="6">
                    <c:v>2.4980853149879235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HPRT1!$U$4:$U$10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HPRT1!$V$4:$V$10</c:f>
              <c:numCache>
                <c:formatCode>General</c:formatCode>
                <c:ptCount val="7"/>
                <c:pt idx="0">
                  <c:v>1</c:v>
                </c:pt>
                <c:pt idx="1">
                  <c:v>0.99700499193253622</c:v>
                </c:pt>
                <c:pt idx="2">
                  <c:v>0.93871153594593049</c:v>
                </c:pt>
                <c:pt idx="3">
                  <c:v>0.78251714630549207</c:v>
                </c:pt>
                <c:pt idx="4">
                  <c:v>0.60847636786198855</c:v>
                </c:pt>
                <c:pt idx="5">
                  <c:v>0.59569953190535518</c:v>
                </c:pt>
                <c:pt idx="6">
                  <c:v>0.603676880405655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C75-4937-8F7F-47BD8A21E66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81055872"/>
        <c:axId val="581057184"/>
      </c:barChart>
      <c:catAx>
        <c:axId val="58105587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81057184"/>
        <c:crosses val="autoZero"/>
        <c:auto val="1"/>
        <c:lblAlgn val="ctr"/>
        <c:lblOffset val="100"/>
        <c:noMultiLvlLbl val="0"/>
      </c:catAx>
      <c:valAx>
        <c:axId val="581057184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HPRT1</a:t>
                </a:r>
                <a:r>
                  <a:rPr lang="en-US" altLang="ja-JP" dirty="0">
                    <a:solidFill>
                      <a:schemeClr val="tx1"/>
                    </a:solidFill>
                  </a:rPr>
                  <a:t> mRNA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6.166330247814087E-2"/>
              <c:y val="4.7378189245399743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81055872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B2M-3'!$K$4:$K$10</c:f>
                <c:numCache>
                  <c:formatCode>General</c:formatCode>
                  <c:ptCount val="7"/>
                  <c:pt idx="0">
                    <c:v>4.40511351823549E-2</c:v>
                  </c:pt>
                  <c:pt idx="1">
                    <c:v>4.2177928341119034E-3</c:v>
                  </c:pt>
                  <c:pt idx="2">
                    <c:v>6.4636021360498494E-2</c:v>
                  </c:pt>
                  <c:pt idx="3">
                    <c:v>6.0289624239015259E-2</c:v>
                  </c:pt>
                  <c:pt idx="4">
                    <c:v>1.1837136621432476E-2</c:v>
                  </c:pt>
                  <c:pt idx="5">
                    <c:v>1.888549959734254E-2</c:v>
                  </c:pt>
                  <c:pt idx="6">
                    <c:v>2.4020924131146568E-3</c:v>
                  </c:pt>
                </c:numCache>
              </c:numRef>
            </c:plus>
            <c:minus>
              <c:numRef>
                <c:f>'B2M-3'!$K$4:$K$10</c:f>
                <c:numCache>
                  <c:formatCode>General</c:formatCode>
                  <c:ptCount val="7"/>
                  <c:pt idx="0">
                    <c:v>4.40511351823549E-2</c:v>
                  </c:pt>
                  <c:pt idx="1">
                    <c:v>4.2177928341119034E-3</c:v>
                  </c:pt>
                  <c:pt idx="2">
                    <c:v>6.4636021360498494E-2</c:v>
                  </c:pt>
                  <c:pt idx="3">
                    <c:v>6.0289624239015259E-2</c:v>
                  </c:pt>
                  <c:pt idx="4">
                    <c:v>1.1837136621432476E-2</c:v>
                  </c:pt>
                  <c:pt idx="5">
                    <c:v>1.888549959734254E-2</c:v>
                  </c:pt>
                  <c:pt idx="6">
                    <c:v>2.4020924131146568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B2M-3'!$I$4:$I$10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'B2M-3'!$J$4:$J$10</c:f>
              <c:numCache>
                <c:formatCode>General</c:formatCode>
                <c:ptCount val="7"/>
                <c:pt idx="0">
                  <c:v>1</c:v>
                </c:pt>
                <c:pt idx="1">
                  <c:v>0.98370750925651762</c:v>
                </c:pt>
                <c:pt idx="2">
                  <c:v>0.97662585512497557</c:v>
                </c:pt>
                <c:pt idx="3">
                  <c:v>0.94555398435562399</c:v>
                </c:pt>
                <c:pt idx="4">
                  <c:v>0.93281897434704864</c:v>
                </c:pt>
                <c:pt idx="5">
                  <c:v>0.95832909996442106</c:v>
                </c:pt>
                <c:pt idx="6">
                  <c:v>1.007447330154648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B75-42BF-AC4C-09223A90BA8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11176144"/>
        <c:axId val="511172536"/>
      </c:barChart>
      <c:catAx>
        <c:axId val="51117614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11172536"/>
        <c:crosses val="autoZero"/>
        <c:auto val="1"/>
        <c:lblAlgn val="ctr"/>
        <c:lblOffset val="100"/>
        <c:noMultiLvlLbl val="0"/>
      </c:catAx>
      <c:valAx>
        <c:axId val="511172536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B2M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11176144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RPLP0!$K$4:$K$10</c:f>
                <c:numCache>
                  <c:formatCode>General</c:formatCode>
                  <c:ptCount val="7"/>
                  <c:pt idx="0">
                    <c:v>7.6542378937835415E-2</c:v>
                  </c:pt>
                  <c:pt idx="1">
                    <c:v>3.4263711301837821E-2</c:v>
                  </c:pt>
                  <c:pt idx="2">
                    <c:v>4.6401527282331621E-2</c:v>
                  </c:pt>
                  <c:pt idx="3">
                    <c:v>6.5056704815123309E-2</c:v>
                  </c:pt>
                  <c:pt idx="4">
                    <c:v>7.9102807403220551E-2</c:v>
                  </c:pt>
                  <c:pt idx="5">
                    <c:v>7.1219094443114722E-2</c:v>
                  </c:pt>
                  <c:pt idx="6">
                    <c:v>4.2676766271513934E-2</c:v>
                  </c:pt>
                </c:numCache>
              </c:numRef>
            </c:plus>
            <c:minus>
              <c:numRef>
                <c:f>RPLP0!$K$4:$K$10</c:f>
                <c:numCache>
                  <c:formatCode>General</c:formatCode>
                  <c:ptCount val="7"/>
                  <c:pt idx="0">
                    <c:v>7.6542378937835415E-2</c:v>
                  </c:pt>
                  <c:pt idx="1">
                    <c:v>3.4263711301837821E-2</c:v>
                  </c:pt>
                  <c:pt idx="2">
                    <c:v>4.6401527282331621E-2</c:v>
                  </c:pt>
                  <c:pt idx="3">
                    <c:v>6.5056704815123309E-2</c:v>
                  </c:pt>
                  <c:pt idx="4">
                    <c:v>7.9102807403220551E-2</c:v>
                  </c:pt>
                  <c:pt idx="5">
                    <c:v>7.1219094443114722E-2</c:v>
                  </c:pt>
                  <c:pt idx="6">
                    <c:v>4.2676766271513934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RPLP0!$I$4:$I$10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RPLP0!$J$4:$J$10</c:f>
              <c:numCache>
                <c:formatCode>General</c:formatCode>
                <c:ptCount val="7"/>
                <c:pt idx="0">
                  <c:v>1</c:v>
                </c:pt>
                <c:pt idx="1">
                  <c:v>1.1380712191868978</c:v>
                </c:pt>
                <c:pt idx="2">
                  <c:v>1.1039718404659515</c:v>
                </c:pt>
                <c:pt idx="3">
                  <c:v>1.0721540560483831</c:v>
                </c:pt>
                <c:pt idx="4">
                  <c:v>1.1011739742102558</c:v>
                </c:pt>
                <c:pt idx="5">
                  <c:v>1.0650559493393887</c:v>
                </c:pt>
                <c:pt idx="6">
                  <c:v>1.106955224453327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538-4971-9364-D3FBDA7DF30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29453552"/>
        <c:axId val="629454208"/>
      </c:barChart>
      <c:catAx>
        <c:axId val="62945355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29454208"/>
        <c:crosses val="autoZero"/>
        <c:auto val="1"/>
        <c:lblAlgn val="ctr"/>
        <c:lblOffset val="100"/>
        <c:noMultiLvlLbl val="0"/>
      </c:catAx>
      <c:valAx>
        <c:axId val="629454208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RPLP0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6.166330247814087E-2"/>
              <c:y val="5.5274554119633036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29453552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4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PRS18-5'!$K$4:$K$10</c:f>
                <c:numCache>
                  <c:formatCode>General</c:formatCode>
                  <c:ptCount val="7"/>
                  <c:pt idx="0">
                    <c:v>1.8546079736554831E-2</c:v>
                  </c:pt>
                  <c:pt idx="1">
                    <c:v>3.9374347275583942E-2</c:v>
                  </c:pt>
                  <c:pt idx="2">
                    <c:v>5.6665457059164349E-2</c:v>
                  </c:pt>
                  <c:pt idx="3">
                    <c:v>4.2981034501344245E-2</c:v>
                  </c:pt>
                  <c:pt idx="4">
                    <c:v>3.7991009081711595E-2</c:v>
                  </c:pt>
                  <c:pt idx="5">
                    <c:v>4.3769892782784349E-2</c:v>
                  </c:pt>
                  <c:pt idx="6">
                    <c:v>2.8740822704420219E-2</c:v>
                  </c:pt>
                </c:numCache>
              </c:numRef>
            </c:plus>
            <c:minus>
              <c:numRef>
                <c:f>'PRS18-5'!$K$4:$K$10</c:f>
                <c:numCache>
                  <c:formatCode>General</c:formatCode>
                  <c:ptCount val="7"/>
                  <c:pt idx="0">
                    <c:v>1.8546079736554831E-2</c:v>
                  </c:pt>
                  <c:pt idx="1">
                    <c:v>3.9374347275583942E-2</c:v>
                  </c:pt>
                  <c:pt idx="2">
                    <c:v>5.6665457059164349E-2</c:v>
                  </c:pt>
                  <c:pt idx="3">
                    <c:v>4.2981034501344245E-2</c:v>
                  </c:pt>
                  <c:pt idx="4">
                    <c:v>3.7991009081711595E-2</c:v>
                  </c:pt>
                  <c:pt idx="5">
                    <c:v>4.3769892782784349E-2</c:v>
                  </c:pt>
                  <c:pt idx="6">
                    <c:v>2.8740822704420219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PRS18-5'!$I$4:$I$10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'PRS18-5'!$J$4:$J$10</c:f>
              <c:numCache>
                <c:formatCode>General</c:formatCode>
                <c:ptCount val="7"/>
                <c:pt idx="0">
                  <c:v>1</c:v>
                </c:pt>
                <c:pt idx="1">
                  <c:v>0.99020582765993537</c:v>
                </c:pt>
                <c:pt idx="2">
                  <c:v>0.95493422519846105</c:v>
                </c:pt>
                <c:pt idx="3">
                  <c:v>0.93236137934441754</c:v>
                </c:pt>
                <c:pt idx="4">
                  <c:v>0.92039208731615096</c:v>
                </c:pt>
                <c:pt idx="5">
                  <c:v>0.91594978936726001</c:v>
                </c:pt>
                <c:pt idx="6">
                  <c:v>0.9283664147596019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B69-46A4-92F9-139099B2183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17282096"/>
        <c:axId val="617277832"/>
      </c:barChart>
      <c:catAx>
        <c:axId val="61728209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17277832"/>
        <c:crosses val="autoZero"/>
        <c:auto val="1"/>
        <c:lblAlgn val="ctr"/>
        <c:lblOffset val="100"/>
        <c:noMultiLvlLbl val="0"/>
      </c:catAx>
      <c:valAx>
        <c:axId val="617277832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RPS18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6.1663329696212098E-2"/>
              <c:y val="6.3170918993866329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17282096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4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TBP!$K$4:$K$10</c:f>
                <c:numCache>
                  <c:formatCode>General</c:formatCode>
                  <c:ptCount val="7"/>
                  <c:pt idx="0">
                    <c:v>1.219736654594452E-2</c:v>
                  </c:pt>
                  <c:pt idx="1">
                    <c:v>6.12800461237165E-2</c:v>
                  </c:pt>
                  <c:pt idx="2">
                    <c:v>3.5624660063214221E-2</c:v>
                  </c:pt>
                  <c:pt idx="3">
                    <c:v>8.3283791882442625E-3</c:v>
                  </c:pt>
                  <c:pt idx="4">
                    <c:v>7.1635228913419127E-2</c:v>
                  </c:pt>
                  <c:pt idx="5">
                    <c:v>1.9632540596539121E-2</c:v>
                  </c:pt>
                  <c:pt idx="6">
                    <c:v>5.8818324421797977E-2</c:v>
                  </c:pt>
                </c:numCache>
              </c:numRef>
            </c:plus>
            <c:minus>
              <c:numRef>
                <c:f>TBP!$K$4:$K$10</c:f>
                <c:numCache>
                  <c:formatCode>General</c:formatCode>
                  <c:ptCount val="7"/>
                  <c:pt idx="0">
                    <c:v>1.219736654594452E-2</c:v>
                  </c:pt>
                  <c:pt idx="1">
                    <c:v>6.12800461237165E-2</c:v>
                  </c:pt>
                  <c:pt idx="2">
                    <c:v>3.5624660063214221E-2</c:v>
                  </c:pt>
                  <c:pt idx="3">
                    <c:v>8.3283791882442625E-3</c:v>
                  </c:pt>
                  <c:pt idx="4">
                    <c:v>7.1635228913419127E-2</c:v>
                  </c:pt>
                  <c:pt idx="5">
                    <c:v>1.9632540596539121E-2</c:v>
                  </c:pt>
                  <c:pt idx="6">
                    <c:v>5.881832442179797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TBP!$I$4:$I$10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TBP!$J$4:$J$10</c:f>
              <c:numCache>
                <c:formatCode>General</c:formatCode>
                <c:ptCount val="7"/>
                <c:pt idx="0">
                  <c:v>1</c:v>
                </c:pt>
                <c:pt idx="1">
                  <c:v>1.0407187113585805</c:v>
                </c:pt>
                <c:pt idx="2">
                  <c:v>0.92264776589359787</c:v>
                </c:pt>
                <c:pt idx="3">
                  <c:v>0.91325879717077274</c:v>
                </c:pt>
                <c:pt idx="4">
                  <c:v>0.7992017301314549</c:v>
                </c:pt>
                <c:pt idx="5">
                  <c:v>0.85096911647786921</c:v>
                </c:pt>
                <c:pt idx="6">
                  <c:v>0.8958461349156365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8C7-44C4-88B1-1DD31FF9481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27692328"/>
        <c:axId val="527697576"/>
      </c:barChart>
      <c:catAx>
        <c:axId val="52769232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27697576"/>
        <c:crosses val="autoZero"/>
        <c:auto val="1"/>
        <c:lblAlgn val="ctr"/>
        <c:lblOffset val="100"/>
        <c:noMultiLvlLbl val="0"/>
      </c:catAx>
      <c:valAx>
        <c:axId val="527697576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TBP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27692328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4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PGK1'!$K$4:$K$10</c:f>
                <c:numCache>
                  <c:formatCode>General</c:formatCode>
                  <c:ptCount val="7"/>
                  <c:pt idx="0">
                    <c:v>4.9646477216986215E-2</c:v>
                  </c:pt>
                  <c:pt idx="1">
                    <c:v>6.1206932553508127E-2</c:v>
                  </c:pt>
                  <c:pt idx="2">
                    <c:v>4.2186607061157455E-2</c:v>
                  </c:pt>
                  <c:pt idx="3">
                    <c:v>3.263629505632322E-2</c:v>
                  </c:pt>
                  <c:pt idx="4">
                    <c:v>4.461617086997928E-2</c:v>
                  </c:pt>
                  <c:pt idx="5">
                    <c:v>4.2420922436929777E-2</c:v>
                  </c:pt>
                  <c:pt idx="6">
                    <c:v>3.4651907296137145E-2</c:v>
                  </c:pt>
                </c:numCache>
              </c:numRef>
            </c:plus>
            <c:minus>
              <c:numRef>
                <c:f>'PGK1'!$K$4:$K$10</c:f>
                <c:numCache>
                  <c:formatCode>General</c:formatCode>
                  <c:ptCount val="7"/>
                  <c:pt idx="0">
                    <c:v>4.9646477216986215E-2</c:v>
                  </c:pt>
                  <c:pt idx="1">
                    <c:v>6.1206932553508127E-2</c:v>
                  </c:pt>
                  <c:pt idx="2">
                    <c:v>4.2186607061157455E-2</c:v>
                  </c:pt>
                  <c:pt idx="3">
                    <c:v>3.263629505632322E-2</c:v>
                  </c:pt>
                  <c:pt idx="4">
                    <c:v>4.461617086997928E-2</c:v>
                  </c:pt>
                  <c:pt idx="5">
                    <c:v>4.2420922436929777E-2</c:v>
                  </c:pt>
                  <c:pt idx="6">
                    <c:v>3.4651907296137145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PGK1'!$I$4:$I$10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'PGK1'!$J$4:$J$10</c:f>
              <c:numCache>
                <c:formatCode>General</c:formatCode>
                <c:ptCount val="7"/>
                <c:pt idx="0">
                  <c:v>1</c:v>
                </c:pt>
                <c:pt idx="1">
                  <c:v>1.05060636990374</c:v>
                </c:pt>
                <c:pt idx="2">
                  <c:v>1.1029774527211733</c:v>
                </c:pt>
                <c:pt idx="3">
                  <c:v>1.2279029816410596</c:v>
                </c:pt>
                <c:pt idx="4">
                  <c:v>1.1936510417056627</c:v>
                </c:pt>
                <c:pt idx="5">
                  <c:v>1.0687594773591496</c:v>
                </c:pt>
                <c:pt idx="6">
                  <c:v>0.981772376897702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46E-4E3C-A96F-A537E00B76A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27735624"/>
        <c:axId val="527736280"/>
      </c:barChart>
      <c:catAx>
        <c:axId val="52773562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27736280"/>
        <c:crosses val="autoZero"/>
        <c:auto val="1"/>
        <c:lblAlgn val="ctr"/>
        <c:lblOffset val="100"/>
        <c:noMultiLvlLbl val="0"/>
      </c:catAx>
      <c:valAx>
        <c:axId val="527736280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PGK1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27735624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4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PPIA-4'!$K$4:$K$10</c:f>
                <c:numCache>
                  <c:formatCode>General</c:formatCode>
                  <c:ptCount val="7"/>
                  <c:pt idx="0">
                    <c:v>2.0125587648796815E-2</c:v>
                  </c:pt>
                  <c:pt idx="1">
                    <c:v>1.0788179304349683E-2</c:v>
                  </c:pt>
                  <c:pt idx="2">
                    <c:v>3.8116263066364529E-2</c:v>
                  </c:pt>
                  <c:pt idx="3">
                    <c:v>1.4649323965508207E-2</c:v>
                  </c:pt>
                  <c:pt idx="4">
                    <c:v>1.3439089149423638E-2</c:v>
                  </c:pt>
                  <c:pt idx="5">
                    <c:v>2.1257760374067861E-2</c:v>
                  </c:pt>
                  <c:pt idx="6">
                    <c:v>2.0678107181877316E-2</c:v>
                  </c:pt>
                </c:numCache>
              </c:numRef>
            </c:plus>
            <c:minus>
              <c:numRef>
                <c:f>'PPIA-4'!$K$4:$K$10</c:f>
                <c:numCache>
                  <c:formatCode>General</c:formatCode>
                  <c:ptCount val="7"/>
                  <c:pt idx="0">
                    <c:v>2.0125587648796815E-2</c:v>
                  </c:pt>
                  <c:pt idx="1">
                    <c:v>1.0788179304349683E-2</c:v>
                  </c:pt>
                  <c:pt idx="2">
                    <c:v>3.8116263066364529E-2</c:v>
                  </c:pt>
                  <c:pt idx="3">
                    <c:v>1.4649323965508207E-2</c:v>
                  </c:pt>
                  <c:pt idx="4">
                    <c:v>1.3439089149423638E-2</c:v>
                  </c:pt>
                  <c:pt idx="5">
                    <c:v>2.1257760374067861E-2</c:v>
                  </c:pt>
                  <c:pt idx="6">
                    <c:v>2.067810718187731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PPIA-4'!$I$4:$I$10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'PPIA-4'!$J$4:$J$10</c:f>
              <c:numCache>
                <c:formatCode>General</c:formatCode>
                <c:ptCount val="7"/>
                <c:pt idx="0">
                  <c:v>1.0000000000000002</c:v>
                </c:pt>
                <c:pt idx="1">
                  <c:v>0.9906871072625355</c:v>
                </c:pt>
                <c:pt idx="2">
                  <c:v>1.027553336292869</c:v>
                </c:pt>
                <c:pt idx="3">
                  <c:v>0.97181614937470862</c:v>
                </c:pt>
                <c:pt idx="4">
                  <c:v>0.96565799656758633</c:v>
                </c:pt>
                <c:pt idx="5">
                  <c:v>0.98496827721941738</c:v>
                </c:pt>
                <c:pt idx="6">
                  <c:v>0.994426827892466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F3B-43E8-A177-8F1D18C843E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17271928"/>
        <c:axId val="617275208"/>
      </c:barChart>
      <c:catAx>
        <c:axId val="61727192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17275208"/>
        <c:crosses val="autoZero"/>
        <c:auto val="1"/>
        <c:lblAlgn val="ctr"/>
        <c:lblOffset val="100"/>
        <c:noMultiLvlLbl val="0"/>
      </c:catAx>
      <c:valAx>
        <c:axId val="617275208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PPIA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17271928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4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GAPDH-2'!$K$4:$K$10</c:f>
                <c:numCache>
                  <c:formatCode>General</c:formatCode>
                  <c:ptCount val="7"/>
                  <c:pt idx="0">
                    <c:v>5.144486473712525E-2</c:v>
                  </c:pt>
                  <c:pt idx="1">
                    <c:v>1.1809062808117853E-2</c:v>
                  </c:pt>
                  <c:pt idx="2">
                    <c:v>3.6328073233850768E-2</c:v>
                  </c:pt>
                  <c:pt idx="3">
                    <c:v>3.5631393219147385E-2</c:v>
                  </c:pt>
                  <c:pt idx="4">
                    <c:v>4.45185235387709E-2</c:v>
                  </c:pt>
                  <c:pt idx="5">
                    <c:v>1.9560270559781691E-2</c:v>
                  </c:pt>
                  <c:pt idx="6">
                    <c:v>6.8090118291752377E-2</c:v>
                  </c:pt>
                </c:numCache>
              </c:numRef>
            </c:plus>
            <c:minus>
              <c:numRef>
                <c:f>'GAPDH-2'!$K$4:$K$10</c:f>
                <c:numCache>
                  <c:formatCode>General</c:formatCode>
                  <c:ptCount val="7"/>
                  <c:pt idx="0">
                    <c:v>5.144486473712525E-2</c:v>
                  </c:pt>
                  <c:pt idx="1">
                    <c:v>1.1809062808117853E-2</c:v>
                  </c:pt>
                  <c:pt idx="2">
                    <c:v>3.6328073233850768E-2</c:v>
                  </c:pt>
                  <c:pt idx="3">
                    <c:v>3.5631393219147385E-2</c:v>
                  </c:pt>
                  <c:pt idx="4">
                    <c:v>4.45185235387709E-2</c:v>
                  </c:pt>
                  <c:pt idx="5">
                    <c:v>1.9560270559781691E-2</c:v>
                  </c:pt>
                  <c:pt idx="6">
                    <c:v>6.809011829175237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GAPDH-2'!$I$4:$I$10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'GAPDH-2'!$J$4:$J$10</c:f>
              <c:numCache>
                <c:formatCode>General</c:formatCode>
                <c:ptCount val="7"/>
                <c:pt idx="0">
                  <c:v>1</c:v>
                </c:pt>
                <c:pt idx="1">
                  <c:v>0.99748320746740937</c:v>
                </c:pt>
                <c:pt idx="2">
                  <c:v>1.0636036114217491</c:v>
                </c:pt>
                <c:pt idx="3">
                  <c:v>1.0071202179002448</c:v>
                </c:pt>
                <c:pt idx="4">
                  <c:v>0.93704452083838741</c:v>
                </c:pt>
                <c:pt idx="5">
                  <c:v>0.90307485620253736</c:v>
                </c:pt>
                <c:pt idx="6">
                  <c:v>0.916803051550132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C30-4857-8FFE-A714A3B73E5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03344632"/>
        <c:axId val="503342008"/>
      </c:barChart>
      <c:catAx>
        <c:axId val="50334463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03342008"/>
        <c:crosses val="autoZero"/>
        <c:auto val="1"/>
        <c:lblAlgn val="ctr"/>
        <c:lblOffset val="100"/>
        <c:noMultiLvlLbl val="0"/>
      </c:catAx>
      <c:valAx>
        <c:axId val="503342008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GAPDH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6.166330247814087E-2"/>
              <c:y val="2.4317576054655187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03344632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4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GUSB-3'!$K$4:$K$10</c:f>
                <c:numCache>
                  <c:formatCode>General</c:formatCode>
                  <c:ptCount val="7"/>
                  <c:pt idx="0">
                    <c:v>5.9374958327340896E-2</c:v>
                  </c:pt>
                  <c:pt idx="1">
                    <c:v>3.846151122216545E-2</c:v>
                  </c:pt>
                  <c:pt idx="2">
                    <c:v>9.8528122389533637E-2</c:v>
                  </c:pt>
                  <c:pt idx="3">
                    <c:v>3.8966018857480259E-2</c:v>
                  </c:pt>
                  <c:pt idx="4">
                    <c:v>4.1631124585157248E-2</c:v>
                  </c:pt>
                  <c:pt idx="5">
                    <c:v>5.7036638168813984E-2</c:v>
                  </c:pt>
                  <c:pt idx="6">
                    <c:v>7.1827078989995435E-2</c:v>
                  </c:pt>
                </c:numCache>
              </c:numRef>
            </c:plus>
            <c:minus>
              <c:numRef>
                <c:f>'GUSB-3'!$K$4:$K$10</c:f>
                <c:numCache>
                  <c:formatCode>General</c:formatCode>
                  <c:ptCount val="7"/>
                  <c:pt idx="0">
                    <c:v>5.9374958327340896E-2</c:v>
                  </c:pt>
                  <c:pt idx="1">
                    <c:v>3.846151122216545E-2</c:v>
                  </c:pt>
                  <c:pt idx="2">
                    <c:v>9.8528122389533637E-2</c:v>
                  </c:pt>
                  <c:pt idx="3">
                    <c:v>3.8966018857480259E-2</c:v>
                  </c:pt>
                  <c:pt idx="4">
                    <c:v>4.1631124585157248E-2</c:v>
                  </c:pt>
                  <c:pt idx="5">
                    <c:v>5.7036638168813984E-2</c:v>
                  </c:pt>
                  <c:pt idx="6">
                    <c:v>7.1827078989995435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GUSB-3'!$I$4:$I$10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'GUSB-3'!$J$4:$J$10</c:f>
              <c:numCache>
                <c:formatCode>General</c:formatCode>
                <c:ptCount val="7"/>
                <c:pt idx="0">
                  <c:v>1</c:v>
                </c:pt>
                <c:pt idx="1">
                  <c:v>1.1005790633659138</c:v>
                </c:pt>
                <c:pt idx="2">
                  <c:v>1.0375863465047279</c:v>
                </c:pt>
                <c:pt idx="3">
                  <c:v>0.98995845606752697</c:v>
                </c:pt>
                <c:pt idx="4">
                  <c:v>0.91374911307130058</c:v>
                </c:pt>
                <c:pt idx="5">
                  <c:v>0.9456605969787879</c:v>
                </c:pt>
                <c:pt idx="6">
                  <c:v>0.971177871992469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48A-4583-BC02-72B8A02D0A9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16465912"/>
        <c:axId val="516462632"/>
      </c:barChart>
      <c:catAx>
        <c:axId val="51646591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16462632"/>
        <c:crosses val="autoZero"/>
        <c:auto val="1"/>
        <c:lblAlgn val="ctr"/>
        <c:lblOffset val="100"/>
        <c:noMultiLvlLbl val="0"/>
      </c:catAx>
      <c:valAx>
        <c:axId val="516462632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GUSB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6.166330247814087E-2"/>
              <c:y val="4.8635152109310374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16465912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4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ATP5F1!$K$28:$K$34</c:f>
                <c:numCache>
                  <c:formatCode>General</c:formatCode>
                  <c:ptCount val="7"/>
                  <c:pt idx="0">
                    <c:v>0.10613393229299717</c:v>
                  </c:pt>
                  <c:pt idx="1">
                    <c:v>0.11184316132553404</c:v>
                  </c:pt>
                  <c:pt idx="2">
                    <c:v>4.5810794723912765E-2</c:v>
                  </c:pt>
                  <c:pt idx="3">
                    <c:v>5.2800367980897697E-2</c:v>
                  </c:pt>
                  <c:pt idx="4">
                    <c:v>6.8339662590097147E-2</c:v>
                  </c:pt>
                  <c:pt idx="5">
                    <c:v>3.6518575823593927E-2</c:v>
                  </c:pt>
                  <c:pt idx="6">
                    <c:v>2.7604546983164672E-2</c:v>
                  </c:pt>
                </c:numCache>
              </c:numRef>
            </c:plus>
            <c:minus>
              <c:numRef>
                <c:f>ATP5F1!$K$28:$K$34</c:f>
                <c:numCache>
                  <c:formatCode>General</c:formatCode>
                  <c:ptCount val="7"/>
                  <c:pt idx="0">
                    <c:v>0.10613393229299717</c:v>
                  </c:pt>
                  <c:pt idx="1">
                    <c:v>0.11184316132553404</c:v>
                  </c:pt>
                  <c:pt idx="2">
                    <c:v>4.5810794723912765E-2</c:v>
                  </c:pt>
                  <c:pt idx="3">
                    <c:v>5.2800367980897697E-2</c:v>
                  </c:pt>
                  <c:pt idx="4">
                    <c:v>6.8339662590097147E-2</c:v>
                  </c:pt>
                  <c:pt idx="5">
                    <c:v>3.6518575823593927E-2</c:v>
                  </c:pt>
                  <c:pt idx="6">
                    <c:v>2.760454698316467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ATP5F1!$I$28:$I$34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ATP5F1!$J$28:$J$34</c:f>
              <c:numCache>
                <c:formatCode>General</c:formatCode>
                <c:ptCount val="7"/>
                <c:pt idx="0">
                  <c:v>1</c:v>
                </c:pt>
                <c:pt idx="1">
                  <c:v>0.90233290421441481</c:v>
                </c:pt>
                <c:pt idx="2">
                  <c:v>1.2326169391357482</c:v>
                </c:pt>
                <c:pt idx="3">
                  <c:v>1.1383205462813162</c:v>
                </c:pt>
                <c:pt idx="4">
                  <c:v>1.133704577495638</c:v>
                </c:pt>
                <c:pt idx="5">
                  <c:v>1.1152092387769941</c:v>
                </c:pt>
                <c:pt idx="6">
                  <c:v>1.06784180147493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E19-4434-8819-2A6828557DE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17157848"/>
        <c:axId val="517158176"/>
      </c:barChart>
      <c:catAx>
        <c:axId val="51715784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dirty="0">
                    <a:solidFill>
                      <a:schemeClr val="tx1"/>
                    </a:solidFill>
                  </a:rPr>
                  <a:t>Atorvastatin (µM)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17158176"/>
        <c:crosses val="autoZero"/>
        <c:auto val="1"/>
        <c:lblAlgn val="ctr"/>
        <c:lblOffset val="100"/>
        <c:noMultiLvlLbl val="0"/>
      </c:catAx>
      <c:valAx>
        <c:axId val="517158176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ATP5F1</a:t>
                </a:r>
                <a:r>
                  <a:rPr lang="en-US" altLang="ja-JP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6.1663329696212098E-2"/>
              <c:y val="2.3689094622699872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17157848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4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TFRC-3'!$K$28:$K$34</c:f>
                <c:numCache>
                  <c:formatCode>General</c:formatCode>
                  <c:ptCount val="7"/>
                  <c:pt idx="0">
                    <c:v>0.10071156131149503</c:v>
                  </c:pt>
                  <c:pt idx="1">
                    <c:v>1.4521607762423984E-2</c:v>
                  </c:pt>
                  <c:pt idx="2">
                    <c:v>6.9450439016811485E-2</c:v>
                  </c:pt>
                  <c:pt idx="3">
                    <c:v>1.4714032055377664E-2</c:v>
                  </c:pt>
                  <c:pt idx="4">
                    <c:v>2.5855852462915933E-2</c:v>
                  </c:pt>
                  <c:pt idx="5">
                    <c:v>4.7779860028253782E-2</c:v>
                  </c:pt>
                  <c:pt idx="6">
                    <c:v>2.0408137005352218E-2</c:v>
                  </c:pt>
                </c:numCache>
              </c:numRef>
            </c:plus>
            <c:minus>
              <c:numRef>
                <c:f>'TFRC-3'!$K$28:$K$34</c:f>
                <c:numCache>
                  <c:formatCode>General</c:formatCode>
                  <c:ptCount val="7"/>
                  <c:pt idx="0">
                    <c:v>0.10071156131149503</c:v>
                  </c:pt>
                  <c:pt idx="1">
                    <c:v>1.4521607762423984E-2</c:v>
                  </c:pt>
                  <c:pt idx="2">
                    <c:v>6.9450439016811485E-2</c:v>
                  </c:pt>
                  <c:pt idx="3">
                    <c:v>1.4714032055377664E-2</c:v>
                  </c:pt>
                  <c:pt idx="4">
                    <c:v>2.5855852462915933E-2</c:v>
                  </c:pt>
                  <c:pt idx="5">
                    <c:v>4.7779860028253782E-2</c:v>
                  </c:pt>
                  <c:pt idx="6">
                    <c:v>2.040813700535221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TFRC-3'!$I$28:$I$34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'TFRC-3'!$J$28:$J$34</c:f>
              <c:numCache>
                <c:formatCode>General</c:formatCode>
                <c:ptCount val="7"/>
                <c:pt idx="0">
                  <c:v>1</c:v>
                </c:pt>
                <c:pt idx="1">
                  <c:v>0.98270949008804864</c:v>
                </c:pt>
                <c:pt idx="2">
                  <c:v>1.0189318218021377</c:v>
                </c:pt>
                <c:pt idx="3">
                  <c:v>1.0363468403451213</c:v>
                </c:pt>
                <c:pt idx="4">
                  <c:v>0.96030436147592579</c:v>
                </c:pt>
                <c:pt idx="5">
                  <c:v>1.1034732671845968</c:v>
                </c:pt>
                <c:pt idx="6">
                  <c:v>1.119238397771196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BB9-4B66-8C02-3DFA716EDE2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09174136"/>
        <c:axId val="509172168"/>
      </c:barChart>
      <c:catAx>
        <c:axId val="50917413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09172168"/>
        <c:crosses val="autoZero"/>
        <c:auto val="1"/>
        <c:lblAlgn val="ctr"/>
        <c:lblOffset val="100"/>
        <c:noMultiLvlLbl val="0"/>
      </c:catAx>
      <c:valAx>
        <c:axId val="509172168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TFRC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09174136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4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YWHAZ-3'!$K$28:$K$34</c:f>
                <c:numCache>
                  <c:formatCode>General</c:formatCode>
                  <c:ptCount val="7"/>
                  <c:pt idx="0">
                    <c:v>1.7752825413445045E-2</c:v>
                  </c:pt>
                  <c:pt idx="1">
                    <c:v>4.1535627281654632E-3</c:v>
                  </c:pt>
                  <c:pt idx="2">
                    <c:v>1.8866816610064518E-2</c:v>
                  </c:pt>
                  <c:pt idx="3">
                    <c:v>5.8710043611380699E-2</c:v>
                  </c:pt>
                  <c:pt idx="4">
                    <c:v>3.1598076403740342E-2</c:v>
                  </c:pt>
                  <c:pt idx="5">
                    <c:v>1.4630561260584275E-2</c:v>
                  </c:pt>
                  <c:pt idx="6">
                    <c:v>3.4831340672255982E-2</c:v>
                  </c:pt>
                </c:numCache>
              </c:numRef>
            </c:plus>
            <c:minus>
              <c:numRef>
                <c:f>'YWHAZ-3'!$K$28:$K$34</c:f>
                <c:numCache>
                  <c:formatCode>General</c:formatCode>
                  <c:ptCount val="7"/>
                  <c:pt idx="0">
                    <c:v>1.7752825413445045E-2</c:v>
                  </c:pt>
                  <c:pt idx="1">
                    <c:v>4.1535627281654632E-3</c:v>
                  </c:pt>
                  <c:pt idx="2">
                    <c:v>1.8866816610064518E-2</c:v>
                  </c:pt>
                  <c:pt idx="3">
                    <c:v>5.8710043611380699E-2</c:v>
                  </c:pt>
                  <c:pt idx="4">
                    <c:v>3.1598076403740342E-2</c:v>
                  </c:pt>
                  <c:pt idx="5">
                    <c:v>1.4630561260584275E-2</c:v>
                  </c:pt>
                  <c:pt idx="6">
                    <c:v>3.483134067225598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YWHAZ-3'!$I$28:$I$34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'YWHAZ-3'!$J$28:$J$34</c:f>
              <c:numCache>
                <c:formatCode>General</c:formatCode>
                <c:ptCount val="7"/>
                <c:pt idx="0">
                  <c:v>1</c:v>
                </c:pt>
                <c:pt idx="1">
                  <c:v>0.89793254934552502</c:v>
                </c:pt>
                <c:pt idx="2">
                  <c:v>0.9970720276918511</c:v>
                </c:pt>
                <c:pt idx="3">
                  <c:v>0.99429802945212098</c:v>
                </c:pt>
                <c:pt idx="4">
                  <c:v>0.96317506472933623</c:v>
                </c:pt>
                <c:pt idx="5">
                  <c:v>0.94349492215936148</c:v>
                </c:pt>
                <c:pt idx="6">
                  <c:v>1.045263268211544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6AE-4BD5-99F9-D7523660A89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16153624"/>
        <c:axId val="516154936"/>
      </c:barChart>
      <c:catAx>
        <c:axId val="51615362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16154936"/>
        <c:crosses val="autoZero"/>
        <c:auto val="1"/>
        <c:lblAlgn val="ctr"/>
        <c:lblOffset val="100"/>
        <c:noMultiLvlLbl val="0"/>
      </c:catAx>
      <c:valAx>
        <c:axId val="516154936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YWHAZ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6.1663329696212098E-2"/>
              <c:y val="1.5792729748466582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16153624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4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RPLP0!$K$28:$K$34</c:f>
                <c:numCache>
                  <c:formatCode>General</c:formatCode>
                  <c:ptCount val="7"/>
                  <c:pt idx="0">
                    <c:v>6.6379442662817964E-2</c:v>
                  </c:pt>
                  <c:pt idx="1">
                    <c:v>9.3419402925819323E-2</c:v>
                  </c:pt>
                  <c:pt idx="2">
                    <c:v>7.1070944096406519E-2</c:v>
                  </c:pt>
                  <c:pt idx="3">
                    <c:v>2.3349822341242579E-2</c:v>
                  </c:pt>
                  <c:pt idx="4">
                    <c:v>1.3389216818818297E-2</c:v>
                  </c:pt>
                  <c:pt idx="5">
                    <c:v>5.4242542952531281E-2</c:v>
                  </c:pt>
                  <c:pt idx="6">
                    <c:v>6.6927475641079523E-2</c:v>
                  </c:pt>
                </c:numCache>
              </c:numRef>
            </c:plus>
            <c:minus>
              <c:numRef>
                <c:f>RPLP0!$K$28:$K$34</c:f>
                <c:numCache>
                  <c:formatCode>General</c:formatCode>
                  <c:ptCount val="7"/>
                  <c:pt idx="0">
                    <c:v>6.6379442662817964E-2</c:v>
                  </c:pt>
                  <c:pt idx="1">
                    <c:v>9.3419402925819323E-2</c:v>
                  </c:pt>
                  <c:pt idx="2">
                    <c:v>7.1070944096406519E-2</c:v>
                  </c:pt>
                  <c:pt idx="3">
                    <c:v>2.3349822341242579E-2</c:v>
                  </c:pt>
                  <c:pt idx="4">
                    <c:v>1.3389216818818297E-2</c:v>
                  </c:pt>
                  <c:pt idx="5">
                    <c:v>5.4242542952531281E-2</c:v>
                  </c:pt>
                  <c:pt idx="6">
                    <c:v>6.692747564107952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RPLP0!$I$28:$I$34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RPLP0!$J$28:$J$34</c:f>
              <c:numCache>
                <c:formatCode>General</c:formatCode>
                <c:ptCount val="7"/>
                <c:pt idx="0">
                  <c:v>1</c:v>
                </c:pt>
                <c:pt idx="1">
                  <c:v>1.0081879454522824</c:v>
                </c:pt>
                <c:pt idx="2">
                  <c:v>1.0009969436995443</c:v>
                </c:pt>
                <c:pt idx="3">
                  <c:v>1.0006574201708396</c:v>
                </c:pt>
                <c:pt idx="4">
                  <c:v>1.0288382448622742</c:v>
                </c:pt>
                <c:pt idx="5">
                  <c:v>0.99635732586460068</c:v>
                </c:pt>
                <c:pt idx="6">
                  <c:v>0.952441268053144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31E-4388-94CA-A3D83FEE02D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7697120"/>
        <c:axId val="459931752"/>
      </c:barChart>
      <c:catAx>
        <c:axId val="42769712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59931752"/>
        <c:crosses val="autoZero"/>
        <c:auto val="1"/>
        <c:lblAlgn val="ctr"/>
        <c:lblOffset val="100"/>
        <c:noMultiLvlLbl val="0"/>
      </c:catAx>
      <c:valAx>
        <c:axId val="459931752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RPLP0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6.1663329696212098E-2"/>
              <c:y val="6.3170918993866329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27697120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RPLP1!$K$4:$K$10</c:f>
                <c:numCache>
                  <c:formatCode>General</c:formatCode>
                  <c:ptCount val="7"/>
                  <c:pt idx="0">
                    <c:v>3.6416800024915791E-2</c:v>
                  </c:pt>
                  <c:pt idx="1">
                    <c:v>8.6970835611238514E-2</c:v>
                  </c:pt>
                  <c:pt idx="2">
                    <c:v>7.6502274413392704E-2</c:v>
                  </c:pt>
                  <c:pt idx="3">
                    <c:v>7.6018194650450524E-2</c:v>
                  </c:pt>
                  <c:pt idx="4">
                    <c:v>3.6344548858874476E-2</c:v>
                  </c:pt>
                  <c:pt idx="5">
                    <c:v>3.8603101171299357E-2</c:v>
                  </c:pt>
                  <c:pt idx="6">
                    <c:v>7.9707184876159395E-2</c:v>
                  </c:pt>
                </c:numCache>
              </c:numRef>
            </c:plus>
            <c:minus>
              <c:numRef>
                <c:f>RPLP1!$K$4:$K$10</c:f>
                <c:numCache>
                  <c:formatCode>General</c:formatCode>
                  <c:ptCount val="7"/>
                  <c:pt idx="0">
                    <c:v>3.6416800024915791E-2</c:v>
                  </c:pt>
                  <c:pt idx="1">
                    <c:v>8.6970835611238514E-2</c:v>
                  </c:pt>
                  <c:pt idx="2">
                    <c:v>7.6502274413392704E-2</c:v>
                  </c:pt>
                  <c:pt idx="3">
                    <c:v>7.6018194650450524E-2</c:v>
                  </c:pt>
                  <c:pt idx="4">
                    <c:v>3.6344548858874476E-2</c:v>
                  </c:pt>
                  <c:pt idx="5">
                    <c:v>3.8603101171299357E-2</c:v>
                  </c:pt>
                  <c:pt idx="6">
                    <c:v>7.9707184876159395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RPLP1!$I$4:$I$10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RPLP1!$J$4:$J$10</c:f>
              <c:numCache>
                <c:formatCode>General</c:formatCode>
                <c:ptCount val="7"/>
                <c:pt idx="0">
                  <c:v>1</c:v>
                </c:pt>
                <c:pt idx="1">
                  <c:v>1.0103952524160142</c:v>
                </c:pt>
                <c:pt idx="2">
                  <c:v>0.98645046489830757</c:v>
                </c:pt>
                <c:pt idx="3">
                  <c:v>1.0561076935794225</c:v>
                </c:pt>
                <c:pt idx="4">
                  <c:v>1.0165405065688464</c:v>
                </c:pt>
                <c:pt idx="5">
                  <c:v>1.1061489694327111</c:v>
                </c:pt>
                <c:pt idx="6">
                  <c:v>1.073748386143838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9B5-4876-923F-5B2BEE9FBF6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16535272"/>
        <c:axId val="616534288"/>
      </c:barChart>
      <c:catAx>
        <c:axId val="61653527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16534288"/>
        <c:crosses val="autoZero"/>
        <c:auto val="1"/>
        <c:lblAlgn val="ctr"/>
        <c:lblOffset val="100"/>
        <c:noMultiLvlLbl val="0"/>
      </c:catAx>
      <c:valAx>
        <c:axId val="616534288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RPLP1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6.166330247814087E-2"/>
              <c:y val="3.1585459496933165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16535272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5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PLP1-2'!$K$28:$K$34</c:f>
                <c:numCache>
                  <c:formatCode>General</c:formatCode>
                  <c:ptCount val="7"/>
                  <c:pt idx="0">
                    <c:v>3.4731240615928576E-2</c:v>
                  </c:pt>
                  <c:pt idx="1">
                    <c:v>9.4512625615410739E-2</c:v>
                  </c:pt>
                  <c:pt idx="2">
                    <c:v>3.8928636031135763E-2</c:v>
                  </c:pt>
                  <c:pt idx="3">
                    <c:v>4.6334394333510165E-2</c:v>
                  </c:pt>
                  <c:pt idx="4">
                    <c:v>6.4157797013285013E-3</c:v>
                  </c:pt>
                  <c:pt idx="5">
                    <c:v>1.8080021648527182E-2</c:v>
                  </c:pt>
                  <c:pt idx="6">
                    <c:v>8.0099113583298576E-2</c:v>
                  </c:pt>
                </c:numCache>
              </c:numRef>
            </c:plus>
            <c:minus>
              <c:numRef>
                <c:f>'RPLP1-2'!$K$28:$K$34</c:f>
                <c:numCache>
                  <c:formatCode>General</c:formatCode>
                  <c:ptCount val="7"/>
                  <c:pt idx="0">
                    <c:v>3.4731240615928576E-2</c:v>
                  </c:pt>
                  <c:pt idx="1">
                    <c:v>9.4512625615410739E-2</c:v>
                  </c:pt>
                  <c:pt idx="2">
                    <c:v>3.8928636031135763E-2</c:v>
                  </c:pt>
                  <c:pt idx="3">
                    <c:v>4.6334394333510165E-2</c:v>
                  </c:pt>
                  <c:pt idx="4">
                    <c:v>6.4157797013285013E-3</c:v>
                  </c:pt>
                  <c:pt idx="5">
                    <c:v>1.8080021648527182E-2</c:v>
                  </c:pt>
                  <c:pt idx="6">
                    <c:v>8.009911358329857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RPLP1-2'!$I$28:$I$34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'RPLP1-2'!$J$28:$J$34</c:f>
              <c:numCache>
                <c:formatCode>General</c:formatCode>
                <c:ptCount val="7"/>
                <c:pt idx="0">
                  <c:v>1</c:v>
                </c:pt>
                <c:pt idx="1">
                  <c:v>0.9726030817997916</c:v>
                </c:pt>
                <c:pt idx="2">
                  <c:v>1.0073844214775114</c:v>
                </c:pt>
                <c:pt idx="3">
                  <c:v>0.95412747423144584</c:v>
                </c:pt>
                <c:pt idx="4">
                  <c:v>0.98568462513677202</c:v>
                </c:pt>
                <c:pt idx="5">
                  <c:v>0.9433358834785549</c:v>
                </c:pt>
                <c:pt idx="6">
                  <c:v>0.9691397498884484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5DF-417C-A00E-5F44598A84A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59896800"/>
        <c:axId val="559894832"/>
      </c:barChart>
      <c:catAx>
        <c:axId val="55989680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59894832"/>
        <c:crosses val="autoZero"/>
        <c:auto val="1"/>
        <c:lblAlgn val="ctr"/>
        <c:lblOffset val="100"/>
        <c:noMultiLvlLbl val="0"/>
      </c:catAx>
      <c:valAx>
        <c:axId val="559894832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RPLP1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6.166330247814087E-2"/>
              <c:y val="6.317087971667612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59896800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5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ACTB-3'!$K$28:$K$34</c:f>
                <c:numCache>
                  <c:formatCode>General</c:formatCode>
                  <c:ptCount val="7"/>
                  <c:pt idx="0">
                    <c:v>1.1584339633204304E-2</c:v>
                  </c:pt>
                  <c:pt idx="1">
                    <c:v>2.8986909893521352E-2</c:v>
                  </c:pt>
                  <c:pt idx="2">
                    <c:v>6.0528240723124113E-3</c:v>
                  </c:pt>
                  <c:pt idx="3">
                    <c:v>4.318716364114028E-2</c:v>
                  </c:pt>
                  <c:pt idx="4">
                    <c:v>9.9285553031763681E-3</c:v>
                  </c:pt>
                  <c:pt idx="5">
                    <c:v>3.1465311799516935E-2</c:v>
                  </c:pt>
                  <c:pt idx="6">
                    <c:v>8.2779665752192921E-2</c:v>
                  </c:pt>
                </c:numCache>
              </c:numRef>
            </c:plus>
            <c:minus>
              <c:numRef>
                <c:f>'ACTB-3'!$K$28:$K$34</c:f>
                <c:numCache>
                  <c:formatCode>General</c:formatCode>
                  <c:ptCount val="7"/>
                  <c:pt idx="0">
                    <c:v>1.1584339633204304E-2</c:v>
                  </c:pt>
                  <c:pt idx="1">
                    <c:v>2.8986909893521352E-2</c:v>
                  </c:pt>
                  <c:pt idx="2">
                    <c:v>6.0528240723124113E-3</c:v>
                  </c:pt>
                  <c:pt idx="3">
                    <c:v>4.318716364114028E-2</c:v>
                  </c:pt>
                  <c:pt idx="4">
                    <c:v>9.9285553031763681E-3</c:v>
                  </c:pt>
                  <c:pt idx="5">
                    <c:v>3.1465311799516935E-2</c:v>
                  </c:pt>
                  <c:pt idx="6">
                    <c:v>8.277966575219292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ACTB-3'!$I$28:$I$34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'ACTB-3'!$J$28:$J$34</c:f>
              <c:numCache>
                <c:formatCode>General</c:formatCode>
                <c:ptCount val="7"/>
                <c:pt idx="0">
                  <c:v>1</c:v>
                </c:pt>
                <c:pt idx="1">
                  <c:v>0.95317749558644704</c:v>
                </c:pt>
                <c:pt idx="2">
                  <c:v>1.0148814055749402</c:v>
                </c:pt>
                <c:pt idx="3">
                  <c:v>1.0067850828633762</c:v>
                </c:pt>
                <c:pt idx="4">
                  <c:v>1.0017919057007674</c:v>
                </c:pt>
                <c:pt idx="5">
                  <c:v>0.98543510236177123</c:v>
                </c:pt>
                <c:pt idx="6">
                  <c:v>0.926361868439302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75D-4BCE-B618-4D73C146817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36798592"/>
        <c:axId val="636793016"/>
      </c:barChart>
      <c:catAx>
        <c:axId val="63679859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36793016"/>
        <c:crosses val="autoZero"/>
        <c:auto val="1"/>
        <c:lblAlgn val="ctr"/>
        <c:lblOffset val="100"/>
        <c:noMultiLvlLbl val="0"/>
      </c:catAx>
      <c:valAx>
        <c:axId val="636793016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ACTB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36798592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5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RPLP2!$K$28:$K$34</c:f>
                <c:numCache>
                  <c:formatCode>General</c:formatCode>
                  <c:ptCount val="7"/>
                  <c:pt idx="0">
                    <c:v>5.2507380558244249E-2</c:v>
                  </c:pt>
                  <c:pt idx="1">
                    <c:v>2.8836611424783151E-2</c:v>
                  </c:pt>
                  <c:pt idx="2">
                    <c:v>5.6594864958712097E-2</c:v>
                  </c:pt>
                  <c:pt idx="3">
                    <c:v>3.2359284585143061E-2</c:v>
                  </c:pt>
                  <c:pt idx="4">
                    <c:v>2.5873330800511952E-2</c:v>
                  </c:pt>
                  <c:pt idx="5">
                    <c:v>4.6865600859083362E-3</c:v>
                  </c:pt>
                  <c:pt idx="6">
                    <c:v>3.8245987537824509E-2</c:v>
                  </c:pt>
                </c:numCache>
              </c:numRef>
            </c:plus>
            <c:minus>
              <c:numRef>
                <c:f>RPLP2!$K$28:$K$34</c:f>
                <c:numCache>
                  <c:formatCode>General</c:formatCode>
                  <c:ptCount val="7"/>
                  <c:pt idx="0">
                    <c:v>5.2507380558244249E-2</c:v>
                  </c:pt>
                  <c:pt idx="1">
                    <c:v>2.8836611424783151E-2</c:v>
                  </c:pt>
                  <c:pt idx="2">
                    <c:v>5.6594864958712097E-2</c:v>
                  </c:pt>
                  <c:pt idx="3">
                    <c:v>3.2359284585143061E-2</c:v>
                  </c:pt>
                  <c:pt idx="4">
                    <c:v>2.5873330800511952E-2</c:v>
                  </c:pt>
                  <c:pt idx="5">
                    <c:v>4.6865600859083362E-3</c:v>
                  </c:pt>
                  <c:pt idx="6">
                    <c:v>3.8245987537824509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RPLP2!$I$28:$I$34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RPLP2!$J$28:$J$34</c:f>
              <c:numCache>
                <c:formatCode>General</c:formatCode>
                <c:ptCount val="7"/>
                <c:pt idx="0">
                  <c:v>1</c:v>
                </c:pt>
                <c:pt idx="1">
                  <c:v>0.9893714481146364</c:v>
                </c:pt>
                <c:pt idx="2">
                  <c:v>0.98724876224665792</c:v>
                </c:pt>
                <c:pt idx="3">
                  <c:v>0.98443954367667619</c:v>
                </c:pt>
                <c:pt idx="4">
                  <c:v>1.0018259959282805</c:v>
                </c:pt>
                <c:pt idx="5">
                  <c:v>0.953073969847959</c:v>
                </c:pt>
                <c:pt idx="6">
                  <c:v>0.989442611521636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A75-4861-861E-1C8DB7A62BD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81057840"/>
        <c:axId val="581058824"/>
      </c:barChart>
      <c:catAx>
        <c:axId val="58105784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81058824"/>
        <c:crosses val="autoZero"/>
        <c:auto val="1"/>
        <c:lblAlgn val="ctr"/>
        <c:lblOffset val="100"/>
        <c:noMultiLvlLbl val="0"/>
      </c:catAx>
      <c:valAx>
        <c:axId val="581058824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RPLP2</a:t>
                </a:r>
                <a:r>
                  <a:rPr lang="en-US" altLang="ja-JP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6.1663329696212098E-2"/>
              <c:y val="6.3170918993866329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81057840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5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HPRT1!$W$28:$W$34</c:f>
                <c:numCache>
                  <c:formatCode>General</c:formatCode>
                  <c:ptCount val="7"/>
                  <c:pt idx="0">
                    <c:v>2.4310761599077226E-2</c:v>
                  </c:pt>
                  <c:pt idx="1">
                    <c:v>7.7864833721349461E-2</c:v>
                  </c:pt>
                  <c:pt idx="2">
                    <c:v>4.5692617514983463E-2</c:v>
                  </c:pt>
                  <c:pt idx="3">
                    <c:v>2.0061824953655764E-2</c:v>
                  </c:pt>
                  <c:pt idx="4">
                    <c:v>3.7400830895004386E-2</c:v>
                  </c:pt>
                  <c:pt idx="5">
                    <c:v>5.6981342373460385E-2</c:v>
                  </c:pt>
                  <c:pt idx="6">
                    <c:v>5.6206476235316931E-2</c:v>
                  </c:pt>
                </c:numCache>
              </c:numRef>
            </c:plus>
            <c:minus>
              <c:numRef>
                <c:f>HPRT1!$W$28:$W$34</c:f>
                <c:numCache>
                  <c:formatCode>General</c:formatCode>
                  <c:ptCount val="7"/>
                  <c:pt idx="0">
                    <c:v>2.4310761599077226E-2</c:v>
                  </c:pt>
                  <c:pt idx="1">
                    <c:v>7.7864833721349461E-2</c:v>
                  </c:pt>
                  <c:pt idx="2">
                    <c:v>4.5692617514983463E-2</c:v>
                  </c:pt>
                  <c:pt idx="3">
                    <c:v>2.0061824953655764E-2</c:v>
                  </c:pt>
                  <c:pt idx="4">
                    <c:v>3.7400830895004386E-2</c:v>
                  </c:pt>
                  <c:pt idx="5">
                    <c:v>5.6981342373460385E-2</c:v>
                  </c:pt>
                  <c:pt idx="6">
                    <c:v>5.620647623531693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HPRT1!$U$28:$U$34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HPRT1!$V$28:$V$34</c:f>
              <c:numCache>
                <c:formatCode>General</c:formatCode>
                <c:ptCount val="7"/>
                <c:pt idx="0">
                  <c:v>1</c:v>
                </c:pt>
                <c:pt idx="1">
                  <c:v>1.0216869571491747</c:v>
                </c:pt>
                <c:pt idx="2">
                  <c:v>1.0409519351557002</c:v>
                </c:pt>
                <c:pt idx="3">
                  <c:v>0.9850512134419932</c:v>
                </c:pt>
                <c:pt idx="4">
                  <c:v>0.96907435891674698</c:v>
                </c:pt>
                <c:pt idx="5">
                  <c:v>0.99547287192695089</c:v>
                </c:pt>
                <c:pt idx="6">
                  <c:v>0.9561797236744394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46B-41B7-B872-BC8E5C0CB5C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12167232"/>
        <c:axId val="512170512"/>
      </c:barChart>
      <c:catAx>
        <c:axId val="51216723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12170512"/>
        <c:crosses val="autoZero"/>
        <c:auto val="1"/>
        <c:lblAlgn val="ctr"/>
        <c:lblOffset val="100"/>
        <c:noMultiLvlLbl val="0"/>
      </c:catAx>
      <c:valAx>
        <c:axId val="512170512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HPRT1</a:t>
                </a:r>
                <a:r>
                  <a:rPr lang="en-US" altLang="ja-JP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6.166330247814087E-2"/>
              <c:y val="6.3170918993866329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12167232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5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B2M-3'!$K$28:$K$34</c:f>
                <c:numCache>
                  <c:formatCode>General</c:formatCode>
                  <c:ptCount val="7"/>
                  <c:pt idx="0">
                    <c:v>5.7612696380866961E-2</c:v>
                  </c:pt>
                  <c:pt idx="1">
                    <c:v>2.6088772941631599E-2</c:v>
                  </c:pt>
                  <c:pt idx="2">
                    <c:v>5.182034915280586E-2</c:v>
                  </c:pt>
                  <c:pt idx="3">
                    <c:v>3.6771011604029222E-2</c:v>
                  </c:pt>
                  <c:pt idx="4">
                    <c:v>9.8110433136526662E-2</c:v>
                  </c:pt>
                  <c:pt idx="5">
                    <c:v>3.9377887809096686E-2</c:v>
                  </c:pt>
                  <c:pt idx="6">
                    <c:v>2.9272807903872853E-2</c:v>
                  </c:pt>
                </c:numCache>
              </c:numRef>
            </c:plus>
            <c:minus>
              <c:numRef>
                <c:f>'B2M-3'!$K$28:$K$34</c:f>
                <c:numCache>
                  <c:formatCode>General</c:formatCode>
                  <c:ptCount val="7"/>
                  <c:pt idx="0">
                    <c:v>5.7612696380866961E-2</c:v>
                  </c:pt>
                  <c:pt idx="1">
                    <c:v>2.6088772941631599E-2</c:v>
                  </c:pt>
                  <c:pt idx="2">
                    <c:v>5.182034915280586E-2</c:v>
                  </c:pt>
                  <c:pt idx="3">
                    <c:v>3.6771011604029222E-2</c:v>
                  </c:pt>
                  <c:pt idx="4">
                    <c:v>9.8110433136526662E-2</c:v>
                  </c:pt>
                  <c:pt idx="5">
                    <c:v>3.9377887809096686E-2</c:v>
                  </c:pt>
                  <c:pt idx="6">
                    <c:v>2.927280790387285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B2M-3'!$I$28:$I$34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'B2M-3'!$J$28:$J$34</c:f>
              <c:numCache>
                <c:formatCode>General</c:formatCode>
                <c:ptCount val="7"/>
                <c:pt idx="0">
                  <c:v>1</c:v>
                </c:pt>
                <c:pt idx="1">
                  <c:v>0.98949879501146132</c:v>
                </c:pt>
                <c:pt idx="2">
                  <c:v>1.0073718553243005</c:v>
                </c:pt>
                <c:pt idx="3">
                  <c:v>0.9834514389112422</c:v>
                </c:pt>
                <c:pt idx="4">
                  <c:v>0.93816092901131254</c:v>
                </c:pt>
                <c:pt idx="5">
                  <c:v>0.91635740759310613</c:v>
                </c:pt>
                <c:pt idx="6">
                  <c:v>0.9448421734611088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322-4D7B-AB95-97BFAC32DBA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11176144"/>
        <c:axId val="511172536"/>
      </c:barChart>
      <c:catAx>
        <c:axId val="51117614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11172536"/>
        <c:crosses val="autoZero"/>
        <c:auto val="1"/>
        <c:lblAlgn val="ctr"/>
        <c:lblOffset val="100"/>
        <c:noMultiLvlLbl val="0"/>
      </c:catAx>
      <c:valAx>
        <c:axId val="511172536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B2M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11176144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5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PRS18-5'!$K$28:$K$34</c:f>
                <c:numCache>
                  <c:formatCode>General</c:formatCode>
                  <c:ptCount val="7"/>
                  <c:pt idx="0">
                    <c:v>7.1377309992853119E-2</c:v>
                  </c:pt>
                  <c:pt idx="1">
                    <c:v>6.5830695011271104E-2</c:v>
                  </c:pt>
                  <c:pt idx="2">
                    <c:v>7.6623162184399948E-2</c:v>
                  </c:pt>
                  <c:pt idx="3">
                    <c:v>3.2505052314759635E-2</c:v>
                  </c:pt>
                  <c:pt idx="4">
                    <c:v>3.5389251301917008E-3</c:v>
                  </c:pt>
                  <c:pt idx="5">
                    <c:v>1.8183203372127522E-2</c:v>
                  </c:pt>
                  <c:pt idx="6">
                    <c:v>5.5242932424297918E-2</c:v>
                  </c:pt>
                </c:numCache>
              </c:numRef>
            </c:plus>
            <c:minus>
              <c:numRef>
                <c:f>'PRS18-5'!$K$28:$K$34</c:f>
                <c:numCache>
                  <c:formatCode>General</c:formatCode>
                  <c:ptCount val="7"/>
                  <c:pt idx="0">
                    <c:v>7.1377309992853119E-2</c:v>
                  </c:pt>
                  <c:pt idx="1">
                    <c:v>6.5830695011271104E-2</c:v>
                  </c:pt>
                  <c:pt idx="2">
                    <c:v>7.6623162184399948E-2</c:v>
                  </c:pt>
                  <c:pt idx="3">
                    <c:v>3.2505052314759635E-2</c:v>
                  </c:pt>
                  <c:pt idx="4">
                    <c:v>3.5389251301917008E-3</c:v>
                  </c:pt>
                  <c:pt idx="5">
                    <c:v>1.8183203372127522E-2</c:v>
                  </c:pt>
                  <c:pt idx="6">
                    <c:v>5.524293242429791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PRS18-5'!$I$28:$I$34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'PRS18-5'!$J$28:$J$34</c:f>
              <c:numCache>
                <c:formatCode>General</c:formatCode>
                <c:ptCount val="7"/>
                <c:pt idx="0">
                  <c:v>1</c:v>
                </c:pt>
                <c:pt idx="1">
                  <c:v>0.86724870484847927</c:v>
                </c:pt>
                <c:pt idx="2">
                  <c:v>0.8566276972923651</c:v>
                </c:pt>
                <c:pt idx="3">
                  <c:v>0.87725331543487506</c:v>
                </c:pt>
                <c:pt idx="4">
                  <c:v>0.86777763795973151</c:v>
                </c:pt>
                <c:pt idx="5">
                  <c:v>0.84279570208853938</c:v>
                </c:pt>
                <c:pt idx="6">
                  <c:v>0.7953813615009308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044-4D97-AB70-45C87D8EA1C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17282096"/>
        <c:axId val="617277832"/>
      </c:barChart>
      <c:catAx>
        <c:axId val="61728209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17277832"/>
        <c:crosses val="autoZero"/>
        <c:auto val="1"/>
        <c:lblAlgn val="ctr"/>
        <c:lblOffset val="100"/>
        <c:noMultiLvlLbl val="0"/>
      </c:catAx>
      <c:valAx>
        <c:axId val="617277832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RPS18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6.1663329696212098E-2"/>
              <c:y val="4.7378189245399743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17282096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5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TBP!$K$28:$K$34</c:f>
                <c:numCache>
                  <c:formatCode>General</c:formatCode>
                  <c:ptCount val="7"/>
                  <c:pt idx="0">
                    <c:v>7.5526006796875947E-2</c:v>
                  </c:pt>
                  <c:pt idx="1">
                    <c:v>3.8151473858695925E-2</c:v>
                  </c:pt>
                  <c:pt idx="2">
                    <c:v>2.5084259337378137E-2</c:v>
                  </c:pt>
                  <c:pt idx="3">
                    <c:v>3.0214461536749712E-2</c:v>
                  </c:pt>
                  <c:pt idx="4">
                    <c:v>2.1757285190788678E-2</c:v>
                  </c:pt>
                  <c:pt idx="5">
                    <c:v>8.7190446020992858E-3</c:v>
                  </c:pt>
                  <c:pt idx="6">
                    <c:v>5.5253760321621728E-2</c:v>
                  </c:pt>
                </c:numCache>
              </c:numRef>
            </c:plus>
            <c:minus>
              <c:numRef>
                <c:f>TBP!$K$28:$K$34</c:f>
                <c:numCache>
                  <c:formatCode>General</c:formatCode>
                  <c:ptCount val="7"/>
                  <c:pt idx="0">
                    <c:v>7.5526006796875947E-2</c:v>
                  </c:pt>
                  <c:pt idx="1">
                    <c:v>3.8151473858695925E-2</c:v>
                  </c:pt>
                  <c:pt idx="2">
                    <c:v>2.5084259337378137E-2</c:v>
                  </c:pt>
                  <c:pt idx="3">
                    <c:v>3.0214461536749712E-2</c:v>
                  </c:pt>
                  <c:pt idx="4">
                    <c:v>2.1757285190788678E-2</c:v>
                  </c:pt>
                  <c:pt idx="5">
                    <c:v>8.7190446020992858E-3</c:v>
                  </c:pt>
                  <c:pt idx="6">
                    <c:v>5.525376032162172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TBP!$I$28:$I$34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TBP!$J$28:$J$34</c:f>
              <c:numCache>
                <c:formatCode>General</c:formatCode>
                <c:ptCount val="7"/>
                <c:pt idx="0">
                  <c:v>1</c:v>
                </c:pt>
                <c:pt idx="1">
                  <c:v>0.94161128160348007</c:v>
                </c:pt>
                <c:pt idx="2">
                  <c:v>1.0284208819369824</c:v>
                </c:pt>
                <c:pt idx="3">
                  <c:v>0.97024362778098483</c:v>
                </c:pt>
                <c:pt idx="4">
                  <c:v>1.0134953900318839</c:v>
                </c:pt>
                <c:pt idx="5">
                  <c:v>0.98319100400720416</c:v>
                </c:pt>
                <c:pt idx="6">
                  <c:v>0.9358788826415086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F05-42CD-B776-30C2985E3F8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27673960"/>
        <c:axId val="527673304"/>
      </c:barChart>
      <c:catAx>
        <c:axId val="52767396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27673304"/>
        <c:crosses val="autoZero"/>
        <c:auto val="1"/>
        <c:lblAlgn val="ctr"/>
        <c:lblOffset val="100"/>
        <c:noMultiLvlLbl val="0"/>
      </c:catAx>
      <c:valAx>
        <c:axId val="527673304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TBP</a:t>
                </a:r>
                <a:r>
                  <a:rPr lang="en-US" altLang="ja-JP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27673960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5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6596051781306607"/>
          <c:y val="8.6860013616566201E-2"/>
          <c:w val="0.6723761524907218"/>
          <c:h val="0.5625152720048994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PGK1'!$K$28:$K$34</c:f>
                <c:numCache>
                  <c:formatCode>General</c:formatCode>
                  <c:ptCount val="7"/>
                  <c:pt idx="0">
                    <c:v>3.6091285420964951E-2</c:v>
                  </c:pt>
                  <c:pt idx="1">
                    <c:v>1.714118195208636E-2</c:v>
                  </c:pt>
                  <c:pt idx="2">
                    <c:v>1.0260701465210525E-2</c:v>
                  </c:pt>
                  <c:pt idx="3">
                    <c:v>1.2049897254643905E-2</c:v>
                  </c:pt>
                  <c:pt idx="4">
                    <c:v>2.3595045619133344E-2</c:v>
                  </c:pt>
                  <c:pt idx="5">
                    <c:v>5.2332262671870369E-2</c:v>
                  </c:pt>
                  <c:pt idx="6">
                    <c:v>5.9977088774870881E-2</c:v>
                  </c:pt>
                </c:numCache>
              </c:numRef>
            </c:plus>
            <c:minus>
              <c:numRef>
                <c:f>'PGK1'!$K$28:$K$34</c:f>
                <c:numCache>
                  <c:formatCode>General</c:formatCode>
                  <c:ptCount val="7"/>
                  <c:pt idx="0">
                    <c:v>3.6091285420964951E-2</c:v>
                  </c:pt>
                  <c:pt idx="1">
                    <c:v>1.714118195208636E-2</c:v>
                  </c:pt>
                  <c:pt idx="2">
                    <c:v>1.0260701465210525E-2</c:v>
                  </c:pt>
                  <c:pt idx="3">
                    <c:v>1.2049897254643905E-2</c:v>
                  </c:pt>
                  <c:pt idx="4">
                    <c:v>2.3595045619133344E-2</c:v>
                  </c:pt>
                  <c:pt idx="5">
                    <c:v>5.2332262671870369E-2</c:v>
                  </c:pt>
                  <c:pt idx="6">
                    <c:v>5.997708877487088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PGK1'!$I$28:$I$34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'PGK1'!$J$28:$J$34</c:f>
              <c:numCache>
                <c:formatCode>General</c:formatCode>
                <c:ptCount val="7"/>
                <c:pt idx="0">
                  <c:v>1</c:v>
                </c:pt>
                <c:pt idx="1">
                  <c:v>0.94110972466230314</c:v>
                </c:pt>
                <c:pt idx="2">
                  <c:v>0.99117505023673491</c:v>
                </c:pt>
                <c:pt idx="3">
                  <c:v>0.98789010925507836</c:v>
                </c:pt>
                <c:pt idx="4">
                  <c:v>0.98481374872841787</c:v>
                </c:pt>
                <c:pt idx="5">
                  <c:v>0.99974675657967305</c:v>
                </c:pt>
                <c:pt idx="6">
                  <c:v>1.16704884062912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E98-45B7-A87A-C6A61908EFE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27723816"/>
        <c:axId val="527732344"/>
      </c:barChart>
      <c:catAx>
        <c:axId val="52772381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27732344"/>
        <c:crosses val="autoZero"/>
        <c:auto val="1"/>
        <c:lblAlgn val="ctr"/>
        <c:lblOffset val="100"/>
        <c:noMultiLvlLbl val="0"/>
      </c:catAx>
      <c:valAx>
        <c:axId val="527732344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PGK1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27723816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5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PPIA-4'!$K$28:$K$34</c:f>
                <c:numCache>
                  <c:formatCode>General</c:formatCode>
                  <c:ptCount val="7"/>
                  <c:pt idx="0">
                    <c:v>2.5660335755034461E-2</c:v>
                  </c:pt>
                  <c:pt idx="1">
                    <c:v>1.2276930499888298E-2</c:v>
                  </c:pt>
                  <c:pt idx="2">
                    <c:v>4.046487360667176E-2</c:v>
                  </c:pt>
                  <c:pt idx="3">
                    <c:v>1.955880109548597E-2</c:v>
                  </c:pt>
                  <c:pt idx="4">
                    <c:v>1.6412848380686202E-2</c:v>
                  </c:pt>
                  <c:pt idx="5">
                    <c:v>1.1335085185632407E-2</c:v>
                  </c:pt>
                  <c:pt idx="6">
                    <c:v>1.450477816783423E-2</c:v>
                  </c:pt>
                </c:numCache>
              </c:numRef>
            </c:plus>
            <c:minus>
              <c:numRef>
                <c:f>'PPIA-4'!$K$28:$K$34</c:f>
                <c:numCache>
                  <c:formatCode>General</c:formatCode>
                  <c:ptCount val="7"/>
                  <c:pt idx="0">
                    <c:v>2.5660335755034461E-2</c:v>
                  </c:pt>
                  <c:pt idx="1">
                    <c:v>1.2276930499888298E-2</c:v>
                  </c:pt>
                  <c:pt idx="2">
                    <c:v>4.046487360667176E-2</c:v>
                  </c:pt>
                  <c:pt idx="3">
                    <c:v>1.955880109548597E-2</c:v>
                  </c:pt>
                  <c:pt idx="4">
                    <c:v>1.6412848380686202E-2</c:v>
                  </c:pt>
                  <c:pt idx="5">
                    <c:v>1.1335085185632407E-2</c:v>
                  </c:pt>
                  <c:pt idx="6">
                    <c:v>1.45047781678342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PPIA-4'!$I$28:$I$34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'PPIA-4'!$J$28:$J$34</c:f>
              <c:numCache>
                <c:formatCode>General</c:formatCode>
                <c:ptCount val="7"/>
                <c:pt idx="0">
                  <c:v>1</c:v>
                </c:pt>
                <c:pt idx="1">
                  <c:v>0.97657610234748515</c:v>
                </c:pt>
                <c:pt idx="2">
                  <c:v>1.0056350243498386</c:v>
                </c:pt>
                <c:pt idx="3">
                  <c:v>0.98894255932491226</c:v>
                </c:pt>
                <c:pt idx="4">
                  <c:v>0.9988813665456755</c:v>
                </c:pt>
                <c:pt idx="5">
                  <c:v>0.98395684644639692</c:v>
                </c:pt>
                <c:pt idx="6">
                  <c:v>0.9930655220491377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FB1-4C76-962B-0914E0A6DF2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17271928"/>
        <c:axId val="617275208"/>
      </c:barChart>
      <c:catAx>
        <c:axId val="61727192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17275208"/>
        <c:crosses val="autoZero"/>
        <c:auto val="1"/>
        <c:lblAlgn val="ctr"/>
        <c:lblOffset val="100"/>
        <c:noMultiLvlLbl val="0"/>
      </c:catAx>
      <c:valAx>
        <c:axId val="617275208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PPIA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6.1663329696212098E-2"/>
              <c:y val="5.6893706045772235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17271928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5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GAPDH-2'!$K$28:$K$34</c:f>
                <c:numCache>
                  <c:formatCode>General</c:formatCode>
                  <c:ptCount val="7"/>
                  <c:pt idx="0">
                    <c:v>3.4528805289345189E-2</c:v>
                  </c:pt>
                  <c:pt idx="1">
                    <c:v>7.3384106143365643E-2</c:v>
                  </c:pt>
                  <c:pt idx="2">
                    <c:v>2.5046315917147996E-2</c:v>
                  </c:pt>
                  <c:pt idx="3">
                    <c:v>8.0433115432339164E-2</c:v>
                  </c:pt>
                  <c:pt idx="4">
                    <c:v>5.8912031821871269E-2</c:v>
                  </c:pt>
                  <c:pt idx="5">
                    <c:v>2.586001033925479E-2</c:v>
                  </c:pt>
                  <c:pt idx="6">
                    <c:v>6.5649319768994421E-2</c:v>
                  </c:pt>
                </c:numCache>
              </c:numRef>
            </c:plus>
            <c:minus>
              <c:numRef>
                <c:f>'GAPDH-2'!$K$28:$K$34</c:f>
                <c:numCache>
                  <c:formatCode>General</c:formatCode>
                  <c:ptCount val="7"/>
                  <c:pt idx="0">
                    <c:v>3.4528805289345189E-2</c:v>
                  </c:pt>
                  <c:pt idx="1">
                    <c:v>7.3384106143365643E-2</c:v>
                  </c:pt>
                  <c:pt idx="2">
                    <c:v>2.5046315917147996E-2</c:v>
                  </c:pt>
                  <c:pt idx="3">
                    <c:v>8.0433115432339164E-2</c:v>
                  </c:pt>
                  <c:pt idx="4">
                    <c:v>5.8912031821871269E-2</c:v>
                  </c:pt>
                  <c:pt idx="5">
                    <c:v>2.586001033925479E-2</c:v>
                  </c:pt>
                  <c:pt idx="6">
                    <c:v>6.564931976899442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GAPDH-2'!$I$28:$I$34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'GAPDH-2'!$J$28:$J$34</c:f>
              <c:numCache>
                <c:formatCode>General</c:formatCode>
                <c:ptCount val="7"/>
                <c:pt idx="0">
                  <c:v>1</c:v>
                </c:pt>
                <c:pt idx="1">
                  <c:v>0.9466454697138541</c:v>
                </c:pt>
                <c:pt idx="2">
                  <c:v>0.969804072278869</c:v>
                </c:pt>
                <c:pt idx="3">
                  <c:v>0.94783600560095371</c:v>
                </c:pt>
                <c:pt idx="4">
                  <c:v>0.97912017712923927</c:v>
                </c:pt>
                <c:pt idx="5">
                  <c:v>0.97725097117296678</c:v>
                </c:pt>
                <c:pt idx="6">
                  <c:v>1.054364376348601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BE9-4E36-9A69-092AD2D79F2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03344632"/>
        <c:axId val="503342008"/>
      </c:barChart>
      <c:catAx>
        <c:axId val="50334463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03342008"/>
        <c:crosses val="autoZero"/>
        <c:auto val="1"/>
        <c:lblAlgn val="ctr"/>
        <c:lblOffset val="100"/>
        <c:noMultiLvlLbl val="0"/>
      </c:catAx>
      <c:valAx>
        <c:axId val="503342008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GAPDH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6.1663329696212098E-2"/>
              <c:y val="2.438301687675953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03344632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ACTB-2'!$K$4:$K$10</c:f>
                <c:numCache>
                  <c:formatCode>General</c:formatCode>
                  <c:ptCount val="7"/>
                  <c:pt idx="0">
                    <c:v>6.9535173616433341E-2</c:v>
                  </c:pt>
                  <c:pt idx="1">
                    <c:v>2.8797993290081494E-2</c:v>
                  </c:pt>
                  <c:pt idx="2">
                    <c:v>4.2290262479477439E-2</c:v>
                  </c:pt>
                  <c:pt idx="3">
                    <c:v>2.0570075492685216E-2</c:v>
                  </c:pt>
                  <c:pt idx="4">
                    <c:v>5.0442336071481679E-2</c:v>
                  </c:pt>
                  <c:pt idx="5">
                    <c:v>1.9376811830040818E-2</c:v>
                  </c:pt>
                  <c:pt idx="6">
                    <c:v>2.7517980721692575E-2</c:v>
                  </c:pt>
                </c:numCache>
              </c:numRef>
            </c:plus>
            <c:minus>
              <c:numRef>
                <c:f>'ACTB-2'!$K$4:$K$10</c:f>
                <c:numCache>
                  <c:formatCode>General</c:formatCode>
                  <c:ptCount val="7"/>
                  <c:pt idx="0">
                    <c:v>6.9535173616433341E-2</c:v>
                  </c:pt>
                  <c:pt idx="1">
                    <c:v>2.8797993290081494E-2</c:v>
                  </c:pt>
                  <c:pt idx="2">
                    <c:v>4.2290262479477439E-2</c:v>
                  </c:pt>
                  <c:pt idx="3">
                    <c:v>2.0570075492685216E-2</c:v>
                  </c:pt>
                  <c:pt idx="4">
                    <c:v>5.0442336071481679E-2</c:v>
                  </c:pt>
                  <c:pt idx="5">
                    <c:v>1.9376811830040818E-2</c:v>
                  </c:pt>
                  <c:pt idx="6">
                    <c:v>2.7517980721692575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ACTB-2'!$I$4:$I$10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'ACTB-2'!$J$4:$J$10</c:f>
              <c:numCache>
                <c:formatCode>General</c:formatCode>
                <c:ptCount val="7"/>
                <c:pt idx="0">
                  <c:v>1.0000000000000002</c:v>
                </c:pt>
                <c:pt idx="1">
                  <c:v>0.94256745987829771</c:v>
                </c:pt>
                <c:pt idx="2">
                  <c:v>0.96474918321983505</c:v>
                </c:pt>
                <c:pt idx="3">
                  <c:v>0.69181565335713524</c:v>
                </c:pt>
                <c:pt idx="4">
                  <c:v>0.62054618937022799</c:v>
                </c:pt>
                <c:pt idx="5">
                  <c:v>0.665174951461596</c:v>
                </c:pt>
                <c:pt idx="6">
                  <c:v>0.6256148970898793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CDA-46AC-A63D-355B0976238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76846640"/>
        <c:axId val="576847624"/>
      </c:barChart>
      <c:catAx>
        <c:axId val="57684664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76847624"/>
        <c:crosses val="autoZero"/>
        <c:auto val="1"/>
        <c:lblAlgn val="ctr"/>
        <c:lblOffset val="100"/>
        <c:noMultiLvlLbl val="0"/>
      </c:catAx>
      <c:valAx>
        <c:axId val="576847624"/>
        <c:scaling>
          <c:orientation val="minMax"/>
          <c:max val="1.1000000000000001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ACTB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76846640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6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GUSB-3'!$K$28:$K$34</c:f>
                <c:numCache>
                  <c:formatCode>General</c:formatCode>
                  <c:ptCount val="7"/>
                  <c:pt idx="0">
                    <c:v>4.2809653221764978E-2</c:v>
                  </c:pt>
                  <c:pt idx="1">
                    <c:v>2.9598147139503674E-2</c:v>
                  </c:pt>
                  <c:pt idx="2">
                    <c:v>3.6307985181939714E-2</c:v>
                  </c:pt>
                  <c:pt idx="3">
                    <c:v>5.1396420115435514E-2</c:v>
                  </c:pt>
                  <c:pt idx="4">
                    <c:v>5.1994109439704811E-2</c:v>
                  </c:pt>
                  <c:pt idx="5">
                    <c:v>1.1225780263004196E-2</c:v>
                  </c:pt>
                  <c:pt idx="6">
                    <c:v>9.986649472224382E-2</c:v>
                  </c:pt>
                </c:numCache>
              </c:numRef>
            </c:plus>
            <c:minus>
              <c:numRef>
                <c:f>'GUSB-3'!$K$28:$K$34</c:f>
                <c:numCache>
                  <c:formatCode>General</c:formatCode>
                  <c:ptCount val="7"/>
                  <c:pt idx="0">
                    <c:v>4.2809653221764978E-2</c:v>
                  </c:pt>
                  <c:pt idx="1">
                    <c:v>2.9598147139503674E-2</c:v>
                  </c:pt>
                  <c:pt idx="2">
                    <c:v>3.6307985181939714E-2</c:v>
                  </c:pt>
                  <c:pt idx="3">
                    <c:v>5.1396420115435514E-2</c:v>
                  </c:pt>
                  <c:pt idx="4">
                    <c:v>5.1994109439704811E-2</c:v>
                  </c:pt>
                  <c:pt idx="5">
                    <c:v>1.1225780263004196E-2</c:v>
                  </c:pt>
                  <c:pt idx="6">
                    <c:v>9.98664947222438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GUSB-3'!$I$28:$I$34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'GUSB-3'!$J$28:$J$34</c:f>
              <c:numCache>
                <c:formatCode>General</c:formatCode>
                <c:ptCount val="7"/>
                <c:pt idx="0">
                  <c:v>1</c:v>
                </c:pt>
                <c:pt idx="1">
                  <c:v>0.99135767483405191</c:v>
                </c:pt>
                <c:pt idx="2">
                  <c:v>1.026297024988114</c:v>
                </c:pt>
                <c:pt idx="3">
                  <c:v>0.94005195208196068</c:v>
                </c:pt>
                <c:pt idx="4">
                  <c:v>0.99045244870148919</c:v>
                </c:pt>
                <c:pt idx="5">
                  <c:v>0.9176247268807578</c:v>
                </c:pt>
                <c:pt idx="6">
                  <c:v>0.9608741352666129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719-4F73-9C31-64BDA0951EA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16465912"/>
        <c:axId val="516462632"/>
      </c:barChart>
      <c:catAx>
        <c:axId val="51646591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16462632"/>
        <c:crosses val="autoZero"/>
        <c:auto val="1"/>
        <c:lblAlgn val="ctr"/>
        <c:lblOffset val="100"/>
        <c:noMultiLvlLbl val="0"/>
      </c:catAx>
      <c:valAx>
        <c:axId val="516462632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GUSB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6.166330247814087E-2"/>
              <c:y val="5.6893706045772235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16465912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6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ATP5F1-5'!$K$4:$K$10</c:f>
                <c:numCache>
                  <c:formatCode>General</c:formatCode>
                  <c:ptCount val="7"/>
                  <c:pt idx="0">
                    <c:v>2.1941553600464188E-2</c:v>
                  </c:pt>
                  <c:pt idx="1">
                    <c:v>3.1928371444696235E-2</c:v>
                  </c:pt>
                  <c:pt idx="2">
                    <c:v>4.0929433961400294E-2</c:v>
                  </c:pt>
                  <c:pt idx="3">
                    <c:v>5.2054417217207404E-2</c:v>
                  </c:pt>
                  <c:pt idx="4">
                    <c:v>1.5604796019553576E-2</c:v>
                  </c:pt>
                  <c:pt idx="5">
                    <c:v>2.8519446756838457E-2</c:v>
                  </c:pt>
                  <c:pt idx="6">
                    <c:v>3.7654890283077593E-2</c:v>
                  </c:pt>
                </c:numCache>
              </c:numRef>
            </c:plus>
            <c:minus>
              <c:numRef>
                <c:f>'ATP5F1-5'!$K$4:$K$10</c:f>
                <c:numCache>
                  <c:formatCode>General</c:formatCode>
                  <c:ptCount val="7"/>
                  <c:pt idx="0">
                    <c:v>2.1941553600464188E-2</c:v>
                  </c:pt>
                  <c:pt idx="1">
                    <c:v>3.1928371444696235E-2</c:v>
                  </c:pt>
                  <c:pt idx="2">
                    <c:v>4.0929433961400294E-2</c:v>
                  </c:pt>
                  <c:pt idx="3">
                    <c:v>5.2054417217207404E-2</c:v>
                  </c:pt>
                  <c:pt idx="4">
                    <c:v>1.5604796019553576E-2</c:v>
                  </c:pt>
                  <c:pt idx="5">
                    <c:v>2.8519446756838457E-2</c:v>
                  </c:pt>
                  <c:pt idx="6">
                    <c:v>3.765489028307759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ATP5F1-5'!$I$4:$I$10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'ATP5F1-5'!$J$4:$J$10</c:f>
              <c:numCache>
                <c:formatCode>General</c:formatCode>
                <c:ptCount val="7"/>
                <c:pt idx="0">
                  <c:v>1</c:v>
                </c:pt>
                <c:pt idx="1">
                  <c:v>0.98645111279551445</c:v>
                </c:pt>
                <c:pt idx="2">
                  <c:v>0.97420886058095946</c:v>
                </c:pt>
                <c:pt idx="3">
                  <c:v>1.0036497552508643</c:v>
                </c:pt>
                <c:pt idx="4">
                  <c:v>0.95111233984027443</c:v>
                </c:pt>
                <c:pt idx="5">
                  <c:v>1.0050450080281119</c:v>
                </c:pt>
                <c:pt idx="6">
                  <c:v>0.9108551494962977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267-412C-96CF-5849791BAC5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59631392"/>
        <c:axId val="659631720"/>
      </c:barChart>
      <c:catAx>
        <c:axId val="65963139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59631720"/>
        <c:crosses val="autoZero"/>
        <c:auto val="1"/>
        <c:lblAlgn val="ctr"/>
        <c:lblOffset val="100"/>
        <c:noMultiLvlLbl val="0"/>
      </c:catAx>
      <c:valAx>
        <c:axId val="659631720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ATP5F1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6.1663329696212098E-2"/>
              <c:y val="2.3689094622699872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59631392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6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TFRC-2'!$K$4:$K$10</c:f>
                <c:numCache>
                  <c:formatCode>General</c:formatCode>
                  <c:ptCount val="7"/>
                  <c:pt idx="0">
                    <c:v>2.6943161612188671E-2</c:v>
                  </c:pt>
                  <c:pt idx="1">
                    <c:v>5.1566315461334951E-2</c:v>
                  </c:pt>
                  <c:pt idx="2">
                    <c:v>2.7607545810003565E-2</c:v>
                  </c:pt>
                  <c:pt idx="3">
                    <c:v>2.8796253103509636E-2</c:v>
                  </c:pt>
                  <c:pt idx="4">
                    <c:v>3.6075686785758725E-2</c:v>
                  </c:pt>
                  <c:pt idx="5">
                    <c:v>3.9711871956973427E-2</c:v>
                  </c:pt>
                  <c:pt idx="6">
                    <c:v>3.5127887926277315E-2</c:v>
                  </c:pt>
                </c:numCache>
              </c:numRef>
            </c:plus>
            <c:minus>
              <c:numRef>
                <c:f>'TFRC-2'!$K$4:$K$10</c:f>
                <c:numCache>
                  <c:formatCode>General</c:formatCode>
                  <c:ptCount val="7"/>
                  <c:pt idx="0">
                    <c:v>2.6943161612188671E-2</c:v>
                  </c:pt>
                  <c:pt idx="1">
                    <c:v>5.1566315461334951E-2</c:v>
                  </c:pt>
                  <c:pt idx="2">
                    <c:v>2.7607545810003565E-2</c:v>
                  </c:pt>
                  <c:pt idx="3">
                    <c:v>2.8796253103509636E-2</c:v>
                  </c:pt>
                  <c:pt idx="4">
                    <c:v>3.6075686785758725E-2</c:v>
                  </c:pt>
                  <c:pt idx="5">
                    <c:v>3.9711871956973427E-2</c:v>
                  </c:pt>
                  <c:pt idx="6">
                    <c:v>3.5127887926277315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TFRC-2'!$I$4:$I$10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'TFRC-2'!$J$4:$J$10</c:f>
              <c:numCache>
                <c:formatCode>General</c:formatCode>
                <c:ptCount val="7"/>
                <c:pt idx="0">
                  <c:v>1</c:v>
                </c:pt>
                <c:pt idx="1">
                  <c:v>1.00923917694078</c:v>
                </c:pt>
                <c:pt idx="2">
                  <c:v>0.98892423729752077</c:v>
                </c:pt>
                <c:pt idx="3">
                  <c:v>0.96474913997221357</c:v>
                </c:pt>
                <c:pt idx="4">
                  <c:v>0.96430339944465338</c:v>
                </c:pt>
                <c:pt idx="5">
                  <c:v>0.99364341023483371</c:v>
                </c:pt>
                <c:pt idx="6">
                  <c:v>0.992938558927387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73C-4CAF-9928-A7CBC0D1832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74260344"/>
        <c:axId val="674263296"/>
      </c:barChart>
      <c:catAx>
        <c:axId val="67426034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74263296"/>
        <c:crosses val="autoZero"/>
        <c:auto val="1"/>
        <c:lblAlgn val="ctr"/>
        <c:lblOffset val="100"/>
        <c:noMultiLvlLbl val="0"/>
      </c:catAx>
      <c:valAx>
        <c:axId val="674263296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TFRC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en-US" altLang="ja-JP" dirty="0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74260344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6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YWHAZ!$K$4:$K$10</c:f>
                <c:numCache>
                  <c:formatCode>General</c:formatCode>
                  <c:ptCount val="7"/>
                  <c:pt idx="0">
                    <c:v>3.6497518057883011E-2</c:v>
                  </c:pt>
                  <c:pt idx="1">
                    <c:v>2.27748027960042E-2</c:v>
                  </c:pt>
                  <c:pt idx="2">
                    <c:v>2.6427460974670528E-2</c:v>
                  </c:pt>
                  <c:pt idx="3">
                    <c:v>2.4261793607948546E-2</c:v>
                  </c:pt>
                  <c:pt idx="4">
                    <c:v>4.2010144116596794E-2</c:v>
                  </c:pt>
                  <c:pt idx="5">
                    <c:v>5.0473497346234047E-2</c:v>
                  </c:pt>
                  <c:pt idx="6">
                    <c:v>1.1171952820621835E-2</c:v>
                  </c:pt>
                </c:numCache>
              </c:numRef>
            </c:plus>
            <c:minus>
              <c:numRef>
                <c:f>YWHAZ!$K$4:$K$10</c:f>
                <c:numCache>
                  <c:formatCode>General</c:formatCode>
                  <c:ptCount val="7"/>
                  <c:pt idx="0">
                    <c:v>3.6497518057883011E-2</c:v>
                  </c:pt>
                  <c:pt idx="1">
                    <c:v>2.27748027960042E-2</c:v>
                  </c:pt>
                  <c:pt idx="2">
                    <c:v>2.6427460974670528E-2</c:v>
                  </c:pt>
                  <c:pt idx="3">
                    <c:v>2.4261793607948546E-2</c:v>
                  </c:pt>
                  <c:pt idx="4">
                    <c:v>4.2010144116596794E-2</c:v>
                  </c:pt>
                  <c:pt idx="5">
                    <c:v>5.0473497346234047E-2</c:v>
                  </c:pt>
                  <c:pt idx="6">
                    <c:v>1.1171952820621835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YWHAZ!$I$4:$I$10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YWHAZ!$J$4:$J$10</c:f>
              <c:numCache>
                <c:formatCode>General</c:formatCode>
                <c:ptCount val="7"/>
                <c:pt idx="0">
                  <c:v>1</c:v>
                </c:pt>
                <c:pt idx="1">
                  <c:v>1.0191519389689621</c:v>
                </c:pt>
                <c:pt idx="2">
                  <c:v>0.99115062303732937</c:v>
                </c:pt>
                <c:pt idx="3">
                  <c:v>1.0328733057354913</c:v>
                </c:pt>
                <c:pt idx="4">
                  <c:v>0.97582345211719079</c:v>
                </c:pt>
                <c:pt idx="5">
                  <c:v>1.0212165877050308</c:v>
                </c:pt>
                <c:pt idx="6">
                  <c:v>0.974346294557869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08D-4604-B76C-4AFE55C7FF5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17027832"/>
        <c:axId val="417032424"/>
      </c:barChart>
      <c:catAx>
        <c:axId val="41702783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17032424"/>
        <c:crosses val="autoZero"/>
        <c:auto val="1"/>
        <c:lblAlgn val="ctr"/>
        <c:lblOffset val="100"/>
        <c:noMultiLvlLbl val="0"/>
      </c:catAx>
      <c:valAx>
        <c:axId val="417032424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YWHAZ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6.1663329696212098E-2"/>
              <c:y val="1.5792729748466582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17027832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6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RPLP0!$K$4:$K$10</c:f>
                <c:numCache>
                  <c:formatCode>General</c:formatCode>
                  <c:ptCount val="7"/>
                  <c:pt idx="0">
                    <c:v>4.6498619325879703E-2</c:v>
                  </c:pt>
                  <c:pt idx="1">
                    <c:v>3.1692203847881913E-2</c:v>
                  </c:pt>
                  <c:pt idx="2">
                    <c:v>1.6631566412391809E-2</c:v>
                  </c:pt>
                  <c:pt idx="3">
                    <c:v>1.9595872821482441E-2</c:v>
                  </c:pt>
                  <c:pt idx="4">
                    <c:v>3.1576263703236719E-2</c:v>
                  </c:pt>
                  <c:pt idx="5">
                    <c:v>6.2749812532535601E-2</c:v>
                  </c:pt>
                  <c:pt idx="6">
                    <c:v>6.7966338949083258E-2</c:v>
                  </c:pt>
                </c:numCache>
              </c:numRef>
            </c:plus>
            <c:minus>
              <c:numRef>
                <c:f>RPLP0!$K$4:$K$10</c:f>
                <c:numCache>
                  <c:formatCode>General</c:formatCode>
                  <c:ptCount val="7"/>
                  <c:pt idx="0">
                    <c:v>4.6498619325879703E-2</c:v>
                  </c:pt>
                  <c:pt idx="1">
                    <c:v>3.1692203847881913E-2</c:v>
                  </c:pt>
                  <c:pt idx="2">
                    <c:v>1.6631566412391809E-2</c:v>
                  </c:pt>
                  <c:pt idx="3">
                    <c:v>1.9595872821482441E-2</c:v>
                  </c:pt>
                  <c:pt idx="4">
                    <c:v>3.1576263703236719E-2</c:v>
                  </c:pt>
                  <c:pt idx="5">
                    <c:v>6.2749812532535601E-2</c:v>
                  </c:pt>
                  <c:pt idx="6">
                    <c:v>6.796633894908325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RPLP0!$I$4:$I$10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RPLP0!$J$4:$J$10</c:f>
              <c:numCache>
                <c:formatCode>General</c:formatCode>
                <c:ptCount val="7"/>
                <c:pt idx="0">
                  <c:v>1</c:v>
                </c:pt>
                <c:pt idx="1">
                  <c:v>1.070977199662672</c:v>
                </c:pt>
                <c:pt idx="2">
                  <c:v>0.99856357271240537</c:v>
                </c:pt>
                <c:pt idx="3">
                  <c:v>1.0539076155675773</c:v>
                </c:pt>
                <c:pt idx="4">
                  <c:v>0.95588424606076883</c:v>
                </c:pt>
                <c:pt idx="5">
                  <c:v>1.000664508303923</c:v>
                </c:pt>
                <c:pt idx="6">
                  <c:v>0.9624458355278807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0C2-4821-B045-69E336B7825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68946960"/>
        <c:axId val="568944336"/>
      </c:barChart>
      <c:catAx>
        <c:axId val="56894696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68944336"/>
        <c:crosses val="autoZero"/>
        <c:auto val="1"/>
        <c:lblAlgn val="ctr"/>
        <c:lblOffset val="100"/>
        <c:noMultiLvlLbl val="0"/>
      </c:catAx>
      <c:valAx>
        <c:axId val="568944336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RPLP0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6.1802701180621825E-2"/>
              <c:y val="4.7378189245399743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68946960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6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RPLP1!$K$4:$K$10</c:f>
                <c:numCache>
                  <c:formatCode>General</c:formatCode>
                  <c:ptCount val="7"/>
                  <c:pt idx="0">
                    <c:v>1.2259095697618981E-2</c:v>
                  </c:pt>
                  <c:pt idx="1">
                    <c:v>3.9773374418953358E-2</c:v>
                  </c:pt>
                  <c:pt idx="2">
                    <c:v>3.4721949356105855E-2</c:v>
                  </c:pt>
                  <c:pt idx="3">
                    <c:v>5.3065778314334587E-2</c:v>
                  </c:pt>
                  <c:pt idx="4">
                    <c:v>4.0601606467286444E-2</c:v>
                  </c:pt>
                  <c:pt idx="5">
                    <c:v>0.10940023979778486</c:v>
                  </c:pt>
                  <c:pt idx="6">
                    <c:v>4.0337065531300925E-2</c:v>
                  </c:pt>
                </c:numCache>
              </c:numRef>
            </c:plus>
            <c:minus>
              <c:numRef>
                <c:f>RPLP1!$K$4:$K$10</c:f>
                <c:numCache>
                  <c:formatCode>General</c:formatCode>
                  <c:ptCount val="7"/>
                  <c:pt idx="0">
                    <c:v>1.2259095697618981E-2</c:v>
                  </c:pt>
                  <c:pt idx="1">
                    <c:v>3.9773374418953358E-2</c:v>
                  </c:pt>
                  <c:pt idx="2">
                    <c:v>3.4721949356105855E-2</c:v>
                  </c:pt>
                  <c:pt idx="3">
                    <c:v>5.3065778314334587E-2</c:v>
                  </c:pt>
                  <c:pt idx="4">
                    <c:v>4.0601606467286444E-2</c:v>
                  </c:pt>
                  <c:pt idx="5">
                    <c:v>0.10940023979778486</c:v>
                  </c:pt>
                  <c:pt idx="6">
                    <c:v>4.0337065531300925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RPLP1!$I$4:$I$10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RPLP1!$J$4:$J$10</c:f>
              <c:numCache>
                <c:formatCode>General</c:formatCode>
                <c:ptCount val="7"/>
                <c:pt idx="0">
                  <c:v>1</c:v>
                </c:pt>
                <c:pt idx="1">
                  <c:v>1.0043295359006261</c:v>
                </c:pt>
                <c:pt idx="2">
                  <c:v>0.97560374141787343</c:v>
                </c:pt>
                <c:pt idx="3">
                  <c:v>1.0201463016293457</c:v>
                </c:pt>
                <c:pt idx="4">
                  <c:v>0.98802093048221684</c:v>
                </c:pt>
                <c:pt idx="5">
                  <c:v>1.0611346837704716</c:v>
                </c:pt>
                <c:pt idx="6">
                  <c:v>0.9917587902305030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515-417C-A413-3ED5C063488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21081192"/>
        <c:axId val="521084472"/>
      </c:barChart>
      <c:catAx>
        <c:axId val="52108119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21084472"/>
        <c:crosses val="autoZero"/>
        <c:auto val="1"/>
        <c:lblAlgn val="ctr"/>
        <c:lblOffset val="100"/>
        <c:noMultiLvlLbl val="0"/>
      </c:catAx>
      <c:valAx>
        <c:axId val="521084472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RPLP1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6.1802701180621825E-2"/>
              <c:y val="5.5274554119633036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21081192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6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ACTB-2'!$K$4:$K$10</c:f>
                <c:numCache>
                  <c:formatCode>General</c:formatCode>
                  <c:ptCount val="7"/>
                  <c:pt idx="0">
                    <c:v>5.5688793126286711E-2</c:v>
                  </c:pt>
                  <c:pt idx="1">
                    <c:v>1.8605012922824737E-2</c:v>
                  </c:pt>
                  <c:pt idx="2">
                    <c:v>4.097330957343711E-2</c:v>
                  </c:pt>
                  <c:pt idx="3">
                    <c:v>1.1702952108535978E-2</c:v>
                  </c:pt>
                  <c:pt idx="4">
                    <c:v>1.6408193328269226E-2</c:v>
                  </c:pt>
                  <c:pt idx="5">
                    <c:v>3.9269647649880009E-2</c:v>
                  </c:pt>
                  <c:pt idx="6">
                    <c:v>1.7787696153321833E-2</c:v>
                  </c:pt>
                </c:numCache>
              </c:numRef>
            </c:plus>
            <c:minus>
              <c:numRef>
                <c:f>'ACTB-2'!$K$4:$K$10</c:f>
                <c:numCache>
                  <c:formatCode>General</c:formatCode>
                  <c:ptCount val="7"/>
                  <c:pt idx="0">
                    <c:v>5.5688793126286711E-2</c:v>
                  </c:pt>
                  <c:pt idx="1">
                    <c:v>1.8605012922824737E-2</c:v>
                  </c:pt>
                  <c:pt idx="2">
                    <c:v>4.097330957343711E-2</c:v>
                  </c:pt>
                  <c:pt idx="3">
                    <c:v>1.1702952108535978E-2</c:v>
                  </c:pt>
                  <c:pt idx="4">
                    <c:v>1.6408193328269226E-2</c:v>
                  </c:pt>
                  <c:pt idx="5">
                    <c:v>3.9269647649880009E-2</c:v>
                  </c:pt>
                  <c:pt idx="6">
                    <c:v>1.778769615332183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ACTB-2'!$I$4:$I$10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'ACTB-2'!$J$4:$J$10</c:f>
              <c:numCache>
                <c:formatCode>General</c:formatCode>
                <c:ptCount val="7"/>
                <c:pt idx="0">
                  <c:v>1</c:v>
                </c:pt>
                <c:pt idx="1">
                  <c:v>1.0203161878854348</c:v>
                </c:pt>
                <c:pt idx="2">
                  <c:v>1.0275968939199605</c:v>
                </c:pt>
                <c:pt idx="3">
                  <c:v>1.0883101955192365</c:v>
                </c:pt>
                <c:pt idx="4">
                  <c:v>0.85231603212386631</c:v>
                </c:pt>
                <c:pt idx="5">
                  <c:v>0.72528734398788364</c:v>
                </c:pt>
                <c:pt idx="6">
                  <c:v>0.6005213490868478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BBF-431B-AD38-5FA1A187152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15837632"/>
        <c:axId val="515838616"/>
      </c:barChart>
      <c:catAx>
        <c:axId val="51583763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15838616"/>
        <c:crosses val="autoZero"/>
        <c:auto val="1"/>
        <c:lblAlgn val="ctr"/>
        <c:lblOffset val="100"/>
        <c:noMultiLvlLbl val="0"/>
      </c:catAx>
      <c:valAx>
        <c:axId val="515838616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ACTB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15837632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6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RPLP2!$K$4:$K$10</c:f>
                <c:numCache>
                  <c:formatCode>General</c:formatCode>
                  <c:ptCount val="7"/>
                  <c:pt idx="0">
                    <c:v>4.8179621092285047E-2</c:v>
                  </c:pt>
                  <c:pt idx="1">
                    <c:v>2.2215919524126611E-2</c:v>
                  </c:pt>
                  <c:pt idx="2">
                    <c:v>3.9841738009419404E-2</c:v>
                  </c:pt>
                  <c:pt idx="3">
                    <c:v>3.0357224920301146E-2</c:v>
                  </c:pt>
                  <c:pt idx="4">
                    <c:v>4.0058381806172119E-2</c:v>
                  </c:pt>
                  <c:pt idx="5">
                    <c:v>4.2399350836459383E-2</c:v>
                  </c:pt>
                  <c:pt idx="6">
                    <c:v>9.9862088525703423E-3</c:v>
                  </c:pt>
                </c:numCache>
              </c:numRef>
            </c:plus>
            <c:minus>
              <c:numRef>
                <c:f>RPLP2!$K$4:$K$10</c:f>
                <c:numCache>
                  <c:formatCode>General</c:formatCode>
                  <c:ptCount val="7"/>
                  <c:pt idx="0">
                    <c:v>4.8179621092285047E-2</c:v>
                  </c:pt>
                  <c:pt idx="1">
                    <c:v>2.2215919524126611E-2</c:v>
                  </c:pt>
                  <c:pt idx="2">
                    <c:v>3.9841738009419404E-2</c:v>
                  </c:pt>
                  <c:pt idx="3">
                    <c:v>3.0357224920301146E-2</c:v>
                  </c:pt>
                  <c:pt idx="4">
                    <c:v>4.0058381806172119E-2</c:v>
                  </c:pt>
                  <c:pt idx="5">
                    <c:v>4.2399350836459383E-2</c:v>
                  </c:pt>
                  <c:pt idx="6">
                    <c:v>9.9862088525703423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RPLP2!$I$4:$I$10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RPLP2!$J$4:$J$10</c:f>
              <c:numCache>
                <c:formatCode>General</c:formatCode>
                <c:ptCount val="7"/>
                <c:pt idx="0">
                  <c:v>1</c:v>
                </c:pt>
                <c:pt idx="1">
                  <c:v>0.99920214952483455</c:v>
                </c:pt>
                <c:pt idx="2">
                  <c:v>0.99007876261081018</c:v>
                </c:pt>
                <c:pt idx="3">
                  <c:v>1.0380336851222152</c:v>
                </c:pt>
                <c:pt idx="4">
                  <c:v>0.95294630348315479</c:v>
                </c:pt>
                <c:pt idx="5">
                  <c:v>0.99776878312436834</c:v>
                </c:pt>
                <c:pt idx="6">
                  <c:v>0.9457203752565653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4B8-4BA1-8140-EB04E421A98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15836976"/>
        <c:axId val="515835008"/>
      </c:barChart>
      <c:catAx>
        <c:axId val="51583697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15835008"/>
        <c:crosses val="autoZero"/>
        <c:auto val="1"/>
        <c:lblAlgn val="ctr"/>
        <c:lblOffset val="100"/>
        <c:noMultiLvlLbl val="0"/>
      </c:catAx>
      <c:valAx>
        <c:axId val="515835008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RPLP2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6.1802701180621825E-2"/>
              <c:y val="5.5274554119633036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15836976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6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HPRT1-2'!$K$4:$K$10</c:f>
                <c:numCache>
                  <c:formatCode>General</c:formatCode>
                  <c:ptCount val="7"/>
                  <c:pt idx="0">
                    <c:v>3.1401109339524426E-2</c:v>
                  </c:pt>
                  <c:pt idx="1">
                    <c:v>3.3383964672607805E-2</c:v>
                  </c:pt>
                  <c:pt idx="2">
                    <c:v>1.293098403149507E-2</c:v>
                  </c:pt>
                  <c:pt idx="3">
                    <c:v>3.2517337863453087E-2</c:v>
                  </c:pt>
                  <c:pt idx="4">
                    <c:v>2.9519399909125534E-2</c:v>
                  </c:pt>
                  <c:pt idx="5">
                    <c:v>1.4509462183612687E-2</c:v>
                  </c:pt>
                  <c:pt idx="6">
                    <c:v>1.7251424279284583E-2</c:v>
                  </c:pt>
                </c:numCache>
              </c:numRef>
            </c:plus>
            <c:minus>
              <c:numRef>
                <c:f>'HPRT1-2'!$K$4:$K$10</c:f>
                <c:numCache>
                  <c:formatCode>General</c:formatCode>
                  <c:ptCount val="7"/>
                  <c:pt idx="0">
                    <c:v>3.1401109339524426E-2</c:v>
                  </c:pt>
                  <c:pt idx="1">
                    <c:v>3.3383964672607805E-2</c:v>
                  </c:pt>
                  <c:pt idx="2">
                    <c:v>1.293098403149507E-2</c:v>
                  </c:pt>
                  <c:pt idx="3">
                    <c:v>3.2517337863453087E-2</c:v>
                  </c:pt>
                  <c:pt idx="4">
                    <c:v>2.9519399909125534E-2</c:v>
                  </c:pt>
                  <c:pt idx="5">
                    <c:v>1.4509462183612687E-2</c:v>
                  </c:pt>
                  <c:pt idx="6">
                    <c:v>1.725142427928458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HPRT1-2'!$I$4:$I$10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'HPRT1-2'!$J$4:$J$10</c:f>
              <c:numCache>
                <c:formatCode>General</c:formatCode>
                <c:ptCount val="7"/>
                <c:pt idx="0">
                  <c:v>1</c:v>
                </c:pt>
                <c:pt idx="1">
                  <c:v>0.97837755185675057</c:v>
                </c:pt>
                <c:pt idx="2">
                  <c:v>0.96561883551039784</c:v>
                </c:pt>
                <c:pt idx="3">
                  <c:v>0.98867818654113704</c:v>
                </c:pt>
                <c:pt idx="4">
                  <c:v>0.93676869902936</c:v>
                </c:pt>
                <c:pt idx="5">
                  <c:v>0.86560194337124552</c:v>
                </c:pt>
                <c:pt idx="6">
                  <c:v>0.8258796344300355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EC3-4D92-95A2-8D50A718144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35118392"/>
        <c:axId val="535119048"/>
      </c:barChart>
      <c:catAx>
        <c:axId val="53511839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35119048"/>
        <c:crosses val="autoZero"/>
        <c:auto val="1"/>
        <c:lblAlgn val="ctr"/>
        <c:lblOffset val="100"/>
        <c:noMultiLvlLbl val="0"/>
      </c:catAx>
      <c:valAx>
        <c:axId val="535119048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HPRT1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6.1802701180621825E-2"/>
              <c:y val="4.7378189245399743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35118392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6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B2M!$K$4:$K$10</c:f>
                <c:numCache>
                  <c:formatCode>General</c:formatCode>
                  <c:ptCount val="7"/>
                  <c:pt idx="0">
                    <c:v>7.254081907285323E-2</c:v>
                  </c:pt>
                  <c:pt idx="1">
                    <c:v>2.3571856305476792E-2</c:v>
                  </c:pt>
                  <c:pt idx="2">
                    <c:v>1.6152352513588906E-2</c:v>
                  </c:pt>
                  <c:pt idx="3">
                    <c:v>3.4987065213412487E-2</c:v>
                  </c:pt>
                  <c:pt idx="4">
                    <c:v>3.0927902388293089E-2</c:v>
                  </c:pt>
                  <c:pt idx="5">
                    <c:v>2.3929570654688394E-2</c:v>
                  </c:pt>
                  <c:pt idx="6">
                    <c:v>2.9869145589832932E-2</c:v>
                  </c:pt>
                </c:numCache>
              </c:numRef>
            </c:plus>
            <c:minus>
              <c:numRef>
                <c:f>B2M!$K$4:$K$10</c:f>
                <c:numCache>
                  <c:formatCode>General</c:formatCode>
                  <c:ptCount val="7"/>
                  <c:pt idx="0">
                    <c:v>7.254081907285323E-2</c:v>
                  </c:pt>
                  <c:pt idx="1">
                    <c:v>2.3571856305476792E-2</c:v>
                  </c:pt>
                  <c:pt idx="2">
                    <c:v>1.6152352513588906E-2</c:v>
                  </c:pt>
                  <c:pt idx="3">
                    <c:v>3.4987065213412487E-2</c:v>
                  </c:pt>
                  <c:pt idx="4">
                    <c:v>3.0927902388293089E-2</c:v>
                  </c:pt>
                  <c:pt idx="5">
                    <c:v>2.3929570654688394E-2</c:v>
                  </c:pt>
                  <c:pt idx="6">
                    <c:v>2.986914558983293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B2M!$I$4:$I$10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B2M!$J$4:$J$10</c:f>
              <c:numCache>
                <c:formatCode>General</c:formatCode>
                <c:ptCount val="7"/>
                <c:pt idx="0">
                  <c:v>1.0000000000000002</c:v>
                </c:pt>
                <c:pt idx="1">
                  <c:v>1.0516729393327506</c:v>
                </c:pt>
                <c:pt idx="2">
                  <c:v>1.0339037527516599</c:v>
                </c:pt>
                <c:pt idx="3">
                  <c:v>1.0134197206569124</c:v>
                </c:pt>
                <c:pt idx="4">
                  <c:v>1.0394087842371538</c:v>
                </c:pt>
                <c:pt idx="5">
                  <c:v>1.063485627016864</c:v>
                </c:pt>
                <c:pt idx="6">
                  <c:v>1.15540952975961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226-438D-9832-2ADC3D4ECD6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86298384"/>
        <c:axId val="586296744"/>
      </c:barChart>
      <c:catAx>
        <c:axId val="58629838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86296744"/>
        <c:crosses val="autoZero"/>
        <c:auto val="1"/>
        <c:lblAlgn val="ctr"/>
        <c:lblOffset val="100"/>
        <c:noMultiLvlLbl val="0"/>
      </c:catAx>
      <c:valAx>
        <c:axId val="586296744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B2M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86298384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RPLP2!$K$4:$K$10</c:f>
                <c:numCache>
                  <c:formatCode>General</c:formatCode>
                  <c:ptCount val="7"/>
                  <c:pt idx="0">
                    <c:v>1.0655860240281284E-2</c:v>
                  </c:pt>
                  <c:pt idx="1">
                    <c:v>4.1512470169859525E-2</c:v>
                  </c:pt>
                  <c:pt idx="2">
                    <c:v>1.7755064151003554E-2</c:v>
                  </c:pt>
                  <c:pt idx="3">
                    <c:v>8.4601011707485102E-2</c:v>
                  </c:pt>
                  <c:pt idx="4">
                    <c:v>0.10384105087848675</c:v>
                  </c:pt>
                  <c:pt idx="5">
                    <c:v>8.757346901745856E-3</c:v>
                  </c:pt>
                  <c:pt idx="6">
                    <c:v>2.8878357303546098E-2</c:v>
                  </c:pt>
                </c:numCache>
              </c:numRef>
            </c:plus>
            <c:minus>
              <c:numRef>
                <c:f>RPLP2!$K$4:$K$10</c:f>
                <c:numCache>
                  <c:formatCode>General</c:formatCode>
                  <c:ptCount val="7"/>
                  <c:pt idx="0">
                    <c:v>1.0655860240281284E-2</c:v>
                  </c:pt>
                  <c:pt idx="1">
                    <c:v>4.1512470169859525E-2</c:v>
                  </c:pt>
                  <c:pt idx="2">
                    <c:v>1.7755064151003554E-2</c:v>
                  </c:pt>
                  <c:pt idx="3">
                    <c:v>8.4601011707485102E-2</c:v>
                  </c:pt>
                  <c:pt idx="4">
                    <c:v>0.10384105087848675</c:v>
                  </c:pt>
                  <c:pt idx="5">
                    <c:v>8.757346901745856E-3</c:v>
                  </c:pt>
                  <c:pt idx="6">
                    <c:v>2.887835730354609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RPLP2!$I$4:$I$10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RPLP2!$J$4:$J$10</c:f>
              <c:numCache>
                <c:formatCode>General</c:formatCode>
                <c:ptCount val="7"/>
                <c:pt idx="0">
                  <c:v>1</c:v>
                </c:pt>
                <c:pt idx="1">
                  <c:v>1.0856393666394502</c:v>
                </c:pt>
                <c:pt idx="2">
                  <c:v>1.0646839136715114</c:v>
                </c:pt>
                <c:pt idx="3">
                  <c:v>1.0751313202706474</c:v>
                </c:pt>
                <c:pt idx="4">
                  <c:v>1.0349941275975219</c:v>
                </c:pt>
                <c:pt idx="5">
                  <c:v>1.0280502623303522</c:v>
                </c:pt>
                <c:pt idx="6">
                  <c:v>1.05394431774994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6CF-43D0-A488-D49A3D9E35D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7722768"/>
        <c:axId val="427719488"/>
      </c:barChart>
      <c:catAx>
        <c:axId val="42772276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27719488"/>
        <c:crosses val="autoZero"/>
        <c:auto val="1"/>
        <c:lblAlgn val="ctr"/>
        <c:lblOffset val="100"/>
        <c:noMultiLvlLbl val="0"/>
      </c:catAx>
      <c:valAx>
        <c:axId val="427719488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RPLP2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6.166330247814087E-2"/>
              <c:y val="6.3170918993866329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27722768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7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PS18-3'!$K$4:$K$10</c:f>
                <c:numCache>
                  <c:formatCode>General</c:formatCode>
                  <c:ptCount val="7"/>
                  <c:pt idx="0">
                    <c:v>2.1628110028606817E-2</c:v>
                  </c:pt>
                  <c:pt idx="1">
                    <c:v>4.9529904412465721E-2</c:v>
                  </c:pt>
                  <c:pt idx="2">
                    <c:v>8.5363894235700913E-2</c:v>
                  </c:pt>
                  <c:pt idx="3">
                    <c:v>4.2300425525242553E-2</c:v>
                  </c:pt>
                  <c:pt idx="4">
                    <c:v>4.5964071829611687E-2</c:v>
                  </c:pt>
                  <c:pt idx="5">
                    <c:v>1.5983000287769049E-2</c:v>
                  </c:pt>
                  <c:pt idx="6">
                    <c:v>4.5701194789356712E-2</c:v>
                  </c:pt>
                </c:numCache>
              </c:numRef>
            </c:plus>
            <c:minus>
              <c:numRef>
                <c:f>'RPS18-3'!$K$4:$K$10</c:f>
                <c:numCache>
                  <c:formatCode>General</c:formatCode>
                  <c:ptCount val="7"/>
                  <c:pt idx="0">
                    <c:v>2.1628110028606817E-2</c:v>
                  </c:pt>
                  <c:pt idx="1">
                    <c:v>4.9529904412465721E-2</c:v>
                  </c:pt>
                  <c:pt idx="2">
                    <c:v>8.5363894235700913E-2</c:v>
                  </c:pt>
                  <c:pt idx="3">
                    <c:v>4.2300425525242553E-2</c:v>
                  </c:pt>
                  <c:pt idx="4">
                    <c:v>4.5964071829611687E-2</c:v>
                  </c:pt>
                  <c:pt idx="5">
                    <c:v>1.5983000287769049E-2</c:v>
                  </c:pt>
                  <c:pt idx="6">
                    <c:v>4.570119478935671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RPS18-3'!$I$4:$I$10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'RPS18-3'!$J$4:$J$10</c:f>
              <c:numCache>
                <c:formatCode>General</c:formatCode>
                <c:ptCount val="7"/>
                <c:pt idx="0">
                  <c:v>1</c:v>
                </c:pt>
                <c:pt idx="1">
                  <c:v>0.98348259780883529</c:v>
                </c:pt>
                <c:pt idx="2">
                  <c:v>0.97023462808403249</c:v>
                </c:pt>
                <c:pt idx="3">
                  <c:v>1.0188427467703889</c:v>
                </c:pt>
                <c:pt idx="4">
                  <c:v>0.95071410758600206</c:v>
                </c:pt>
                <c:pt idx="5">
                  <c:v>0.94198775919894195</c:v>
                </c:pt>
                <c:pt idx="6">
                  <c:v>0.9709876851637918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E27-4B6F-AC3D-5C7659C360C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33126512"/>
        <c:axId val="533125200"/>
      </c:barChart>
      <c:catAx>
        <c:axId val="53312651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33125200"/>
        <c:crosses val="autoZero"/>
        <c:auto val="1"/>
        <c:lblAlgn val="ctr"/>
        <c:lblOffset val="100"/>
        <c:noMultiLvlLbl val="0"/>
      </c:catAx>
      <c:valAx>
        <c:axId val="533125200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RPS18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6.1802701180621825E-2"/>
              <c:y val="5.5274554119633036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33126512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7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TBP!$K$4:$K$10</c:f>
                <c:numCache>
                  <c:formatCode>General</c:formatCode>
                  <c:ptCount val="7"/>
                  <c:pt idx="0">
                    <c:v>6.7461174221859529E-2</c:v>
                  </c:pt>
                  <c:pt idx="1">
                    <c:v>3.1405296623981338E-2</c:v>
                  </c:pt>
                  <c:pt idx="2">
                    <c:v>2.0529952820997118E-2</c:v>
                  </c:pt>
                  <c:pt idx="3">
                    <c:v>2.9549176164880713E-2</c:v>
                  </c:pt>
                  <c:pt idx="4">
                    <c:v>6.6963470330856173E-2</c:v>
                  </c:pt>
                  <c:pt idx="5">
                    <c:v>5.7954567853298361E-2</c:v>
                  </c:pt>
                  <c:pt idx="6">
                    <c:v>1.4812887340549044E-2</c:v>
                  </c:pt>
                </c:numCache>
              </c:numRef>
            </c:plus>
            <c:minus>
              <c:numRef>
                <c:f>TBP!$K$4:$K$10</c:f>
                <c:numCache>
                  <c:formatCode>General</c:formatCode>
                  <c:ptCount val="7"/>
                  <c:pt idx="0">
                    <c:v>6.7461174221859529E-2</c:v>
                  </c:pt>
                  <c:pt idx="1">
                    <c:v>3.1405296623981338E-2</c:v>
                  </c:pt>
                  <c:pt idx="2">
                    <c:v>2.0529952820997118E-2</c:v>
                  </c:pt>
                  <c:pt idx="3">
                    <c:v>2.9549176164880713E-2</c:v>
                  </c:pt>
                  <c:pt idx="4">
                    <c:v>6.6963470330856173E-2</c:v>
                  </c:pt>
                  <c:pt idx="5">
                    <c:v>5.7954567853298361E-2</c:v>
                  </c:pt>
                  <c:pt idx="6">
                    <c:v>1.4812887340549044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TBP!$I$4:$I$10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TBP!$J$4:$J$10</c:f>
              <c:numCache>
                <c:formatCode>General</c:formatCode>
                <c:ptCount val="7"/>
                <c:pt idx="0">
                  <c:v>1</c:v>
                </c:pt>
                <c:pt idx="1">
                  <c:v>1.014927260821608</c:v>
                </c:pt>
                <c:pt idx="2">
                  <c:v>0.99979108516659343</c:v>
                </c:pt>
                <c:pt idx="3">
                  <c:v>1.0200734381118466</c:v>
                </c:pt>
                <c:pt idx="4">
                  <c:v>0.95499492266209651</c:v>
                </c:pt>
                <c:pt idx="5">
                  <c:v>0.90009585826848093</c:v>
                </c:pt>
                <c:pt idx="6">
                  <c:v>0.85053444514717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1F5-4F91-A329-86B45FF8180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36411312"/>
        <c:axId val="536413936"/>
      </c:barChart>
      <c:catAx>
        <c:axId val="53641131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36413936"/>
        <c:crosses val="autoZero"/>
        <c:auto val="1"/>
        <c:lblAlgn val="ctr"/>
        <c:lblOffset val="100"/>
        <c:noMultiLvlLbl val="0"/>
      </c:catAx>
      <c:valAx>
        <c:axId val="536413936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TBP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36411312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7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PGK1'!$K$4:$K$10</c:f>
                <c:numCache>
                  <c:formatCode>General</c:formatCode>
                  <c:ptCount val="7"/>
                  <c:pt idx="0">
                    <c:v>1.0215902494267359E-2</c:v>
                  </c:pt>
                  <c:pt idx="1">
                    <c:v>3.70198802191571E-2</c:v>
                  </c:pt>
                  <c:pt idx="2">
                    <c:v>1.8848878718063726E-2</c:v>
                  </c:pt>
                  <c:pt idx="3">
                    <c:v>3.0536860634442574E-2</c:v>
                  </c:pt>
                  <c:pt idx="4">
                    <c:v>8.1278145641707142E-2</c:v>
                  </c:pt>
                  <c:pt idx="5">
                    <c:v>4.5331474398277186E-2</c:v>
                  </c:pt>
                  <c:pt idx="6">
                    <c:v>2.0762016208818797E-2</c:v>
                  </c:pt>
                </c:numCache>
              </c:numRef>
            </c:plus>
            <c:minus>
              <c:numRef>
                <c:f>'PGK1'!$K$4:$K$10</c:f>
                <c:numCache>
                  <c:formatCode>General</c:formatCode>
                  <c:ptCount val="7"/>
                  <c:pt idx="0">
                    <c:v>1.0215902494267359E-2</c:v>
                  </c:pt>
                  <c:pt idx="1">
                    <c:v>3.70198802191571E-2</c:v>
                  </c:pt>
                  <c:pt idx="2">
                    <c:v>1.8848878718063726E-2</c:v>
                  </c:pt>
                  <c:pt idx="3">
                    <c:v>3.0536860634442574E-2</c:v>
                  </c:pt>
                  <c:pt idx="4">
                    <c:v>8.1278145641707142E-2</c:v>
                  </c:pt>
                  <c:pt idx="5">
                    <c:v>4.5331474398277186E-2</c:v>
                  </c:pt>
                  <c:pt idx="6">
                    <c:v>2.076201620881879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PGK1'!$I$4:$I$10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'PGK1'!$J$4:$J$10</c:f>
              <c:numCache>
                <c:formatCode>General</c:formatCode>
                <c:ptCount val="7"/>
                <c:pt idx="0">
                  <c:v>1</c:v>
                </c:pt>
                <c:pt idx="1">
                  <c:v>0.99446105641487847</c:v>
                </c:pt>
                <c:pt idx="2">
                  <c:v>0.96327634837552933</c:v>
                </c:pt>
                <c:pt idx="3">
                  <c:v>0.99938581335659293</c:v>
                </c:pt>
                <c:pt idx="4">
                  <c:v>1.0016691922718415</c:v>
                </c:pt>
                <c:pt idx="5">
                  <c:v>1.0517188605020611</c:v>
                </c:pt>
                <c:pt idx="6">
                  <c:v>1.02499206339919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64F-40E6-9884-ED7E25D6BF5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48672544"/>
        <c:axId val="548678120"/>
      </c:barChart>
      <c:catAx>
        <c:axId val="54867254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48678120"/>
        <c:crosses val="autoZero"/>
        <c:auto val="1"/>
        <c:lblAlgn val="ctr"/>
        <c:lblOffset val="100"/>
        <c:noMultiLvlLbl val="0"/>
      </c:catAx>
      <c:valAx>
        <c:axId val="548678120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PGK1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48672544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7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PPIA-2'!$K$4:$K$10</c:f>
                <c:numCache>
                  <c:formatCode>General</c:formatCode>
                  <c:ptCount val="7"/>
                  <c:pt idx="0">
                    <c:v>3.05138787885505E-2</c:v>
                  </c:pt>
                  <c:pt idx="1">
                    <c:v>3.8552479777076473E-2</c:v>
                  </c:pt>
                  <c:pt idx="2">
                    <c:v>8.7369982600676244E-2</c:v>
                  </c:pt>
                  <c:pt idx="3">
                    <c:v>1.7775690861913124E-2</c:v>
                  </c:pt>
                  <c:pt idx="4">
                    <c:v>5.6477807728767815E-2</c:v>
                  </c:pt>
                  <c:pt idx="5">
                    <c:v>5.2760427010009325E-2</c:v>
                  </c:pt>
                  <c:pt idx="6">
                    <c:v>5.6106903045833469E-2</c:v>
                  </c:pt>
                </c:numCache>
              </c:numRef>
            </c:plus>
            <c:minus>
              <c:numRef>
                <c:f>'PPIA-2'!$K$4:$K$10</c:f>
                <c:numCache>
                  <c:formatCode>General</c:formatCode>
                  <c:ptCount val="7"/>
                  <c:pt idx="0">
                    <c:v>3.05138787885505E-2</c:v>
                  </c:pt>
                  <c:pt idx="1">
                    <c:v>3.8552479777076473E-2</c:v>
                  </c:pt>
                  <c:pt idx="2">
                    <c:v>8.7369982600676244E-2</c:v>
                  </c:pt>
                  <c:pt idx="3">
                    <c:v>1.7775690861913124E-2</c:v>
                  </c:pt>
                  <c:pt idx="4">
                    <c:v>5.6477807728767815E-2</c:v>
                  </c:pt>
                  <c:pt idx="5">
                    <c:v>5.2760427010009325E-2</c:v>
                  </c:pt>
                  <c:pt idx="6">
                    <c:v>5.6106903045833469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PPIA-2'!$I$4:$I$10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'PPIA-2'!$J$4:$J$10</c:f>
              <c:numCache>
                <c:formatCode>General</c:formatCode>
                <c:ptCount val="7"/>
                <c:pt idx="0">
                  <c:v>1</c:v>
                </c:pt>
                <c:pt idx="1">
                  <c:v>1.0463701480249041</c:v>
                </c:pt>
                <c:pt idx="2">
                  <c:v>1.0810255796315997</c:v>
                </c:pt>
                <c:pt idx="3">
                  <c:v>1.1642018070567319</c:v>
                </c:pt>
                <c:pt idx="4">
                  <c:v>1.1059510086549897</c:v>
                </c:pt>
                <c:pt idx="5">
                  <c:v>1.211894452876811</c:v>
                </c:pt>
                <c:pt idx="6">
                  <c:v>0.9728744262299725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A59-42C7-AAC8-C10542A413E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36794616"/>
        <c:axId val="636804784"/>
      </c:barChart>
      <c:catAx>
        <c:axId val="63679461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36804784"/>
        <c:crosses val="autoZero"/>
        <c:auto val="1"/>
        <c:lblAlgn val="ctr"/>
        <c:lblOffset val="100"/>
        <c:noMultiLvlLbl val="0"/>
      </c:catAx>
      <c:valAx>
        <c:axId val="636804784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PPIA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36794616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7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GAPDH!$K$4:$K$10</c:f>
                <c:numCache>
                  <c:formatCode>General</c:formatCode>
                  <c:ptCount val="7"/>
                  <c:pt idx="0">
                    <c:v>2.4742910933443461E-2</c:v>
                  </c:pt>
                  <c:pt idx="1">
                    <c:v>2.891198408561154E-2</c:v>
                  </c:pt>
                  <c:pt idx="2">
                    <c:v>1.3139685536806193E-2</c:v>
                  </c:pt>
                  <c:pt idx="3">
                    <c:v>4.0599835340624203E-2</c:v>
                  </c:pt>
                  <c:pt idx="4">
                    <c:v>3.6954741654224819E-2</c:v>
                  </c:pt>
                  <c:pt idx="5">
                    <c:v>6.2941533860911836E-2</c:v>
                  </c:pt>
                  <c:pt idx="6">
                    <c:v>4.3944775911170679E-2</c:v>
                  </c:pt>
                </c:numCache>
              </c:numRef>
            </c:plus>
            <c:minus>
              <c:numRef>
                <c:f>GAPDH!$K$4:$K$10</c:f>
                <c:numCache>
                  <c:formatCode>General</c:formatCode>
                  <c:ptCount val="7"/>
                  <c:pt idx="0">
                    <c:v>2.4742910933443461E-2</c:v>
                  </c:pt>
                  <c:pt idx="1">
                    <c:v>2.891198408561154E-2</c:v>
                  </c:pt>
                  <c:pt idx="2">
                    <c:v>1.3139685536806193E-2</c:v>
                  </c:pt>
                  <c:pt idx="3">
                    <c:v>4.0599835340624203E-2</c:v>
                  </c:pt>
                  <c:pt idx="4">
                    <c:v>3.6954741654224819E-2</c:v>
                  </c:pt>
                  <c:pt idx="5">
                    <c:v>6.2941533860911836E-2</c:v>
                  </c:pt>
                  <c:pt idx="6">
                    <c:v>4.3944775911170679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GAPDH!$I$4:$I$10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GAPDH!$J$4:$J$10</c:f>
              <c:numCache>
                <c:formatCode>General</c:formatCode>
                <c:ptCount val="7"/>
                <c:pt idx="0">
                  <c:v>1</c:v>
                </c:pt>
                <c:pt idx="1">
                  <c:v>1.0166648684514892</c:v>
                </c:pt>
                <c:pt idx="2">
                  <c:v>0.91141287588761244</c:v>
                </c:pt>
                <c:pt idx="3">
                  <c:v>0.96092221997380778</c:v>
                </c:pt>
                <c:pt idx="4">
                  <c:v>0.92839552821920612</c:v>
                </c:pt>
                <c:pt idx="5">
                  <c:v>1.0277239040229087</c:v>
                </c:pt>
                <c:pt idx="6">
                  <c:v>0.9209772852279831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209-47FD-B96F-1BC9419A4C4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61853976"/>
        <c:axId val="561852008"/>
      </c:barChart>
      <c:catAx>
        <c:axId val="56185397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61852008"/>
        <c:crosses val="autoZero"/>
        <c:auto val="1"/>
        <c:lblAlgn val="ctr"/>
        <c:lblOffset val="100"/>
        <c:noMultiLvlLbl val="0"/>
      </c:catAx>
      <c:valAx>
        <c:axId val="561852008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GAPDH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6.1802701180621825E-2"/>
              <c:y val="3.9481824371166457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61853976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7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GUSB-2'!$K$4:$K$10</c:f>
                <c:numCache>
                  <c:formatCode>General</c:formatCode>
                  <c:ptCount val="7"/>
                  <c:pt idx="0">
                    <c:v>2.1984093100642411E-2</c:v>
                  </c:pt>
                  <c:pt idx="1">
                    <c:v>4.8019251755997729E-2</c:v>
                  </c:pt>
                  <c:pt idx="2">
                    <c:v>6.537319355006399E-3</c:v>
                  </c:pt>
                  <c:pt idx="3">
                    <c:v>7.4294365004258997E-2</c:v>
                  </c:pt>
                  <c:pt idx="4">
                    <c:v>4.8734570208109666E-2</c:v>
                  </c:pt>
                  <c:pt idx="5">
                    <c:v>3.9096709432471177E-2</c:v>
                  </c:pt>
                  <c:pt idx="6">
                    <c:v>4.1304353840437284E-2</c:v>
                  </c:pt>
                </c:numCache>
              </c:numRef>
            </c:plus>
            <c:minus>
              <c:numRef>
                <c:f>'GUSB-2'!$K$4:$K$10</c:f>
                <c:numCache>
                  <c:formatCode>General</c:formatCode>
                  <c:ptCount val="7"/>
                  <c:pt idx="0">
                    <c:v>2.1984093100642411E-2</c:v>
                  </c:pt>
                  <c:pt idx="1">
                    <c:v>4.8019251755997729E-2</c:v>
                  </c:pt>
                  <c:pt idx="2">
                    <c:v>6.537319355006399E-3</c:v>
                  </c:pt>
                  <c:pt idx="3">
                    <c:v>7.4294365004258997E-2</c:v>
                  </c:pt>
                  <c:pt idx="4">
                    <c:v>4.8734570208109666E-2</c:v>
                  </c:pt>
                  <c:pt idx="5">
                    <c:v>3.9096709432471177E-2</c:v>
                  </c:pt>
                  <c:pt idx="6">
                    <c:v>4.1304353840437284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GUSB-2'!$I$4:$I$10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'GUSB-2'!$J$4:$J$10</c:f>
              <c:numCache>
                <c:formatCode>General</c:formatCode>
                <c:ptCount val="7"/>
                <c:pt idx="0">
                  <c:v>1</c:v>
                </c:pt>
                <c:pt idx="1">
                  <c:v>1.0619808458834454</c:v>
                </c:pt>
                <c:pt idx="2">
                  <c:v>1.0022503090889907</c:v>
                </c:pt>
                <c:pt idx="3">
                  <c:v>1.1163487747269329</c:v>
                </c:pt>
                <c:pt idx="4">
                  <c:v>1.0077984315177</c:v>
                </c:pt>
                <c:pt idx="5">
                  <c:v>1.0450876758525138</c:v>
                </c:pt>
                <c:pt idx="6">
                  <c:v>0.9376357595156695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47D-4973-938C-E0E00CDB120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58446856"/>
        <c:axId val="458449480"/>
      </c:barChart>
      <c:catAx>
        <c:axId val="45844685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58449480"/>
        <c:crosses val="autoZero"/>
        <c:auto val="1"/>
        <c:lblAlgn val="ctr"/>
        <c:lblOffset val="100"/>
        <c:noMultiLvlLbl val="0"/>
      </c:catAx>
      <c:valAx>
        <c:axId val="458449480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GUSB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6.1802701180621825E-2"/>
              <c:y val="7.1067283868099615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58446856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7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ATP5F1-5'!$K$28:$K$34</c:f>
                <c:numCache>
                  <c:formatCode>General</c:formatCode>
                  <c:ptCount val="7"/>
                  <c:pt idx="0">
                    <c:v>4.0760852447117323E-2</c:v>
                  </c:pt>
                  <c:pt idx="1">
                    <c:v>6.7648580256087804E-2</c:v>
                  </c:pt>
                  <c:pt idx="2">
                    <c:v>4.3572844530439248E-2</c:v>
                  </c:pt>
                  <c:pt idx="3">
                    <c:v>1.1650284756886649E-2</c:v>
                  </c:pt>
                  <c:pt idx="4">
                    <c:v>6.8807109321426072E-2</c:v>
                  </c:pt>
                  <c:pt idx="5">
                    <c:v>7.4531912193276664E-2</c:v>
                  </c:pt>
                  <c:pt idx="6">
                    <c:v>3.6165828587621331E-2</c:v>
                  </c:pt>
                </c:numCache>
              </c:numRef>
            </c:plus>
            <c:minus>
              <c:numRef>
                <c:f>'ATP5F1-5'!$K$28:$K$34</c:f>
                <c:numCache>
                  <c:formatCode>General</c:formatCode>
                  <c:ptCount val="7"/>
                  <c:pt idx="0">
                    <c:v>4.0760852447117323E-2</c:v>
                  </c:pt>
                  <c:pt idx="1">
                    <c:v>6.7648580256087804E-2</c:v>
                  </c:pt>
                  <c:pt idx="2">
                    <c:v>4.3572844530439248E-2</c:v>
                  </c:pt>
                  <c:pt idx="3">
                    <c:v>1.1650284756886649E-2</c:v>
                  </c:pt>
                  <c:pt idx="4">
                    <c:v>6.8807109321426072E-2</c:v>
                  </c:pt>
                  <c:pt idx="5">
                    <c:v>7.4531912193276664E-2</c:v>
                  </c:pt>
                  <c:pt idx="6">
                    <c:v>3.616582858762133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ATP5F1-5'!$I$28:$I$34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'ATP5F1-5'!$J$28:$J$34</c:f>
              <c:numCache>
                <c:formatCode>General</c:formatCode>
                <c:ptCount val="7"/>
                <c:pt idx="0">
                  <c:v>1</c:v>
                </c:pt>
                <c:pt idx="1">
                  <c:v>0.98164266947358136</c:v>
                </c:pt>
                <c:pt idx="2">
                  <c:v>0.98947820289092725</c:v>
                </c:pt>
                <c:pt idx="3">
                  <c:v>0.97551301094778964</c:v>
                </c:pt>
                <c:pt idx="4">
                  <c:v>0.9949831856797271</c:v>
                </c:pt>
                <c:pt idx="5">
                  <c:v>0.94682377387735084</c:v>
                </c:pt>
                <c:pt idx="6">
                  <c:v>0.853841173327176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0E2-4DBB-82D3-A627C652D60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59631392"/>
        <c:axId val="659631720"/>
      </c:barChart>
      <c:catAx>
        <c:axId val="65963139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59631720"/>
        <c:crosses val="autoZero"/>
        <c:auto val="1"/>
        <c:lblAlgn val="ctr"/>
        <c:lblOffset val="100"/>
        <c:noMultiLvlLbl val="0"/>
      </c:catAx>
      <c:valAx>
        <c:axId val="659631720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ATP5F1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6.1663329696212098E-2"/>
              <c:y val="1.5792729748466582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59631392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7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TFRC!$K$28:$K$34</c:f>
                <c:numCache>
                  <c:formatCode>General</c:formatCode>
                  <c:ptCount val="7"/>
                  <c:pt idx="0">
                    <c:v>5.1018278359170131E-2</c:v>
                  </c:pt>
                  <c:pt idx="1">
                    <c:v>3.301722590314695E-2</c:v>
                  </c:pt>
                  <c:pt idx="2">
                    <c:v>3.9835541675481798E-2</c:v>
                  </c:pt>
                  <c:pt idx="3">
                    <c:v>4.9090429095048856E-2</c:v>
                  </c:pt>
                  <c:pt idx="4">
                    <c:v>1.3089792574426464E-2</c:v>
                  </c:pt>
                  <c:pt idx="5">
                    <c:v>7.9266937850477545E-2</c:v>
                  </c:pt>
                  <c:pt idx="6">
                    <c:v>5.1487555897855343E-2</c:v>
                  </c:pt>
                </c:numCache>
              </c:numRef>
            </c:plus>
            <c:minus>
              <c:numRef>
                <c:f>TFRC!$K$28:$K$34</c:f>
                <c:numCache>
                  <c:formatCode>General</c:formatCode>
                  <c:ptCount val="7"/>
                  <c:pt idx="0">
                    <c:v>5.1018278359170131E-2</c:v>
                  </c:pt>
                  <c:pt idx="1">
                    <c:v>3.301722590314695E-2</c:v>
                  </c:pt>
                  <c:pt idx="2">
                    <c:v>3.9835541675481798E-2</c:v>
                  </c:pt>
                  <c:pt idx="3">
                    <c:v>4.9090429095048856E-2</c:v>
                  </c:pt>
                  <c:pt idx="4">
                    <c:v>1.3089792574426464E-2</c:v>
                  </c:pt>
                  <c:pt idx="5">
                    <c:v>7.9266937850477545E-2</c:v>
                  </c:pt>
                  <c:pt idx="6">
                    <c:v>5.148755589785534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TFRC!$I$28:$I$34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TFRC!$J$28:$J$34</c:f>
              <c:numCache>
                <c:formatCode>General</c:formatCode>
                <c:ptCount val="7"/>
                <c:pt idx="0">
                  <c:v>1</c:v>
                </c:pt>
                <c:pt idx="1">
                  <c:v>0.95112727928025631</c:v>
                </c:pt>
                <c:pt idx="2">
                  <c:v>0.9785874753944318</c:v>
                </c:pt>
                <c:pt idx="3">
                  <c:v>0.98440124017133535</c:v>
                </c:pt>
                <c:pt idx="4">
                  <c:v>1.0870888186549348</c:v>
                </c:pt>
                <c:pt idx="5">
                  <c:v>1.5993330228798956</c:v>
                </c:pt>
                <c:pt idx="6">
                  <c:v>1.673665081757594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3D7-4D56-8AB4-F76918FB4FC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20019984"/>
        <c:axId val="520024576"/>
      </c:barChart>
      <c:catAx>
        <c:axId val="52001998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20024576"/>
        <c:crosses val="autoZero"/>
        <c:auto val="1"/>
        <c:lblAlgn val="ctr"/>
        <c:lblOffset val="100"/>
        <c:noMultiLvlLbl val="0"/>
      </c:catAx>
      <c:valAx>
        <c:axId val="520024576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TFRC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6.1663329696212098E-2"/>
              <c:y val="6.3170918993866329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20019984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7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YWHAZ-3'!$K$28:$K$34</c:f>
                <c:numCache>
                  <c:formatCode>General</c:formatCode>
                  <c:ptCount val="7"/>
                  <c:pt idx="0">
                    <c:v>2.9735481869526396E-2</c:v>
                  </c:pt>
                  <c:pt idx="1">
                    <c:v>2.2422510576171582E-2</c:v>
                  </c:pt>
                  <c:pt idx="2">
                    <c:v>3.4733706670002605E-2</c:v>
                  </c:pt>
                  <c:pt idx="3">
                    <c:v>9.9469606903265534E-2</c:v>
                  </c:pt>
                  <c:pt idx="4">
                    <c:v>5.237276781346268E-2</c:v>
                  </c:pt>
                  <c:pt idx="5">
                    <c:v>0.16320253422558142</c:v>
                  </c:pt>
                  <c:pt idx="6">
                    <c:v>4.855313492703224E-2</c:v>
                  </c:pt>
                </c:numCache>
              </c:numRef>
            </c:plus>
            <c:minus>
              <c:numRef>
                <c:f>'YWHAZ-3'!$K$28:$K$34</c:f>
                <c:numCache>
                  <c:formatCode>General</c:formatCode>
                  <c:ptCount val="7"/>
                  <c:pt idx="0">
                    <c:v>2.9735481869526396E-2</c:v>
                  </c:pt>
                  <c:pt idx="1">
                    <c:v>2.2422510576171582E-2</c:v>
                  </c:pt>
                  <c:pt idx="2">
                    <c:v>3.4733706670002605E-2</c:v>
                  </c:pt>
                  <c:pt idx="3">
                    <c:v>9.9469606903265534E-2</c:v>
                  </c:pt>
                  <c:pt idx="4">
                    <c:v>5.237276781346268E-2</c:v>
                  </c:pt>
                  <c:pt idx="5">
                    <c:v>0.16320253422558142</c:v>
                  </c:pt>
                  <c:pt idx="6">
                    <c:v>4.855313492703224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YWHAZ-3'!$I$28:$I$34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'YWHAZ-3'!$J$28:$J$34</c:f>
              <c:numCache>
                <c:formatCode>General</c:formatCode>
                <c:ptCount val="7"/>
                <c:pt idx="0">
                  <c:v>1</c:v>
                </c:pt>
                <c:pt idx="1">
                  <c:v>1.0789338796788794</c:v>
                </c:pt>
                <c:pt idx="2">
                  <c:v>1.0660754881156065</c:v>
                </c:pt>
                <c:pt idx="3">
                  <c:v>1.1598341622462505</c:v>
                </c:pt>
                <c:pt idx="4">
                  <c:v>1.283704960266483</c:v>
                </c:pt>
                <c:pt idx="5">
                  <c:v>1.2951801192626176</c:v>
                </c:pt>
                <c:pt idx="6">
                  <c:v>1.401269298720945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392-42A4-9352-2529B164977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74344448"/>
        <c:axId val="574351336"/>
      </c:barChart>
      <c:catAx>
        <c:axId val="57434444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74351336"/>
        <c:crosses val="autoZero"/>
        <c:auto val="1"/>
        <c:lblAlgn val="ctr"/>
        <c:lblOffset val="100"/>
        <c:noMultiLvlLbl val="0"/>
      </c:catAx>
      <c:valAx>
        <c:axId val="574351336"/>
        <c:scaling>
          <c:orientation val="minMax"/>
          <c:max val="1.5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YWHAZ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6.166330247814087E-2"/>
              <c:y val="3.1585459496933165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74344448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7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RPLP0!$K$28:$K$34</c:f>
                <c:numCache>
                  <c:formatCode>General</c:formatCode>
                  <c:ptCount val="7"/>
                  <c:pt idx="0">
                    <c:v>5.0722958838747487E-2</c:v>
                  </c:pt>
                  <c:pt idx="1">
                    <c:v>3.3579120289875086E-2</c:v>
                  </c:pt>
                  <c:pt idx="2">
                    <c:v>2.5708339638483332E-2</c:v>
                  </c:pt>
                  <c:pt idx="3">
                    <c:v>1.6743512982257087E-2</c:v>
                  </c:pt>
                  <c:pt idx="4">
                    <c:v>4.6941539409495026E-2</c:v>
                  </c:pt>
                  <c:pt idx="5">
                    <c:v>0.11603531672739728</c:v>
                  </c:pt>
                  <c:pt idx="6">
                    <c:v>9.0631661715789666E-2</c:v>
                  </c:pt>
                </c:numCache>
              </c:numRef>
            </c:plus>
            <c:minus>
              <c:numRef>
                <c:f>RPLP0!$K$28:$K$34</c:f>
                <c:numCache>
                  <c:formatCode>General</c:formatCode>
                  <c:ptCount val="7"/>
                  <c:pt idx="0">
                    <c:v>5.0722958838747487E-2</c:v>
                  </c:pt>
                  <c:pt idx="1">
                    <c:v>3.3579120289875086E-2</c:v>
                  </c:pt>
                  <c:pt idx="2">
                    <c:v>2.5708339638483332E-2</c:v>
                  </c:pt>
                  <c:pt idx="3">
                    <c:v>1.6743512982257087E-2</c:v>
                  </c:pt>
                  <c:pt idx="4">
                    <c:v>4.6941539409495026E-2</c:v>
                  </c:pt>
                  <c:pt idx="5">
                    <c:v>0.11603531672739728</c:v>
                  </c:pt>
                  <c:pt idx="6">
                    <c:v>9.063166171578966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RPLP0!$I$28:$I$34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RPLP0!$J$28:$J$34</c:f>
              <c:numCache>
                <c:formatCode>General</c:formatCode>
                <c:ptCount val="7"/>
                <c:pt idx="0">
                  <c:v>1</c:v>
                </c:pt>
                <c:pt idx="1">
                  <c:v>1.0225821106491859</c:v>
                </c:pt>
                <c:pt idx="2">
                  <c:v>1.0808488674114229</c:v>
                </c:pt>
                <c:pt idx="3">
                  <c:v>1.0056279076150352</c:v>
                </c:pt>
                <c:pt idx="4">
                  <c:v>1.0398176199653315</c:v>
                </c:pt>
                <c:pt idx="5">
                  <c:v>0.9857545835165662</c:v>
                </c:pt>
                <c:pt idx="6">
                  <c:v>1.13790324612374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66C-44AF-913B-C7FD3E86529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68946960"/>
        <c:axId val="568944336"/>
      </c:barChart>
      <c:catAx>
        <c:axId val="56894696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68944336"/>
        <c:crosses val="autoZero"/>
        <c:auto val="1"/>
        <c:lblAlgn val="ctr"/>
        <c:lblOffset val="100"/>
        <c:noMultiLvlLbl val="0"/>
      </c:catAx>
      <c:valAx>
        <c:axId val="568944336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RPLP0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6.1802701180621825E-2"/>
              <c:y val="3.1585459496933165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68946960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HPRT1-3'!$K$4:$K$10</c:f>
                <c:numCache>
                  <c:formatCode>General</c:formatCode>
                  <c:ptCount val="7"/>
                  <c:pt idx="0">
                    <c:v>6.2187272991576462E-2</c:v>
                  </c:pt>
                  <c:pt idx="1">
                    <c:v>4.5134651117384246E-2</c:v>
                  </c:pt>
                  <c:pt idx="2">
                    <c:v>2.8583144992083011E-2</c:v>
                  </c:pt>
                  <c:pt idx="3">
                    <c:v>2.8606897775878392E-2</c:v>
                  </c:pt>
                  <c:pt idx="4">
                    <c:v>1.8743635111923913E-2</c:v>
                  </c:pt>
                  <c:pt idx="5">
                    <c:v>1.2919585913611401E-2</c:v>
                  </c:pt>
                  <c:pt idx="6">
                    <c:v>4.3639276685851595E-2</c:v>
                  </c:pt>
                </c:numCache>
              </c:numRef>
            </c:plus>
            <c:minus>
              <c:numRef>
                <c:f>'HPRT1-3'!$K$4:$K$10</c:f>
                <c:numCache>
                  <c:formatCode>General</c:formatCode>
                  <c:ptCount val="7"/>
                  <c:pt idx="0">
                    <c:v>6.2187272991576462E-2</c:v>
                  </c:pt>
                  <c:pt idx="1">
                    <c:v>4.5134651117384246E-2</c:v>
                  </c:pt>
                  <c:pt idx="2">
                    <c:v>2.8583144992083011E-2</c:v>
                  </c:pt>
                  <c:pt idx="3">
                    <c:v>2.8606897775878392E-2</c:v>
                  </c:pt>
                  <c:pt idx="4">
                    <c:v>1.8743635111923913E-2</c:v>
                  </c:pt>
                  <c:pt idx="5">
                    <c:v>1.2919585913611401E-2</c:v>
                  </c:pt>
                  <c:pt idx="6">
                    <c:v>4.3639276685851595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HPRT1-3'!$I$4:$I$10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'HPRT1-3'!$J$4:$J$10</c:f>
              <c:numCache>
                <c:formatCode>General</c:formatCode>
                <c:ptCount val="7"/>
                <c:pt idx="0">
                  <c:v>1</c:v>
                </c:pt>
                <c:pt idx="1">
                  <c:v>1.0510449564674291</c:v>
                </c:pt>
                <c:pt idx="2">
                  <c:v>0.85659011283552744</c:v>
                </c:pt>
                <c:pt idx="3">
                  <c:v>0.69102620492434708</c:v>
                </c:pt>
                <c:pt idx="4">
                  <c:v>0.66837628767386337</c:v>
                </c:pt>
                <c:pt idx="5">
                  <c:v>0.72504129630213787</c:v>
                </c:pt>
                <c:pt idx="6">
                  <c:v>0.7512027722156627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5BE-47CD-B19D-CF12404AE37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28688272"/>
        <c:axId val="528688600"/>
      </c:barChart>
      <c:catAx>
        <c:axId val="52868827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28688600"/>
        <c:crosses val="autoZero"/>
        <c:auto val="1"/>
        <c:lblAlgn val="ctr"/>
        <c:lblOffset val="100"/>
        <c:noMultiLvlLbl val="0"/>
      </c:catAx>
      <c:valAx>
        <c:axId val="528688600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HPRT1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6.166330247814087E-2"/>
              <c:y val="4.7378189245399743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28688272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  <c:userShapes r:id="rId4"/>
</c:chartSpace>
</file>

<file path=ppt/charts/chart8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RPLP1!$K$28:$K$34</c:f>
                <c:numCache>
                  <c:formatCode>General</c:formatCode>
                  <c:ptCount val="7"/>
                  <c:pt idx="0">
                    <c:v>3.4466529669067533E-2</c:v>
                  </c:pt>
                  <c:pt idx="1">
                    <c:v>3.0818750346596417E-2</c:v>
                  </c:pt>
                  <c:pt idx="2">
                    <c:v>4.6238791781895945E-2</c:v>
                  </c:pt>
                  <c:pt idx="3">
                    <c:v>5.1050934035435341E-2</c:v>
                  </c:pt>
                  <c:pt idx="4">
                    <c:v>7.2839840223918012E-2</c:v>
                  </c:pt>
                  <c:pt idx="5">
                    <c:v>9.5477222330425451E-2</c:v>
                  </c:pt>
                  <c:pt idx="6">
                    <c:v>5.7424364311539806E-2</c:v>
                  </c:pt>
                </c:numCache>
              </c:numRef>
            </c:plus>
            <c:minus>
              <c:numRef>
                <c:f>RPLP1!$K$28:$K$34</c:f>
                <c:numCache>
                  <c:formatCode>General</c:formatCode>
                  <c:ptCount val="7"/>
                  <c:pt idx="0">
                    <c:v>3.4466529669067533E-2</c:v>
                  </c:pt>
                  <c:pt idx="1">
                    <c:v>3.0818750346596417E-2</c:v>
                  </c:pt>
                  <c:pt idx="2">
                    <c:v>4.6238791781895945E-2</c:v>
                  </c:pt>
                  <c:pt idx="3">
                    <c:v>5.1050934035435341E-2</c:v>
                  </c:pt>
                  <c:pt idx="4">
                    <c:v>7.2839840223918012E-2</c:v>
                  </c:pt>
                  <c:pt idx="5">
                    <c:v>9.5477222330425451E-2</c:v>
                  </c:pt>
                  <c:pt idx="6">
                    <c:v>5.742436431153980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RPLP1!$I$28:$I$34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RPLP1!$J$28:$J$34</c:f>
              <c:numCache>
                <c:formatCode>General</c:formatCode>
                <c:ptCount val="7"/>
                <c:pt idx="0">
                  <c:v>1</c:v>
                </c:pt>
                <c:pt idx="1">
                  <c:v>1.0376540793810165</c:v>
                </c:pt>
                <c:pt idx="2">
                  <c:v>1.0713410205295941</c:v>
                </c:pt>
                <c:pt idx="3">
                  <c:v>1.0513101801813063</c:v>
                </c:pt>
                <c:pt idx="4">
                  <c:v>1.0984465773392917</c:v>
                </c:pt>
                <c:pt idx="5">
                  <c:v>0.96009684821138175</c:v>
                </c:pt>
                <c:pt idx="6">
                  <c:v>1.021761154765126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06A-4E34-AB16-0CF96D2230B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21081192"/>
        <c:axId val="521084472"/>
      </c:barChart>
      <c:catAx>
        <c:axId val="52108119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21084472"/>
        <c:crosses val="autoZero"/>
        <c:auto val="1"/>
        <c:lblAlgn val="ctr"/>
        <c:lblOffset val="100"/>
        <c:noMultiLvlLbl val="0"/>
      </c:catAx>
      <c:valAx>
        <c:axId val="521084472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RPLP1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6.1802701180621825E-2"/>
              <c:y val="3.1585459496933165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21081192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8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ACTB-2'!$K$28:$K$34</c:f>
                <c:numCache>
                  <c:formatCode>General</c:formatCode>
                  <c:ptCount val="7"/>
                  <c:pt idx="0">
                    <c:v>2.593225967821355E-2</c:v>
                  </c:pt>
                  <c:pt idx="1">
                    <c:v>7.6097727579809843E-2</c:v>
                  </c:pt>
                  <c:pt idx="2">
                    <c:v>1.40161666203242E-2</c:v>
                  </c:pt>
                  <c:pt idx="3">
                    <c:v>1.6662826640945559E-2</c:v>
                  </c:pt>
                  <c:pt idx="4">
                    <c:v>4.3586487039469012E-2</c:v>
                  </c:pt>
                  <c:pt idx="5">
                    <c:v>5.4875893582007625E-2</c:v>
                  </c:pt>
                  <c:pt idx="6">
                    <c:v>3.1179684229698693E-2</c:v>
                  </c:pt>
                </c:numCache>
              </c:numRef>
            </c:plus>
            <c:minus>
              <c:numRef>
                <c:f>'ACTB-2'!$K$28:$K$34</c:f>
                <c:numCache>
                  <c:formatCode>General</c:formatCode>
                  <c:ptCount val="7"/>
                  <c:pt idx="0">
                    <c:v>2.593225967821355E-2</c:v>
                  </c:pt>
                  <c:pt idx="1">
                    <c:v>7.6097727579809843E-2</c:v>
                  </c:pt>
                  <c:pt idx="2">
                    <c:v>1.40161666203242E-2</c:v>
                  </c:pt>
                  <c:pt idx="3">
                    <c:v>1.6662826640945559E-2</c:v>
                  </c:pt>
                  <c:pt idx="4">
                    <c:v>4.3586487039469012E-2</c:v>
                  </c:pt>
                  <c:pt idx="5">
                    <c:v>5.4875893582007625E-2</c:v>
                  </c:pt>
                  <c:pt idx="6">
                    <c:v>3.117968422969869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ACTB-2'!$I$28:$I$34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'ACTB-2'!$J$28:$J$34</c:f>
              <c:numCache>
                <c:formatCode>General</c:formatCode>
                <c:ptCount val="7"/>
                <c:pt idx="0">
                  <c:v>1</c:v>
                </c:pt>
                <c:pt idx="1">
                  <c:v>0.96322071681080368</c:v>
                </c:pt>
                <c:pt idx="2">
                  <c:v>1.0509669550532732</c:v>
                </c:pt>
                <c:pt idx="3">
                  <c:v>1.015911013044136</c:v>
                </c:pt>
                <c:pt idx="4">
                  <c:v>0.93529160531943534</c:v>
                </c:pt>
                <c:pt idx="5">
                  <c:v>0.63205661137343949</c:v>
                </c:pt>
                <c:pt idx="6">
                  <c:v>0.6419572675303392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555-4B21-8F28-7E2B8541E24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15837632"/>
        <c:axId val="515838616"/>
      </c:barChart>
      <c:catAx>
        <c:axId val="51583763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15838616"/>
        <c:crosses val="autoZero"/>
        <c:auto val="1"/>
        <c:lblAlgn val="ctr"/>
        <c:lblOffset val="100"/>
        <c:noMultiLvlLbl val="0"/>
      </c:catAx>
      <c:valAx>
        <c:axId val="515838616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ACTB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6.1802701180621825E-2"/>
              <c:y val="6.3170918993866329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15837632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8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RPLP2!$K$28:$K$34</c:f>
                <c:numCache>
                  <c:formatCode>General</c:formatCode>
                  <c:ptCount val="7"/>
                  <c:pt idx="0">
                    <c:v>3.6214437202891227E-2</c:v>
                  </c:pt>
                  <c:pt idx="1">
                    <c:v>4.6310402655647488E-2</c:v>
                  </c:pt>
                  <c:pt idx="2">
                    <c:v>1.6766302871650787E-2</c:v>
                  </c:pt>
                  <c:pt idx="3">
                    <c:v>2.1082901046637986E-2</c:v>
                  </c:pt>
                  <c:pt idx="4">
                    <c:v>5.0296515699534E-2</c:v>
                  </c:pt>
                  <c:pt idx="5">
                    <c:v>2.4002683586774876E-2</c:v>
                  </c:pt>
                  <c:pt idx="6">
                    <c:v>4.3163777111692662E-2</c:v>
                  </c:pt>
                </c:numCache>
              </c:numRef>
            </c:plus>
            <c:minus>
              <c:numRef>
                <c:f>RPLP2!$K$28:$K$34</c:f>
                <c:numCache>
                  <c:formatCode>General</c:formatCode>
                  <c:ptCount val="7"/>
                  <c:pt idx="0">
                    <c:v>3.6214437202891227E-2</c:v>
                  </c:pt>
                  <c:pt idx="1">
                    <c:v>4.6310402655647488E-2</c:v>
                  </c:pt>
                  <c:pt idx="2">
                    <c:v>1.6766302871650787E-2</c:v>
                  </c:pt>
                  <c:pt idx="3">
                    <c:v>2.1082901046637986E-2</c:v>
                  </c:pt>
                  <c:pt idx="4">
                    <c:v>5.0296515699534E-2</c:v>
                  </c:pt>
                  <c:pt idx="5">
                    <c:v>2.4002683586774876E-2</c:v>
                  </c:pt>
                  <c:pt idx="6">
                    <c:v>4.316377711169266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RPLP2!$I$28:$I$34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RPLP2!$J$28:$J$34</c:f>
              <c:numCache>
                <c:formatCode>General</c:formatCode>
                <c:ptCount val="7"/>
                <c:pt idx="0">
                  <c:v>1</c:v>
                </c:pt>
                <c:pt idx="1">
                  <c:v>1.0158625453647037</c:v>
                </c:pt>
                <c:pt idx="2">
                  <c:v>1.0245766156685174</c:v>
                </c:pt>
                <c:pt idx="3">
                  <c:v>1.0899410723077883</c:v>
                </c:pt>
                <c:pt idx="4">
                  <c:v>1.0205154090759005</c:v>
                </c:pt>
                <c:pt idx="5">
                  <c:v>1.0154867584394272</c:v>
                </c:pt>
                <c:pt idx="6">
                  <c:v>1.04430276203390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19E-4BBF-8466-F4ACB981429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15836976"/>
        <c:axId val="515835008"/>
      </c:barChart>
      <c:catAx>
        <c:axId val="51583697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15835008"/>
        <c:crosses val="autoZero"/>
        <c:auto val="1"/>
        <c:lblAlgn val="ctr"/>
        <c:lblOffset val="100"/>
        <c:noMultiLvlLbl val="0"/>
      </c:catAx>
      <c:valAx>
        <c:axId val="515835008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RPLP2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6.1802701180621825E-2"/>
              <c:y val="6.3170918993866329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15836976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8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HPRT1-2'!$K$28:$K$34</c:f>
                <c:numCache>
                  <c:formatCode>General</c:formatCode>
                  <c:ptCount val="7"/>
                  <c:pt idx="0">
                    <c:v>3.8432755657067066E-2</c:v>
                  </c:pt>
                  <c:pt idx="1">
                    <c:v>7.5210795045633216E-2</c:v>
                  </c:pt>
                  <c:pt idx="2">
                    <c:v>3.1339908848391489E-2</c:v>
                  </c:pt>
                  <c:pt idx="3">
                    <c:v>3.4276157670541957E-2</c:v>
                  </c:pt>
                  <c:pt idx="4">
                    <c:v>4.7737514211851594E-3</c:v>
                  </c:pt>
                  <c:pt idx="5">
                    <c:v>3.3669875643180469E-2</c:v>
                  </c:pt>
                  <c:pt idx="6">
                    <c:v>3.6546068079555134E-2</c:v>
                  </c:pt>
                </c:numCache>
              </c:numRef>
            </c:plus>
            <c:minus>
              <c:numRef>
                <c:f>'HPRT1-2'!$K$28:$K$34</c:f>
                <c:numCache>
                  <c:formatCode>General</c:formatCode>
                  <c:ptCount val="7"/>
                  <c:pt idx="0">
                    <c:v>3.8432755657067066E-2</c:v>
                  </c:pt>
                  <c:pt idx="1">
                    <c:v>7.5210795045633216E-2</c:v>
                  </c:pt>
                  <c:pt idx="2">
                    <c:v>3.1339908848391489E-2</c:v>
                  </c:pt>
                  <c:pt idx="3">
                    <c:v>3.4276157670541957E-2</c:v>
                  </c:pt>
                  <c:pt idx="4">
                    <c:v>4.7737514211851594E-3</c:v>
                  </c:pt>
                  <c:pt idx="5">
                    <c:v>3.3669875643180469E-2</c:v>
                  </c:pt>
                  <c:pt idx="6">
                    <c:v>3.6546068079555134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HPRT1-2'!$I$28:$I$34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'HPRT1-2'!$J$28:$J$34</c:f>
              <c:numCache>
                <c:formatCode>General</c:formatCode>
                <c:ptCount val="7"/>
                <c:pt idx="0">
                  <c:v>1</c:v>
                </c:pt>
                <c:pt idx="1">
                  <c:v>1.0039011492574839</c:v>
                </c:pt>
                <c:pt idx="2">
                  <c:v>1.0553387764608531</c:v>
                </c:pt>
                <c:pt idx="3">
                  <c:v>1.0387382715594347</c:v>
                </c:pt>
                <c:pt idx="4">
                  <c:v>1.0495372349110699</c:v>
                </c:pt>
                <c:pt idx="5">
                  <c:v>1.1475453601429215</c:v>
                </c:pt>
                <c:pt idx="6">
                  <c:v>1.25909779744904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031-47A8-95F2-C7A4D3E5745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35118392"/>
        <c:axId val="535119048"/>
      </c:barChart>
      <c:catAx>
        <c:axId val="53511839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35119048"/>
        <c:crosses val="autoZero"/>
        <c:auto val="1"/>
        <c:lblAlgn val="ctr"/>
        <c:lblOffset val="100"/>
        <c:noMultiLvlLbl val="0"/>
      </c:catAx>
      <c:valAx>
        <c:axId val="535119048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HPRT1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6.1802701180621825E-2"/>
              <c:y val="4.7378189245399743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35118392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8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B2M!$K$28:$K$34</c:f>
                <c:numCache>
                  <c:formatCode>General</c:formatCode>
                  <c:ptCount val="7"/>
                  <c:pt idx="0">
                    <c:v>6.769491538176655E-3</c:v>
                  </c:pt>
                  <c:pt idx="1">
                    <c:v>3.4536420820777375E-2</c:v>
                  </c:pt>
                  <c:pt idx="2">
                    <c:v>4.0415621488596627E-2</c:v>
                  </c:pt>
                  <c:pt idx="3">
                    <c:v>2.608123287361799E-2</c:v>
                  </c:pt>
                  <c:pt idx="4">
                    <c:v>7.2686825953418299E-2</c:v>
                  </c:pt>
                  <c:pt idx="5">
                    <c:v>2.8582463690901096E-2</c:v>
                  </c:pt>
                  <c:pt idx="6">
                    <c:v>1.5081583372442345E-2</c:v>
                  </c:pt>
                </c:numCache>
              </c:numRef>
            </c:plus>
            <c:minus>
              <c:numRef>
                <c:f>B2M!$K$28:$K$34</c:f>
                <c:numCache>
                  <c:formatCode>General</c:formatCode>
                  <c:ptCount val="7"/>
                  <c:pt idx="0">
                    <c:v>6.769491538176655E-3</c:v>
                  </c:pt>
                  <c:pt idx="1">
                    <c:v>3.4536420820777375E-2</c:v>
                  </c:pt>
                  <c:pt idx="2">
                    <c:v>4.0415621488596627E-2</c:v>
                  </c:pt>
                  <c:pt idx="3">
                    <c:v>2.608123287361799E-2</c:v>
                  </c:pt>
                  <c:pt idx="4">
                    <c:v>7.2686825953418299E-2</c:v>
                  </c:pt>
                  <c:pt idx="5">
                    <c:v>2.8582463690901096E-2</c:v>
                  </c:pt>
                  <c:pt idx="6">
                    <c:v>1.5081583372442345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B2M!$I$28:$I$34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B2M!$J$28:$J$34</c:f>
              <c:numCache>
                <c:formatCode>General</c:formatCode>
                <c:ptCount val="7"/>
                <c:pt idx="0">
                  <c:v>1</c:v>
                </c:pt>
                <c:pt idx="1">
                  <c:v>1.0032651921820122</c:v>
                </c:pt>
                <c:pt idx="2">
                  <c:v>1.0347686688690125</c:v>
                </c:pt>
                <c:pt idx="3">
                  <c:v>1.009801707362685</c:v>
                </c:pt>
                <c:pt idx="4">
                  <c:v>0.97965337977971501</c:v>
                </c:pt>
                <c:pt idx="5">
                  <c:v>0.96449064037224275</c:v>
                </c:pt>
                <c:pt idx="6">
                  <c:v>1.055342441352865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289-42BD-964A-1A0B24BAA30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86298384"/>
        <c:axId val="586296744"/>
      </c:barChart>
      <c:catAx>
        <c:axId val="58629838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86296744"/>
        <c:crosses val="autoZero"/>
        <c:auto val="1"/>
        <c:lblAlgn val="ctr"/>
        <c:lblOffset val="100"/>
        <c:noMultiLvlLbl val="0"/>
      </c:catAx>
      <c:valAx>
        <c:axId val="586296744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B2M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86298384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8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PS18-3'!$K$28:$K$34</c:f>
                <c:numCache>
                  <c:formatCode>General</c:formatCode>
                  <c:ptCount val="7"/>
                  <c:pt idx="0">
                    <c:v>5.1462932895871775E-2</c:v>
                  </c:pt>
                  <c:pt idx="1">
                    <c:v>5.5295922600543161E-2</c:v>
                  </c:pt>
                  <c:pt idx="2">
                    <c:v>3.3528566923269117E-2</c:v>
                  </c:pt>
                  <c:pt idx="3">
                    <c:v>6.5023812152654153E-2</c:v>
                  </c:pt>
                  <c:pt idx="4">
                    <c:v>6.4501262529252965E-2</c:v>
                  </c:pt>
                  <c:pt idx="5">
                    <c:v>6.8412964389335904E-2</c:v>
                  </c:pt>
                  <c:pt idx="6">
                    <c:v>4.3992130956877283E-2</c:v>
                  </c:pt>
                </c:numCache>
              </c:numRef>
            </c:plus>
            <c:minus>
              <c:numRef>
                <c:f>'RPS18-3'!$K$28:$K$34</c:f>
                <c:numCache>
                  <c:formatCode>General</c:formatCode>
                  <c:ptCount val="7"/>
                  <c:pt idx="0">
                    <c:v>5.1462932895871775E-2</c:v>
                  </c:pt>
                  <c:pt idx="1">
                    <c:v>5.5295922600543161E-2</c:v>
                  </c:pt>
                  <c:pt idx="2">
                    <c:v>3.3528566923269117E-2</c:v>
                  </c:pt>
                  <c:pt idx="3">
                    <c:v>6.5023812152654153E-2</c:v>
                  </c:pt>
                  <c:pt idx="4">
                    <c:v>6.4501262529252965E-2</c:v>
                  </c:pt>
                  <c:pt idx="5">
                    <c:v>6.8412964389335904E-2</c:v>
                  </c:pt>
                  <c:pt idx="6">
                    <c:v>4.399213095687728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RPS18-3'!$I$28:$I$34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'RPS18-3'!$J$28:$J$34</c:f>
              <c:numCache>
                <c:formatCode>General</c:formatCode>
                <c:ptCount val="7"/>
                <c:pt idx="0">
                  <c:v>1</c:v>
                </c:pt>
                <c:pt idx="1">
                  <c:v>0.95311703398946401</c:v>
                </c:pt>
                <c:pt idx="2">
                  <c:v>0.99484808509170042</c:v>
                </c:pt>
                <c:pt idx="3">
                  <c:v>0.96820756501787175</c:v>
                </c:pt>
                <c:pt idx="4">
                  <c:v>0.98538327827729033</c:v>
                </c:pt>
                <c:pt idx="5">
                  <c:v>0.89934132630292574</c:v>
                </c:pt>
                <c:pt idx="6">
                  <c:v>0.8992386378552571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97A-4EA9-B85C-4B9A474D5B3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33126512"/>
        <c:axId val="533125200"/>
      </c:barChart>
      <c:catAx>
        <c:axId val="53312651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33125200"/>
        <c:crosses val="autoZero"/>
        <c:auto val="1"/>
        <c:lblAlgn val="ctr"/>
        <c:lblOffset val="100"/>
        <c:noMultiLvlLbl val="0"/>
      </c:catAx>
      <c:valAx>
        <c:axId val="533125200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RPS18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6.1802701180621825E-2"/>
              <c:y val="6.3170918993866329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33126512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8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TBP!$K$28:$K$34</c:f>
                <c:numCache>
                  <c:formatCode>General</c:formatCode>
                  <c:ptCount val="7"/>
                  <c:pt idx="0">
                    <c:v>1.4327669562593591E-2</c:v>
                  </c:pt>
                  <c:pt idx="1">
                    <c:v>2.5141343632613479E-2</c:v>
                  </c:pt>
                  <c:pt idx="2">
                    <c:v>1.6267685192851235E-2</c:v>
                  </c:pt>
                  <c:pt idx="3">
                    <c:v>2.13472954487633E-2</c:v>
                  </c:pt>
                  <c:pt idx="4">
                    <c:v>3.5981701608720246E-2</c:v>
                  </c:pt>
                  <c:pt idx="5">
                    <c:v>3.3147364074092578E-2</c:v>
                  </c:pt>
                  <c:pt idx="6">
                    <c:v>5.391732168464855E-2</c:v>
                  </c:pt>
                </c:numCache>
              </c:numRef>
            </c:plus>
            <c:minus>
              <c:numRef>
                <c:f>TBP!$K$28:$K$34</c:f>
                <c:numCache>
                  <c:formatCode>General</c:formatCode>
                  <c:ptCount val="7"/>
                  <c:pt idx="0">
                    <c:v>1.4327669562593591E-2</c:v>
                  </c:pt>
                  <c:pt idx="1">
                    <c:v>2.5141343632613479E-2</c:v>
                  </c:pt>
                  <c:pt idx="2">
                    <c:v>1.6267685192851235E-2</c:v>
                  </c:pt>
                  <c:pt idx="3">
                    <c:v>2.13472954487633E-2</c:v>
                  </c:pt>
                  <c:pt idx="4">
                    <c:v>3.5981701608720246E-2</c:v>
                  </c:pt>
                  <c:pt idx="5">
                    <c:v>3.3147364074092578E-2</c:v>
                  </c:pt>
                  <c:pt idx="6">
                    <c:v>5.391732168464855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TBP!$I$28:$I$34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TBP!$J$28:$J$34</c:f>
              <c:numCache>
                <c:formatCode>General</c:formatCode>
                <c:ptCount val="7"/>
                <c:pt idx="0">
                  <c:v>0.99999999999999989</c:v>
                </c:pt>
                <c:pt idx="1">
                  <c:v>0.87909054471009274</c:v>
                </c:pt>
                <c:pt idx="2">
                  <c:v>0.93016425509368827</c:v>
                </c:pt>
                <c:pt idx="3">
                  <c:v>0.9489470581314432</c:v>
                </c:pt>
                <c:pt idx="4">
                  <c:v>0.93255481871388379</c:v>
                </c:pt>
                <c:pt idx="5">
                  <c:v>0.93391051881934961</c:v>
                </c:pt>
                <c:pt idx="6">
                  <c:v>0.979134397194355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6E9-4A30-AE3C-A7FB091A1AF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36411312"/>
        <c:axId val="536413936"/>
      </c:barChart>
      <c:catAx>
        <c:axId val="53641131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36413936"/>
        <c:crosses val="autoZero"/>
        <c:auto val="1"/>
        <c:lblAlgn val="ctr"/>
        <c:lblOffset val="100"/>
        <c:noMultiLvlLbl val="0"/>
      </c:catAx>
      <c:valAx>
        <c:axId val="536413936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TBP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36411312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8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PGK1'!$K$28:$K$34</c:f>
                <c:numCache>
                  <c:formatCode>General</c:formatCode>
                  <c:ptCount val="7"/>
                  <c:pt idx="0">
                    <c:v>1.8604891192707106E-2</c:v>
                  </c:pt>
                  <c:pt idx="1">
                    <c:v>1.849101495498023E-2</c:v>
                  </c:pt>
                  <c:pt idx="2">
                    <c:v>1.0551378832854584E-2</c:v>
                  </c:pt>
                  <c:pt idx="3">
                    <c:v>8.2512930697453316E-2</c:v>
                  </c:pt>
                  <c:pt idx="4">
                    <c:v>2.0389688194591239E-2</c:v>
                  </c:pt>
                  <c:pt idx="5">
                    <c:v>7.574120501145179E-2</c:v>
                  </c:pt>
                  <c:pt idx="6">
                    <c:v>3.6312859936020778E-2</c:v>
                  </c:pt>
                </c:numCache>
              </c:numRef>
            </c:plus>
            <c:minus>
              <c:numRef>
                <c:f>'PGK1'!$K$28:$K$34</c:f>
                <c:numCache>
                  <c:formatCode>General</c:formatCode>
                  <c:ptCount val="7"/>
                  <c:pt idx="0">
                    <c:v>1.8604891192707106E-2</c:v>
                  </c:pt>
                  <c:pt idx="1">
                    <c:v>1.849101495498023E-2</c:v>
                  </c:pt>
                  <c:pt idx="2">
                    <c:v>1.0551378832854584E-2</c:v>
                  </c:pt>
                  <c:pt idx="3">
                    <c:v>8.2512930697453316E-2</c:v>
                  </c:pt>
                  <c:pt idx="4">
                    <c:v>2.0389688194591239E-2</c:v>
                  </c:pt>
                  <c:pt idx="5">
                    <c:v>7.574120501145179E-2</c:v>
                  </c:pt>
                  <c:pt idx="6">
                    <c:v>3.631285993602077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PGK1'!$I$28:$I$34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'PGK1'!$J$28:$J$34</c:f>
              <c:numCache>
                <c:formatCode>General</c:formatCode>
                <c:ptCount val="7"/>
                <c:pt idx="0">
                  <c:v>1</c:v>
                </c:pt>
                <c:pt idx="1">
                  <c:v>1.0010838686162804</c:v>
                </c:pt>
                <c:pt idx="2">
                  <c:v>1.0658933746716379</c:v>
                </c:pt>
                <c:pt idx="3">
                  <c:v>1.1204769842525708</c:v>
                </c:pt>
                <c:pt idx="4">
                  <c:v>1.0833934729904942</c:v>
                </c:pt>
                <c:pt idx="5">
                  <c:v>1.1653672062178391</c:v>
                </c:pt>
                <c:pt idx="6">
                  <c:v>1.136338718832535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586-4C71-A9CB-7A8EDA4B7F7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48672544"/>
        <c:axId val="548678120"/>
      </c:barChart>
      <c:catAx>
        <c:axId val="54867254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48678120"/>
        <c:crosses val="autoZero"/>
        <c:auto val="1"/>
        <c:lblAlgn val="ctr"/>
        <c:lblOffset val="100"/>
        <c:noMultiLvlLbl val="0"/>
      </c:catAx>
      <c:valAx>
        <c:axId val="548678120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PGK1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6.1802701180621825E-2"/>
              <c:y val="6.3170918993866329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48672544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8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PPIA-2'!$K$28:$K$34</c:f>
                <c:numCache>
                  <c:formatCode>General</c:formatCode>
                  <c:ptCount val="7"/>
                  <c:pt idx="0">
                    <c:v>9.2086168853618297E-2</c:v>
                  </c:pt>
                  <c:pt idx="1">
                    <c:v>2.3962535514136643E-2</c:v>
                  </c:pt>
                  <c:pt idx="2">
                    <c:v>8.1274925904726195E-2</c:v>
                  </c:pt>
                  <c:pt idx="3">
                    <c:v>8.8754326985066301E-2</c:v>
                  </c:pt>
                  <c:pt idx="4">
                    <c:v>3.0687309180827706E-2</c:v>
                  </c:pt>
                  <c:pt idx="5">
                    <c:v>7.9432910351007968E-2</c:v>
                  </c:pt>
                  <c:pt idx="6">
                    <c:v>9.2690808045367543E-2</c:v>
                  </c:pt>
                </c:numCache>
              </c:numRef>
            </c:plus>
            <c:minus>
              <c:numRef>
                <c:f>'PPIA-2'!$K$28:$K$34</c:f>
                <c:numCache>
                  <c:formatCode>General</c:formatCode>
                  <c:ptCount val="7"/>
                  <c:pt idx="0">
                    <c:v>9.2086168853618297E-2</c:v>
                  </c:pt>
                  <c:pt idx="1">
                    <c:v>2.3962535514136643E-2</c:v>
                  </c:pt>
                  <c:pt idx="2">
                    <c:v>8.1274925904726195E-2</c:v>
                  </c:pt>
                  <c:pt idx="3">
                    <c:v>8.8754326985066301E-2</c:v>
                  </c:pt>
                  <c:pt idx="4">
                    <c:v>3.0687309180827706E-2</c:v>
                  </c:pt>
                  <c:pt idx="5">
                    <c:v>7.9432910351007968E-2</c:v>
                  </c:pt>
                  <c:pt idx="6">
                    <c:v>9.269080804536754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PPIA-2'!$I$28:$I$34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'PPIA-2'!$J$28:$J$34</c:f>
              <c:numCache>
                <c:formatCode>General</c:formatCode>
                <c:ptCount val="7"/>
                <c:pt idx="0">
                  <c:v>1</c:v>
                </c:pt>
                <c:pt idx="1">
                  <c:v>1.024951110659188</c:v>
                </c:pt>
                <c:pt idx="2">
                  <c:v>1.022046653172427</c:v>
                </c:pt>
                <c:pt idx="3">
                  <c:v>1.124261120475877</c:v>
                </c:pt>
                <c:pt idx="4">
                  <c:v>1.2175414900664736</c:v>
                </c:pt>
                <c:pt idx="5">
                  <c:v>1.1206240419042131</c:v>
                </c:pt>
                <c:pt idx="6">
                  <c:v>1.128114074896409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54D-4F22-AB4D-160792BE83E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36794616"/>
        <c:axId val="636804784"/>
      </c:barChart>
      <c:catAx>
        <c:axId val="63679461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36804784"/>
        <c:crosses val="autoZero"/>
        <c:auto val="1"/>
        <c:lblAlgn val="ctr"/>
        <c:lblOffset val="100"/>
        <c:noMultiLvlLbl val="0"/>
      </c:catAx>
      <c:valAx>
        <c:axId val="636804784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PPIA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36794616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8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GAPDH!$K$28:$K$34</c:f>
                <c:numCache>
                  <c:formatCode>General</c:formatCode>
                  <c:ptCount val="7"/>
                  <c:pt idx="0">
                    <c:v>2.753336136417027E-2</c:v>
                  </c:pt>
                  <c:pt idx="1">
                    <c:v>4.1734575226341525E-2</c:v>
                  </c:pt>
                  <c:pt idx="2">
                    <c:v>2.9667793877451755E-2</c:v>
                  </c:pt>
                  <c:pt idx="3">
                    <c:v>1.9771106514024365E-2</c:v>
                  </c:pt>
                  <c:pt idx="4">
                    <c:v>8.5413922702629999E-2</c:v>
                  </c:pt>
                  <c:pt idx="5">
                    <c:v>8.1314677452702142E-2</c:v>
                  </c:pt>
                  <c:pt idx="6">
                    <c:v>2.7678104181697544E-2</c:v>
                  </c:pt>
                </c:numCache>
              </c:numRef>
            </c:plus>
            <c:minus>
              <c:numRef>
                <c:f>GAPDH!$K$28:$K$34</c:f>
                <c:numCache>
                  <c:formatCode>General</c:formatCode>
                  <c:ptCount val="7"/>
                  <c:pt idx="0">
                    <c:v>2.753336136417027E-2</c:v>
                  </c:pt>
                  <c:pt idx="1">
                    <c:v>4.1734575226341525E-2</c:v>
                  </c:pt>
                  <c:pt idx="2">
                    <c:v>2.9667793877451755E-2</c:v>
                  </c:pt>
                  <c:pt idx="3">
                    <c:v>1.9771106514024365E-2</c:v>
                  </c:pt>
                  <c:pt idx="4">
                    <c:v>8.5413922702629999E-2</c:v>
                  </c:pt>
                  <c:pt idx="5">
                    <c:v>8.1314677452702142E-2</c:v>
                  </c:pt>
                  <c:pt idx="6">
                    <c:v>2.7678104181697544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GAPDH!$I$28:$I$34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GAPDH!$J$28:$J$34</c:f>
              <c:numCache>
                <c:formatCode>General</c:formatCode>
                <c:ptCount val="7"/>
                <c:pt idx="0">
                  <c:v>1</c:v>
                </c:pt>
                <c:pt idx="1">
                  <c:v>0.97139695457929864</c:v>
                </c:pt>
                <c:pt idx="2">
                  <c:v>0.94487858115331569</c:v>
                </c:pt>
                <c:pt idx="3">
                  <c:v>0.95143767108791666</c:v>
                </c:pt>
                <c:pt idx="4">
                  <c:v>0.9835318222237891</c:v>
                </c:pt>
                <c:pt idx="5">
                  <c:v>0.99952385201538718</c:v>
                </c:pt>
                <c:pt idx="6">
                  <c:v>0.9076615986791760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700-4DD5-B0F7-9E36815C415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61853976"/>
        <c:axId val="561852008"/>
      </c:barChart>
      <c:catAx>
        <c:axId val="56185397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61852008"/>
        <c:crosses val="autoZero"/>
        <c:auto val="1"/>
        <c:lblAlgn val="ctr"/>
        <c:lblOffset val="100"/>
        <c:noMultiLvlLbl val="0"/>
      </c:catAx>
      <c:valAx>
        <c:axId val="561852008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GAPDH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6.1802701180621825E-2"/>
              <c:y val="4.7378189245399743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61853976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B2M!$K$4:$K$10</c:f>
                <c:numCache>
                  <c:formatCode>General</c:formatCode>
                  <c:ptCount val="7"/>
                  <c:pt idx="0">
                    <c:v>6.788983611522624E-2</c:v>
                  </c:pt>
                  <c:pt idx="1">
                    <c:v>3.6055074794729268E-2</c:v>
                  </c:pt>
                  <c:pt idx="2">
                    <c:v>5.5675105424768417E-2</c:v>
                  </c:pt>
                  <c:pt idx="3">
                    <c:v>5.6865274878613814E-2</c:v>
                  </c:pt>
                  <c:pt idx="4">
                    <c:v>6.3656085278427421E-2</c:v>
                  </c:pt>
                  <c:pt idx="5">
                    <c:v>2.4171702986154852E-2</c:v>
                  </c:pt>
                  <c:pt idx="6">
                    <c:v>6.7334220552925997E-2</c:v>
                  </c:pt>
                </c:numCache>
              </c:numRef>
            </c:plus>
            <c:minus>
              <c:numRef>
                <c:f>B2M!$K$4:$K$10</c:f>
                <c:numCache>
                  <c:formatCode>General</c:formatCode>
                  <c:ptCount val="7"/>
                  <c:pt idx="0">
                    <c:v>6.788983611522624E-2</c:v>
                  </c:pt>
                  <c:pt idx="1">
                    <c:v>3.6055074794729268E-2</c:v>
                  </c:pt>
                  <c:pt idx="2">
                    <c:v>5.5675105424768417E-2</c:v>
                  </c:pt>
                  <c:pt idx="3">
                    <c:v>5.6865274878613814E-2</c:v>
                  </c:pt>
                  <c:pt idx="4">
                    <c:v>6.3656085278427421E-2</c:v>
                  </c:pt>
                  <c:pt idx="5">
                    <c:v>2.4171702986154852E-2</c:v>
                  </c:pt>
                  <c:pt idx="6">
                    <c:v>6.733422055292599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B2M!$I$4:$I$10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B2M!$J$4:$J$10</c:f>
              <c:numCache>
                <c:formatCode>General</c:formatCode>
                <c:ptCount val="7"/>
                <c:pt idx="0">
                  <c:v>1</c:v>
                </c:pt>
                <c:pt idx="1">
                  <c:v>1.055860859537481</c:v>
                </c:pt>
                <c:pt idx="2">
                  <c:v>1.0460782318216157</c:v>
                </c:pt>
                <c:pt idx="3">
                  <c:v>1.0085017948943389</c:v>
                </c:pt>
                <c:pt idx="4">
                  <c:v>1.091005018447063</c:v>
                </c:pt>
                <c:pt idx="5">
                  <c:v>1.0694514447774903</c:v>
                </c:pt>
                <c:pt idx="6">
                  <c:v>1.07840347962267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D9C-4DD0-B789-E0AA87CBBEB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43044032"/>
        <c:axId val="543036816"/>
      </c:barChart>
      <c:catAx>
        <c:axId val="54304403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 (µM)</a:t>
                </a:r>
                <a:endParaRPr lang="ja-JP" altLang="en-US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43036816"/>
        <c:crosses val="autoZero"/>
        <c:auto val="1"/>
        <c:lblAlgn val="ctr"/>
        <c:lblOffset val="100"/>
        <c:noMultiLvlLbl val="0"/>
      </c:catAx>
      <c:valAx>
        <c:axId val="543036816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B2M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43044032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9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GUSB-3'!$K$28:$K$34</c:f>
                <c:numCache>
                  <c:formatCode>General</c:formatCode>
                  <c:ptCount val="7"/>
                  <c:pt idx="0">
                    <c:v>1.791258619841193E-2</c:v>
                  </c:pt>
                  <c:pt idx="1">
                    <c:v>4.3890662887561029E-2</c:v>
                  </c:pt>
                  <c:pt idx="2">
                    <c:v>1.1279369681050023E-2</c:v>
                  </c:pt>
                  <c:pt idx="3">
                    <c:v>3.6893503863896386E-2</c:v>
                  </c:pt>
                  <c:pt idx="4">
                    <c:v>3.8908607923277411E-2</c:v>
                  </c:pt>
                  <c:pt idx="5">
                    <c:v>3.4686690225254897E-2</c:v>
                  </c:pt>
                  <c:pt idx="6">
                    <c:v>3.3228141984818139E-2</c:v>
                  </c:pt>
                </c:numCache>
              </c:numRef>
            </c:plus>
            <c:minus>
              <c:numRef>
                <c:f>'GUSB-3'!$K$28:$K$34</c:f>
                <c:numCache>
                  <c:formatCode>General</c:formatCode>
                  <c:ptCount val="7"/>
                  <c:pt idx="0">
                    <c:v>1.791258619841193E-2</c:v>
                  </c:pt>
                  <c:pt idx="1">
                    <c:v>4.3890662887561029E-2</c:v>
                  </c:pt>
                  <c:pt idx="2">
                    <c:v>1.1279369681050023E-2</c:v>
                  </c:pt>
                  <c:pt idx="3">
                    <c:v>3.6893503863896386E-2</c:v>
                  </c:pt>
                  <c:pt idx="4">
                    <c:v>3.8908607923277411E-2</c:v>
                  </c:pt>
                  <c:pt idx="5">
                    <c:v>3.4686690225254897E-2</c:v>
                  </c:pt>
                  <c:pt idx="6">
                    <c:v>3.3228141984818139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GUSB-3'!$I$28:$I$34</c:f>
              <c:numCache>
                <c:formatCode>General</c:formatCode>
                <c:ptCount val="7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30</c:v>
                </c:pt>
              </c:numCache>
            </c:numRef>
          </c:cat>
          <c:val>
            <c:numRef>
              <c:f>'GUSB-3'!$J$28:$J$34</c:f>
              <c:numCache>
                <c:formatCode>General</c:formatCode>
                <c:ptCount val="7"/>
                <c:pt idx="0">
                  <c:v>1</c:v>
                </c:pt>
                <c:pt idx="1">
                  <c:v>0.99700617694720428</c:v>
                </c:pt>
                <c:pt idx="2">
                  <c:v>0.99606587127139523</c:v>
                </c:pt>
                <c:pt idx="3">
                  <c:v>1.0033264914901303</c:v>
                </c:pt>
                <c:pt idx="4">
                  <c:v>0.97501795880510489</c:v>
                </c:pt>
                <c:pt idx="5">
                  <c:v>0.92738544872489037</c:v>
                </c:pt>
                <c:pt idx="6">
                  <c:v>0.9769526601213125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0D7-4386-8A64-B8273A6F63A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43493152"/>
        <c:axId val="543496432"/>
      </c:barChart>
      <c:catAx>
        <c:axId val="54349315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dirty="0">
                    <a:solidFill>
                      <a:schemeClr val="tx1"/>
                    </a:solidFill>
                  </a:rPr>
                  <a:t>Atorvastatin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</a:t>
                </a:r>
                <a:r>
                  <a:rPr lang="en-US" altLang="ja-JP" baseline="0">
                    <a:solidFill>
                      <a:schemeClr val="tx1"/>
                    </a:solidFill>
                  </a:rPr>
                  <a:t>(µM)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43496432"/>
        <c:crosses val="autoZero"/>
        <c:auto val="1"/>
        <c:lblAlgn val="ctr"/>
        <c:lblOffset val="100"/>
        <c:noMultiLvlLbl val="0"/>
      </c:catAx>
      <c:valAx>
        <c:axId val="543496432"/>
        <c:scaling>
          <c:orientation val="minMax"/>
          <c:min val="0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i="1" dirty="0">
                    <a:solidFill>
                      <a:schemeClr val="tx1"/>
                    </a:solidFill>
                  </a:rPr>
                  <a:t>GUSB</a:t>
                </a:r>
                <a:r>
                  <a:rPr lang="en-US" altLang="ja-JP" baseline="0" dirty="0">
                    <a:solidFill>
                      <a:schemeClr val="tx1"/>
                    </a:solidFill>
                  </a:rPr>
                  <a:t> mRNA level</a:t>
                </a:r>
                <a:endParaRPr lang="ja-JP" altLang="en-US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6.1802701180621825E-2"/>
              <c:y val="6.3170918993866329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43493152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44264</cdr:x>
      <cdr:y>0.21347</cdr:y>
    </cdr:from>
    <cdr:to>
      <cdr:x>0.73388</cdr:x>
      <cdr:y>0.43457</cdr:y>
    </cdr:to>
    <cdr:sp macro="" textlink="">
      <cdr:nvSpPr>
        <cdr:cNvPr id="2" name="テキスト ボックス 4">
          <a:extLst xmlns:a="http://schemas.openxmlformats.org/drawingml/2006/main">
            <a:ext uri="{FF2B5EF4-FFF2-40B4-BE49-F238E27FC236}">
              <a16:creationId xmlns:a16="http://schemas.microsoft.com/office/drawing/2014/main" id="{62644995-5C1E-A272-B7B9-B1F966A12742}"/>
            </a:ext>
          </a:extLst>
        </cdr:cNvPr>
        <cdr:cNvSpPr txBox="1"/>
      </cdr:nvSpPr>
      <cdr:spPr>
        <a:xfrm xmlns:a="http://schemas.openxmlformats.org/drawingml/2006/main">
          <a:off x="1002811" y="343329"/>
          <a:ext cx="659822" cy="355600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defPPr>
            <a:defRPr lang="en-US"/>
          </a:defPPr>
          <a:lvl1pPr marL="0" algn="l" defTabSz="457200" rtl="0" eaLnBrk="1" latinLnBrk="0" hangingPunct="1">
            <a:defRPr sz="1800" kern="12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algn="l" defTabSz="457200" rtl="0" eaLnBrk="1" latinLnBrk="0" hangingPunct="1">
            <a:defRPr sz="1800" kern="12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algn="l" defTabSz="457200" rtl="0" eaLnBrk="1" latinLnBrk="0" hangingPunct="1">
            <a:defRPr sz="1800" kern="12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algn="l" defTabSz="457200" rtl="0" eaLnBrk="1" latinLnBrk="0" hangingPunct="1">
            <a:defRPr sz="1800" kern="12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algn="l" defTabSz="457200" rtl="0" eaLnBrk="1" latinLnBrk="0" hangingPunct="1">
            <a:defRPr sz="1800" kern="12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algn="l" defTabSz="457200" rtl="0" eaLnBrk="1" latinLnBrk="0" hangingPunct="1">
            <a:defRPr sz="1800" kern="12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algn="l" defTabSz="457200" rtl="0" eaLnBrk="1" latinLnBrk="0" hangingPunct="1">
            <a:defRPr sz="1800" kern="12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algn="l" defTabSz="457200" rtl="0" eaLnBrk="1" latinLnBrk="0" hangingPunct="1">
            <a:defRPr sz="1800" kern="12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algn="l" defTabSz="457200" rtl="0" eaLnBrk="1" latinLnBrk="0" hangingPunct="1">
            <a:defRPr sz="1800" kern="12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1050" dirty="0">
              <a:latin typeface="Times New Roman" panose="02020603050405020304" pitchFamily="18" charset="0"/>
              <a:cs typeface="Times New Roman" panose="02020603050405020304" pitchFamily="18" charset="0"/>
            </a:rPr>
            <a:t>**</a:t>
          </a:r>
          <a:endParaRPr kumimoji="1" lang="ja-JP" altLang="en-US" sz="105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28428-527D-4BC8-8CF5-AE8165FCE1DF}" type="datetimeFigureOut">
              <a:rPr kumimoji="1" lang="ja-JP" altLang="en-US" smtClean="0"/>
              <a:t>2023/7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28BAC6-1CDE-4689-9251-300D9C174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49178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28428-527D-4BC8-8CF5-AE8165FCE1DF}" type="datetimeFigureOut">
              <a:rPr kumimoji="1" lang="ja-JP" altLang="en-US" smtClean="0"/>
              <a:t>2023/7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28BAC6-1CDE-4689-9251-300D9C174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61375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28428-527D-4BC8-8CF5-AE8165FCE1DF}" type="datetimeFigureOut">
              <a:rPr kumimoji="1" lang="ja-JP" altLang="en-US" smtClean="0"/>
              <a:t>2023/7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28BAC6-1CDE-4689-9251-300D9C174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56319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28428-527D-4BC8-8CF5-AE8165FCE1DF}" type="datetimeFigureOut">
              <a:rPr kumimoji="1" lang="ja-JP" altLang="en-US" smtClean="0"/>
              <a:t>2023/7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28BAC6-1CDE-4689-9251-300D9C174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95404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28428-527D-4BC8-8CF5-AE8165FCE1DF}" type="datetimeFigureOut">
              <a:rPr kumimoji="1" lang="ja-JP" altLang="en-US" smtClean="0"/>
              <a:t>2023/7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28BAC6-1CDE-4689-9251-300D9C174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39196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28428-527D-4BC8-8CF5-AE8165FCE1DF}" type="datetimeFigureOut">
              <a:rPr kumimoji="1" lang="ja-JP" altLang="en-US" smtClean="0"/>
              <a:t>2023/7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28BAC6-1CDE-4689-9251-300D9C174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44782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28428-527D-4BC8-8CF5-AE8165FCE1DF}" type="datetimeFigureOut">
              <a:rPr kumimoji="1" lang="ja-JP" altLang="en-US" smtClean="0"/>
              <a:t>2023/7/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28BAC6-1CDE-4689-9251-300D9C174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96711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28428-527D-4BC8-8CF5-AE8165FCE1DF}" type="datetimeFigureOut">
              <a:rPr kumimoji="1" lang="ja-JP" altLang="en-US" smtClean="0"/>
              <a:t>2023/7/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28BAC6-1CDE-4689-9251-300D9C174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70011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28428-527D-4BC8-8CF5-AE8165FCE1DF}" type="datetimeFigureOut">
              <a:rPr kumimoji="1" lang="ja-JP" altLang="en-US" smtClean="0"/>
              <a:t>2023/7/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28BAC6-1CDE-4689-9251-300D9C174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54353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28428-527D-4BC8-8CF5-AE8165FCE1DF}" type="datetimeFigureOut">
              <a:rPr kumimoji="1" lang="ja-JP" altLang="en-US" smtClean="0"/>
              <a:t>2023/7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28BAC6-1CDE-4689-9251-300D9C174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15978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28428-527D-4BC8-8CF5-AE8165FCE1DF}" type="datetimeFigureOut">
              <a:rPr kumimoji="1" lang="ja-JP" altLang="en-US" smtClean="0"/>
              <a:t>2023/7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28BAC6-1CDE-4689-9251-300D9C174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38307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428428-527D-4BC8-8CF5-AE8165FCE1DF}" type="datetimeFigureOut">
              <a:rPr kumimoji="1" lang="ja-JP" altLang="en-US" smtClean="0"/>
              <a:t>2023/7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28BAC6-1CDE-4689-9251-300D9C174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36433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13" Type="http://schemas.openxmlformats.org/officeDocument/2006/relationships/chart" Target="../charts/chart12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12" Type="http://schemas.openxmlformats.org/officeDocument/2006/relationships/chart" Target="../charts/chart11.xml"/><Relationship Id="rId2" Type="http://schemas.openxmlformats.org/officeDocument/2006/relationships/chart" Target="../charts/chart1.xml"/><Relationship Id="rId16" Type="http://schemas.openxmlformats.org/officeDocument/2006/relationships/chart" Target="../charts/chart15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11" Type="http://schemas.openxmlformats.org/officeDocument/2006/relationships/chart" Target="../charts/chart10.xml"/><Relationship Id="rId5" Type="http://schemas.openxmlformats.org/officeDocument/2006/relationships/chart" Target="../charts/chart4.xml"/><Relationship Id="rId15" Type="http://schemas.openxmlformats.org/officeDocument/2006/relationships/chart" Target="../charts/chart14.xml"/><Relationship Id="rId10" Type="http://schemas.openxmlformats.org/officeDocument/2006/relationships/chart" Target="../charts/chart9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Relationship Id="rId14" Type="http://schemas.openxmlformats.org/officeDocument/2006/relationships/chart" Target="../charts/chart13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chart" Target="../charts/chart22.xml"/><Relationship Id="rId13" Type="http://schemas.openxmlformats.org/officeDocument/2006/relationships/chart" Target="../charts/chart27.xml"/><Relationship Id="rId3" Type="http://schemas.openxmlformats.org/officeDocument/2006/relationships/chart" Target="../charts/chart17.xml"/><Relationship Id="rId7" Type="http://schemas.openxmlformats.org/officeDocument/2006/relationships/chart" Target="../charts/chart21.xml"/><Relationship Id="rId12" Type="http://schemas.openxmlformats.org/officeDocument/2006/relationships/chart" Target="../charts/chart26.xml"/><Relationship Id="rId2" Type="http://schemas.openxmlformats.org/officeDocument/2006/relationships/chart" Target="../charts/chart16.xml"/><Relationship Id="rId16" Type="http://schemas.openxmlformats.org/officeDocument/2006/relationships/chart" Target="../charts/chart30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20.xml"/><Relationship Id="rId11" Type="http://schemas.openxmlformats.org/officeDocument/2006/relationships/chart" Target="../charts/chart25.xml"/><Relationship Id="rId5" Type="http://schemas.openxmlformats.org/officeDocument/2006/relationships/chart" Target="../charts/chart19.xml"/><Relationship Id="rId15" Type="http://schemas.openxmlformats.org/officeDocument/2006/relationships/chart" Target="../charts/chart29.xml"/><Relationship Id="rId10" Type="http://schemas.openxmlformats.org/officeDocument/2006/relationships/chart" Target="../charts/chart24.xml"/><Relationship Id="rId4" Type="http://schemas.openxmlformats.org/officeDocument/2006/relationships/chart" Target="../charts/chart18.xml"/><Relationship Id="rId9" Type="http://schemas.openxmlformats.org/officeDocument/2006/relationships/chart" Target="../charts/chart23.xml"/><Relationship Id="rId14" Type="http://schemas.openxmlformats.org/officeDocument/2006/relationships/chart" Target="../charts/chart28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chart" Target="../charts/chart37.xml"/><Relationship Id="rId13" Type="http://schemas.openxmlformats.org/officeDocument/2006/relationships/chart" Target="../charts/chart42.xml"/><Relationship Id="rId3" Type="http://schemas.openxmlformats.org/officeDocument/2006/relationships/chart" Target="../charts/chart32.xml"/><Relationship Id="rId7" Type="http://schemas.openxmlformats.org/officeDocument/2006/relationships/chart" Target="../charts/chart36.xml"/><Relationship Id="rId12" Type="http://schemas.openxmlformats.org/officeDocument/2006/relationships/chart" Target="../charts/chart41.xml"/><Relationship Id="rId2" Type="http://schemas.openxmlformats.org/officeDocument/2006/relationships/chart" Target="../charts/chart31.xml"/><Relationship Id="rId16" Type="http://schemas.openxmlformats.org/officeDocument/2006/relationships/chart" Target="../charts/chart45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35.xml"/><Relationship Id="rId11" Type="http://schemas.openxmlformats.org/officeDocument/2006/relationships/chart" Target="../charts/chart40.xml"/><Relationship Id="rId5" Type="http://schemas.openxmlformats.org/officeDocument/2006/relationships/chart" Target="../charts/chart34.xml"/><Relationship Id="rId15" Type="http://schemas.openxmlformats.org/officeDocument/2006/relationships/chart" Target="../charts/chart44.xml"/><Relationship Id="rId10" Type="http://schemas.openxmlformats.org/officeDocument/2006/relationships/chart" Target="../charts/chart39.xml"/><Relationship Id="rId4" Type="http://schemas.openxmlformats.org/officeDocument/2006/relationships/chart" Target="../charts/chart33.xml"/><Relationship Id="rId9" Type="http://schemas.openxmlformats.org/officeDocument/2006/relationships/chart" Target="../charts/chart38.xml"/><Relationship Id="rId14" Type="http://schemas.openxmlformats.org/officeDocument/2006/relationships/chart" Target="../charts/chart43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chart" Target="../charts/chart52.xml"/><Relationship Id="rId13" Type="http://schemas.openxmlformats.org/officeDocument/2006/relationships/chart" Target="../charts/chart57.xml"/><Relationship Id="rId3" Type="http://schemas.openxmlformats.org/officeDocument/2006/relationships/chart" Target="../charts/chart47.xml"/><Relationship Id="rId7" Type="http://schemas.openxmlformats.org/officeDocument/2006/relationships/chart" Target="../charts/chart51.xml"/><Relationship Id="rId12" Type="http://schemas.openxmlformats.org/officeDocument/2006/relationships/chart" Target="../charts/chart56.xml"/><Relationship Id="rId2" Type="http://schemas.openxmlformats.org/officeDocument/2006/relationships/chart" Target="../charts/chart46.xml"/><Relationship Id="rId16" Type="http://schemas.openxmlformats.org/officeDocument/2006/relationships/chart" Target="../charts/chart60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0.xml"/><Relationship Id="rId11" Type="http://schemas.openxmlformats.org/officeDocument/2006/relationships/chart" Target="../charts/chart55.xml"/><Relationship Id="rId5" Type="http://schemas.openxmlformats.org/officeDocument/2006/relationships/chart" Target="../charts/chart49.xml"/><Relationship Id="rId15" Type="http://schemas.openxmlformats.org/officeDocument/2006/relationships/chart" Target="../charts/chart59.xml"/><Relationship Id="rId10" Type="http://schemas.openxmlformats.org/officeDocument/2006/relationships/chart" Target="../charts/chart54.xml"/><Relationship Id="rId4" Type="http://schemas.openxmlformats.org/officeDocument/2006/relationships/chart" Target="../charts/chart48.xml"/><Relationship Id="rId9" Type="http://schemas.openxmlformats.org/officeDocument/2006/relationships/chart" Target="../charts/chart53.xml"/><Relationship Id="rId14" Type="http://schemas.openxmlformats.org/officeDocument/2006/relationships/chart" Target="../charts/chart58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chart" Target="../charts/chart67.xml"/><Relationship Id="rId13" Type="http://schemas.openxmlformats.org/officeDocument/2006/relationships/chart" Target="../charts/chart72.xml"/><Relationship Id="rId3" Type="http://schemas.openxmlformats.org/officeDocument/2006/relationships/chart" Target="../charts/chart62.xml"/><Relationship Id="rId7" Type="http://schemas.openxmlformats.org/officeDocument/2006/relationships/chart" Target="../charts/chart66.xml"/><Relationship Id="rId12" Type="http://schemas.openxmlformats.org/officeDocument/2006/relationships/chart" Target="../charts/chart71.xml"/><Relationship Id="rId2" Type="http://schemas.openxmlformats.org/officeDocument/2006/relationships/chart" Target="../charts/chart61.xml"/><Relationship Id="rId16" Type="http://schemas.openxmlformats.org/officeDocument/2006/relationships/chart" Target="../charts/chart75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65.xml"/><Relationship Id="rId11" Type="http://schemas.openxmlformats.org/officeDocument/2006/relationships/chart" Target="../charts/chart70.xml"/><Relationship Id="rId5" Type="http://schemas.openxmlformats.org/officeDocument/2006/relationships/chart" Target="../charts/chart64.xml"/><Relationship Id="rId15" Type="http://schemas.openxmlformats.org/officeDocument/2006/relationships/chart" Target="../charts/chart74.xml"/><Relationship Id="rId10" Type="http://schemas.openxmlformats.org/officeDocument/2006/relationships/chart" Target="../charts/chart69.xml"/><Relationship Id="rId4" Type="http://schemas.openxmlformats.org/officeDocument/2006/relationships/chart" Target="../charts/chart63.xml"/><Relationship Id="rId9" Type="http://schemas.openxmlformats.org/officeDocument/2006/relationships/chart" Target="../charts/chart68.xml"/><Relationship Id="rId14" Type="http://schemas.openxmlformats.org/officeDocument/2006/relationships/chart" Target="../charts/chart73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chart" Target="../charts/chart82.xml"/><Relationship Id="rId13" Type="http://schemas.openxmlformats.org/officeDocument/2006/relationships/chart" Target="../charts/chart87.xml"/><Relationship Id="rId3" Type="http://schemas.openxmlformats.org/officeDocument/2006/relationships/chart" Target="../charts/chart77.xml"/><Relationship Id="rId7" Type="http://schemas.openxmlformats.org/officeDocument/2006/relationships/chart" Target="../charts/chart81.xml"/><Relationship Id="rId12" Type="http://schemas.openxmlformats.org/officeDocument/2006/relationships/chart" Target="../charts/chart86.xml"/><Relationship Id="rId2" Type="http://schemas.openxmlformats.org/officeDocument/2006/relationships/chart" Target="../charts/chart76.xml"/><Relationship Id="rId16" Type="http://schemas.openxmlformats.org/officeDocument/2006/relationships/chart" Target="../charts/chart90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80.xml"/><Relationship Id="rId11" Type="http://schemas.openxmlformats.org/officeDocument/2006/relationships/chart" Target="../charts/chart85.xml"/><Relationship Id="rId5" Type="http://schemas.openxmlformats.org/officeDocument/2006/relationships/chart" Target="../charts/chart79.xml"/><Relationship Id="rId15" Type="http://schemas.openxmlformats.org/officeDocument/2006/relationships/chart" Target="../charts/chart89.xml"/><Relationship Id="rId10" Type="http://schemas.openxmlformats.org/officeDocument/2006/relationships/chart" Target="../charts/chart84.xml"/><Relationship Id="rId4" Type="http://schemas.openxmlformats.org/officeDocument/2006/relationships/chart" Target="../charts/chart78.xml"/><Relationship Id="rId9" Type="http://schemas.openxmlformats.org/officeDocument/2006/relationships/chart" Target="../charts/chart83.xml"/><Relationship Id="rId14" Type="http://schemas.openxmlformats.org/officeDocument/2006/relationships/chart" Target="../charts/chart8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20DE2A5-B3B5-4D56-90E7-125203245394}"/>
              </a:ext>
            </a:extLst>
          </p:cNvPr>
          <p:cNvSpPr txBox="1"/>
          <p:nvPr/>
        </p:nvSpPr>
        <p:spPr>
          <a:xfrm>
            <a:off x="86056" y="283055"/>
            <a:ext cx="66858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>
                <a:latin typeface="Arial" panose="020B0604020202020204" pitchFamily="34" charset="0"/>
                <a:cs typeface="Arial" panose="020B0604020202020204" pitchFamily="34" charset="0"/>
              </a:rPr>
              <a:t>Figure S1 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7" name="グラフ 36">
            <a:extLst>
              <a:ext uri="{FF2B5EF4-FFF2-40B4-BE49-F238E27FC236}">
                <a16:creationId xmlns:a16="http://schemas.microsoft.com/office/drawing/2014/main" id="{88CB1B00-6604-4478-9764-37BC51F98DD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88835696"/>
              </p:ext>
            </p:extLst>
          </p:nvPr>
        </p:nvGraphicFramePr>
        <p:xfrm>
          <a:off x="20471" y="928652"/>
          <a:ext cx="2265529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8" name="グラフ 37">
            <a:extLst>
              <a:ext uri="{FF2B5EF4-FFF2-40B4-BE49-F238E27FC236}">
                <a16:creationId xmlns:a16="http://schemas.microsoft.com/office/drawing/2014/main" id="{771193B7-3C0D-4EC4-BA51-3253FD7338D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25649031"/>
              </p:ext>
            </p:extLst>
          </p:nvPr>
        </p:nvGraphicFramePr>
        <p:xfrm>
          <a:off x="2296235" y="928652"/>
          <a:ext cx="2265529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9" name="グラフ 38">
            <a:extLst>
              <a:ext uri="{FF2B5EF4-FFF2-40B4-BE49-F238E27FC236}">
                <a16:creationId xmlns:a16="http://schemas.microsoft.com/office/drawing/2014/main" id="{641994A3-2478-42E7-B580-A1811FD55CA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97939516"/>
              </p:ext>
            </p:extLst>
          </p:nvPr>
        </p:nvGraphicFramePr>
        <p:xfrm>
          <a:off x="4572000" y="928652"/>
          <a:ext cx="2265529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40" name="グラフ 39">
            <a:extLst>
              <a:ext uri="{FF2B5EF4-FFF2-40B4-BE49-F238E27FC236}">
                <a16:creationId xmlns:a16="http://schemas.microsoft.com/office/drawing/2014/main" id="{30537D9A-1B67-4F3E-A864-7BFDF0B298E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33599134"/>
              </p:ext>
            </p:extLst>
          </p:nvPr>
        </p:nvGraphicFramePr>
        <p:xfrm>
          <a:off x="20471" y="2733451"/>
          <a:ext cx="2265529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41" name="グラフ 40">
            <a:extLst>
              <a:ext uri="{FF2B5EF4-FFF2-40B4-BE49-F238E27FC236}">
                <a16:creationId xmlns:a16="http://schemas.microsoft.com/office/drawing/2014/main" id="{2353C1E5-71C1-495C-B74D-6E814464E0A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34687119"/>
              </p:ext>
            </p:extLst>
          </p:nvPr>
        </p:nvGraphicFramePr>
        <p:xfrm>
          <a:off x="2296235" y="2733451"/>
          <a:ext cx="2265529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42" name="グラフ 41">
            <a:extLst>
              <a:ext uri="{FF2B5EF4-FFF2-40B4-BE49-F238E27FC236}">
                <a16:creationId xmlns:a16="http://schemas.microsoft.com/office/drawing/2014/main" id="{D0C90AC1-571E-4D30-AA51-7A335F05C24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59333853"/>
              </p:ext>
            </p:extLst>
          </p:nvPr>
        </p:nvGraphicFramePr>
        <p:xfrm>
          <a:off x="4571999" y="2733451"/>
          <a:ext cx="2265530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43" name="グラフ 42">
            <a:extLst>
              <a:ext uri="{FF2B5EF4-FFF2-40B4-BE49-F238E27FC236}">
                <a16:creationId xmlns:a16="http://schemas.microsoft.com/office/drawing/2014/main" id="{15751A1C-D04C-4E34-A4A5-FAF6555779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6542786"/>
              </p:ext>
            </p:extLst>
          </p:nvPr>
        </p:nvGraphicFramePr>
        <p:xfrm>
          <a:off x="20471" y="4538250"/>
          <a:ext cx="2265529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44" name="グラフ 43">
            <a:extLst>
              <a:ext uri="{FF2B5EF4-FFF2-40B4-BE49-F238E27FC236}">
                <a16:creationId xmlns:a16="http://schemas.microsoft.com/office/drawing/2014/main" id="{480B48CA-AADF-4040-8A79-D1BE054D14F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82484495"/>
              </p:ext>
            </p:extLst>
          </p:nvPr>
        </p:nvGraphicFramePr>
        <p:xfrm>
          <a:off x="2296235" y="4538250"/>
          <a:ext cx="2265529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45" name="グラフ 44">
            <a:extLst>
              <a:ext uri="{FF2B5EF4-FFF2-40B4-BE49-F238E27FC236}">
                <a16:creationId xmlns:a16="http://schemas.microsoft.com/office/drawing/2014/main" id="{3C91FA9C-687E-414B-ABBA-1383EDA615A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80152169"/>
              </p:ext>
            </p:extLst>
          </p:nvPr>
        </p:nvGraphicFramePr>
        <p:xfrm>
          <a:off x="4572000" y="4538250"/>
          <a:ext cx="2265529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46" name="グラフ 45">
            <a:extLst>
              <a:ext uri="{FF2B5EF4-FFF2-40B4-BE49-F238E27FC236}">
                <a16:creationId xmlns:a16="http://schemas.microsoft.com/office/drawing/2014/main" id="{AE0C78FC-C0C2-456F-9B17-98466506A1F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88205419"/>
              </p:ext>
            </p:extLst>
          </p:nvPr>
        </p:nvGraphicFramePr>
        <p:xfrm>
          <a:off x="20471" y="6343049"/>
          <a:ext cx="2265529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47" name="グラフ 46">
            <a:extLst>
              <a:ext uri="{FF2B5EF4-FFF2-40B4-BE49-F238E27FC236}">
                <a16:creationId xmlns:a16="http://schemas.microsoft.com/office/drawing/2014/main" id="{624339B8-88B6-4B78-A0BB-A28B793CF31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95386837"/>
              </p:ext>
            </p:extLst>
          </p:nvPr>
        </p:nvGraphicFramePr>
        <p:xfrm>
          <a:off x="2296235" y="6343049"/>
          <a:ext cx="2265529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graphicFrame>
        <p:nvGraphicFramePr>
          <p:cNvPr id="48" name="グラフ 47">
            <a:extLst>
              <a:ext uri="{FF2B5EF4-FFF2-40B4-BE49-F238E27FC236}">
                <a16:creationId xmlns:a16="http://schemas.microsoft.com/office/drawing/2014/main" id="{DB60CE0F-6A49-40EE-8BAA-9C773C93164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42552807"/>
              </p:ext>
            </p:extLst>
          </p:nvPr>
        </p:nvGraphicFramePr>
        <p:xfrm>
          <a:off x="4571999" y="6343049"/>
          <a:ext cx="2265530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graphicFrame>
        <p:nvGraphicFramePr>
          <p:cNvPr id="49" name="グラフ 48">
            <a:extLst>
              <a:ext uri="{FF2B5EF4-FFF2-40B4-BE49-F238E27FC236}">
                <a16:creationId xmlns:a16="http://schemas.microsoft.com/office/drawing/2014/main" id="{E467137E-8F99-44B1-99A9-A075FC217C7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24524360"/>
              </p:ext>
            </p:extLst>
          </p:nvPr>
        </p:nvGraphicFramePr>
        <p:xfrm>
          <a:off x="20471" y="8147848"/>
          <a:ext cx="2265529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graphicFrame>
        <p:nvGraphicFramePr>
          <p:cNvPr id="50" name="グラフ 49">
            <a:extLst>
              <a:ext uri="{FF2B5EF4-FFF2-40B4-BE49-F238E27FC236}">
                <a16:creationId xmlns:a16="http://schemas.microsoft.com/office/drawing/2014/main" id="{D9251AA2-4380-4E30-8F6B-96EB56B8D54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47326640"/>
              </p:ext>
            </p:extLst>
          </p:nvPr>
        </p:nvGraphicFramePr>
        <p:xfrm>
          <a:off x="2296235" y="8256811"/>
          <a:ext cx="2262000" cy="14993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5"/>
          </a:graphicData>
        </a:graphic>
      </p:graphicFrame>
      <p:graphicFrame>
        <p:nvGraphicFramePr>
          <p:cNvPr id="51" name="グラフ 50">
            <a:extLst>
              <a:ext uri="{FF2B5EF4-FFF2-40B4-BE49-F238E27FC236}">
                <a16:creationId xmlns:a16="http://schemas.microsoft.com/office/drawing/2014/main" id="{9A7E2C22-2664-4675-B272-F8439839165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68896347"/>
              </p:ext>
            </p:extLst>
          </p:nvPr>
        </p:nvGraphicFramePr>
        <p:xfrm>
          <a:off x="4571999" y="8236629"/>
          <a:ext cx="2265530" cy="15195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6"/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8DB38FE8-7575-B3A2-D140-39424EF9FDD9}"/>
              </a:ext>
            </a:extLst>
          </p:cNvPr>
          <p:cNvSpPr txBox="1"/>
          <p:nvPr/>
        </p:nvSpPr>
        <p:spPr>
          <a:xfrm>
            <a:off x="172112" y="637439"/>
            <a:ext cx="66858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4">
            <a:extLst>
              <a:ext uri="{FF2B5EF4-FFF2-40B4-BE49-F238E27FC236}">
                <a16:creationId xmlns:a16="http://schemas.microsoft.com/office/drawing/2014/main" id="{D6BD8735-618B-30B8-7AC0-244DD022792F}"/>
              </a:ext>
            </a:extLst>
          </p:cNvPr>
          <p:cNvSpPr txBox="1"/>
          <p:nvPr/>
        </p:nvSpPr>
        <p:spPr>
          <a:xfrm>
            <a:off x="1236998" y="1307506"/>
            <a:ext cx="659822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5">
            <a:extLst>
              <a:ext uri="{FF2B5EF4-FFF2-40B4-BE49-F238E27FC236}">
                <a16:creationId xmlns:a16="http://schemas.microsoft.com/office/drawing/2014/main" id="{AB1EBD4C-D591-6356-C851-F7F0708B60C8}"/>
              </a:ext>
            </a:extLst>
          </p:cNvPr>
          <p:cNvSpPr txBox="1"/>
          <p:nvPr/>
        </p:nvSpPr>
        <p:spPr>
          <a:xfrm>
            <a:off x="1065840" y="1125257"/>
            <a:ext cx="659821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4">
            <a:extLst>
              <a:ext uri="{FF2B5EF4-FFF2-40B4-BE49-F238E27FC236}">
                <a16:creationId xmlns:a16="http://schemas.microsoft.com/office/drawing/2014/main" id="{7F2D5643-5E95-ED3E-67AC-246709F8A974}"/>
              </a:ext>
            </a:extLst>
          </p:cNvPr>
          <p:cNvSpPr txBox="1"/>
          <p:nvPr/>
        </p:nvSpPr>
        <p:spPr>
          <a:xfrm>
            <a:off x="1456784" y="1336234"/>
            <a:ext cx="659822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4">
            <a:extLst>
              <a:ext uri="{FF2B5EF4-FFF2-40B4-BE49-F238E27FC236}">
                <a16:creationId xmlns:a16="http://schemas.microsoft.com/office/drawing/2014/main" id="{A7A97E7B-E709-E9B7-B4B2-1BFD3F004C40}"/>
              </a:ext>
            </a:extLst>
          </p:cNvPr>
          <p:cNvSpPr txBox="1"/>
          <p:nvPr/>
        </p:nvSpPr>
        <p:spPr>
          <a:xfrm>
            <a:off x="1666833" y="1324528"/>
            <a:ext cx="659822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4">
            <a:extLst>
              <a:ext uri="{FF2B5EF4-FFF2-40B4-BE49-F238E27FC236}">
                <a16:creationId xmlns:a16="http://schemas.microsoft.com/office/drawing/2014/main" id="{A0FE9A17-BA8F-54B8-0DB4-42A6B9EB16D4}"/>
              </a:ext>
            </a:extLst>
          </p:cNvPr>
          <p:cNvSpPr txBox="1"/>
          <p:nvPr/>
        </p:nvSpPr>
        <p:spPr>
          <a:xfrm>
            <a:off x="1885284" y="1336695"/>
            <a:ext cx="659822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4">
            <a:extLst>
              <a:ext uri="{FF2B5EF4-FFF2-40B4-BE49-F238E27FC236}">
                <a16:creationId xmlns:a16="http://schemas.microsoft.com/office/drawing/2014/main" id="{81FCCB0B-474C-8087-328D-334160A5B170}"/>
              </a:ext>
            </a:extLst>
          </p:cNvPr>
          <p:cNvSpPr txBox="1"/>
          <p:nvPr/>
        </p:nvSpPr>
        <p:spPr>
          <a:xfrm>
            <a:off x="3728063" y="1499820"/>
            <a:ext cx="659822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4">
            <a:extLst>
              <a:ext uri="{FF2B5EF4-FFF2-40B4-BE49-F238E27FC236}">
                <a16:creationId xmlns:a16="http://schemas.microsoft.com/office/drawing/2014/main" id="{4D6FA4D2-C3B1-AAFB-70B8-B9CDAE772173}"/>
              </a:ext>
            </a:extLst>
          </p:cNvPr>
          <p:cNvSpPr txBox="1"/>
          <p:nvPr/>
        </p:nvSpPr>
        <p:spPr>
          <a:xfrm>
            <a:off x="4156553" y="1435386"/>
            <a:ext cx="659822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4">
            <a:extLst>
              <a:ext uri="{FF2B5EF4-FFF2-40B4-BE49-F238E27FC236}">
                <a16:creationId xmlns:a16="http://schemas.microsoft.com/office/drawing/2014/main" id="{F86B2EF1-1EDA-3220-D61D-91D876436621}"/>
              </a:ext>
            </a:extLst>
          </p:cNvPr>
          <p:cNvSpPr txBox="1"/>
          <p:nvPr/>
        </p:nvSpPr>
        <p:spPr>
          <a:xfrm>
            <a:off x="6008720" y="3301992"/>
            <a:ext cx="659822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4">
            <a:extLst>
              <a:ext uri="{FF2B5EF4-FFF2-40B4-BE49-F238E27FC236}">
                <a16:creationId xmlns:a16="http://schemas.microsoft.com/office/drawing/2014/main" id="{A225BEEB-23EE-22E5-3F40-16CA87EE8420}"/>
              </a:ext>
            </a:extLst>
          </p:cNvPr>
          <p:cNvSpPr txBox="1"/>
          <p:nvPr/>
        </p:nvSpPr>
        <p:spPr>
          <a:xfrm>
            <a:off x="6222273" y="3291975"/>
            <a:ext cx="659822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4">
            <a:extLst>
              <a:ext uri="{FF2B5EF4-FFF2-40B4-BE49-F238E27FC236}">
                <a16:creationId xmlns:a16="http://schemas.microsoft.com/office/drawing/2014/main" id="{7046962E-DA81-2EFA-356C-A0CF376DD0E2}"/>
              </a:ext>
            </a:extLst>
          </p:cNvPr>
          <p:cNvSpPr txBox="1"/>
          <p:nvPr/>
        </p:nvSpPr>
        <p:spPr>
          <a:xfrm>
            <a:off x="6439245" y="3327152"/>
            <a:ext cx="659822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4">
            <a:extLst>
              <a:ext uri="{FF2B5EF4-FFF2-40B4-BE49-F238E27FC236}">
                <a16:creationId xmlns:a16="http://schemas.microsoft.com/office/drawing/2014/main" id="{045DE784-D55A-ECFF-AB1B-4991EF5934C3}"/>
              </a:ext>
            </a:extLst>
          </p:cNvPr>
          <p:cNvSpPr txBox="1"/>
          <p:nvPr/>
        </p:nvSpPr>
        <p:spPr>
          <a:xfrm>
            <a:off x="5792800" y="3253462"/>
            <a:ext cx="659822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4">
            <a:extLst>
              <a:ext uri="{FF2B5EF4-FFF2-40B4-BE49-F238E27FC236}">
                <a16:creationId xmlns:a16="http://schemas.microsoft.com/office/drawing/2014/main" id="{63B28CCE-2B03-1C3B-8DA4-225CE7D5CBCC}"/>
              </a:ext>
            </a:extLst>
          </p:cNvPr>
          <p:cNvSpPr txBox="1"/>
          <p:nvPr/>
        </p:nvSpPr>
        <p:spPr>
          <a:xfrm>
            <a:off x="3728584" y="5146422"/>
            <a:ext cx="659822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4">
            <a:extLst>
              <a:ext uri="{FF2B5EF4-FFF2-40B4-BE49-F238E27FC236}">
                <a16:creationId xmlns:a16="http://schemas.microsoft.com/office/drawing/2014/main" id="{89AED86B-1B5D-28F5-C9DC-4863E3531E0D}"/>
              </a:ext>
            </a:extLst>
          </p:cNvPr>
          <p:cNvSpPr txBox="1"/>
          <p:nvPr/>
        </p:nvSpPr>
        <p:spPr>
          <a:xfrm>
            <a:off x="3946379" y="5079000"/>
            <a:ext cx="659822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4">
            <a:extLst>
              <a:ext uri="{FF2B5EF4-FFF2-40B4-BE49-F238E27FC236}">
                <a16:creationId xmlns:a16="http://schemas.microsoft.com/office/drawing/2014/main" id="{1BF9924A-C3BB-906A-0391-CA96A240FDCF}"/>
              </a:ext>
            </a:extLst>
          </p:cNvPr>
          <p:cNvSpPr txBox="1"/>
          <p:nvPr/>
        </p:nvSpPr>
        <p:spPr>
          <a:xfrm>
            <a:off x="4156553" y="5003799"/>
            <a:ext cx="659822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4">
            <a:extLst>
              <a:ext uri="{FF2B5EF4-FFF2-40B4-BE49-F238E27FC236}">
                <a16:creationId xmlns:a16="http://schemas.microsoft.com/office/drawing/2014/main" id="{62644995-5C1E-A272-B7B9-B1F966A12742}"/>
              </a:ext>
            </a:extLst>
          </p:cNvPr>
          <p:cNvSpPr txBox="1"/>
          <p:nvPr/>
        </p:nvSpPr>
        <p:spPr>
          <a:xfrm>
            <a:off x="3520780" y="5114075"/>
            <a:ext cx="659822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4">
            <a:extLst>
              <a:ext uri="{FF2B5EF4-FFF2-40B4-BE49-F238E27FC236}">
                <a16:creationId xmlns:a16="http://schemas.microsoft.com/office/drawing/2014/main" id="{FEB7ECD7-0DF9-93B8-EF49-E1CE1FC4E9EA}"/>
              </a:ext>
            </a:extLst>
          </p:cNvPr>
          <p:cNvSpPr txBox="1"/>
          <p:nvPr/>
        </p:nvSpPr>
        <p:spPr>
          <a:xfrm>
            <a:off x="3735320" y="6904047"/>
            <a:ext cx="659822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5">
            <a:extLst>
              <a:ext uri="{FF2B5EF4-FFF2-40B4-BE49-F238E27FC236}">
                <a16:creationId xmlns:a16="http://schemas.microsoft.com/office/drawing/2014/main" id="{17E96280-69E8-1914-569C-0C5F2A041507}"/>
              </a:ext>
            </a:extLst>
          </p:cNvPr>
          <p:cNvSpPr txBox="1"/>
          <p:nvPr/>
        </p:nvSpPr>
        <p:spPr>
          <a:xfrm>
            <a:off x="6468273" y="6422085"/>
            <a:ext cx="659821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663816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5" name="グラフ 34">
            <a:extLst>
              <a:ext uri="{FF2B5EF4-FFF2-40B4-BE49-F238E27FC236}">
                <a16:creationId xmlns:a16="http://schemas.microsoft.com/office/drawing/2014/main" id="{5194D9DC-FDF2-4D99-867C-4BC5B3A2215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49559946"/>
              </p:ext>
            </p:extLst>
          </p:nvPr>
        </p:nvGraphicFramePr>
        <p:xfrm>
          <a:off x="21600" y="928800"/>
          <a:ext cx="2265528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7" name="グラフ 66">
            <a:extLst>
              <a:ext uri="{FF2B5EF4-FFF2-40B4-BE49-F238E27FC236}">
                <a16:creationId xmlns:a16="http://schemas.microsoft.com/office/drawing/2014/main" id="{51DFC86F-A77D-41BD-92B5-7E7512B418B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62959670"/>
              </p:ext>
            </p:extLst>
          </p:nvPr>
        </p:nvGraphicFramePr>
        <p:xfrm>
          <a:off x="2296800" y="928800"/>
          <a:ext cx="2265529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8" name="グラフ 67">
            <a:extLst>
              <a:ext uri="{FF2B5EF4-FFF2-40B4-BE49-F238E27FC236}">
                <a16:creationId xmlns:a16="http://schemas.microsoft.com/office/drawing/2014/main" id="{42AA9225-A37B-423D-A737-85BED2CBB00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91213460"/>
              </p:ext>
            </p:extLst>
          </p:nvPr>
        </p:nvGraphicFramePr>
        <p:xfrm>
          <a:off x="4572000" y="928800"/>
          <a:ext cx="2265528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69" name="グラフ 68">
            <a:extLst>
              <a:ext uri="{FF2B5EF4-FFF2-40B4-BE49-F238E27FC236}">
                <a16:creationId xmlns:a16="http://schemas.microsoft.com/office/drawing/2014/main" id="{B76EB831-B422-41B5-A55D-CFE3EF82450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03620555"/>
              </p:ext>
            </p:extLst>
          </p:nvPr>
        </p:nvGraphicFramePr>
        <p:xfrm>
          <a:off x="21600" y="2733300"/>
          <a:ext cx="2265528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70" name="グラフ 69">
            <a:extLst>
              <a:ext uri="{FF2B5EF4-FFF2-40B4-BE49-F238E27FC236}">
                <a16:creationId xmlns:a16="http://schemas.microsoft.com/office/drawing/2014/main" id="{35EA71DC-E8D9-4A72-94B3-B0648989378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01731289"/>
              </p:ext>
            </p:extLst>
          </p:nvPr>
        </p:nvGraphicFramePr>
        <p:xfrm>
          <a:off x="2296800" y="2733300"/>
          <a:ext cx="2265529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71" name="グラフ 70">
            <a:extLst>
              <a:ext uri="{FF2B5EF4-FFF2-40B4-BE49-F238E27FC236}">
                <a16:creationId xmlns:a16="http://schemas.microsoft.com/office/drawing/2014/main" id="{13E9B203-96F6-4CF5-8D4D-442F86407C2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22925969"/>
              </p:ext>
            </p:extLst>
          </p:nvPr>
        </p:nvGraphicFramePr>
        <p:xfrm>
          <a:off x="4572000" y="2733300"/>
          <a:ext cx="2265528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72" name="グラフ 71">
            <a:extLst>
              <a:ext uri="{FF2B5EF4-FFF2-40B4-BE49-F238E27FC236}">
                <a16:creationId xmlns:a16="http://schemas.microsoft.com/office/drawing/2014/main" id="{3BFF5FF8-04BF-47AA-A1B0-0548D3F302E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68442201"/>
              </p:ext>
            </p:extLst>
          </p:nvPr>
        </p:nvGraphicFramePr>
        <p:xfrm>
          <a:off x="21600" y="4537800"/>
          <a:ext cx="2265528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73" name="グラフ 72">
            <a:extLst>
              <a:ext uri="{FF2B5EF4-FFF2-40B4-BE49-F238E27FC236}">
                <a16:creationId xmlns:a16="http://schemas.microsoft.com/office/drawing/2014/main" id="{D4240A3B-E771-4FC1-9CF8-C61A718C582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83082259"/>
              </p:ext>
            </p:extLst>
          </p:nvPr>
        </p:nvGraphicFramePr>
        <p:xfrm>
          <a:off x="2296800" y="4537800"/>
          <a:ext cx="2265528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74" name="グラフ 73">
            <a:extLst>
              <a:ext uri="{FF2B5EF4-FFF2-40B4-BE49-F238E27FC236}">
                <a16:creationId xmlns:a16="http://schemas.microsoft.com/office/drawing/2014/main" id="{0472CFE2-001E-4B96-AF6E-8A09C43BFCB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77031567"/>
              </p:ext>
            </p:extLst>
          </p:nvPr>
        </p:nvGraphicFramePr>
        <p:xfrm>
          <a:off x="4571999" y="4537800"/>
          <a:ext cx="2265529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75" name="グラフ 74">
            <a:extLst>
              <a:ext uri="{FF2B5EF4-FFF2-40B4-BE49-F238E27FC236}">
                <a16:creationId xmlns:a16="http://schemas.microsoft.com/office/drawing/2014/main" id="{AA76075F-2123-4D6A-83C9-E7743EACC59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21757626"/>
              </p:ext>
            </p:extLst>
          </p:nvPr>
        </p:nvGraphicFramePr>
        <p:xfrm>
          <a:off x="21600" y="6342300"/>
          <a:ext cx="2265528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76" name="グラフ 75">
            <a:extLst>
              <a:ext uri="{FF2B5EF4-FFF2-40B4-BE49-F238E27FC236}">
                <a16:creationId xmlns:a16="http://schemas.microsoft.com/office/drawing/2014/main" id="{C0B6C30B-ABF0-4CFC-BD44-86348D9FBAE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16789376"/>
              </p:ext>
            </p:extLst>
          </p:nvPr>
        </p:nvGraphicFramePr>
        <p:xfrm>
          <a:off x="2296800" y="6342300"/>
          <a:ext cx="2265529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graphicFrame>
        <p:nvGraphicFramePr>
          <p:cNvPr id="78" name="グラフ 77">
            <a:extLst>
              <a:ext uri="{FF2B5EF4-FFF2-40B4-BE49-F238E27FC236}">
                <a16:creationId xmlns:a16="http://schemas.microsoft.com/office/drawing/2014/main" id="{82D7DFA5-682D-4F08-BCE2-DD314229B48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27699780"/>
              </p:ext>
            </p:extLst>
          </p:nvPr>
        </p:nvGraphicFramePr>
        <p:xfrm>
          <a:off x="21600" y="8146800"/>
          <a:ext cx="2265528" cy="15641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graphicFrame>
        <p:nvGraphicFramePr>
          <p:cNvPr id="79" name="グラフ 78">
            <a:extLst>
              <a:ext uri="{FF2B5EF4-FFF2-40B4-BE49-F238E27FC236}">
                <a16:creationId xmlns:a16="http://schemas.microsoft.com/office/drawing/2014/main" id="{817DE7EF-9C11-4B81-87AE-D5A18093058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48649172"/>
              </p:ext>
            </p:extLst>
          </p:nvPr>
        </p:nvGraphicFramePr>
        <p:xfrm>
          <a:off x="2296800" y="8146801"/>
          <a:ext cx="2262002" cy="156414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graphicFrame>
        <p:nvGraphicFramePr>
          <p:cNvPr id="80" name="グラフ 79">
            <a:extLst>
              <a:ext uri="{FF2B5EF4-FFF2-40B4-BE49-F238E27FC236}">
                <a16:creationId xmlns:a16="http://schemas.microsoft.com/office/drawing/2014/main" id="{826C2F41-B6A8-45D7-BDF9-F38420D5FA1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96790259"/>
              </p:ext>
            </p:extLst>
          </p:nvPr>
        </p:nvGraphicFramePr>
        <p:xfrm>
          <a:off x="4576936" y="8138105"/>
          <a:ext cx="2260592" cy="157284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5"/>
          </a:graphicData>
        </a:graphic>
      </p:graphicFrame>
      <p:graphicFrame>
        <p:nvGraphicFramePr>
          <p:cNvPr id="19" name="グラフ 18">
            <a:extLst>
              <a:ext uri="{FF2B5EF4-FFF2-40B4-BE49-F238E27FC236}">
                <a16:creationId xmlns:a16="http://schemas.microsoft.com/office/drawing/2014/main" id="{78AC9C17-4C93-4EEA-8C8D-3A1C780AFC5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82636405"/>
              </p:ext>
            </p:extLst>
          </p:nvPr>
        </p:nvGraphicFramePr>
        <p:xfrm>
          <a:off x="4571999" y="6342300"/>
          <a:ext cx="2265528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6"/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8FB1004E-8F52-ABA1-0566-67148A5D2BCA}"/>
              </a:ext>
            </a:extLst>
          </p:cNvPr>
          <p:cNvSpPr txBox="1"/>
          <p:nvPr/>
        </p:nvSpPr>
        <p:spPr>
          <a:xfrm>
            <a:off x="172112" y="637439"/>
            <a:ext cx="66858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4">
            <a:extLst>
              <a:ext uri="{FF2B5EF4-FFF2-40B4-BE49-F238E27FC236}">
                <a16:creationId xmlns:a16="http://schemas.microsoft.com/office/drawing/2014/main" id="{820C99E9-62DD-73F2-EC7A-29B9DF8726BF}"/>
              </a:ext>
            </a:extLst>
          </p:cNvPr>
          <p:cNvSpPr txBox="1"/>
          <p:nvPr/>
        </p:nvSpPr>
        <p:spPr>
          <a:xfrm>
            <a:off x="1883878" y="1370110"/>
            <a:ext cx="659822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4">
            <a:extLst>
              <a:ext uri="{FF2B5EF4-FFF2-40B4-BE49-F238E27FC236}">
                <a16:creationId xmlns:a16="http://schemas.microsoft.com/office/drawing/2014/main" id="{E02F1DF2-7E0F-5A90-91C7-EDCADC627C15}"/>
              </a:ext>
            </a:extLst>
          </p:cNvPr>
          <p:cNvSpPr txBox="1"/>
          <p:nvPr/>
        </p:nvSpPr>
        <p:spPr>
          <a:xfrm>
            <a:off x="4156507" y="5011056"/>
            <a:ext cx="659822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EAD83413-36E4-5ECC-BB7A-0EF15222F1BA}"/>
              </a:ext>
            </a:extLst>
          </p:cNvPr>
          <p:cNvSpPr txBox="1"/>
          <p:nvPr/>
        </p:nvSpPr>
        <p:spPr>
          <a:xfrm>
            <a:off x="4157823" y="3130297"/>
            <a:ext cx="659822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26A68B39-F27C-6C7B-C509-68B5C3A39C3A}"/>
              </a:ext>
            </a:extLst>
          </p:cNvPr>
          <p:cNvSpPr txBox="1"/>
          <p:nvPr/>
        </p:nvSpPr>
        <p:spPr>
          <a:xfrm>
            <a:off x="6213990" y="3072569"/>
            <a:ext cx="659822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E6E74871-E778-76E1-51C6-B4730AC8EE37}"/>
              </a:ext>
            </a:extLst>
          </p:cNvPr>
          <p:cNvSpPr txBox="1"/>
          <p:nvPr/>
        </p:nvSpPr>
        <p:spPr>
          <a:xfrm>
            <a:off x="6431925" y="3437839"/>
            <a:ext cx="659822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5">
            <a:extLst>
              <a:ext uri="{FF2B5EF4-FFF2-40B4-BE49-F238E27FC236}">
                <a16:creationId xmlns:a16="http://schemas.microsoft.com/office/drawing/2014/main" id="{2090711D-993D-B534-3FD4-D1217BCA4547}"/>
              </a:ext>
            </a:extLst>
          </p:cNvPr>
          <p:cNvSpPr txBox="1"/>
          <p:nvPr/>
        </p:nvSpPr>
        <p:spPr>
          <a:xfrm>
            <a:off x="1911911" y="4794053"/>
            <a:ext cx="659821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5">
            <a:extLst>
              <a:ext uri="{FF2B5EF4-FFF2-40B4-BE49-F238E27FC236}">
                <a16:creationId xmlns:a16="http://schemas.microsoft.com/office/drawing/2014/main" id="{A379A6D5-8220-43A5-4965-AAAC32D2C7BF}"/>
              </a:ext>
            </a:extLst>
          </p:cNvPr>
          <p:cNvSpPr txBox="1"/>
          <p:nvPr/>
        </p:nvSpPr>
        <p:spPr>
          <a:xfrm>
            <a:off x="3980466" y="4762105"/>
            <a:ext cx="659821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4">
            <a:extLst>
              <a:ext uri="{FF2B5EF4-FFF2-40B4-BE49-F238E27FC236}">
                <a16:creationId xmlns:a16="http://schemas.microsoft.com/office/drawing/2014/main" id="{93C50473-457A-06E5-3925-75ACCA249A54}"/>
              </a:ext>
            </a:extLst>
          </p:cNvPr>
          <p:cNvSpPr txBox="1"/>
          <p:nvPr/>
        </p:nvSpPr>
        <p:spPr>
          <a:xfrm>
            <a:off x="4158011" y="6891961"/>
            <a:ext cx="659822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5">
            <a:extLst>
              <a:ext uri="{FF2B5EF4-FFF2-40B4-BE49-F238E27FC236}">
                <a16:creationId xmlns:a16="http://schemas.microsoft.com/office/drawing/2014/main" id="{88DFEBBA-0522-1F70-B567-15F2821A7A9D}"/>
              </a:ext>
            </a:extLst>
          </p:cNvPr>
          <p:cNvSpPr txBox="1"/>
          <p:nvPr/>
        </p:nvSpPr>
        <p:spPr>
          <a:xfrm>
            <a:off x="6469527" y="6557213"/>
            <a:ext cx="659821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5">
            <a:extLst>
              <a:ext uri="{FF2B5EF4-FFF2-40B4-BE49-F238E27FC236}">
                <a16:creationId xmlns:a16="http://schemas.microsoft.com/office/drawing/2014/main" id="{16CE66FE-A5E3-031D-5914-F1DD499F0ED9}"/>
              </a:ext>
            </a:extLst>
          </p:cNvPr>
          <p:cNvSpPr txBox="1"/>
          <p:nvPr/>
        </p:nvSpPr>
        <p:spPr>
          <a:xfrm>
            <a:off x="4187039" y="8362632"/>
            <a:ext cx="659821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5">
            <a:extLst>
              <a:ext uri="{FF2B5EF4-FFF2-40B4-BE49-F238E27FC236}">
                <a16:creationId xmlns:a16="http://schemas.microsoft.com/office/drawing/2014/main" id="{6868549A-E0EA-B0DC-C580-2158587BCC45}"/>
              </a:ext>
            </a:extLst>
          </p:cNvPr>
          <p:cNvSpPr txBox="1"/>
          <p:nvPr/>
        </p:nvSpPr>
        <p:spPr>
          <a:xfrm>
            <a:off x="6469590" y="8515031"/>
            <a:ext cx="659821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3995212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7" name="グラフ 36">
            <a:extLst>
              <a:ext uri="{FF2B5EF4-FFF2-40B4-BE49-F238E27FC236}">
                <a16:creationId xmlns:a16="http://schemas.microsoft.com/office/drawing/2014/main" id="{85DDD61F-E430-47DA-8948-BADE568603A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13097102"/>
              </p:ext>
            </p:extLst>
          </p:nvPr>
        </p:nvGraphicFramePr>
        <p:xfrm>
          <a:off x="21600" y="928800"/>
          <a:ext cx="2265529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8" name="グラフ 37">
            <a:extLst>
              <a:ext uri="{FF2B5EF4-FFF2-40B4-BE49-F238E27FC236}">
                <a16:creationId xmlns:a16="http://schemas.microsoft.com/office/drawing/2014/main" id="{AF66567F-A067-4CF4-95A8-41128EF818B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05012002"/>
              </p:ext>
            </p:extLst>
          </p:nvPr>
        </p:nvGraphicFramePr>
        <p:xfrm>
          <a:off x="2296801" y="928800"/>
          <a:ext cx="2265528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9" name="グラフ 38">
            <a:extLst>
              <a:ext uri="{FF2B5EF4-FFF2-40B4-BE49-F238E27FC236}">
                <a16:creationId xmlns:a16="http://schemas.microsoft.com/office/drawing/2014/main" id="{3463AEBE-C6C9-4DD9-88E2-17308D91CC8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37111198"/>
              </p:ext>
            </p:extLst>
          </p:nvPr>
        </p:nvGraphicFramePr>
        <p:xfrm>
          <a:off x="4571617" y="928800"/>
          <a:ext cx="2265528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40" name="グラフ 39">
            <a:extLst>
              <a:ext uri="{FF2B5EF4-FFF2-40B4-BE49-F238E27FC236}">
                <a16:creationId xmlns:a16="http://schemas.microsoft.com/office/drawing/2014/main" id="{874505EF-88C8-487F-85B6-9E9A6508CE1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8809269"/>
              </p:ext>
            </p:extLst>
          </p:nvPr>
        </p:nvGraphicFramePr>
        <p:xfrm>
          <a:off x="21600" y="2733300"/>
          <a:ext cx="2265529" cy="16083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41" name="グラフ 40">
            <a:extLst>
              <a:ext uri="{FF2B5EF4-FFF2-40B4-BE49-F238E27FC236}">
                <a16:creationId xmlns:a16="http://schemas.microsoft.com/office/drawing/2014/main" id="{6739FEF4-DDA8-4399-AEBC-A489A8608D2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28466585"/>
              </p:ext>
            </p:extLst>
          </p:nvPr>
        </p:nvGraphicFramePr>
        <p:xfrm>
          <a:off x="2296801" y="2733300"/>
          <a:ext cx="2265528" cy="16083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42" name="グラフ 41">
            <a:extLst>
              <a:ext uri="{FF2B5EF4-FFF2-40B4-BE49-F238E27FC236}">
                <a16:creationId xmlns:a16="http://schemas.microsoft.com/office/drawing/2014/main" id="{7D4D3F94-80ED-496F-B8F7-8F7CA27BC22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07304390"/>
              </p:ext>
            </p:extLst>
          </p:nvPr>
        </p:nvGraphicFramePr>
        <p:xfrm>
          <a:off x="4571617" y="2733300"/>
          <a:ext cx="2265528" cy="16083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43" name="グラフ 42">
            <a:extLst>
              <a:ext uri="{FF2B5EF4-FFF2-40B4-BE49-F238E27FC236}">
                <a16:creationId xmlns:a16="http://schemas.microsoft.com/office/drawing/2014/main" id="{0FE84D6C-F4A9-4938-9C34-D5B7EB46E15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47400763"/>
              </p:ext>
            </p:extLst>
          </p:nvPr>
        </p:nvGraphicFramePr>
        <p:xfrm>
          <a:off x="21601" y="4537801"/>
          <a:ext cx="2265528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44" name="グラフ 43">
            <a:extLst>
              <a:ext uri="{FF2B5EF4-FFF2-40B4-BE49-F238E27FC236}">
                <a16:creationId xmlns:a16="http://schemas.microsoft.com/office/drawing/2014/main" id="{0280F7A6-ADB5-43F2-8328-94EB67BEA14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59032845"/>
              </p:ext>
            </p:extLst>
          </p:nvPr>
        </p:nvGraphicFramePr>
        <p:xfrm>
          <a:off x="2296801" y="4537801"/>
          <a:ext cx="2265529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45" name="グラフ 44">
            <a:extLst>
              <a:ext uri="{FF2B5EF4-FFF2-40B4-BE49-F238E27FC236}">
                <a16:creationId xmlns:a16="http://schemas.microsoft.com/office/drawing/2014/main" id="{0BC9B9E3-B76B-476B-9F87-3ADCDDBD432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56735428"/>
              </p:ext>
            </p:extLst>
          </p:nvPr>
        </p:nvGraphicFramePr>
        <p:xfrm>
          <a:off x="4571617" y="4537801"/>
          <a:ext cx="2265528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46" name="グラフ 45">
            <a:extLst>
              <a:ext uri="{FF2B5EF4-FFF2-40B4-BE49-F238E27FC236}">
                <a16:creationId xmlns:a16="http://schemas.microsoft.com/office/drawing/2014/main" id="{38EAF138-4431-424A-B0D9-9AC201C5059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83926810"/>
              </p:ext>
            </p:extLst>
          </p:nvPr>
        </p:nvGraphicFramePr>
        <p:xfrm>
          <a:off x="21601" y="6347779"/>
          <a:ext cx="2265528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47" name="グラフ 46">
            <a:extLst>
              <a:ext uri="{FF2B5EF4-FFF2-40B4-BE49-F238E27FC236}">
                <a16:creationId xmlns:a16="http://schemas.microsoft.com/office/drawing/2014/main" id="{0600C725-096E-4FE7-8B86-76740C291AD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75765976"/>
              </p:ext>
            </p:extLst>
          </p:nvPr>
        </p:nvGraphicFramePr>
        <p:xfrm>
          <a:off x="2296801" y="6347779"/>
          <a:ext cx="2265528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graphicFrame>
        <p:nvGraphicFramePr>
          <p:cNvPr id="48" name="グラフ 47">
            <a:extLst>
              <a:ext uri="{FF2B5EF4-FFF2-40B4-BE49-F238E27FC236}">
                <a16:creationId xmlns:a16="http://schemas.microsoft.com/office/drawing/2014/main" id="{772B2C10-B3C8-421C-AAA3-13D7B3F4219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87879298"/>
              </p:ext>
            </p:extLst>
          </p:nvPr>
        </p:nvGraphicFramePr>
        <p:xfrm>
          <a:off x="4571617" y="6347779"/>
          <a:ext cx="2265528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graphicFrame>
        <p:nvGraphicFramePr>
          <p:cNvPr id="49" name="グラフ 48">
            <a:extLst>
              <a:ext uri="{FF2B5EF4-FFF2-40B4-BE49-F238E27FC236}">
                <a16:creationId xmlns:a16="http://schemas.microsoft.com/office/drawing/2014/main" id="{A1A80513-333A-47C0-B8B9-262CDA6154A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4412320"/>
              </p:ext>
            </p:extLst>
          </p:nvPr>
        </p:nvGraphicFramePr>
        <p:xfrm>
          <a:off x="21601" y="8146800"/>
          <a:ext cx="2265528" cy="15667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graphicFrame>
        <p:nvGraphicFramePr>
          <p:cNvPr id="50" name="グラフ 49">
            <a:extLst>
              <a:ext uri="{FF2B5EF4-FFF2-40B4-BE49-F238E27FC236}">
                <a16:creationId xmlns:a16="http://schemas.microsoft.com/office/drawing/2014/main" id="{F58CB61D-F2C0-44BE-AD72-425B8BDBA42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46336562"/>
              </p:ext>
            </p:extLst>
          </p:nvPr>
        </p:nvGraphicFramePr>
        <p:xfrm>
          <a:off x="2296801" y="8146800"/>
          <a:ext cx="2265529" cy="15667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5"/>
          </a:graphicData>
        </a:graphic>
      </p:graphicFrame>
      <p:graphicFrame>
        <p:nvGraphicFramePr>
          <p:cNvPr id="51" name="グラフ 50">
            <a:extLst>
              <a:ext uri="{FF2B5EF4-FFF2-40B4-BE49-F238E27FC236}">
                <a16:creationId xmlns:a16="http://schemas.microsoft.com/office/drawing/2014/main" id="{4808EDA8-5135-4F1C-B510-488CABD17D5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80292577"/>
              </p:ext>
            </p:extLst>
          </p:nvPr>
        </p:nvGraphicFramePr>
        <p:xfrm>
          <a:off x="4571617" y="8146800"/>
          <a:ext cx="2265529" cy="15667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6"/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8B63DB2B-69DD-B403-C6D6-687F82A90B8C}"/>
              </a:ext>
            </a:extLst>
          </p:cNvPr>
          <p:cNvSpPr txBox="1"/>
          <p:nvPr/>
        </p:nvSpPr>
        <p:spPr>
          <a:xfrm>
            <a:off x="172112" y="637439"/>
            <a:ext cx="66858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4">
            <a:extLst>
              <a:ext uri="{FF2B5EF4-FFF2-40B4-BE49-F238E27FC236}">
                <a16:creationId xmlns:a16="http://schemas.microsoft.com/office/drawing/2014/main" id="{CF6B94C9-0EBB-E7A2-2C5F-B18EF5062098}"/>
              </a:ext>
            </a:extLst>
          </p:cNvPr>
          <p:cNvSpPr txBox="1"/>
          <p:nvPr/>
        </p:nvSpPr>
        <p:spPr>
          <a:xfrm>
            <a:off x="1455707" y="1435424"/>
            <a:ext cx="659822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4">
            <a:extLst>
              <a:ext uri="{FF2B5EF4-FFF2-40B4-BE49-F238E27FC236}">
                <a16:creationId xmlns:a16="http://schemas.microsoft.com/office/drawing/2014/main" id="{D0E65472-C819-93B1-BACA-F7DC90E8AE47}"/>
              </a:ext>
            </a:extLst>
          </p:cNvPr>
          <p:cNvSpPr txBox="1"/>
          <p:nvPr/>
        </p:nvSpPr>
        <p:spPr>
          <a:xfrm>
            <a:off x="1666367" y="1499024"/>
            <a:ext cx="659822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FBBA082E-49EE-0D5C-2565-287CF73DA877}"/>
              </a:ext>
            </a:extLst>
          </p:cNvPr>
          <p:cNvSpPr txBox="1"/>
          <p:nvPr/>
        </p:nvSpPr>
        <p:spPr>
          <a:xfrm>
            <a:off x="1887350" y="1387877"/>
            <a:ext cx="659822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46C4E908-0DD6-4219-FAC2-95A03895DFD3}"/>
              </a:ext>
            </a:extLst>
          </p:cNvPr>
          <p:cNvSpPr txBox="1"/>
          <p:nvPr/>
        </p:nvSpPr>
        <p:spPr>
          <a:xfrm>
            <a:off x="3978213" y="1342995"/>
            <a:ext cx="659821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CC9877DA-5381-0B30-7E01-E53C45F8DD8D}"/>
              </a:ext>
            </a:extLst>
          </p:cNvPr>
          <p:cNvSpPr txBox="1"/>
          <p:nvPr/>
        </p:nvSpPr>
        <p:spPr>
          <a:xfrm>
            <a:off x="4188398" y="1368619"/>
            <a:ext cx="659821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4">
            <a:extLst>
              <a:ext uri="{FF2B5EF4-FFF2-40B4-BE49-F238E27FC236}">
                <a16:creationId xmlns:a16="http://schemas.microsoft.com/office/drawing/2014/main" id="{2FC58093-8554-3420-67D7-3D36B956729C}"/>
              </a:ext>
            </a:extLst>
          </p:cNvPr>
          <p:cNvSpPr txBox="1"/>
          <p:nvPr/>
        </p:nvSpPr>
        <p:spPr>
          <a:xfrm>
            <a:off x="6003762" y="1172876"/>
            <a:ext cx="659822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4">
            <a:extLst>
              <a:ext uri="{FF2B5EF4-FFF2-40B4-BE49-F238E27FC236}">
                <a16:creationId xmlns:a16="http://schemas.microsoft.com/office/drawing/2014/main" id="{4DFAF848-0C84-2EB1-61F9-3922F0083996}"/>
              </a:ext>
            </a:extLst>
          </p:cNvPr>
          <p:cNvSpPr txBox="1"/>
          <p:nvPr/>
        </p:nvSpPr>
        <p:spPr>
          <a:xfrm>
            <a:off x="6213879" y="1096674"/>
            <a:ext cx="659822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4">
            <a:extLst>
              <a:ext uri="{FF2B5EF4-FFF2-40B4-BE49-F238E27FC236}">
                <a16:creationId xmlns:a16="http://schemas.microsoft.com/office/drawing/2014/main" id="{DB069B73-5BFC-AF80-96DA-25A9534688E6}"/>
              </a:ext>
            </a:extLst>
          </p:cNvPr>
          <p:cNvSpPr txBox="1"/>
          <p:nvPr/>
        </p:nvSpPr>
        <p:spPr>
          <a:xfrm>
            <a:off x="6428074" y="975062"/>
            <a:ext cx="659822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4">
            <a:extLst>
              <a:ext uri="{FF2B5EF4-FFF2-40B4-BE49-F238E27FC236}">
                <a16:creationId xmlns:a16="http://schemas.microsoft.com/office/drawing/2014/main" id="{E7627472-5533-AA2E-583F-3DDB40247287}"/>
              </a:ext>
            </a:extLst>
          </p:cNvPr>
          <p:cNvSpPr txBox="1"/>
          <p:nvPr/>
        </p:nvSpPr>
        <p:spPr>
          <a:xfrm>
            <a:off x="5796824" y="3116345"/>
            <a:ext cx="659822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4">
            <a:extLst>
              <a:ext uri="{FF2B5EF4-FFF2-40B4-BE49-F238E27FC236}">
                <a16:creationId xmlns:a16="http://schemas.microsoft.com/office/drawing/2014/main" id="{1819FA65-53FE-F013-91B3-0F5CD889FE8B}"/>
              </a:ext>
            </a:extLst>
          </p:cNvPr>
          <p:cNvSpPr txBox="1"/>
          <p:nvPr/>
        </p:nvSpPr>
        <p:spPr>
          <a:xfrm>
            <a:off x="6006941" y="3148999"/>
            <a:ext cx="659822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4">
            <a:extLst>
              <a:ext uri="{FF2B5EF4-FFF2-40B4-BE49-F238E27FC236}">
                <a16:creationId xmlns:a16="http://schemas.microsoft.com/office/drawing/2014/main" id="{5A387F0F-C49D-76F1-801B-2A36979D92B0}"/>
              </a:ext>
            </a:extLst>
          </p:cNvPr>
          <p:cNvSpPr txBox="1"/>
          <p:nvPr/>
        </p:nvSpPr>
        <p:spPr>
          <a:xfrm>
            <a:off x="6428074" y="3099034"/>
            <a:ext cx="659822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4">
            <a:extLst>
              <a:ext uri="{FF2B5EF4-FFF2-40B4-BE49-F238E27FC236}">
                <a16:creationId xmlns:a16="http://schemas.microsoft.com/office/drawing/2014/main" id="{08B4F4D7-1CB5-553D-2040-A0FAE4A465F5}"/>
              </a:ext>
            </a:extLst>
          </p:cNvPr>
          <p:cNvSpPr txBox="1"/>
          <p:nvPr/>
        </p:nvSpPr>
        <p:spPr>
          <a:xfrm>
            <a:off x="3512231" y="4923972"/>
            <a:ext cx="659822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4">
            <a:extLst>
              <a:ext uri="{FF2B5EF4-FFF2-40B4-BE49-F238E27FC236}">
                <a16:creationId xmlns:a16="http://schemas.microsoft.com/office/drawing/2014/main" id="{E3B8666E-397D-CDD2-B049-7CE7A7390FEC}"/>
              </a:ext>
            </a:extLst>
          </p:cNvPr>
          <p:cNvSpPr txBox="1"/>
          <p:nvPr/>
        </p:nvSpPr>
        <p:spPr>
          <a:xfrm>
            <a:off x="3729605" y="5196109"/>
            <a:ext cx="659822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4">
            <a:extLst>
              <a:ext uri="{FF2B5EF4-FFF2-40B4-BE49-F238E27FC236}">
                <a16:creationId xmlns:a16="http://schemas.microsoft.com/office/drawing/2014/main" id="{83705861-723C-CF6D-845F-B9F4282FA229}"/>
              </a:ext>
            </a:extLst>
          </p:cNvPr>
          <p:cNvSpPr txBox="1"/>
          <p:nvPr/>
        </p:nvSpPr>
        <p:spPr>
          <a:xfrm>
            <a:off x="4157995" y="5196945"/>
            <a:ext cx="659822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4">
            <a:extLst>
              <a:ext uri="{FF2B5EF4-FFF2-40B4-BE49-F238E27FC236}">
                <a16:creationId xmlns:a16="http://schemas.microsoft.com/office/drawing/2014/main" id="{4BF73597-5CC3-8AFA-ABA0-62349617EFE8}"/>
              </a:ext>
            </a:extLst>
          </p:cNvPr>
          <p:cNvSpPr txBox="1"/>
          <p:nvPr/>
        </p:nvSpPr>
        <p:spPr>
          <a:xfrm>
            <a:off x="3946256" y="5200573"/>
            <a:ext cx="659822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4">
            <a:extLst>
              <a:ext uri="{FF2B5EF4-FFF2-40B4-BE49-F238E27FC236}">
                <a16:creationId xmlns:a16="http://schemas.microsoft.com/office/drawing/2014/main" id="{5CE83465-6A7B-CF40-0588-1A2B10C5D12C}"/>
              </a:ext>
            </a:extLst>
          </p:cNvPr>
          <p:cNvSpPr txBox="1"/>
          <p:nvPr/>
        </p:nvSpPr>
        <p:spPr>
          <a:xfrm>
            <a:off x="3729605" y="6707285"/>
            <a:ext cx="659822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8796C18E-D58C-F120-C7EF-163AEDC736D3}"/>
              </a:ext>
            </a:extLst>
          </p:cNvPr>
          <p:cNvSpPr txBox="1"/>
          <p:nvPr/>
        </p:nvSpPr>
        <p:spPr>
          <a:xfrm>
            <a:off x="3978212" y="6688962"/>
            <a:ext cx="659821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4">
            <a:extLst>
              <a:ext uri="{FF2B5EF4-FFF2-40B4-BE49-F238E27FC236}">
                <a16:creationId xmlns:a16="http://schemas.microsoft.com/office/drawing/2014/main" id="{675D700C-1F17-2042-7EAA-37B0BEF6DADE}"/>
              </a:ext>
            </a:extLst>
          </p:cNvPr>
          <p:cNvSpPr txBox="1"/>
          <p:nvPr/>
        </p:nvSpPr>
        <p:spPr>
          <a:xfrm>
            <a:off x="5793015" y="6342028"/>
            <a:ext cx="659822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4">
            <a:extLst>
              <a:ext uri="{FF2B5EF4-FFF2-40B4-BE49-F238E27FC236}">
                <a16:creationId xmlns:a16="http://schemas.microsoft.com/office/drawing/2014/main" id="{B8F8727D-9F5F-EEF8-2304-57BBC74B0365}"/>
              </a:ext>
            </a:extLst>
          </p:cNvPr>
          <p:cNvSpPr txBox="1"/>
          <p:nvPr/>
        </p:nvSpPr>
        <p:spPr>
          <a:xfrm>
            <a:off x="6004823" y="6346633"/>
            <a:ext cx="659822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5129315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45C0EB13-627C-4E93-9DE6-D0629771FF1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30933554"/>
              </p:ext>
            </p:extLst>
          </p:nvPr>
        </p:nvGraphicFramePr>
        <p:xfrm>
          <a:off x="43746" y="928800"/>
          <a:ext cx="2265528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グラフ 4">
            <a:extLst>
              <a:ext uri="{FF2B5EF4-FFF2-40B4-BE49-F238E27FC236}">
                <a16:creationId xmlns:a16="http://schemas.microsoft.com/office/drawing/2014/main" id="{F5689105-06BD-4762-BF41-3792F5C6C63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46631460"/>
              </p:ext>
            </p:extLst>
          </p:nvPr>
        </p:nvGraphicFramePr>
        <p:xfrm>
          <a:off x="2296800" y="928800"/>
          <a:ext cx="2265528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グラフ 5">
            <a:extLst>
              <a:ext uri="{FF2B5EF4-FFF2-40B4-BE49-F238E27FC236}">
                <a16:creationId xmlns:a16="http://schemas.microsoft.com/office/drawing/2014/main" id="{5F382A67-ECC3-4246-B144-E32F7004849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79631248"/>
              </p:ext>
            </p:extLst>
          </p:nvPr>
        </p:nvGraphicFramePr>
        <p:xfrm>
          <a:off x="4572000" y="928800"/>
          <a:ext cx="2265528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" name="グラフ 6">
            <a:extLst>
              <a:ext uri="{FF2B5EF4-FFF2-40B4-BE49-F238E27FC236}">
                <a16:creationId xmlns:a16="http://schemas.microsoft.com/office/drawing/2014/main" id="{3128AF31-8381-45FF-A870-7ED83DBDB57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97782660"/>
              </p:ext>
            </p:extLst>
          </p:nvPr>
        </p:nvGraphicFramePr>
        <p:xfrm>
          <a:off x="43746" y="2733300"/>
          <a:ext cx="2265528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8" name="グラフ 7">
            <a:extLst>
              <a:ext uri="{FF2B5EF4-FFF2-40B4-BE49-F238E27FC236}">
                <a16:creationId xmlns:a16="http://schemas.microsoft.com/office/drawing/2014/main" id="{4A80554F-A4AC-4AC0-8A63-47E99E8F992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50138198"/>
              </p:ext>
            </p:extLst>
          </p:nvPr>
        </p:nvGraphicFramePr>
        <p:xfrm>
          <a:off x="2296800" y="2733299"/>
          <a:ext cx="2265529" cy="16083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9" name="グラフ 8">
            <a:extLst>
              <a:ext uri="{FF2B5EF4-FFF2-40B4-BE49-F238E27FC236}">
                <a16:creationId xmlns:a16="http://schemas.microsoft.com/office/drawing/2014/main" id="{D8EB9569-703A-4BF4-A42B-63D69E26D94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18795294"/>
              </p:ext>
            </p:extLst>
          </p:nvPr>
        </p:nvGraphicFramePr>
        <p:xfrm>
          <a:off x="4572000" y="2733300"/>
          <a:ext cx="2265528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0" name="グラフ 9">
            <a:extLst>
              <a:ext uri="{FF2B5EF4-FFF2-40B4-BE49-F238E27FC236}">
                <a16:creationId xmlns:a16="http://schemas.microsoft.com/office/drawing/2014/main" id="{087409E2-C41E-442B-8C23-58EE816F105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35337936"/>
              </p:ext>
            </p:extLst>
          </p:nvPr>
        </p:nvGraphicFramePr>
        <p:xfrm>
          <a:off x="43746" y="4537800"/>
          <a:ext cx="2265528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1" name="グラフ 10">
            <a:extLst>
              <a:ext uri="{FF2B5EF4-FFF2-40B4-BE49-F238E27FC236}">
                <a16:creationId xmlns:a16="http://schemas.microsoft.com/office/drawing/2014/main" id="{89E9258A-5681-4BCE-96AE-BAF3A0C5A36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46864059"/>
              </p:ext>
            </p:extLst>
          </p:nvPr>
        </p:nvGraphicFramePr>
        <p:xfrm>
          <a:off x="2296800" y="4537800"/>
          <a:ext cx="2265529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12" name="グラフ 11">
            <a:extLst>
              <a:ext uri="{FF2B5EF4-FFF2-40B4-BE49-F238E27FC236}">
                <a16:creationId xmlns:a16="http://schemas.microsoft.com/office/drawing/2014/main" id="{54C094B9-37BE-4674-876E-BA2982BB211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24044509"/>
              </p:ext>
            </p:extLst>
          </p:nvPr>
        </p:nvGraphicFramePr>
        <p:xfrm>
          <a:off x="4572000" y="4537800"/>
          <a:ext cx="2265528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13" name="グラフ 12">
            <a:extLst>
              <a:ext uri="{FF2B5EF4-FFF2-40B4-BE49-F238E27FC236}">
                <a16:creationId xmlns:a16="http://schemas.microsoft.com/office/drawing/2014/main" id="{89639B14-3649-4E9C-8EEC-CA96A24C287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41995347"/>
              </p:ext>
            </p:extLst>
          </p:nvPr>
        </p:nvGraphicFramePr>
        <p:xfrm>
          <a:off x="43746" y="6342300"/>
          <a:ext cx="2265528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14" name="グラフ 13">
            <a:extLst>
              <a:ext uri="{FF2B5EF4-FFF2-40B4-BE49-F238E27FC236}">
                <a16:creationId xmlns:a16="http://schemas.microsoft.com/office/drawing/2014/main" id="{C6311D3D-5EA5-4350-950F-8C65FADC60C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0909563"/>
              </p:ext>
            </p:extLst>
          </p:nvPr>
        </p:nvGraphicFramePr>
        <p:xfrm>
          <a:off x="2296800" y="6342300"/>
          <a:ext cx="2265528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graphicFrame>
        <p:nvGraphicFramePr>
          <p:cNvPr id="15" name="グラフ 14">
            <a:extLst>
              <a:ext uri="{FF2B5EF4-FFF2-40B4-BE49-F238E27FC236}">
                <a16:creationId xmlns:a16="http://schemas.microsoft.com/office/drawing/2014/main" id="{50FB6686-20D6-4574-822B-72040904BF2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73698662"/>
              </p:ext>
            </p:extLst>
          </p:nvPr>
        </p:nvGraphicFramePr>
        <p:xfrm>
          <a:off x="4572000" y="6342300"/>
          <a:ext cx="2265528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graphicFrame>
        <p:nvGraphicFramePr>
          <p:cNvPr id="16" name="グラフ 15">
            <a:extLst>
              <a:ext uri="{FF2B5EF4-FFF2-40B4-BE49-F238E27FC236}">
                <a16:creationId xmlns:a16="http://schemas.microsoft.com/office/drawing/2014/main" id="{6F4DB032-DD17-4845-9F63-54EC2F37FCA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786855"/>
              </p:ext>
            </p:extLst>
          </p:nvPr>
        </p:nvGraphicFramePr>
        <p:xfrm>
          <a:off x="43746" y="8146800"/>
          <a:ext cx="2265528" cy="15625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graphicFrame>
        <p:nvGraphicFramePr>
          <p:cNvPr id="17" name="グラフ 16">
            <a:extLst>
              <a:ext uri="{FF2B5EF4-FFF2-40B4-BE49-F238E27FC236}">
                <a16:creationId xmlns:a16="http://schemas.microsoft.com/office/drawing/2014/main" id="{7E396EE7-4E7C-49F1-AF07-4409B45D576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7799207"/>
              </p:ext>
            </p:extLst>
          </p:nvPr>
        </p:nvGraphicFramePr>
        <p:xfrm>
          <a:off x="2296800" y="8146800"/>
          <a:ext cx="2265528" cy="15625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5"/>
          </a:graphicData>
        </a:graphic>
      </p:graphicFrame>
      <p:graphicFrame>
        <p:nvGraphicFramePr>
          <p:cNvPr id="18" name="グラフ 17">
            <a:extLst>
              <a:ext uri="{FF2B5EF4-FFF2-40B4-BE49-F238E27FC236}">
                <a16:creationId xmlns:a16="http://schemas.microsoft.com/office/drawing/2014/main" id="{090ADC9E-3648-4126-9213-B2D8AEB7620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06726760"/>
              </p:ext>
            </p:extLst>
          </p:nvPr>
        </p:nvGraphicFramePr>
        <p:xfrm>
          <a:off x="4571999" y="8146800"/>
          <a:ext cx="2265529" cy="15625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6"/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1017C56B-A170-EA12-AD49-FDB0941B350D}"/>
              </a:ext>
            </a:extLst>
          </p:cNvPr>
          <p:cNvSpPr txBox="1"/>
          <p:nvPr/>
        </p:nvSpPr>
        <p:spPr>
          <a:xfrm>
            <a:off x="172112" y="637439"/>
            <a:ext cx="66858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4">
            <a:extLst>
              <a:ext uri="{FF2B5EF4-FFF2-40B4-BE49-F238E27FC236}">
                <a16:creationId xmlns:a16="http://schemas.microsoft.com/office/drawing/2014/main" id="{F47077C2-DF7A-4874-5B9D-0FB9E7F9A02E}"/>
              </a:ext>
            </a:extLst>
          </p:cNvPr>
          <p:cNvSpPr txBox="1"/>
          <p:nvPr/>
        </p:nvSpPr>
        <p:spPr>
          <a:xfrm>
            <a:off x="1907901" y="6656609"/>
            <a:ext cx="659822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3FA1D118-97CD-E6BF-708C-5E06107BB09C}"/>
              </a:ext>
            </a:extLst>
          </p:cNvPr>
          <p:cNvSpPr txBox="1"/>
          <p:nvPr/>
        </p:nvSpPr>
        <p:spPr>
          <a:xfrm>
            <a:off x="1089700" y="996253"/>
            <a:ext cx="659821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4192FC52-623F-50FE-0A40-86E41541B8D6}"/>
              </a:ext>
            </a:extLst>
          </p:cNvPr>
          <p:cNvSpPr txBox="1"/>
          <p:nvPr/>
        </p:nvSpPr>
        <p:spPr>
          <a:xfrm>
            <a:off x="5396623" y="1250367"/>
            <a:ext cx="659821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48735C53-7FF3-B9A5-DEF1-72D8E246BD27}"/>
              </a:ext>
            </a:extLst>
          </p:cNvPr>
          <p:cNvSpPr txBox="1"/>
          <p:nvPr/>
        </p:nvSpPr>
        <p:spPr>
          <a:xfrm>
            <a:off x="1722913" y="6629278"/>
            <a:ext cx="659821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テキスト ボックス 4">
            <a:extLst>
              <a:ext uri="{FF2B5EF4-FFF2-40B4-BE49-F238E27FC236}">
                <a16:creationId xmlns:a16="http://schemas.microsoft.com/office/drawing/2014/main" id="{2C2E9583-3858-F85C-7202-A8966AADCE6F}"/>
              </a:ext>
            </a:extLst>
          </p:cNvPr>
          <p:cNvSpPr txBox="1"/>
          <p:nvPr/>
        </p:nvSpPr>
        <p:spPr>
          <a:xfrm>
            <a:off x="6428074" y="6353185"/>
            <a:ext cx="659822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530791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781DCE48-C699-4A39-803D-EE989350133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4267389"/>
              </p:ext>
            </p:extLst>
          </p:nvPr>
        </p:nvGraphicFramePr>
        <p:xfrm>
          <a:off x="21600" y="925170"/>
          <a:ext cx="2265528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グラフ 4">
            <a:extLst>
              <a:ext uri="{FF2B5EF4-FFF2-40B4-BE49-F238E27FC236}">
                <a16:creationId xmlns:a16="http://schemas.microsoft.com/office/drawing/2014/main" id="{AC960F6F-B598-4307-A564-B8D623B378B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84404157"/>
              </p:ext>
            </p:extLst>
          </p:nvPr>
        </p:nvGraphicFramePr>
        <p:xfrm>
          <a:off x="2296800" y="928800"/>
          <a:ext cx="2265528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グラフ 5">
            <a:extLst>
              <a:ext uri="{FF2B5EF4-FFF2-40B4-BE49-F238E27FC236}">
                <a16:creationId xmlns:a16="http://schemas.microsoft.com/office/drawing/2014/main" id="{CDEA703F-1872-488E-B3BC-D9331CABFE5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38406392"/>
              </p:ext>
            </p:extLst>
          </p:nvPr>
        </p:nvGraphicFramePr>
        <p:xfrm>
          <a:off x="4572000" y="928800"/>
          <a:ext cx="2265528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" name="グラフ 6">
            <a:extLst>
              <a:ext uri="{FF2B5EF4-FFF2-40B4-BE49-F238E27FC236}">
                <a16:creationId xmlns:a16="http://schemas.microsoft.com/office/drawing/2014/main" id="{CBFEA30C-DC1D-4AE8-9E42-C829D1C46E6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75130546"/>
              </p:ext>
            </p:extLst>
          </p:nvPr>
        </p:nvGraphicFramePr>
        <p:xfrm>
          <a:off x="21600" y="2729670"/>
          <a:ext cx="2260419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8" name="グラフ 7">
            <a:extLst>
              <a:ext uri="{FF2B5EF4-FFF2-40B4-BE49-F238E27FC236}">
                <a16:creationId xmlns:a16="http://schemas.microsoft.com/office/drawing/2014/main" id="{5BB9D619-788A-4931-9251-3D0CBE8A684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78614284"/>
              </p:ext>
            </p:extLst>
          </p:nvPr>
        </p:nvGraphicFramePr>
        <p:xfrm>
          <a:off x="2296800" y="2670318"/>
          <a:ext cx="2260419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9" name="グラフ 8">
            <a:extLst>
              <a:ext uri="{FF2B5EF4-FFF2-40B4-BE49-F238E27FC236}">
                <a16:creationId xmlns:a16="http://schemas.microsoft.com/office/drawing/2014/main" id="{B8DEE81C-9F91-4EB2-ACA1-B441CFC1387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77713554"/>
              </p:ext>
            </p:extLst>
          </p:nvPr>
        </p:nvGraphicFramePr>
        <p:xfrm>
          <a:off x="4577109" y="2670318"/>
          <a:ext cx="2260419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0" name="グラフ 9">
            <a:extLst>
              <a:ext uri="{FF2B5EF4-FFF2-40B4-BE49-F238E27FC236}">
                <a16:creationId xmlns:a16="http://schemas.microsoft.com/office/drawing/2014/main" id="{A2053F80-ABC1-4EA4-8975-A283AB66F5A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59671449"/>
              </p:ext>
            </p:extLst>
          </p:nvPr>
        </p:nvGraphicFramePr>
        <p:xfrm>
          <a:off x="21600" y="4537800"/>
          <a:ext cx="2260419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1" name="グラフ 10">
            <a:extLst>
              <a:ext uri="{FF2B5EF4-FFF2-40B4-BE49-F238E27FC236}">
                <a16:creationId xmlns:a16="http://schemas.microsoft.com/office/drawing/2014/main" id="{DAA9D8E6-A085-4C50-833C-12B1773B285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77226621"/>
              </p:ext>
            </p:extLst>
          </p:nvPr>
        </p:nvGraphicFramePr>
        <p:xfrm>
          <a:off x="2296800" y="4537800"/>
          <a:ext cx="2260419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12" name="グラフ 11">
            <a:extLst>
              <a:ext uri="{FF2B5EF4-FFF2-40B4-BE49-F238E27FC236}">
                <a16:creationId xmlns:a16="http://schemas.microsoft.com/office/drawing/2014/main" id="{24ABFAC6-E4FC-42D2-9C26-8C617E698A3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61719632"/>
              </p:ext>
            </p:extLst>
          </p:nvPr>
        </p:nvGraphicFramePr>
        <p:xfrm>
          <a:off x="4577109" y="4537800"/>
          <a:ext cx="2260419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13" name="グラフ 12">
            <a:extLst>
              <a:ext uri="{FF2B5EF4-FFF2-40B4-BE49-F238E27FC236}">
                <a16:creationId xmlns:a16="http://schemas.microsoft.com/office/drawing/2014/main" id="{0E59BC81-FF0C-4F06-A014-5356B84686E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09981092"/>
              </p:ext>
            </p:extLst>
          </p:nvPr>
        </p:nvGraphicFramePr>
        <p:xfrm>
          <a:off x="21600" y="6342300"/>
          <a:ext cx="2260419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14" name="グラフ 13">
            <a:extLst>
              <a:ext uri="{FF2B5EF4-FFF2-40B4-BE49-F238E27FC236}">
                <a16:creationId xmlns:a16="http://schemas.microsoft.com/office/drawing/2014/main" id="{65452846-377B-458E-869E-1761ADB646F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41745137"/>
              </p:ext>
            </p:extLst>
          </p:nvPr>
        </p:nvGraphicFramePr>
        <p:xfrm>
          <a:off x="2296800" y="6342300"/>
          <a:ext cx="2260419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graphicFrame>
        <p:nvGraphicFramePr>
          <p:cNvPr id="15" name="グラフ 14">
            <a:extLst>
              <a:ext uri="{FF2B5EF4-FFF2-40B4-BE49-F238E27FC236}">
                <a16:creationId xmlns:a16="http://schemas.microsoft.com/office/drawing/2014/main" id="{142D5DA8-7FC6-4D7E-B6BB-4049D59BC0F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15172146"/>
              </p:ext>
            </p:extLst>
          </p:nvPr>
        </p:nvGraphicFramePr>
        <p:xfrm>
          <a:off x="4577109" y="6342300"/>
          <a:ext cx="2260419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graphicFrame>
        <p:nvGraphicFramePr>
          <p:cNvPr id="16" name="グラフ 15">
            <a:extLst>
              <a:ext uri="{FF2B5EF4-FFF2-40B4-BE49-F238E27FC236}">
                <a16:creationId xmlns:a16="http://schemas.microsoft.com/office/drawing/2014/main" id="{8272977B-3886-4FA8-9B93-62ABBADCD92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89886755"/>
              </p:ext>
            </p:extLst>
          </p:nvPr>
        </p:nvGraphicFramePr>
        <p:xfrm>
          <a:off x="21600" y="8146800"/>
          <a:ext cx="2260419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graphicFrame>
        <p:nvGraphicFramePr>
          <p:cNvPr id="17" name="グラフ 16">
            <a:extLst>
              <a:ext uri="{FF2B5EF4-FFF2-40B4-BE49-F238E27FC236}">
                <a16:creationId xmlns:a16="http://schemas.microsoft.com/office/drawing/2014/main" id="{228DF69F-A5DF-455D-BE96-889BB69CF15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8194151"/>
              </p:ext>
            </p:extLst>
          </p:nvPr>
        </p:nvGraphicFramePr>
        <p:xfrm>
          <a:off x="2296800" y="8146800"/>
          <a:ext cx="2260419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5"/>
          </a:graphicData>
        </a:graphic>
      </p:graphicFrame>
      <p:graphicFrame>
        <p:nvGraphicFramePr>
          <p:cNvPr id="18" name="グラフ 17">
            <a:extLst>
              <a:ext uri="{FF2B5EF4-FFF2-40B4-BE49-F238E27FC236}">
                <a16:creationId xmlns:a16="http://schemas.microsoft.com/office/drawing/2014/main" id="{2365FCF4-9CFA-4452-A68D-C6F3FD91478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9224886"/>
              </p:ext>
            </p:extLst>
          </p:nvPr>
        </p:nvGraphicFramePr>
        <p:xfrm>
          <a:off x="4577109" y="8146800"/>
          <a:ext cx="2260419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6"/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9BD9EFC-935E-58AA-A3FC-E5B4BF21915F}"/>
              </a:ext>
            </a:extLst>
          </p:cNvPr>
          <p:cNvSpPr txBox="1"/>
          <p:nvPr/>
        </p:nvSpPr>
        <p:spPr>
          <a:xfrm>
            <a:off x="172112" y="637439"/>
            <a:ext cx="66858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4">
            <a:extLst>
              <a:ext uri="{FF2B5EF4-FFF2-40B4-BE49-F238E27FC236}">
                <a16:creationId xmlns:a16="http://schemas.microsoft.com/office/drawing/2014/main" id="{C3F7849C-D26E-4A81-48A0-3A56F30F15CE}"/>
              </a:ext>
            </a:extLst>
          </p:cNvPr>
          <p:cNvSpPr txBox="1"/>
          <p:nvPr/>
        </p:nvSpPr>
        <p:spPr>
          <a:xfrm>
            <a:off x="6007160" y="3025838"/>
            <a:ext cx="659822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778F3432-254D-7185-1497-1BCF556B7FCC}"/>
              </a:ext>
            </a:extLst>
          </p:cNvPr>
          <p:cNvSpPr txBox="1"/>
          <p:nvPr/>
        </p:nvSpPr>
        <p:spPr>
          <a:xfrm>
            <a:off x="4186455" y="6622723"/>
            <a:ext cx="659821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4">
            <a:extLst>
              <a:ext uri="{FF2B5EF4-FFF2-40B4-BE49-F238E27FC236}">
                <a16:creationId xmlns:a16="http://schemas.microsoft.com/office/drawing/2014/main" id="{508A1DE8-E6BD-3BA7-92A9-4A57415F6FD4}"/>
              </a:ext>
            </a:extLst>
          </p:cNvPr>
          <p:cNvSpPr txBox="1"/>
          <p:nvPr/>
        </p:nvSpPr>
        <p:spPr>
          <a:xfrm>
            <a:off x="6217616" y="3178238"/>
            <a:ext cx="659822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4">
            <a:extLst>
              <a:ext uri="{FF2B5EF4-FFF2-40B4-BE49-F238E27FC236}">
                <a16:creationId xmlns:a16="http://schemas.microsoft.com/office/drawing/2014/main" id="{ED134B48-134D-637B-8C4D-8F441F22974F}"/>
              </a:ext>
            </a:extLst>
          </p:cNvPr>
          <p:cNvSpPr txBox="1"/>
          <p:nvPr/>
        </p:nvSpPr>
        <p:spPr>
          <a:xfrm>
            <a:off x="6436858" y="3356038"/>
            <a:ext cx="659822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4">
            <a:extLst>
              <a:ext uri="{FF2B5EF4-FFF2-40B4-BE49-F238E27FC236}">
                <a16:creationId xmlns:a16="http://schemas.microsoft.com/office/drawing/2014/main" id="{A47685ED-E872-B338-9823-1118E2C5888C}"/>
              </a:ext>
            </a:extLst>
          </p:cNvPr>
          <p:cNvSpPr txBox="1"/>
          <p:nvPr/>
        </p:nvSpPr>
        <p:spPr>
          <a:xfrm>
            <a:off x="4149331" y="4866623"/>
            <a:ext cx="659822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テキスト ボックス 4">
            <a:extLst>
              <a:ext uri="{FF2B5EF4-FFF2-40B4-BE49-F238E27FC236}">
                <a16:creationId xmlns:a16="http://schemas.microsoft.com/office/drawing/2014/main" id="{430CBC39-49B4-723F-FEF1-A5257D0CA9B1}"/>
              </a:ext>
            </a:extLst>
          </p:cNvPr>
          <p:cNvSpPr txBox="1"/>
          <p:nvPr/>
        </p:nvSpPr>
        <p:spPr>
          <a:xfrm>
            <a:off x="3947240" y="4808862"/>
            <a:ext cx="659822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テキスト ボックス 4">
            <a:extLst>
              <a:ext uri="{FF2B5EF4-FFF2-40B4-BE49-F238E27FC236}">
                <a16:creationId xmlns:a16="http://schemas.microsoft.com/office/drawing/2014/main" id="{B0E7C7BD-3307-456B-7F0C-003637B923F4}"/>
              </a:ext>
            </a:extLst>
          </p:cNvPr>
          <p:cNvSpPr txBox="1"/>
          <p:nvPr/>
        </p:nvSpPr>
        <p:spPr>
          <a:xfrm>
            <a:off x="6436171" y="4623805"/>
            <a:ext cx="659822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テキスト ボックス 4">
            <a:extLst>
              <a:ext uri="{FF2B5EF4-FFF2-40B4-BE49-F238E27FC236}">
                <a16:creationId xmlns:a16="http://schemas.microsoft.com/office/drawing/2014/main" id="{3428DE55-C41E-03FB-D4AD-6A6F1043B00E}"/>
              </a:ext>
            </a:extLst>
          </p:cNvPr>
          <p:cNvSpPr txBox="1"/>
          <p:nvPr/>
        </p:nvSpPr>
        <p:spPr>
          <a:xfrm>
            <a:off x="1658749" y="8220080"/>
            <a:ext cx="659822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3582B84D-C1FD-2989-28D8-DBDE2841AC2C}"/>
              </a:ext>
            </a:extLst>
          </p:cNvPr>
          <p:cNvSpPr txBox="1"/>
          <p:nvPr/>
        </p:nvSpPr>
        <p:spPr>
          <a:xfrm>
            <a:off x="1268890" y="8293360"/>
            <a:ext cx="659821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1700436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A3C1552F-D354-48EA-A004-6D865E4F56B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2030274"/>
              </p:ext>
            </p:extLst>
          </p:nvPr>
        </p:nvGraphicFramePr>
        <p:xfrm>
          <a:off x="0" y="928800"/>
          <a:ext cx="2265528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グラフ 4">
            <a:extLst>
              <a:ext uri="{FF2B5EF4-FFF2-40B4-BE49-F238E27FC236}">
                <a16:creationId xmlns:a16="http://schemas.microsoft.com/office/drawing/2014/main" id="{CC551E11-55D7-4DE7-91D1-6CBBE286D14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77973898"/>
              </p:ext>
            </p:extLst>
          </p:nvPr>
        </p:nvGraphicFramePr>
        <p:xfrm>
          <a:off x="2296800" y="928800"/>
          <a:ext cx="2265528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グラフ 5">
            <a:extLst>
              <a:ext uri="{FF2B5EF4-FFF2-40B4-BE49-F238E27FC236}">
                <a16:creationId xmlns:a16="http://schemas.microsoft.com/office/drawing/2014/main" id="{D0F2AE42-822D-4426-BF66-7840A4A5A90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6952941"/>
              </p:ext>
            </p:extLst>
          </p:nvPr>
        </p:nvGraphicFramePr>
        <p:xfrm>
          <a:off x="4572000" y="928800"/>
          <a:ext cx="2265529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" name="グラフ 6">
            <a:extLst>
              <a:ext uri="{FF2B5EF4-FFF2-40B4-BE49-F238E27FC236}">
                <a16:creationId xmlns:a16="http://schemas.microsoft.com/office/drawing/2014/main" id="{8C995995-BAFD-4F73-AF6E-11BBE04BB20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68115538"/>
              </p:ext>
            </p:extLst>
          </p:nvPr>
        </p:nvGraphicFramePr>
        <p:xfrm>
          <a:off x="0" y="2733300"/>
          <a:ext cx="2260419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8" name="グラフ 7">
            <a:extLst>
              <a:ext uri="{FF2B5EF4-FFF2-40B4-BE49-F238E27FC236}">
                <a16:creationId xmlns:a16="http://schemas.microsoft.com/office/drawing/2014/main" id="{CD9E422A-46E5-4410-B81A-2E225F89773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79576605"/>
              </p:ext>
            </p:extLst>
          </p:nvPr>
        </p:nvGraphicFramePr>
        <p:xfrm>
          <a:off x="2296800" y="2733300"/>
          <a:ext cx="2260419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9" name="グラフ 8">
            <a:extLst>
              <a:ext uri="{FF2B5EF4-FFF2-40B4-BE49-F238E27FC236}">
                <a16:creationId xmlns:a16="http://schemas.microsoft.com/office/drawing/2014/main" id="{09287BC8-09BD-45A8-993B-10BA2B4DF65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69279699"/>
              </p:ext>
            </p:extLst>
          </p:nvPr>
        </p:nvGraphicFramePr>
        <p:xfrm>
          <a:off x="4572000" y="2733300"/>
          <a:ext cx="2260419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0" name="グラフ 9">
            <a:extLst>
              <a:ext uri="{FF2B5EF4-FFF2-40B4-BE49-F238E27FC236}">
                <a16:creationId xmlns:a16="http://schemas.microsoft.com/office/drawing/2014/main" id="{5811D990-0279-4271-B1C7-8D89DBF34FA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96843300"/>
              </p:ext>
            </p:extLst>
          </p:nvPr>
        </p:nvGraphicFramePr>
        <p:xfrm>
          <a:off x="0" y="4549994"/>
          <a:ext cx="2260419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1" name="グラフ 10">
            <a:extLst>
              <a:ext uri="{FF2B5EF4-FFF2-40B4-BE49-F238E27FC236}">
                <a16:creationId xmlns:a16="http://schemas.microsoft.com/office/drawing/2014/main" id="{651FA0A4-5F42-40E8-A85F-8E7CE184E44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82924889"/>
              </p:ext>
            </p:extLst>
          </p:nvPr>
        </p:nvGraphicFramePr>
        <p:xfrm>
          <a:off x="2296800" y="4549994"/>
          <a:ext cx="2260419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12" name="グラフ 11">
            <a:extLst>
              <a:ext uri="{FF2B5EF4-FFF2-40B4-BE49-F238E27FC236}">
                <a16:creationId xmlns:a16="http://schemas.microsoft.com/office/drawing/2014/main" id="{6592190A-5BA3-46BB-A6FF-A7D8B18E6A3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92001691"/>
              </p:ext>
            </p:extLst>
          </p:nvPr>
        </p:nvGraphicFramePr>
        <p:xfrm>
          <a:off x="4572000" y="4549994"/>
          <a:ext cx="2260419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13" name="グラフ 12">
            <a:extLst>
              <a:ext uri="{FF2B5EF4-FFF2-40B4-BE49-F238E27FC236}">
                <a16:creationId xmlns:a16="http://schemas.microsoft.com/office/drawing/2014/main" id="{0F56D464-BE38-45E3-A458-6B6FA58A2F9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75716617"/>
              </p:ext>
            </p:extLst>
          </p:nvPr>
        </p:nvGraphicFramePr>
        <p:xfrm>
          <a:off x="0" y="6342300"/>
          <a:ext cx="2260419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14" name="グラフ 13">
            <a:extLst>
              <a:ext uri="{FF2B5EF4-FFF2-40B4-BE49-F238E27FC236}">
                <a16:creationId xmlns:a16="http://schemas.microsoft.com/office/drawing/2014/main" id="{4BDE9BBA-AB4C-4173-942E-5AF7491D586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69503732"/>
              </p:ext>
            </p:extLst>
          </p:nvPr>
        </p:nvGraphicFramePr>
        <p:xfrm>
          <a:off x="2296800" y="6342300"/>
          <a:ext cx="2260419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graphicFrame>
        <p:nvGraphicFramePr>
          <p:cNvPr id="15" name="グラフ 14">
            <a:extLst>
              <a:ext uri="{FF2B5EF4-FFF2-40B4-BE49-F238E27FC236}">
                <a16:creationId xmlns:a16="http://schemas.microsoft.com/office/drawing/2014/main" id="{57EC7664-EA8B-4691-9C7B-3DBBE49CB42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99515294"/>
              </p:ext>
            </p:extLst>
          </p:nvPr>
        </p:nvGraphicFramePr>
        <p:xfrm>
          <a:off x="4572000" y="6342300"/>
          <a:ext cx="2260419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graphicFrame>
        <p:nvGraphicFramePr>
          <p:cNvPr id="16" name="グラフ 15">
            <a:extLst>
              <a:ext uri="{FF2B5EF4-FFF2-40B4-BE49-F238E27FC236}">
                <a16:creationId xmlns:a16="http://schemas.microsoft.com/office/drawing/2014/main" id="{AFB8D4E8-37CA-4114-A9FB-696025070B9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27719523"/>
              </p:ext>
            </p:extLst>
          </p:nvPr>
        </p:nvGraphicFramePr>
        <p:xfrm>
          <a:off x="0" y="8146800"/>
          <a:ext cx="2260419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graphicFrame>
        <p:nvGraphicFramePr>
          <p:cNvPr id="17" name="グラフ 16">
            <a:extLst>
              <a:ext uri="{FF2B5EF4-FFF2-40B4-BE49-F238E27FC236}">
                <a16:creationId xmlns:a16="http://schemas.microsoft.com/office/drawing/2014/main" id="{8F51C77E-6880-4DC3-BB8B-57591A8830A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24612662"/>
              </p:ext>
            </p:extLst>
          </p:nvPr>
        </p:nvGraphicFramePr>
        <p:xfrm>
          <a:off x="2296800" y="8146800"/>
          <a:ext cx="2260419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5"/>
          </a:graphicData>
        </a:graphic>
      </p:graphicFrame>
      <p:graphicFrame>
        <p:nvGraphicFramePr>
          <p:cNvPr id="18" name="グラフ 17">
            <a:extLst>
              <a:ext uri="{FF2B5EF4-FFF2-40B4-BE49-F238E27FC236}">
                <a16:creationId xmlns:a16="http://schemas.microsoft.com/office/drawing/2014/main" id="{10B0230A-4E9E-420C-A527-A7003692569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48285783"/>
              </p:ext>
            </p:extLst>
          </p:nvPr>
        </p:nvGraphicFramePr>
        <p:xfrm>
          <a:off x="4572000" y="8146800"/>
          <a:ext cx="2260419" cy="16083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6"/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AB85AAA3-31EC-79FA-475F-FBCE4B326388}"/>
              </a:ext>
            </a:extLst>
          </p:cNvPr>
          <p:cNvSpPr txBox="1"/>
          <p:nvPr/>
        </p:nvSpPr>
        <p:spPr>
          <a:xfrm>
            <a:off x="172112" y="637439"/>
            <a:ext cx="66858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4">
            <a:extLst>
              <a:ext uri="{FF2B5EF4-FFF2-40B4-BE49-F238E27FC236}">
                <a16:creationId xmlns:a16="http://schemas.microsoft.com/office/drawing/2014/main" id="{E339BD2F-7ECD-9035-8FFA-34EC50773102}"/>
              </a:ext>
            </a:extLst>
          </p:cNvPr>
          <p:cNvSpPr txBox="1"/>
          <p:nvPr/>
        </p:nvSpPr>
        <p:spPr>
          <a:xfrm>
            <a:off x="3946507" y="1074318"/>
            <a:ext cx="659822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19F55510-D3ED-77BC-3058-B9C5DCAF821D}"/>
              </a:ext>
            </a:extLst>
          </p:cNvPr>
          <p:cNvSpPr txBox="1"/>
          <p:nvPr/>
        </p:nvSpPr>
        <p:spPr>
          <a:xfrm>
            <a:off x="3126126" y="6579241"/>
            <a:ext cx="659821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4">
            <a:extLst>
              <a:ext uri="{FF2B5EF4-FFF2-40B4-BE49-F238E27FC236}">
                <a16:creationId xmlns:a16="http://schemas.microsoft.com/office/drawing/2014/main" id="{E46C7128-9E4C-3467-F191-20E238757945}"/>
              </a:ext>
            </a:extLst>
          </p:cNvPr>
          <p:cNvSpPr txBox="1"/>
          <p:nvPr/>
        </p:nvSpPr>
        <p:spPr>
          <a:xfrm>
            <a:off x="4156963" y="1045290"/>
            <a:ext cx="659822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4">
            <a:extLst>
              <a:ext uri="{FF2B5EF4-FFF2-40B4-BE49-F238E27FC236}">
                <a16:creationId xmlns:a16="http://schemas.microsoft.com/office/drawing/2014/main" id="{B781A68E-0B4D-E6BA-DC0E-BE9947A1F66A}"/>
              </a:ext>
            </a:extLst>
          </p:cNvPr>
          <p:cNvSpPr txBox="1"/>
          <p:nvPr/>
        </p:nvSpPr>
        <p:spPr>
          <a:xfrm>
            <a:off x="6004571" y="1023519"/>
            <a:ext cx="659822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4">
            <a:extLst>
              <a:ext uri="{FF2B5EF4-FFF2-40B4-BE49-F238E27FC236}">
                <a16:creationId xmlns:a16="http://schemas.microsoft.com/office/drawing/2014/main" id="{7AB16C93-776B-3FD4-5EDC-3C285494D5AF}"/>
              </a:ext>
            </a:extLst>
          </p:cNvPr>
          <p:cNvSpPr txBox="1"/>
          <p:nvPr/>
        </p:nvSpPr>
        <p:spPr>
          <a:xfrm>
            <a:off x="6212692" y="925586"/>
            <a:ext cx="659822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テキスト ボックス 4">
            <a:extLst>
              <a:ext uri="{FF2B5EF4-FFF2-40B4-BE49-F238E27FC236}">
                <a16:creationId xmlns:a16="http://schemas.microsoft.com/office/drawing/2014/main" id="{D7D837D8-AD50-6053-A873-69220B1435F2}"/>
              </a:ext>
            </a:extLst>
          </p:cNvPr>
          <p:cNvSpPr txBox="1"/>
          <p:nvPr/>
        </p:nvSpPr>
        <p:spPr>
          <a:xfrm>
            <a:off x="6428449" y="896518"/>
            <a:ext cx="659822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テキスト ボックス 4">
            <a:extLst>
              <a:ext uri="{FF2B5EF4-FFF2-40B4-BE49-F238E27FC236}">
                <a16:creationId xmlns:a16="http://schemas.microsoft.com/office/drawing/2014/main" id="{A3CBF42C-4867-46A9-7303-122AAE860D22}"/>
              </a:ext>
            </a:extLst>
          </p:cNvPr>
          <p:cNvSpPr txBox="1"/>
          <p:nvPr/>
        </p:nvSpPr>
        <p:spPr>
          <a:xfrm>
            <a:off x="6212692" y="3304076"/>
            <a:ext cx="667079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テキスト ボックス 4">
            <a:extLst>
              <a:ext uri="{FF2B5EF4-FFF2-40B4-BE49-F238E27FC236}">
                <a16:creationId xmlns:a16="http://schemas.microsoft.com/office/drawing/2014/main" id="{E2283418-8BAE-ADAB-805B-CE8F4FA3C965}"/>
              </a:ext>
            </a:extLst>
          </p:cNvPr>
          <p:cNvSpPr txBox="1"/>
          <p:nvPr/>
        </p:nvSpPr>
        <p:spPr>
          <a:xfrm>
            <a:off x="6435048" y="3289562"/>
            <a:ext cx="659822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テキスト ボックス 4">
            <a:extLst>
              <a:ext uri="{FF2B5EF4-FFF2-40B4-BE49-F238E27FC236}">
                <a16:creationId xmlns:a16="http://schemas.microsoft.com/office/drawing/2014/main" id="{BE2891AB-2A4A-43BB-52FC-0A00F12FB62C}"/>
              </a:ext>
            </a:extLst>
          </p:cNvPr>
          <p:cNvSpPr txBox="1"/>
          <p:nvPr/>
        </p:nvSpPr>
        <p:spPr>
          <a:xfrm>
            <a:off x="3933949" y="4697643"/>
            <a:ext cx="659822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4">
            <a:extLst>
              <a:ext uri="{FF2B5EF4-FFF2-40B4-BE49-F238E27FC236}">
                <a16:creationId xmlns:a16="http://schemas.microsoft.com/office/drawing/2014/main" id="{E296BCDC-B59B-16E5-DD4C-AC829FB46C33}"/>
              </a:ext>
            </a:extLst>
          </p:cNvPr>
          <p:cNvSpPr txBox="1"/>
          <p:nvPr/>
        </p:nvSpPr>
        <p:spPr>
          <a:xfrm>
            <a:off x="4156304" y="4601535"/>
            <a:ext cx="659822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34F5A7F6-D0BF-AE05-AC01-4B607000471C}"/>
              </a:ext>
            </a:extLst>
          </p:cNvPr>
          <p:cNvSpPr txBox="1"/>
          <p:nvPr/>
        </p:nvSpPr>
        <p:spPr>
          <a:xfrm>
            <a:off x="6248978" y="6366709"/>
            <a:ext cx="659821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ECF9CC0B-230C-53A2-0C49-190E1CD87A4E}"/>
              </a:ext>
            </a:extLst>
          </p:cNvPr>
          <p:cNvSpPr txBox="1"/>
          <p:nvPr/>
        </p:nvSpPr>
        <p:spPr>
          <a:xfrm>
            <a:off x="6464077" y="6448090"/>
            <a:ext cx="659821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2310ACB2-319E-BF68-D2F9-895D63D0829F}"/>
              </a:ext>
            </a:extLst>
          </p:cNvPr>
          <p:cNvSpPr txBox="1"/>
          <p:nvPr/>
        </p:nvSpPr>
        <p:spPr>
          <a:xfrm>
            <a:off x="1460612" y="8151540"/>
            <a:ext cx="659821" cy="35560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3946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51</TotalTime>
  <Words>713</Words>
  <Application>Microsoft Office PowerPoint</Application>
  <PresentationFormat>A4 210 x 297 mm</PresentationFormat>
  <Paragraphs>262</Paragraphs>
  <Slides>6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omoko Warita</dc:creator>
  <cp:lastModifiedBy>Warita Katsuhiko</cp:lastModifiedBy>
  <cp:revision>86</cp:revision>
  <dcterms:created xsi:type="dcterms:W3CDTF">2022-03-02T05:38:16Z</dcterms:created>
  <dcterms:modified xsi:type="dcterms:W3CDTF">2023-07-08T07:41:36Z</dcterms:modified>
</cp:coreProperties>
</file>